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256" r:id="rId2"/>
    <p:sldId id="257" r:id="rId3"/>
    <p:sldId id="258" r:id="rId4"/>
    <p:sldId id="259" r:id="rId5"/>
    <p:sldId id="260" r:id="rId6"/>
    <p:sldId id="261" r:id="rId7"/>
    <p:sldId id="262" r:id="rId8"/>
    <p:sldId id="263" r:id="rId9"/>
    <p:sldId id="267" r:id="rId10"/>
    <p:sldId id="268" r:id="rId11"/>
    <p:sldId id="269" r:id="rId12"/>
    <p:sldId id="270" r:id="rId13"/>
    <p:sldId id="271" r:id="rId14"/>
    <p:sldId id="273" r:id="rId15"/>
    <p:sldId id="266" r:id="rId16"/>
    <p:sldId id="274" r:id="rId17"/>
    <p:sldId id="272" r:id="rId18"/>
    <p:sldId id="264" r:id="rId19"/>
    <p:sldId id="265" r:id="rId20"/>
  </p:sldIdLst>
  <p:sldSz cx="7772400" cy="10058400"/>
  <p:notesSz cx="7772400" cy="100584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FA29D5B1-C98E-D703-DA22-23A0446A0A2B}" name="Twist, Katherine E." initials="TE" userId="S::ketwis2@uky.edu::45331757-1fa0-4e4d-9a75-655a060dde67" providerId="AD"/>
</p188: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B600"/>
    <a:srgbClr val="749BAA"/>
    <a:srgbClr val="3C3939"/>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0CC3DE7B-5279-3B29-9775-114C9D57E971}" v="589" dt="2023-07-20T14:21:30.070"/>
    <p1510:client id="{57872DE8-37A1-38FD-2331-B8FE0636B974}" v="1" dt="2023-08-07T19:23:39.225"/>
    <p1510:client id="{7D25F2B9-8433-8119-F53A-BB61B3568F60}" v="2" dt="2023-07-13T13:15:33.154"/>
    <p1510:client id="{8BE82C1A-B136-2AFE-6FFF-18A3783526F0}" v="518" dt="2023-07-13T14:16:01.351"/>
    <p1510:client id="{9CE19E66-945B-E8E2-2608-944A76F90909}" v="287" dt="2023-07-20T13:09:23.380"/>
    <p1510:client id="{E30D171D-EFF4-ED4B-9D70-E0580DA69565}" v="830" dt="2023-06-30T20:28:43.785"/>
    <p1510:client id="{FE75AA84-895C-DB71-F837-09D140BC8C63}" v="263" dt="2023-07-20T13:09:53.554"/>
  </p1510:revLst>
</p1510:revInfo>
</file>

<file path=ppt/tableStyles.xml><?xml version="1.0" encoding="utf-8"?>
<a:tblStyleLst xmlns:a="http://schemas.openxmlformats.org/drawingml/2006/main" def="{5C22544A-7EE6-4342-B048-85BDC9FD1C3A}">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slideViewPr>
    <p:cSldViewPr snapToGrid="0">
      <p:cViewPr>
        <p:scale>
          <a:sx n="1" d="2"/>
          <a:sy n="1" d="2"/>
        </p:scale>
        <p:origin x="0" y="0"/>
      </p:cViewPr>
      <p:guideLst>
        <p:guide orient="horz" pos="2880"/>
        <p:guide pos="2160"/>
      </p:guideLst>
    </p:cSldViewPr>
  </p:slide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28" Type="http://schemas.microsoft.com/office/2018/10/relationships/authors" Target="author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 Id="rId27"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Yates, Rob A." userId="S::raya228@uky.edu::c4835988-b912-40a4-bf56-31a2afc86d77" providerId="AD" clId="Web-{FE75AA84-895C-DB71-F837-09D140BC8C63}"/>
    <pc:docChg chg="modSld">
      <pc:chgData name="Yates, Rob A." userId="S::raya228@uky.edu::c4835988-b912-40a4-bf56-31a2afc86d77" providerId="AD" clId="Web-{FE75AA84-895C-DB71-F837-09D140BC8C63}" dt="2023-07-20T13:09:53.554" v="152"/>
      <pc:docMkLst>
        <pc:docMk/>
      </pc:docMkLst>
      <pc:sldChg chg="addSp delSp modSp">
        <pc:chgData name="Yates, Rob A." userId="S::raya228@uky.edu::c4835988-b912-40a4-bf56-31a2afc86d77" providerId="AD" clId="Web-{FE75AA84-895C-DB71-F837-09D140BC8C63}" dt="2023-07-20T13:09:01.881" v="135" actId="1076"/>
        <pc:sldMkLst>
          <pc:docMk/>
          <pc:sldMk cId="0" sldId="266"/>
        </pc:sldMkLst>
        <pc:spChg chg="add mod">
          <ac:chgData name="Yates, Rob A." userId="S::raya228@uky.edu::c4835988-b912-40a4-bf56-31a2afc86d77" providerId="AD" clId="Web-{FE75AA84-895C-DB71-F837-09D140BC8C63}" dt="2023-07-20T13:08:06.863" v="125" actId="1076"/>
          <ac:spMkLst>
            <pc:docMk/>
            <pc:sldMk cId="0" sldId="266"/>
            <ac:spMk id="21" creationId="{3C46DF68-206C-975E-B6E9-2D13CFDE9DAC}"/>
          </ac:spMkLst>
        </pc:spChg>
        <pc:spChg chg="del mod">
          <ac:chgData name="Yates, Rob A." userId="S::raya228@uky.edu::c4835988-b912-40a4-bf56-31a2afc86d77" providerId="AD" clId="Web-{FE75AA84-895C-DB71-F837-09D140BC8C63}" dt="2023-07-20T13:07:53.832" v="123"/>
          <ac:spMkLst>
            <pc:docMk/>
            <pc:sldMk cId="0" sldId="266"/>
            <ac:spMk id="22" creationId="{A7959592-0544-8F4E-9699-7D9FB5B398C5}"/>
          </ac:spMkLst>
        </pc:spChg>
        <pc:spChg chg="add mod">
          <ac:chgData name="Yates, Rob A." userId="S::raya228@uky.edu::c4835988-b912-40a4-bf56-31a2afc86d77" providerId="AD" clId="Web-{FE75AA84-895C-DB71-F837-09D140BC8C63}" dt="2023-07-20T13:08:40.974" v="132" actId="1076"/>
          <ac:spMkLst>
            <pc:docMk/>
            <pc:sldMk cId="0" sldId="266"/>
            <ac:spMk id="23" creationId="{C539655A-0866-DA6D-BE56-19235318A4D0}"/>
          </ac:spMkLst>
        </pc:spChg>
        <pc:spChg chg="del mod">
          <ac:chgData name="Yates, Rob A." userId="S::raya228@uky.edu::c4835988-b912-40a4-bf56-31a2afc86d77" providerId="AD" clId="Web-{FE75AA84-895C-DB71-F837-09D140BC8C63}" dt="2023-07-20T13:08:21.098" v="130"/>
          <ac:spMkLst>
            <pc:docMk/>
            <pc:sldMk cId="0" sldId="266"/>
            <ac:spMk id="24" creationId="{E294AACE-CE98-7610-E948-7BB4322FB1D9}"/>
          </ac:spMkLst>
        </pc:spChg>
        <pc:spChg chg="add mod">
          <ac:chgData name="Yates, Rob A." userId="S::raya228@uky.edu::c4835988-b912-40a4-bf56-31a2afc86d77" providerId="AD" clId="Web-{FE75AA84-895C-DB71-F837-09D140BC8C63}" dt="2023-07-20T13:09:01.881" v="135" actId="1076"/>
          <ac:spMkLst>
            <pc:docMk/>
            <pc:sldMk cId="0" sldId="266"/>
            <ac:spMk id="25" creationId="{67CDE65E-C0E8-231F-C585-3A761441DE6B}"/>
          </ac:spMkLst>
        </pc:spChg>
        <pc:spChg chg="del">
          <ac:chgData name="Yates, Rob A." userId="S::raya228@uky.edu::c4835988-b912-40a4-bf56-31a2afc86d77" providerId="AD" clId="Web-{FE75AA84-895C-DB71-F837-09D140BC8C63}" dt="2023-07-20T13:08:50.318" v="133"/>
          <ac:spMkLst>
            <pc:docMk/>
            <pc:sldMk cId="0" sldId="266"/>
            <ac:spMk id="28" creationId="{146DC0BD-7AE3-5BEA-ECA6-EB86F243C910}"/>
          </ac:spMkLst>
        </pc:spChg>
      </pc:sldChg>
      <pc:sldChg chg="addSp delSp modSp">
        <pc:chgData name="Yates, Rob A." userId="S::raya228@uky.edu::c4835988-b912-40a4-bf56-31a2afc86d77" providerId="AD" clId="Web-{FE75AA84-895C-DB71-F837-09D140BC8C63}" dt="2023-07-20T13:09:53.554" v="152"/>
        <pc:sldMkLst>
          <pc:docMk/>
          <pc:sldMk cId="0" sldId="272"/>
        </pc:sldMkLst>
        <pc:spChg chg="del">
          <ac:chgData name="Yates, Rob A." userId="S::raya228@uky.edu::c4835988-b912-40a4-bf56-31a2afc86d77" providerId="AD" clId="Web-{FE75AA84-895C-DB71-F837-09D140BC8C63}" dt="2023-07-20T13:09:43.491" v="144"/>
          <ac:spMkLst>
            <pc:docMk/>
            <pc:sldMk cId="0" sldId="272"/>
            <ac:spMk id="22" creationId="{07DEC141-38B2-9AFD-279A-36616254A09B}"/>
          </ac:spMkLst>
        </pc:spChg>
        <pc:spChg chg="add del mod">
          <ac:chgData name="Yates, Rob A." userId="S::raya228@uky.edu::c4835988-b912-40a4-bf56-31a2afc86d77" providerId="AD" clId="Web-{FE75AA84-895C-DB71-F837-09D140BC8C63}" dt="2023-07-20T13:09:48.820" v="150"/>
          <ac:spMkLst>
            <pc:docMk/>
            <pc:sldMk cId="0" sldId="272"/>
            <ac:spMk id="23" creationId="{AB74A3A8-8ED1-EE96-26DC-94E931D2B8EE}"/>
          </ac:spMkLst>
        </pc:spChg>
        <pc:spChg chg="add">
          <ac:chgData name="Yates, Rob A." userId="S::raya228@uky.edu::c4835988-b912-40a4-bf56-31a2afc86d77" providerId="AD" clId="Web-{FE75AA84-895C-DB71-F837-09D140BC8C63}" dt="2023-07-20T13:09:45.085" v="146"/>
          <ac:spMkLst>
            <pc:docMk/>
            <pc:sldMk cId="0" sldId="272"/>
            <ac:spMk id="25" creationId="{B7AA5194-D6E4-30A8-1724-D475B85B3048}"/>
          </ac:spMkLst>
        </pc:spChg>
        <pc:spChg chg="add del">
          <ac:chgData name="Yates, Rob A." userId="S::raya228@uky.edu::c4835988-b912-40a4-bf56-31a2afc86d77" providerId="AD" clId="Web-{FE75AA84-895C-DB71-F837-09D140BC8C63}" dt="2023-07-20T13:09:50.882" v="151"/>
          <ac:spMkLst>
            <pc:docMk/>
            <pc:sldMk cId="0" sldId="272"/>
            <ac:spMk id="27" creationId="{227683B2-D22E-687D-01AE-B26060B3F0CD}"/>
          </ac:spMkLst>
        </pc:spChg>
        <pc:spChg chg="add del">
          <ac:chgData name="Yates, Rob A." userId="S::raya228@uky.edu::c4835988-b912-40a4-bf56-31a2afc86d77" providerId="AD" clId="Web-{FE75AA84-895C-DB71-F837-09D140BC8C63}" dt="2023-07-20T13:09:53.554" v="152"/>
          <ac:spMkLst>
            <pc:docMk/>
            <pc:sldMk cId="0" sldId="272"/>
            <ac:spMk id="29" creationId="{E2B72F91-3B78-9733-96F3-D1D4937CBD97}"/>
          </ac:spMkLst>
        </pc:spChg>
      </pc:sldChg>
      <pc:sldChg chg="addSp delSp">
        <pc:chgData name="Yates, Rob A." userId="S::raya228@uky.edu::c4835988-b912-40a4-bf56-31a2afc86d77" providerId="AD" clId="Web-{FE75AA84-895C-DB71-F837-09D140BC8C63}" dt="2023-07-20T13:09:39.101" v="143"/>
        <pc:sldMkLst>
          <pc:docMk/>
          <pc:sldMk cId="768398678" sldId="274"/>
        </pc:sldMkLst>
        <pc:spChg chg="del">
          <ac:chgData name="Yates, Rob A." userId="S::raya228@uky.edu::c4835988-b912-40a4-bf56-31a2afc86d77" providerId="AD" clId="Web-{FE75AA84-895C-DB71-F837-09D140BC8C63}" dt="2023-07-20T13:09:29.319" v="136"/>
          <ac:spMkLst>
            <pc:docMk/>
            <pc:sldMk cId="768398678" sldId="274"/>
            <ac:spMk id="22" creationId="{945C90C0-608D-B504-E4FE-49453BC620BF}"/>
          </ac:spMkLst>
        </pc:spChg>
        <pc:spChg chg="add">
          <ac:chgData name="Yates, Rob A." userId="S::raya228@uky.edu::c4835988-b912-40a4-bf56-31a2afc86d77" providerId="AD" clId="Web-{FE75AA84-895C-DB71-F837-09D140BC8C63}" dt="2023-07-20T13:09:39.038" v="140"/>
          <ac:spMkLst>
            <pc:docMk/>
            <pc:sldMk cId="768398678" sldId="274"/>
            <ac:spMk id="23" creationId="{C4FF2EDC-D6A3-674E-6ECE-557A8AA15B0C}"/>
          </ac:spMkLst>
        </pc:spChg>
        <pc:spChg chg="del">
          <ac:chgData name="Yates, Rob A." userId="S::raya228@uky.edu::c4835988-b912-40a4-bf56-31a2afc86d77" providerId="AD" clId="Web-{FE75AA84-895C-DB71-F837-09D140BC8C63}" dt="2023-07-20T13:09:33.897" v="138"/>
          <ac:spMkLst>
            <pc:docMk/>
            <pc:sldMk cId="768398678" sldId="274"/>
            <ac:spMk id="24" creationId="{EBB844BD-8FA0-572D-39AE-A0A80BB6BB44}"/>
          </ac:spMkLst>
        </pc:spChg>
        <pc:spChg chg="del">
          <ac:chgData name="Yates, Rob A." userId="S::raya228@uky.edu::c4835988-b912-40a4-bf56-31a2afc86d77" providerId="AD" clId="Web-{FE75AA84-895C-DB71-F837-09D140BC8C63}" dt="2023-07-20T13:09:31.788" v="137"/>
          <ac:spMkLst>
            <pc:docMk/>
            <pc:sldMk cId="768398678" sldId="274"/>
            <ac:spMk id="26" creationId="{9343616E-F68F-AAC1-26EE-FDA2E6323490}"/>
          </ac:spMkLst>
        </pc:spChg>
        <pc:spChg chg="add">
          <ac:chgData name="Yates, Rob A." userId="S::raya228@uky.edu::c4835988-b912-40a4-bf56-31a2afc86d77" providerId="AD" clId="Web-{FE75AA84-895C-DB71-F837-09D140BC8C63}" dt="2023-07-20T13:09:39.054" v="141"/>
          <ac:spMkLst>
            <pc:docMk/>
            <pc:sldMk cId="768398678" sldId="274"/>
            <ac:spMk id="27" creationId="{AB43F744-E489-19CF-E258-5C156943B87B}"/>
          </ac:spMkLst>
        </pc:spChg>
        <pc:spChg chg="del">
          <ac:chgData name="Yates, Rob A." userId="S::raya228@uky.edu::c4835988-b912-40a4-bf56-31a2afc86d77" providerId="AD" clId="Web-{FE75AA84-895C-DB71-F837-09D140BC8C63}" dt="2023-07-20T13:09:36.069" v="139"/>
          <ac:spMkLst>
            <pc:docMk/>
            <pc:sldMk cId="768398678" sldId="274"/>
            <ac:spMk id="28" creationId="{FCA45253-31F5-233E-97A6-2A02DEDA84D4}"/>
          </ac:spMkLst>
        </pc:spChg>
        <pc:spChg chg="add">
          <ac:chgData name="Yates, Rob A." userId="S::raya228@uky.edu::c4835988-b912-40a4-bf56-31a2afc86d77" providerId="AD" clId="Web-{FE75AA84-895C-DB71-F837-09D140BC8C63}" dt="2023-07-20T13:09:39.085" v="142"/>
          <ac:spMkLst>
            <pc:docMk/>
            <pc:sldMk cId="768398678" sldId="274"/>
            <ac:spMk id="30" creationId="{1583B9A0-CB9B-0A47-11F1-49138FF19F3C}"/>
          </ac:spMkLst>
        </pc:spChg>
        <pc:spChg chg="add">
          <ac:chgData name="Yates, Rob A." userId="S::raya228@uky.edu::c4835988-b912-40a4-bf56-31a2afc86d77" providerId="AD" clId="Web-{FE75AA84-895C-DB71-F837-09D140BC8C63}" dt="2023-07-20T13:09:39.101" v="143"/>
          <ac:spMkLst>
            <pc:docMk/>
            <pc:sldMk cId="768398678" sldId="274"/>
            <ac:spMk id="32" creationId="{D5361EB9-1BB6-CCEE-FC79-2FF791826E71}"/>
          </ac:spMkLst>
        </pc:spChg>
      </pc:sldChg>
    </pc:docChg>
  </pc:docChgLst>
  <pc:docChgLst>
    <pc:chgData name="Yates, Rob A." userId="S::raya228@uky.edu::c4835988-b912-40a4-bf56-31a2afc86d77" providerId="AD" clId="Web-{8BE82C1A-B136-2AFE-6FFF-18A3783526F0}"/>
    <pc:docChg chg="modSld">
      <pc:chgData name="Yates, Rob A." userId="S::raya228@uky.edu::c4835988-b912-40a4-bf56-31a2afc86d77" providerId="AD" clId="Web-{8BE82C1A-B136-2AFE-6FFF-18A3783526F0}" dt="2023-07-13T14:15:57.163" v="301" actId="20577"/>
      <pc:docMkLst>
        <pc:docMk/>
      </pc:docMkLst>
      <pc:sldChg chg="modSp">
        <pc:chgData name="Yates, Rob A." userId="S::raya228@uky.edu::c4835988-b912-40a4-bf56-31a2afc86d77" providerId="AD" clId="Web-{8BE82C1A-B136-2AFE-6FFF-18A3783526F0}" dt="2023-07-13T14:01:37.357" v="18" actId="20577"/>
        <pc:sldMkLst>
          <pc:docMk/>
          <pc:sldMk cId="0" sldId="257"/>
        </pc:sldMkLst>
        <pc:spChg chg="mod">
          <ac:chgData name="Yates, Rob A." userId="S::raya228@uky.edu::c4835988-b912-40a4-bf56-31a2afc86d77" providerId="AD" clId="Web-{8BE82C1A-B136-2AFE-6FFF-18A3783526F0}" dt="2023-07-13T14:01:37.357" v="18" actId="20577"/>
          <ac:spMkLst>
            <pc:docMk/>
            <pc:sldMk cId="0" sldId="257"/>
            <ac:spMk id="2" creationId="{00000000-0000-0000-0000-000000000000}"/>
          </ac:spMkLst>
        </pc:spChg>
      </pc:sldChg>
      <pc:sldChg chg="modSp">
        <pc:chgData name="Yates, Rob A." userId="S::raya228@uky.edu::c4835988-b912-40a4-bf56-31a2afc86d77" providerId="AD" clId="Web-{8BE82C1A-B136-2AFE-6FFF-18A3783526F0}" dt="2023-07-13T14:02:13.234" v="40" actId="20577"/>
        <pc:sldMkLst>
          <pc:docMk/>
          <pc:sldMk cId="0" sldId="258"/>
        </pc:sldMkLst>
        <pc:spChg chg="mod">
          <ac:chgData name="Yates, Rob A." userId="S::raya228@uky.edu::c4835988-b912-40a4-bf56-31a2afc86d77" providerId="AD" clId="Web-{8BE82C1A-B136-2AFE-6FFF-18A3783526F0}" dt="2023-07-13T14:01:47.561" v="25" actId="20577"/>
          <ac:spMkLst>
            <pc:docMk/>
            <pc:sldMk cId="0" sldId="258"/>
            <ac:spMk id="2" creationId="{00000000-0000-0000-0000-000000000000}"/>
          </ac:spMkLst>
        </pc:spChg>
        <pc:spChg chg="mod">
          <ac:chgData name="Yates, Rob A." userId="S::raya228@uky.edu::c4835988-b912-40a4-bf56-31a2afc86d77" providerId="AD" clId="Web-{8BE82C1A-B136-2AFE-6FFF-18A3783526F0}" dt="2023-07-13T14:02:13.234" v="40" actId="20577"/>
          <ac:spMkLst>
            <pc:docMk/>
            <pc:sldMk cId="0" sldId="258"/>
            <ac:spMk id="6" creationId="{00000000-0000-0000-0000-000000000000}"/>
          </ac:spMkLst>
        </pc:spChg>
      </pc:sldChg>
      <pc:sldChg chg="modSp">
        <pc:chgData name="Yates, Rob A." userId="S::raya228@uky.edu::c4835988-b912-40a4-bf56-31a2afc86d77" providerId="AD" clId="Web-{8BE82C1A-B136-2AFE-6FFF-18A3783526F0}" dt="2023-07-13T14:04:52.057" v="65" actId="20577"/>
        <pc:sldMkLst>
          <pc:docMk/>
          <pc:sldMk cId="0" sldId="259"/>
        </pc:sldMkLst>
        <pc:spChg chg="mod">
          <ac:chgData name="Yates, Rob A." userId="S::raya228@uky.edu::c4835988-b912-40a4-bf56-31a2afc86d77" providerId="AD" clId="Web-{8BE82C1A-B136-2AFE-6FFF-18A3783526F0}" dt="2023-07-13T14:03:30.943" v="55" actId="20577"/>
          <ac:spMkLst>
            <pc:docMk/>
            <pc:sldMk cId="0" sldId="259"/>
            <ac:spMk id="2" creationId="{00000000-0000-0000-0000-000000000000}"/>
          </ac:spMkLst>
        </pc:spChg>
        <pc:spChg chg="mod">
          <ac:chgData name="Yates, Rob A." userId="S::raya228@uky.edu::c4835988-b912-40a4-bf56-31a2afc86d77" providerId="AD" clId="Web-{8BE82C1A-B136-2AFE-6FFF-18A3783526F0}" dt="2023-07-13T14:04:52.057" v="65" actId="20577"/>
          <ac:spMkLst>
            <pc:docMk/>
            <pc:sldMk cId="0" sldId="259"/>
            <ac:spMk id="16" creationId="{00000000-0000-0000-0000-000000000000}"/>
          </ac:spMkLst>
        </pc:spChg>
      </pc:sldChg>
      <pc:sldChg chg="addSp delSp modSp">
        <pc:chgData name="Yates, Rob A." userId="S::raya228@uky.edu::c4835988-b912-40a4-bf56-31a2afc86d77" providerId="AD" clId="Web-{8BE82C1A-B136-2AFE-6FFF-18A3783526F0}" dt="2023-07-13T14:05:46.436" v="87" actId="20577"/>
        <pc:sldMkLst>
          <pc:docMk/>
          <pc:sldMk cId="0" sldId="260"/>
        </pc:sldMkLst>
        <pc:spChg chg="add del mod">
          <ac:chgData name="Yates, Rob A." userId="S::raya228@uky.edu::c4835988-b912-40a4-bf56-31a2afc86d77" providerId="AD" clId="Web-{8BE82C1A-B136-2AFE-6FFF-18A3783526F0}" dt="2023-07-13T14:05:18.153" v="73" actId="20577"/>
          <ac:spMkLst>
            <pc:docMk/>
            <pc:sldMk cId="0" sldId="260"/>
            <ac:spMk id="2" creationId="{00000000-0000-0000-0000-000000000000}"/>
          </ac:spMkLst>
        </pc:spChg>
        <pc:spChg chg="mod">
          <ac:chgData name="Yates, Rob A." userId="S::raya228@uky.edu::c4835988-b912-40a4-bf56-31a2afc86d77" providerId="AD" clId="Web-{8BE82C1A-B136-2AFE-6FFF-18A3783526F0}" dt="2023-07-13T13:13:15.349" v="5"/>
          <ac:spMkLst>
            <pc:docMk/>
            <pc:sldMk cId="0" sldId="260"/>
            <ac:spMk id="6" creationId="{00000000-0000-0000-0000-000000000000}"/>
          </ac:spMkLst>
        </pc:spChg>
        <pc:spChg chg="mod">
          <ac:chgData name="Yates, Rob A." userId="S::raya228@uky.edu::c4835988-b912-40a4-bf56-31a2afc86d77" providerId="AD" clId="Web-{8BE82C1A-B136-2AFE-6FFF-18A3783526F0}" dt="2023-07-13T13:13:21.083" v="6"/>
          <ac:spMkLst>
            <pc:docMk/>
            <pc:sldMk cId="0" sldId="260"/>
            <ac:spMk id="11" creationId="{00000000-0000-0000-0000-000000000000}"/>
          </ac:spMkLst>
        </pc:spChg>
        <pc:spChg chg="mod">
          <ac:chgData name="Yates, Rob A." userId="S::raya228@uky.edu::c4835988-b912-40a4-bf56-31a2afc86d77" providerId="AD" clId="Web-{8BE82C1A-B136-2AFE-6FFF-18A3783526F0}" dt="2023-07-13T14:05:46.436" v="87" actId="20577"/>
          <ac:spMkLst>
            <pc:docMk/>
            <pc:sldMk cId="0" sldId="260"/>
            <ac:spMk id="16" creationId="{00000000-0000-0000-0000-000000000000}"/>
          </ac:spMkLst>
        </pc:spChg>
      </pc:sldChg>
      <pc:sldChg chg="modSp">
        <pc:chgData name="Yates, Rob A." userId="S::raya228@uky.edu::c4835988-b912-40a4-bf56-31a2afc86d77" providerId="AD" clId="Web-{8BE82C1A-B136-2AFE-6FFF-18A3783526F0}" dt="2023-07-13T14:06:36.455" v="104" actId="20577"/>
        <pc:sldMkLst>
          <pc:docMk/>
          <pc:sldMk cId="0" sldId="261"/>
        </pc:sldMkLst>
        <pc:spChg chg="mod">
          <ac:chgData name="Yates, Rob A." userId="S::raya228@uky.edu::c4835988-b912-40a4-bf56-31a2afc86d77" providerId="AD" clId="Web-{8BE82C1A-B136-2AFE-6FFF-18A3783526F0}" dt="2023-07-13T14:06:36.455" v="104" actId="20577"/>
          <ac:spMkLst>
            <pc:docMk/>
            <pc:sldMk cId="0" sldId="261"/>
            <ac:spMk id="11" creationId="{00000000-0000-0000-0000-000000000000}"/>
          </ac:spMkLst>
        </pc:spChg>
      </pc:sldChg>
      <pc:sldChg chg="addSp modSp">
        <pc:chgData name="Yates, Rob A." userId="S::raya228@uky.edu::c4835988-b912-40a4-bf56-31a2afc86d77" providerId="AD" clId="Web-{8BE82C1A-B136-2AFE-6FFF-18A3783526F0}" dt="2023-07-13T14:13:11.808" v="254" actId="1076"/>
        <pc:sldMkLst>
          <pc:docMk/>
          <pc:sldMk cId="0" sldId="266"/>
        </pc:sldMkLst>
        <pc:spChg chg="mod">
          <ac:chgData name="Yates, Rob A." userId="S::raya228@uky.edu::c4835988-b912-40a4-bf56-31a2afc86d77" providerId="AD" clId="Web-{8BE82C1A-B136-2AFE-6FFF-18A3783526F0}" dt="2023-07-13T14:09:14.965" v="154" actId="20577"/>
          <ac:spMkLst>
            <pc:docMk/>
            <pc:sldMk cId="0" sldId="266"/>
            <ac:spMk id="4" creationId="{00000000-0000-0000-0000-000000000000}"/>
          </ac:spMkLst>
        </pc:spChg>
        <pc:spChg chg="mod">
          <ac:chgData name="Yates, Rob A." userId="S::raya228@uky.edu::c4835988-b912-40a4-bf56-31a2afc86d77" providerId="AD" clId="Web-{8BE82C1A-B136-2AFE-6FFF-18A3783526F0}" dt="2023-07-13T14:09:48.530" v="158" actId="20577"/>
          <ac:spMkLst>
            <pc:docMk/>
            <pc:sldMk cId="0" sldId="266"/>
            <ac:spMk id="8" creationId="{00000000-0000-0000-0000-000000000000}"/>
          </ac:spMkLst>
        </pc:spChg>
        <pc:spChg chg="mod">
          <ac:chgData name="Yates, Rob A." userId="S::raya228@uky.edu::c4835988-b912-40a4-bf56-31a2afc86d77" providerId="AD" clId="Web-{8BE82C1A-B136-2AFE-6FFF-18A3783526F0}" dt="2023-07-13T14:10:06.625" v="162" actId="20577"/>
          <ac:spMkLst>
            <pc:docMk/>
            <pc:sldMk cId="0" sldId="266"/>
            <ac:spMk id="13" creationId="{00000000-0000-0000-0000-000000000000}"/>
          </ac:spMkLst>
        </pc:spChg>
        <pc:spChg chg="mod">
          <ac:chgData name="Yates, Rob A." userId="S::raya228@uky.edu::c4835988-b912-40a4-bf56-31a2afc86d77" providerId="AD" clId="Web-{8BE82C1A-B136-2AFE-6FFF-18A3783526F0}" dt="2023-07-13T14:10:16.438" v="163" actId="1076"/>
          <ac:spMkLst>
            <pc:docMk/>
            <pc:sldMk cId="0" sldId="266"/>
            <ac:spMk id="18" creationId="{00000000-0000-0000-0000-000000000000}"/>
          </ac:spMkLst>
        </pc:spChg>
        <pc:spChg chg="add mod">
          <ac:chgData name="Yates, Rob A." userId="S::raya228@uky.edu::c4835988-b912-40a4-bf56-31a2afc86d77" providerId="AD" clId="Web-{8BE82C1A-B136-2AFE-6FFF-18A3783526F0}" dt="2023-07-13T14:13:11.808" v="254" actId="1076"/>
          <ac:spMkLst>
            <pc:docMk/>
            <pc:sldMk cId="0" sldId="266"/>
            <ac:spMk id="22" creationId="{A7959592-0544-8F4E-9699-7D9FB5B398C5}"/>
          </ac:spMkLst>
        </pc:spChg>
        <pc:spChg chg="add mod">
          <ac:chgData name="Yates, Rob A." userId="S::raya228@uky.edu::c4835988-b912-40a4-bf56-31a2afc86d77" providerId="AD" clId="Web-{8BE82C1A-B136-2AFE-6FFF-18A3783526F0}" dt="2023-07-13T14:13:11.715" v="251" actId="1076"/>
          <ac:spMkLst>
            <pc:docMk/>
            <pc:sldMk cId="0" sldId="266"/>
            <ac:spMk id="24" creationId="{E294AACE-CE98-7610-E948-7BB4322FB1D9}"/>
          </ac:spMkLst>
        </pc:spChg>
        <pc:spChg chg="add mod">
          <ac:chgData name="Yates, Rob A." userId="S::raya228@uky.edu::c4835988-b912-40a4-bf56-31a2afc86d77" providerId="AD" clId="Web-{8BE82C1A-B136-2AFE-6FFF-18A3783526F0}" dt="2023-07-13T14:13:11.746" v="252" actId="1076"/>
          <ac:spMkLst>
            <pc:docMk/>
            <pc:sldMk cId="0" sldId="266"/>
            <ac:spMk id="26" creationId="{8D5CA340-99A5-5FEA-C283-752C38D8C231}"/>
          </ac:spMkLst>
        </pc:spChg>
        <pc:spChg chg="add mod">
          <ac:chgData name="Yates, Rob A." userId="S::raya228@uky.edu::c4835988-b912-40a4-bf56-31a2afc86d77" providerId="AD" clId="Web-{8BE82C1A-B136-2AFE-6FFF-18A3783526F0}" dt="2023-07-13T14:13:11.777" v="253" actId="1076"/>
          <ac:spMkLst>
            <pc:docMk/>
            <pc:sldMk cId="0" sldId="266"/>
            <ac:spMk id="28" creationId="{146DC0BD-7AE3-5BEA-ECA6-EB86F243C910}"/>
          </ac:spMkLst>
        </pc:spChg>
      </pc:sldChg>
      <pc:sldChg chg="modSp">
        <pc:chgData name="Yates, Rob A." userId="S::raya228@uky.edu::c4835988-b912-40a4-bf56-31a2afc86d77" providerId="AD" clId="Web-{8BE82C1A-B136-2AFE-6FFF-18A3783526F0}" dt="2023-07-13T14:07:08.097" v="122" actId="20577"/>
        <pc:sldMkLst>
          <pc:docMk/>
          <pc:sldMk cId="0" sldId="267"/>
        </pc:sldMkLst>
        <pc:spChg chg="mod">
          <ac:chgData name="Yates, Rob A." userId="S::raya228@uky.edu::c4835988-b912-40a4-bf56-31a2afc86d77" providerId="AD" clId="Web-{8BE82C1A-B136-2AFE-6FFF-18A3783526F0}" dt="2023-07-13T14:07:08.097" v="122" actId="20577"/>
          <ac:spMkLst>
            <pc:docMk/>
            <pc:sldMk cId="0" sldId="267"/>
            <ac:spMk id="6" creationId="{00000000-0000-0000-0000-000000000000}"/>
          </ac:spMkLst>
        </pc:spChg>
      </pc:sldChg>
      <pc:sldChg chg="modSp">
        <pc:chgData name="Yates, Rob A." userId="S::raya228@uky.edu::c4835988-b912-40a4-bf56-31a2afc86d77" providerId="AD" clId="Web-{8BE82C1A-B136-2AFE-6FFF-18A3783526F0}" dt="2023-07-13T14:08:45.260" v="150" actId="20577"/>
        <pc:sldMkLst>
          <pc:docMk/>
          <pc:sldMk cId="0" sldId="271"/>
        </pc:sldMkLst>
        <pc:spChg chg="mod">
          <ac:chgData name="Yates, Rob A." userId="S::raya228@uky.edu::c4835988-b912-40a4-bf56-31a2afc86d77" providerId="AD" clId="Web-{8BE82C1A-B136-2AFE-6FFF-18A3783526F0}" dt="2023-07-13T14:08:45.260" v="150" actId="20577"/>
          <ac:spMkLst>
            <pc:docMk/>
            <pc:sldMk cId="0" sldId="271"/>
            <ac:spMk id="11" creationId="{00000000-0000-0000-0000-000000000000}"/>
          </ac:spMkLst>
        </pc:spChg>
        <pc:spChg chg="mod">
          <ac:chgData name="Yates, Rob A." userId="S::raya228@uky.edu::c4835988-b912-40a4-bf56-31a2afc86d77" providerId="AD" clId="Web-{8BE82C1A-B136-2AFE-6FFF-18A3783526F0}" dt="2023-07-13T14:08:14.852" v="136" actId="20577"/>
          <ac:spMkLst>
            <pc:docMk/>
            <pc:sldMk cId="0" sldId="271"/>
            <ac:spMk id="16" creationId="{00000000-0000-0000-0000-000000000000}"/>
          </ac:spMkLst>
        </pc:spChg>
      </pc:sldChg>
      <pc:sldChg chg="addSp delSp modSp">
        <pc:chgData name="Yates, Rob A." userId="S::raya228@uky.edu::c4835988-b912-40a4-bf56-31a2afc86d77" providerId="AD" clId="Web-{8BE82C1A-B136-2AFE-6FFF-18A3783526F0}" dt="2023-07-13T14:15:12.176" v="289" actId="20577"/>
        <pc:sldMkLst>
          <pc:docMk/>
          <pc:sldMk cId="0" sldId="272"/>
        </pc:sldMkLst>
        <pc:spChg chg="mod">
          <ac:chgData name="Yates, Rob A." userId="S::raya228@uky.edu::c4835988-b912-40a4-bf56-31a2afc86d77" providerId="AD" clId="Web-{8BE82C1A-B136-2AFE-6FFF-18A3783526F0}" dt="2023-07-13T14:15:12.176" v="289" actId="20577"/>
          <ac:spMkLst>
            <pc:docMk/>
            <pc:sldMk cId="0" sldId="272"/>
            <ac:spMk id="4" creationId="{00000000-0000-0000-0000-000000000000}"/>
          </ac:spMkLst>
        </pc:spChg>
        <pc:spChg chg="add">
          <ac:chgData name="Yates, Rob A." userId="S::raya228@uky.edu::c4835988-b912-40a4-bf56-31a2afc86d77" providerId="AD" clId="Web-{8BE82C1A-B136-2AFE-6FFF-18A3783526F0}" dt="2023-07-13T14:14:42.814" v="279"/>
          <ac:spMkLst>
            <pc:docMk/>
            <pc:sldMk cId="0" sldId="272"/>
            <ac:spMk id="22" creationId="{07DEC141-38B2-9AFD-279A-36616254A09B}"/>
          </ac:spMkLst>
        </pc:spChg>
        <pc:spChg chg="add del">
          <ac:chgData name="Yates, Rob A." userId="S::raya228@uky.edu::c4835988-b912-40a4-bf56-31a2afc86d77" providerId="AD" clId="Web-{8BE82C1A-B136-2AFE-6FFF-18A3783526F0}" dt="2023-07-13T14:15:01.987" v="286"/>
          <ac:spMkLst>
            <pc:docMk/>
            <pc:sldMk cId="0" sldId="272"/>
            <ac:spMk id="24" creationId="{917CED92-B62C-DCF1-5381-A770896A8878}"/>
          </ac:spMkLst>
        </pc:spChg>
        <pc:spChg chg="add del mod">
          <ac:chgData name="Yates, Rob A." userId="S::raya228@uky.edu::c4835988-b912-40a4-bf56-31a2afc86d77" providerId="AD" clId="Web-{8BE82C1A-B136-2AFE-6FFF-18A3783526F0}" dt="2023-07-13T14:14:59.409" v="285"/>
          <ac:spMkLst>
            <pc:docMk/>
            <pc:sldMk cId="0" sldId="272"/>
            <ac:spMk id="26" creationId="{19BC1FDB-3D6D-E5DA-751B-775331D13465}"/>
          </ac:spMkLst>
        </pc:spChg>
        <pc:spChg chg="add del">
          <ac:chgData name="Yates, Rob A." userId="S::raya228@uky.edu::c4835988-b912-40a4-bf56-31a2afc86d77" providerId="AD" clId="Web-{8BE82C1A-B136-2AFE-6FFF-18A3783526F0}" dt="2023-07-13T14:15:04.878" v="287"/>
          <ac:spMkLst>
            <pc:docMk/>
            <pc:sldMk cId="0" sldId="272"/>
            <ac:spMk id="28" creationId="{12DDBF96-40FE-7626-8618-78BBE783C677}"/>
          </ac:spMkLst>
        </pc:spChg>
      </pc:sldChg>
      <pc:sldChg chg="addSp modSp">
        <pc:chgData name="Yates, Rob A." userId="S::raya228@uky.edu::c4835988-b912-40a4-bf56-31a2afc86d77" providerId="AD" clId="Web-{8BE82C1A-B136-2AFE-6FFF-18A3783526F0}" dt="2023-07-13T14:15:57.163" v="301" actId="20577"/>
        <pc:sldMkLst>
          <pc:docMk/>
          <pc:sldMk cId="768398678" sldId="274"/>
        </pc:sldMkLst>
        <pc:spChg chg="mod">
          <ac:chgData name="Yates, Rob A." userId="S::raya228@uky.edu::c4835988-b912-40a4-bf56-31a2afc86d77" providerId="AD" clId="Web-{8BE82C1A-B136-2AFE-6FFF-18A3783526F0}" dt="2023-07-13T14:15:57.163" v="301" actId="20577"/>
          <ac:spMkLst>
            <pc:docMk/>
            <pc:sldMk cId="768398678" sldId="274"/>
            <ac:spMk id="4" creationId="{00000000-0000-0000-0000-000000000000}"/>
          </ac:spMkLst>
        </pc:spChg>
        <pc:spChg chg="mod">
          <ac:chgData name="Yates, Rob A." userId="S::raya228@uky.edu::c4835988-b912-40a4-bf56-31a2afc86d77" providerId="AD" clId="Web-{8BE82C1A-B136-2AFE-6FFF-18A3783526F0}" dt="2023-07-13T14:15:26.802" v="291" actId="14100"/>
          <ac:spMkLst>
            <pc:docMk/>
            <pc:sldMk cId="768398678" sldId="274"/>
            <ac:spMk id="8" creationId="{00000000-0000-0000-0000-000000000000}"/>
          </ac:spMkLst>
        </pc:spChg>
        <pc:spChg chg="mod">
          <ac:chgData name="Yates, Rob A." userId="S::raya228@uky.edu::c4835988-b912-40a4-bf56-31a2afc86d77" providerId="AD" clId="Web-{8BE82C1A-B136-2AFE-6FFF-18A3783526F0}" dt="2023-07-13T14:15:34.474" v="293" actId="1076"/>
          <ac:spMkLst>
            <pc:docMk/>
            <pc:sldMk cId="768398678" sldId="274"/>
            <ac:spMk id="13" creationId="{00000000-0000-0000-0000-000000000000}"/>
          </ac:spMkLst>
        </pc:spChg>
        <pc:spChg chg="mod">
          <ac:chgData name="Yates, Rob A." userId="S::raya228@uky.edu::c4835988-b912-40a4-bf56-31a2afc86d77" providerId="AD" clId="Web-{8BE82C1A-B136-2AFE-6FFF-18A3783526F0}" dt="2023-07-13T14:13:49.170" v="266" actId="20577"/>
          <ac:spMkLst>
            <pc:docMk/>
            <pc:sldMk cId="768398678" sldId="274"/>
            <ac:spMk id="18" creationId="{00000000-0000-0000-0000-000000000000}"/>
          </ac:spMkLst>
        </pc:spChg>
        <pc:spChg chg="add">
          <ac:chgData name="Yates, Rob A." userId="S::raya228@uky.edu::c4835988-b912-40a4-bf56-31a2afc86d77" providerId="AD" clId="Web-{8BE82C1A-B136-2AFE-6FFF-18A3783526F0}" dt="2023-07-13T14:13:55.030" v="267"/>
          <ac:spMkLst>
            <pc:docMk/>
            <pc:sldMk cId="768398678" sldId="274"/>
            <ac:spMk id="22" creationId="{945C90C0-608D-B504-E4FE-49453BC620BF}"/>
          </ac:spMkLst>
        </pc:spChg>
        <pc:spChg chg="add">
          <ac:chgData name="Yates, Rob A." userId="S::raya228@uky.edu::c4835988-b912-40a4-bf56-31a2afc86d77" providerId="AD" clId="Web-{8BE82C1A-B136-2AFE-6FFF-18A3783526F0}" dt="2023-07-13T14:13:55.061" v="268"/>
          <ac:spMkLst>
            <pc:docMk/>
            <pc:sldMk cId="768398678" sldId="274"/>
            <ac:spMk id="24" creationId="{EBB844BD-8FA0-572D-39AE-A0A80BB6BB44}"/>
          </ac:spMkLst>
        </pc:spChg>
        <pc:spChg chg="add">
          <ac:chgData name="Yates, Rob A." userId="S::raya228@uky.edu::c4835988-b912-40a4-bf56-31a2afc86d77" providerId="AD" clId="Web-{8BE82C1A-B136-2AFE-6FFF-18A3783526F0}" dt="2023-07-13T14:13:55.092" v="269"/>
          <ac:spMkLst>
            <pc:docMk/>
            <pc:sldMk cId="768398678" sldId="274"/>
            <ac:spMk id="26" creationId="{9343616E-F68F-AAC1-26EE-FDA2E6323490}"/>
          </ac:spMkLst>
        </pc:spChg>
        <pc:spChg chg="add">
          <ac:chgData name="Yates, Rob A." userId="S::raya228@uky.edu::c4835988-b912-40a4-bf56-31a2afc86d77" providerId="AD" clId="Web-{8BE82C1A-B136-2AFE-6FFF-18A3783526F0}" dt="2023-07-13T14:13:55.124" v="270"/>
          <ac:spMkLst>
            <pc:docMk/>
            <pc:sldMk cId="768398678" sldId="274"/>
            <ac:spMk id="28" creationId="{FCA45253-31F5-233E-97A6-2A02DEDA84D4}"/>
          </ac:spMkLst>
        </pc:spChg>
      </pc:sldChg>
    </pc:docChg>
  </pc:docChgLst>
  <pc:docChgLst>
    <pc:chgData name="Twist, Katherine E." userId="S::ketwis2@uky.edu::45331757-1fa0-4e4d-9a75-655a060dde67" providerId="AD" clId="Web-{57872DE8-37A1-38FD-2331-B8FE0636B974}"/>
    <pc:docChg chg="">
      <pc:chgData name="Twist, Katherine E." userId="S::ketwis2@uky.edu::45331757-1fa0-4e4d-9a75-655a060dde67" providerId="AD" clId="Web-{57872DE8-37A1-38FD-2331-B8FE0636B974}" dt="2023-08-07T19:23:39.225" v="0"/>
      <pc:docMkLst>
        <pc:docMk/>
      </pc:docMkLst>
      <pc:sldChg chg="delCm">
        <pc:chgData name="Twist, Katherine E." userId="S::ketwis2@uky.edu::45331757-1fa0-4e4d-9a75-655a060dde67" providerId="AD" clId="Web-{57872DE8-37A1-38FD-2331-B8FE0636B974}" dt="2023-08-07T19:23:39.225" v="0"/>
        <pc:sldMkLst>
          <pc:docMk/>
          <pc:sldMk cId="0" sldId="256"/>
        </pc:sldMkLst>
        <pc:extLst>
          <p:ext xmlns:p="http://schemas.openxmlformats.org/presentationml/2006/main" uri="{D6D511B9-2390-475A-947B-AFAB55BFBCF1}">
            <pc226:cmChg xmlns:pc226="http://schemas.microsoft.com/office/powerpoint/2022/06/main/command" chg="del">
              <pc226:chgData name="Twist, Katherine E." userId="S::ketwis2@uky.edu::45331757-1fa0-4e4d-9a75-655a060dde67" providerId="AD" clId="Web-{57872DE8-37A1-38FD-2331-B8FE0636B974}" dt="2023-08-07T19:23:39.225" v="0"/>
              <pc2:cmMkLst xmlns:pc2="http://schemas.microsoft.com/office/powerpoint/2019/9/main/command">
                <pc:docMk/>
                <pc:sldMk cId="0" sldId="256"/>
                <pc2:cmMk id="{4682E7CF-56D5-491E-984E-5F6D6E124E0E}"/>
              </pc2:cmMkLst>
            </pc226:cmChg>
          </p:ext>
        </pc:extLst>
      </pc:sldChg>
    </pc:docChg>
  </pc:docChgLst>
  <pc:docChgLst>
    <pc:chgData name="Yates, Rob A." userId="S::raya228@uky.edu::c4835988-b912-40a4-bf56-31a2afc86d77" providerId="AD" clId="Web-{0CC3DE7B-5279-3B29-9775-114C9D57E971}"/>
    <pc:docChg chg="addSld delSld modSld">
      <pc:chgData name="Yates, Rob A." userId="S::raya228@uky.edu::c4835988-b912-40a4-bf56-31a2afc86d77" providerId="AD" clId="Web-{0CC3DE7B-5279-3B29-9775-114C9D57E971}" dt="2023-07-20T14:21:30.070" v="586"/>
      <pc:docMkLst>
        <pc:docMk/>
      </pc:docMkLst>
      <pc:sldChg chg="addSp delSp">
        <pc:chgData name="Yates, Rob A." userId="S::raya228@uky.edu::c4835988-b912-40a4-bf56-31a2afc86d77" providerId="AD" clId="Web-{0CC3DE7B-5279-3B29-9775-114C9D57E971}" dt="2023-07-20T13:23:41.049" v="35"/>
        <pc:sldMkLst>
          <pc:docMk/>
          <pc:sldMk cId="0" sldId="256"/>
        </pc:sldMkLst>
        <pc:spChg chg="del">
          <ac:chgData name="Yates, Rob A." userId="S::raya228@uky.edu::c4835988-b912-40a4-bf56-31a2afc86d77" providerId="AD" clId="Web-{0CC3DE7B-5279-3B29-9775-114C9D57E971}" dt="2023-07-20T13:23:02.829" v="4"/>
          <ac:spMkLst>
            <pc:docMk/>
            <pc:sldMk cId="0" sldId="256"/>
            <ac:spMk id="4" creationId="{00000000-0000-0000-0000-000000000000}"/>
          </ac:spMkLst>
        </pc:spChg>
        <pc:spChg chg="del">
          <ac:chgData name="Yates, Rob A." userId="S::raya228@uky.edu::c4835988-b912-40a4-bf56-31a2afc86d77" providerId="AD" clId="Web-{0CC3DE7B-5279-3B29-9775-114C9D57E971}" dt="2023-07-20T13:23:04.454" v="5"/>
          <ac:spMkLst>
            <pc:docMk/>
            <pc:sldMk cId="0" sldId="256"/>
            <ac:spMk id="5" creationId="{00000000-0000-0000-0000-000000000000}"/>
          </ac:spMkLst>
        </pc:spChg>
        <pc:spChg chg="del">
          <ac:chgData name="Yates, Rob A." userId="S::raya228@uky.edu::c4835988-b912-40a4-bf56-31a2afc86d77" providerId="AD" clId="Web-{0CC3DE7B-5279-3B29-9775-114C9D57E971}" dt="2023-07-20T13:23:09.188" v="7"/>
          <ac:spMkLst>
            <pc:docMk/>
            <pc:sldMk cId="0" sldId="256"/>
            <ac:spMk id="8" creationId="{00000000-0000-0000-0000-000000000000}"/>
          </ac:spMkLst>
        </pc:spChg>
        <pc:spChg chg="del">
          <ac:chgData name="Yates, Rob A." userId="S::raya228@uky.edu::c4835988-b912-40a4-bf56-31a2afc86d77" providerId="AD" clId="Web-{0CC3DE7B-5279-3B29-9775-114C9D57E971}" dt="2023-07-20T13:23:07.095" v="6"/>
          <ac:spMkLst>
            <pc:docMk/>
            <pc:sldMk cId="0" sldId="256"/>
            <ac:spMk id="9" creationId="{00000000-0000-0000-0000-000000000000}"/>
          </ac:spMkLst>
        </pc:spChg>
        <pc:spChg chg="del">
          <ac:chgData name="Yates, Rob A." userId="S::raya228@uky.edu::c4835988-b912-40a4-bf56-31a2afc86d77" providerId="AD" clId="Web-{0CC3DE7B-5279-3B29-9775-114C9D57E971}" dt="2023-07-20T13:23:17.001" v="11"/>
          <ac:spMkLst>
            <pc:docMk/>
            <pc:sldMk cId="0" sldId="256"/>
            <ac:spMk id="13" creationId="{00000000-0000-0000-0000-000000000000}"/>
          </ac:spMkLst>
        </pc:spChg>
        <pc:spChg chg="del">
          <ac:chgData name="Yates, Rob A." userId="S::raya228@uky.edu::c4835988-b912-40a4-bf56-31a2afc86d77" providerId="AD" clId="Web-{0CC3DE7B-5279-3B29-9775-114C9D57E971}" dt="2023-07-20T13:23:15.985" v="10"/>
          <ac:spMkLst>
            <pc:docMk/>
            <pc:sldMk cId="0" sldId="256"/>
            <ac:spMk id="14" creationId="{00000000-0000-0000-0000-000000000000}"/>
          </ac:spMkLst>
        </pc:spChg>
        <pc:spChg chg="del">
          <ac:chgData name="Yates, Rob A." userId="S::raya228@uky.edu::c4835988-b912-40a4-bf56-31a2afc86d77" providerId="AD" clId="Web-{0CC3DE7B-5279-3B29-9775-114C9D57E971}" dt="2023-07-20T13:23:21.454" v="14"/>
          <ac:spMkLst>
            <pc:docMk/>
            <pc:sldMk cId="0" sldId="256"/>
            <ac:spMk id="18" creationId="{00000000-0000-0000-0000-000000000000}"/>
          </ac:spMkLst>
        </pc:spChg>
        <pc:spChg chg="del">
          <ac:chgData name="Yates, Rob A." userId="S::raya228@uky.edu::c4835988-b912-40a4-bf56-31a2afc86d77" providerId="AD" clId="Web-{0CC3DE7B-5279-3B29-9775-114C9D57E971}" dt="2023-07-20T13:23:33.861" v="17"/>
          <ac:spMkLst>
            <pc:docMk/>
            <pc:sldMk cId="0" sldId="256"/>
            <ac:spMk id="19" creationId="{00000000-0000-0000-0000-000000000000}"/>
          </ac:spMkLst>
        </pc:spChg>
        <pc:spChg chg="add del">
          <ac:chgData name="Yates, Rob A." userId="S::raya228@uky.edu::c4835988-b912-40a4-bf56-31a2afc86d77" providerId="AD" clId="Web-{0CC3DE7B-5279-3B29-9775-114C9D57E971}" dt="2023-07-20T13:23:25.548" v="16"/>
          <ac:spMkLst>
            <pc:docMk/>
            <pc:sldMk cId="0" sldId="256"/>
            <ac:spMk id="20" creationId="{00000000-0000-0000-0000-000000000000}"/>
          </ac:spMkLst>
        </pc:spChg>
        <pc:spChg chg="del">
          <ac:chgData name="Yates, Rob A." userId="S::raya228@uky.edu::c4835988-b912-40a4-bf56-31a2afc86d77" providerId="AD" clId="Web-{0CC3DE7B-5279-3B29-9775-114C9D57E971}" dt="2023-07-20T13:22:59.001" v="3"/>
          <ac:spMkLst>
            <pc:docMk/>
            <pc:sldMk cId="0" sldId="256"/>
            <ac:spMk id="21" creationId="{EAEC0BBE-FEFB-7F43-AFFE-5B8DD8708E2B}"/>
          </ac:spMkLst>
        </pc:spChg>
        <pc:spChg chg="del">
          <ac:chgData name="Yates, Rob A." userId="S::raya228@uky.edu::c4835988-b912-40a4-bf56-31a2afc86d77" providerId="AD" clId="Web-{0CC3DE7B-5279-3B29-9775-114C9D57E971}" dt="2023-07-20T13:22:59.001" v="2"/>
          <ac:spMkLst>
            <pc:docMk/>
            <pc:sldMk cId="0" sldId="256"/>
            <ac:spMk id="22" creationId="{719539FC-2F83-7A42-A5BF-D3E947F4247F}"/>
          </ac:spMkLst>
        </pc:spChg>
        <pc:spChg chg="del">
          <ac:chgData name="Yates, Rob A." userId="S::raya228@uky.edu::c4835988-b912-40a4-bf56-31a2afc86d77" providerId="AD" clId="Web-{0CC3DE7B-5279-3B29-9775-114C9D57E971}" dt="2023-07-20T13:23:19.861" v="13"/>
          <ac:spMkLst>
            <pc:docMk/>
            <pc:sldMk cId="0" sldId="256"/>
            <ac:spMk id="23" creationId="{F0061B45-B90D-E10D-AE4C-CBB35BD5311C}"/>
          </ac:spMkLst>
        </pc:spChg>
        <pc:spChg chg="del">
          <ac:chgData name="Yates, Rob A." userId="S::raya228@uky.edu::c4835988-b912-40a4-bf56-31a2afc86d77" providerId="AD" clId="Web-{0CC3DE7B-5279-3B29-9775-114C9D57E971}" dt="2023-07-20T13:23:18.314" v="12"/>
          <ac:spMkLst>
            <pc:docMk/>
            <pc:sldMk cId="0" sldId="256"/>
            <ac:spMk id="24" creationId="{4F91B61E-7446-E3C1-2CF0-20C7A8008200}"/>
          </ac:spMkLst>
        </pc:spChg>
        <pc:spChg chg="del">
          <ac:chgData name="Yates, Rob A." userId="S::raya228@uky.edu::c4835988-b912-40a4-bf56-31a2afc86d77" providerId="AD" clId="Web-{0CC3DE7B-5279-3B29-9775-114C9D57E971}" dt="2023-07-20T13:23:13.657" v="9"/>
          <ac:spMkLst>
            <pc:docMk/>
            <pc:sldMk cId="0" sldId="256"/>
            <ac:spMk id="25" creationId="{6713822E-51A4-CC30-65D5-1E650DCCD78D}"/>
          </ac:spMkLst>
        </pc:spChg>
        <pc:spChg chg="del">
          <ac:chgData name="Yates, Rob A." userId="S::raya228@uky.edu::c4835988-b912-40a4-bf56-31a2afc86d77" providerId="AD" clId="Web-{0CC3DE7B-5279-3B29-9775-114C9D57E971}" dt="2023-07-20T13:23:11.860" v="8"/>
          <ac:spMkLst>
            <pc:docMk/>
            <pc:sldMk cId="0" sldId="256"/>
            <ac:spMk id="26" creationId="{E452B212-84ED-EB70-516D-F422DFAF057A}"/>
          </ac:spMkLst>
        </pc:spChg>
        <pc:spChg chg="del">
          <ac:chgData name="Yates, Rob A." userId="S::raya228@uky.edu::c4835988-b912-40a4-bf56-31a2afc86d77" providerId="AD" clId="Web-{0CC3DE7B-5279-3B29-9775-114C9D57E971}" dt="2023-07-20T13:23:36.877" v="19"/>
          <ac:spMkLst>
            <pc:docMk/>
            <pc:sldMk cId="0" sldId="256"/>
            <ac:spMk id="27" creationId="{AFD4B923-F079-03AD-C08C-323581DAB76A}"/>
          </ac:spMkLst>
        </pc:spChg>
        <pc:spChg chg="del">
          <ac:chgData name="Yates, Rob A." userId="S::raya228@uky.edu::c4835988-b912-40a4-bf56-31a2afc86d77" providerId="AD" clId="Web-{0CC3DE7B-5279-3B29-9775-114C9D57E971}" dt="2023-07-20T13:23:35.377" v="18"/>
          <ac:spMkLst>
            <pc:docMk/>
            <pc:sldMk cId="0" sldId="256"/>
            <ac:spMk id="28" creationId="{15DCCC4D-273B-ACC4-672D-53BA82C33FA3}"/>
          </ac:spMkLst>
        </pc:spChg>
        <pc:spChg chg="add">
          <ac:chgData name="Yates, Rob A." userId="S::raya228@uky.edu::c4835988-b912-40a4-bf56-31a2afc86d77" providerId="AD" clId="Web-{0CC3DE7B-5279-3B29-9775-114C9D57E971}" dt="2023-07-20T13:23:40.877" v="20"/>
          <ac:spMkLst>
            <pc:docMk/>
            <pc:sldMk cId="0" sldId="256"/>
            <ac:spMk id="30" creationId="{6A453729-E544-96C5-C0A4-5DCCE8958456}"/>
          </ac:spMkLst>
        </pc:spChg>
        <pc:spChg chg="add">
          <ac:chgData name="Yates, Rob A." userId="S::raya228@uky.edu::c4835988-b912-40a4-bf56-31a2afc86d77" providerId="AD" clId="Web-{0CC3DE7B-5279-3B29-9775-114C9D57E971}" dt="2023-07-20T13:23:40.892" v="21"/>
          <ac:spMkLst>
            <pc:docMk/>
            <pc:sldMk cId="0" sldId="256"/>
            <ac:spMk id="32" creationId="{DAD15EDB-5BE7-A223-E499-181410EA76AD}"/>
          </ac:spMkLst>
        </pc:spChg>
        <pc:spChg chg="add">
          <ac:chgData name="Yates, Rob A." userId="S::raya228@uky.edu::c4835988-b912-40a4-bf56-31a2afc86d77" providerId="AD" clId="Web-{0CC3DE7B-5279-3B29-9775-114C9D57E971}" dt="2023-07-20T13:23:40.892" v="22"/>
          <ac:spMkLst>
            <pc:docMk/>
            <pc:sldMk cId="0" sldId="256"/>
            <ac:spMk id="34" creationId="{C0825FE2-37E0-EFA4-A3ED-CB095371E647}"/>
          </ac:spMkLst>
        </pc:spChg>
        <pc:spChg chg="add">
          <ac:chgData name="Yates, Rob A." userId="S::raya228@uky.edu::c4835988-b912-40a4-bf56-31a2afc86d77" providerId="AD" clId="Web-{0CC3DE7B-5279-3B29-9775-114C9D57E971}" dt="2023-07-20T13:23:40.908" v="23"/>
          <ac:spMkLst>
            <pc:docMk/>
            <pc:sldMk cId="0" sldId="256"/>
            <ac:spMk id="36" creationId="{337066DE-AA85-0009-E3DC-6A6A24E2D4F8}"/>
          </ac:spMkLst>
        </pc:spChg>
        <pc:spChg chg="add">
          <ac:chgData name="Yates, Rob A." userId="S::raya228@uky.edu::c4835988-b912-40a4-bf56-31a2afc86d77" providerId="AD" clId="Web-{0CC3DE7B-5279-3B29-9775-114C9D57E971}" dt="2023-07-20T13:23:40.924" v="24"/>
          <ac:spMkLst>
            <pc:docMk/>
            <pc:sldMk cId="0" sldId="256"/>
            <ac:spMk id="38" creationId="{27D23C0A-415D-8C38-ABB3-F960219047C0}"/>
          </ac:spMkLst>
        </pc:spChg>
        <pc:spChg chg="add">
          <ac:chgData name="Yates, Rob A." userId="S::raya228@uky.edu::c4835988-b912-40a4-bf56-31a2afc86d77" providerId="AD" clId="Web-{0CC3DE7B-5279-3B29-9775-114C9D57E971}" dt="2023-07-20T13:23:40.924" v="25"/>
          <ac:spMkLst>
            <pc:docMk/>
            <pc:sldMk cId="0" sldId="256"/>
            <ac:spMk id="40" creationId="{E1A9D038-2DDF-FCCD-7313-BD08849D4DF7}"/>
          </ac:spMkLst>
        </pc:spChg>
        <pc:spChg chg="add">
          <ac:chgData name="Yates, Rob A." userId="S::raya228@uky.edu::c4835988-b912-40a4-bf56-31a2afc86d77" providerId="AD" clId="Web-{0CC3DE7B-5279-3B29-9775-114C9D57E971}" dt="2023-07-20T13:23:40.939" v="26"/>
          <ac:spMkLst>
            <pc:docMk/>
            <pc:sldMk cId="0" sldId="256"/>
            <ac:spMk id="42" creationId="{6FD025C7-5110-171D-4DB1-5310E3237452}"/>
          </ac:spMkLst>
        </pc:spChg>
        <pc:spChg chg="add">
          <ac:chgData name="Yates, Rob A." userId="S::raya228@uky.edu::c4835988-b912-40a4-bf56-31a2afc86d77" providerId="AD" clId="Web-{0CC3DE7B-5279-3B29-9775-114C9D57E971}" dt="2023-07-20T13:23:40.955" v="27"/>
          <ac:spMkLst>
            <pc:docMk/>
            <pc:sldMk cId="0" sldId="256"/>
            <ac:spMk id="44" creationId="{623C15F0-281F-17C7-7523-5F3027F395F9}"/>
          </ac:spMkLst>
        </pc:spChg>
        <pc:spChg chg="add">
          <ac:chgData name="Yates, Rob A." userId="S::raya228@uky.edu::c4835988-b912-40a4-bf56-31a2afc86d77" providerId="AD" clId="Web-{0CC3DE7B-5279-3B29-9775-114C9D57E971}" dt="2023-07-20T13:23:40.955" v="28"/>
          <ac:spMkLst>
            <pc:docMk/>
            <pc:sldMk cId="0" sldId="256"/>
            <ac:spMk id="46" creationId="{7FCF4D5E-FBF3-4E95-E017-19A34E50C19B}"/>
          </ac:spMkLst>
        </pc:spChg>
        <pc:spChg chg="add">
          <ac:chgData name="Yates, Rob A." userId="S::raya228@uky.edu::c4835988-b912-40a4-bf56-31a2afc86d77" providerId="AD" clId="Web-{0CC3DE7B-5279-3B29-9775-114C9D57E971}" dt="2023-07-20T13:23:40.971" v="29"/>
          <ac:spMkLst>
            <pc:docMk/>
            <pc:sldMk cId="0" sldId="256"/>
            <ac:spMk id="48" creationId="{3C69B040-E852-52B7-2574-5B8A6EF50617}"/>
          </ac:spMkLst>
        </pc:spChg>
        <pc:spChg chg="add">
          <ac:chgData name="Yates, Rob A." userId="S::raya228@uky.edu::c4835988-b912-40a4-bf56-31a2afc86d77" providerId="AD" clId="Web-{0CC3DE7B-5279-3B29-9775-114C9D57E971}" dt="2023-07-20T13:23:40.986" v="30"/>
          <ac:spMkLst>
            <pc:docMk/>
            <pc:sldMk cId="0" sldId="256"/>
            <ac:spMk id="50" creationId="{DD45CC03-B71C-E0C9-AC7A-5FFCCD4869EA}"/>
          </ac:spMkLst>
        </pc:spChg>
        <pc:spChg chg="add">
          <ac:chgData name="Yates, Rob A." userId="S::raya228@uky.edu::c4835988-b912-40a4-bf56-31a2afc86d77" providerId="AD" clId="Web-{0CC3DE7B-5279-3B29-9775-114C9D57E971}" dt="2023-07-20T13:23:41.002" v="31"/>
          <ac:spMkLst>
            <pc:docMk/>
            <pc:sldMk cId="0" sldId="256"/>
            <ac:spMk id="52" creationId="{EA727DD7-0A72-10EF-EB87-811B38B7666D}"/>
          </ac:spMkLst>
        </pc:spChg>
        <pc:spChg chg="add">
          <ac:chgData name="Yates, Rob A." userId="S::raya228@uky.edu::c4835988-b912-40a4-bf56-31a2afc86d77" providerId="AD" clId="Web-{0CC3DE7B-5279-3B29-9775-114C9D57E971}" dt="2023-07-20T13:23:41.017" v="32"/>
          <ac:spMkLst>
            <pc:docMk/>
            <pc:sldMk cId="0" sldId="256"/>
            <ac:spMk id="54" creationId="{16D7147A-6EB5-B4E5-71DE-A630A1B428B4}"/>
          </ac:spMkLst>
        </pc:spChg>
        <pc:spChg chg="add">
          <ac:chgData name="Yates, Rob A." userId="S::raya228@uky.edu::c4835988-b912-40a4-bf56-31a2afc86d77" providerId="AD" clId="Web-{0CC3DE7B-5279-3B29-9775-114C9D57E971}" dt="2023-07-20T13:23:41.017" v="33"/>
          <ac:spMkLst>
            <pc:docMk/>
            <pc:sldMk cId="0" sldId="256"/>
            <ac:spMk id="56" creationId="{072D6F00-2BA2-5B4D-BBC9-5E1FCC84F448}"/>
          </ac:spMkLst>
        </pc:spChg>
        <pc:spChg chg="add">
          <ac:chgData name="Yates, Rob A." userId="S::raya228@uky.edu::c4835988-b912-40a4-bf56-31a2afc86d77" providerId="AD" clId="Web-{0CC3DE7B-5279-3B29-9775-114C9D57E971}" dt="2023-07-20T13:23:41.033" v="34"/>
          <ac:spMkLst>
            <pc:docMk/>
            <pc:sldMk cId="0" sldId="256"/>
            <ac:spMk id="58" creationId="{B7DD68B1-D4C8-682D-C5C0-31A50D776171}"/>
          </ac:spMkLst>
        </pc:spChg>
        <pc:spChg chg="add">
          <ac:chgData name="Yates, Rob A." userId="S::raya228@uky.edu::c4835988-b912-40a4-bf56-31a2afc86d77" providerId="AD" clId="Web-{0CC3DE7B-5279-3B29-9775-114C9D57E971}" dt="2023-07-20T13:23:41.049" v="35"/>
          <ac:spMkLst>
            <pc:docMk/>
            <pc:sldMk cId="0" sldId="256"/>
            <ac:spMk id="60" creationId="{CC374905-17B6-442B-98DA-AF368EC756E8}"/>
          </ac:spMkLst>
        </pc:spChg>
      </pc:sldChg>
      <pc:sldChg chg="addSp delSp modSp">
        <pc:chgData name="Yates, Rob A." userId="S::raya228@uky.edu::c4835988-b912-40a4-bf56-31a2afc86d77" providerId="AD" clId="Web-{0CC3DE7B-5279-3B29-9775-114C9D57E971}" dt="2023-07-20T13:25:29.192" v="71" actId="1076"/>
        <pc:sldMkLst>
          <pc:docMk/>
          <pc:sldMk cId="0" sldId="257"/>
        </pc:sldMkLst>
        <pc:spChg chg="del">
          <ac:chgData name="Yates, Rob A." userId="S::raya228@uky.edu::c4835988-b912-40a4-bf56-31a2afc86d77" providerId="AD" clId="Web-{0CC3DE7B-5279-3B29-9775-114C9D57E971}" dt="2023-07-20T13:24:58.676" v="53"/>
          <ac:spMkLst>
            <pc:docMk/>
            <pc:sldMk cId="0" sldId="257"/>
            <ac:spMk id="4" creationId="{00000000-0000-0000-0000-000000000000}"/>
          </ac:spMkLst>
        </pc:spChg>
        <pc:spChg chg="del mod">
          <ac:chgData name="Yates, Rob A." userId="S::raya228@uky.edu::c4835988-b912-40a4-bf56-31a2afc86d77" providerId="AD" clId="Web-{0CC3DE7B-5279-3B29-9775-114C9D57E971}" dt="2023-07-20T13:24:58.676" v="52"/>
          <ac:spMkLst>
            <pc:docMk/>
            <pc:sldMk cId="0" sldId="257"/>
            <ac:spMk id="5" creationId="{00000000-0000-0000-0000-000000000000}"/>
          </ac:spMkLst>
        </pc:spChg>
        <pc:spChg chg="del">
          <ac:chgData name="Yates, Rob A." userId="S::raya228@uky.edu::c4835988-b912-40a4-bf56-31a2afc86d77" providerId="AD" clId="Web-{0CC3DE7B-5279-3B29-9775-114C9D57E971}" dt="2023-07-20T13:24:58.676" v="51"/>
          <ac:spMkLst>
            <pc:docMk/>
            <pc:sldMk cId="0" sldId="257"/>
            <ac:spMk id="8" creationId="{00000000-0000-0000-0000-000000000000}"/>
          </ac:spMkLst>
        </pc:spChg>
        <pc:spChg chg="del">
          <ac:chgData name="Yates, Rob A." userId="S::raya228@uky.edu::c4835988-b912-40a4-bf56-31a2afc86d77" providerId="AD" clId="Web-{0CC3DE7B-5279-3B29-9775-114C9D57E971}" dt="2023-07-20T13:24:58.676" v="50"/>
          <ac:spMkLst>
            <pc:docMk/>
            <pc:sldMk cId="0" sldId="257"/>
            <ac:spMk id="9" creationId="{00000000-0000-0000-0000-000000000000}"/>
          </ac:spMkLst>
        </pc:spChg>
        <pc:spChg chg="del">
          <ac:chgData name="Yates, Rob A." userId="S::raya228@uky.edu::c4835988-b912-40a4-bf56-31a2afc86d77" providerId="AD" clId="Web-{0CC3DE7B-5279-3B29-9775-114C9D57E971}" dt="2023-07-20T13:24:58.676" v="49"/>
          <ac:spMkLst>
            <pc:docMk/>
            <pc:sldMk cId="0" sldId="257"/>
            <ac:spMk id="13" creationId="{00000000-0000-0000-0000-000000000000}"/>
          </ac:spMkLst>
        </pc:spChg>
        <pc:spChg chg="del">
          <ac:chgData name="Yates, Rob A." userId="S::raya228@uky.edu::c4835988-b912-40a4-bf56-31a2afc86d77" providerId="AD" clId="Web-{0CC3DE7B-5279-3B29-9775-114C9D57E971}" dt="2023-07-20T13:24:58.676" v="48"/>
          <ac:spMkLst>
            <pc:docMk/>
            <pc:sldMk cId="0" sldId="257"/>
            <ac:spMk id="14" creationId="{00000000-0000-0000-0000-000000000000}"/>
          </ac:spMkLst>
        </pc:spChg>
        <pc:spChg chg="del">
          <ac:chgData name="Yates, Rob A." userId="S::raya228@uky.edu::c4835988-b912-40a4-bf56-31a2afc86d77" providerId="AD" clId="Web-{0CC3DE7B-5279-3B29-9775-114C9D57E971}" dt="2023-07-20T13:24:58.676" v="47"/>
          <ac:spMkLst>
            <pc:docMk/>
            <pc:sldMk cId="0" sldId="257"/>
            <ac:spMk id="18" creationId="{00000000-0000-0000-0000-000000000000}"/>
          </ac:spMkLst>
        </pc:spChg>
        <pc:spChg chg="del">
          <ac:chgData name="Yates, Rob A." userId="S::raya228@uky.edu::c4835988-b912-40a4-bf56-31a2afc86d77" providerId="AD" clId="Web-{0CC3DE7B-5279-3B29-9775-114C9D57E971}" dt="2023-07-20T13:24:58.676" v="46"/>
          <ac:spMkLst>
            <pc:docMk/>
            <pc:sldMk cId="0" sldId="257"/>
            <ac:spMk id="19" creationId="{00000000-0000-0000-0000-000000000000}"/>
          </ac:spMkLst>
        </pc:spChg>
        <pc:spChg chg="del">
          <ac:chgData name="Yates, Rob A." userId="S::raya228@uky.edu::c4835988-b912-40a4-bf56-31a2afc86d77" providerId="AD" clId="Web-{0CC3DE7B-5279-3B29-9775-114C9D57E971}" dt="2023-07-20T13:24:58.676" v="45"/>
          <ac:spMkLst>
            <pc:docMk/>
            <pc:sldMk cId="0" sldId="257"/>
            <ac:spMk id="21" creationId="{91691879-07FE-79FD-A439-8F128E00CCFA}"/>
          </ac:spMkLst>
        </pc:spChg>
        <pc:spChg chg="del">
          <ac:chgData name="Yates, Rob A." userId="S::raya228@uky.edu::c4835988-b912-40a4-bf56-31a2afc86d77" providerId="AD" clId="Web-{0CC3DE7B-5279-3B29-9775-114C9D57E971}" dt="2023-07-20T13:24:58.676" v="44"/>
          <ac:spMkLst>
            <pc:docMk/>
            <pc:sldMk cId="0" sldId="257"/>
            <ac:spMk id="22" creationId="{B60B4E6D-62F5-F1EE-E78F-CBB30C72140A}"/>
          </ac:spMkLst>
        </pc:spChg>
        <pc:spChg chg="del">
          <ac:chgData name="Yates, Rob A." userId="S::raya228@uky.edu::c4835988-b912-40a4-bf56-31a2afc86d77" providerId="AD" clId="Web-{0CC3DE7B-5279-3B29-9775-114C9D57E971}" dt="2023-07-20T13:24:58.676" v="43"/>
          <ac:spMkLst>
            <pc:docMk/>
            <pc:sldMk cId="0" sldId="257"/>
            <ac:spMk id="23" creationId="{C36B6D69-50D5-8FAF-5B83-497CD972C941}"/>
          </ac:spMkLst>
        </pc:spChg>
        <pc:spChg chg="del">
          <ac:chgData name="Yates, Rob A." userId="S::raya228@uky.edu::c4835988-b912-40a4-bf56-31a2afc86d77" providerId="AD" clId="Web-{0CC3DE7B-5279-3B29-9775-114C9D57E971}" dt="2023-07-20T13:24:58.676" v="42"/>
          <ac:spMkLst>
            <pc:docMk/>
            <pc:sldMk cId="0" sldId="257"/>
            <ac:spMk id="24" creationId="{3AE7D971-BB95-258E-0964-49B026002107}"/>
          </ac:spMkLst>
        </pc:spChg>
        <pc:spChg chg="del">
          <ac:chgData name="Yates, Rob A." userId="S::raya228@uky.edu::c4835988-b912-40a4-bf56-31a2afc86d77" providerId="AD" clId="Web-{0CC3DE7B-5279-3B29-9775-114C9D57E971}" dt="2023-07-20T13:24:58.676" v="41"/>
          <ac:spMkLst>
            <pc:docMk/>
            <pc:sldMk cId="0" sldId="257"/>
            <ac:spMk id="25" creationId="{7BEABC23-4D34-58F3-E07F-9B65303409C5}"/>
          </ac:spMkLst>
        </pc:spChg>
        <pc:spChg chg="del">
          <ac:chgData name="Yates, Rob A." userId="S::raya228@uky.edu::c4835988-b912-40a4-bf56-31a2afc86d77" providerId="AD" clId="Web-{0CC3DE7B-5279-3B29-9775-114C9D57E971}" dt="2023-07-20T13:24:58.676" v="40"/>
          <ac:spMkLst>
            <pc:docMk/>
            <pc:sldMk cId="0" sldId="257"/>
            <ac:spMk id="26" creationId="{EDC56109-2249-81A8-52B1-2F0588FFCDA6}"/>
          </ac:spMkLst>
        </pc:spChg>
        <pc:spChg chg="del">
          <ac:chgData name="Yates, Rob A." userId="S::raya228@uky.edu::c4835988-b912-40a4-bf56-31a2afc86d77" providerId="AD" clId="Web-{0CC3DE7B-5279-3B29-9775-114C9D57E971}" dt="2023-07-20T13:24:58.676" v="39"/>
          <ac:spMkLst>
            <pc:docMk/>
            <pc:sldMk cId="0" sldId="257"/>
            <ac:spMk id="27" creationId="{40DE3317-3BB0-F727-4CDA-C59DD68628DB}"/>
          </ac:spMkLst>
        </pc:spChg>
        <pc:spChg chg="del">
          <ac:chgData name="Yates, Rob A." userId="S::raya228@uky.edu::c4835988-b912-40a4-bf56-31a2afc86d77" providerId="AD" clId="Web-{0CC3DE7B-5279-3B29-9775-114C9D57E971}" dt="2023-07-20T13:24:58.676" v="38"/>
          <ac:spMkLst>
            <pc:docMk/>
            <pc:sldMk cId="0" sldId="257"/>
            <ac:spMk id="28" creationId="{98A0165F-70A5-B6E5-BDBB-79EAE11DEEC8}"/>
          </ac:spMkLst>
        </pc:spChg>
        <pc:spChg chg="add">
          <ac:chgData name="Yates, Rob A." userId="S::raya228@uky.edu::c4835988-b912-40a4-bf56-31a2afc86d77" providerId="AD" clId="Web-{0CC3DE7B-5279-3B29-9775-114C9D57E971}" dt="2023-07-20T13:25:03.879" v="54"/>
          <ac:spMkLst>
            <pc:docMk/>
            <pc:sldMk cId="0" sldId="257"/>
            <ac:spMk id="30" creationId="{FFFC3FCF-D291-5017-4A48-E5C65D65593B}"/>
          </ac:spMkLst>
        </pc:spChg>
        <pc:spChg chg="add">
          <ac:chgData name="Yates, Rob A." userId="S::raya228@uky.edu::c4835988-b912-40a4-bf56-31a2afc86d77" providerId="AD" clId="Web-{0CC3DE7B-5279-3B29-9775-114C9D57E971}" dt="2023-07-20T13:25:03.895" v="55"/>
          <ac:spMkLst>
            <pc:docMk/>
            <pc:sldMk cId="0" sldId="257"/>
            <ac:spMk id="32" creationId="{A63A8303-A105-D15D-D7EF-6907ECD9E31D}"/>
          </ac:spMkLst>
        </pc:spChg>
        <pc:spChg chg="add">
          <ac:chgData name="Yates, Rob A." userId="S::raya228@uky.edu::c4835988-b912-40a4-bf56-31a2afc86d77" providerId="AD" clId="Web-{0CC3DE7B-5279-3B29-9775-114C9D57E971}" dt="2023-07-20T13:25:03.910" v="56"/>
          <ac:spMkLst>
            <pc:docMk/>
            <pc:sldMk cId="0" sldId="257"/>
            <ac:spMk id="34" creationId="{0DD89CFB-1B33-713D-92AF-2D3C8056DB1E}"/>
          </ac:spMkLst>
        </pc:spChg>
        <pc:spChg chg="add">
          <ac:chgData name="Yates, Rob A." userId="S::raya228@uky.edu::c4835988-b912-40a4-bf56-31a2afc86d77" providerId="AD" clId="Web-{0CC3DE7B-5279-3B29-9775-114C9D57E971}" dt="2023-07-20T13:25:03.910" v="57"/>
          <ac:spMkLst>
            <pc:docMk/>
            <pc:sldMk cId="0" sldId="257"/>
            <ac:spMk id="36" creationId="{33A820CF-8D50-36EF-0565-1FECF8664270}"/>
          </ac:spMkLst>
        </pc:spChg>
        <pc:spChg chg="add">
          <ac:chgData name="Yates, Rob A." userId="S::raya228@uky.edu::c4835988-b912-40a4-bf56-31a2afc86d77" providerId="AD" clId="Web-{0CC3DE7B-5279-3B29-9775-114C9D57E971}" dt="2023-07-20T13:25:03.926" v="58"/>
          <ac:spMkLst>
            <pc:docMk/>
            <pc:sldMk cId="0" sldId="257"/>
            <ac:spMk id="38" creationId="{63872448-61CD-B359-6033-BA9781E0A6CB}"/>
          </ac:spMkLst>
        </pc:spChg>
        <pc:spChg chg="add">
          <ac:chgData name="Yates, Rob A." userId="S::raya228@uky.edu::c4835988-b912-40a4-bf56-31a2afc86d77" providerId="AD" clId="Web-{0CC3DE7B-5279-3B29-9775-114C9D57E971}" dt="2023-07-20T13:25:03.942" v="59"/>
          <ac:spMkLst>
            <pc:docMk/>
            <pc:sldMk cId="0" sldId="257"/>
            <ac:spMk id="40" creationId="{E18919CD-04BF-B379-39B2-2ECCFFBD8143}"/>
          </ac:spMkLst>
        </pc:spChg>
        <pc:spChg chg="add">
          <ac:chgData name="Yates, Rob A." userId="S::raya228@uky.edu::c4835988-b912-40a4-bf56-31a2afc86d77" providerId="AD" clId="Web-{0CC3DE7B-5279-3B29-9775-114C9D57E971}" dt="2023-07-20T13:25:03.957" v="60"/>
          <ac:spMkLst>
            <pc:docMk/>
            <pc:sldMk cId="0" sldId="257"/>
            <ac:spMk id="42" creationId="{35DAEB9D-202A-B957-9571-885A1973654A}"/>
          </ac:spMkLst>
        </pc:spChg>
        <pc:spChg chg="add">
          <ac:chgData name="Yates, Rob A." userId="S::raya228@uky.edu::c4835988-b912-40a4-bf56-31a2afc86d77" providerId="AD" clId="Web-{0CC3DE7B-5279-3B29-9775-114C9D57E971}" dt="2023-07-20T13:25:03.973" v="61"/>
          <ac:spMkLst>
            <pc:docMk/>
            <pc:sldMk cId="0" sldId="257"/>
            <ac:spMk id="44" creationId="{46ED1F76-44A0-3A2A-D379-7E84E0750561}"/>
          </ac:spMkLst>
        </pc:spChg>
        <pc:spChg chg="add">
          <ac:chgData name="Yates, Rob A." userId="S::raya228@uky.edu::c4835988-b912-40a4-bf56-31a2afc86d77" providerId="AD" clId="Web-{0CC3DE7B-5279-3B29-9775-114C9D57E971}" dt="2023-07-20T13:25:03.988" v="62"/>
          <ac:spMkLst>
            <pc:docMk/>
            <pc:sldMk cId="0" sldId="257"/>
            <ac:spMk id="46" creationId="{56B57495-D036-69CB-92F6-838C6DC17505}"/>
          </ac:spMkLst>
        </pc:spChg>
        <pc:spChg chg="add">
          <ac:chgData name="Yates, Rob A." userId="S::raya228@uky.edu::c4835988-b912-40a4-bf56-31a2afc86d77" providerId="AD" clId="Web-{0CC3DE7B-5279-3B29-9775-114C9D57E971}" dt="2023-07-20T13:25:04.004" v="63"/>
          <ac:spMkLst>
            <pc:docMk/>
            <pc:sldMk cId="0" sldId="257"/>
            <ac:spMk id="48" creationId="{85955B73-0114-C4FE-8009-F2893B4C1D6A}"/>
          </ac:spMkLst>
        </pc:spChg>
        <pc:spChg chg="add">
          <ac:chgData name="Yates, Rob A." userId="S::raya228@uky.edu::c4835988-b912-40a4-bf56-31a2afc86d77" providerId="AD" clId="Web-{0CC3DE7B-5279-3B29-9775-114C9D57E971}" dt="2023-07-20T13:25:04.020" v="64"/>
          <ac:spMkLst>
            <pc:docMk/>
            <pc:sldMk cId="0" sldId="257"/>
            <ac:spMk id="50" creationId="{3CDFC38B-AB1A-DB04-6F58-1ADA019CB3A1}"/>
          </ac:spMkLst>
        </pc:spChg>
        <pc:spChg chg="add">
          <ac:chgData name="Yates, Rob A." userId="S::raya228@uky.edu::c4835988-b912-40a4-bf56-31a2afc86d77" providerId="AD" clId="Web-{0CC3DE7B-5279-3B29-9775-114C9D57E971}" dt="2023-07-20T13:25:04.035" v="65"/>
          <ac:spMkLst>
            <pc:docMk/>
            <pc:sldMk cId="0" sldId="257"/>
            <ac:spMk id="52" creationId="{2EC5F120-61C4-09F8-41F1-BE11F45C8E86}"/>
          </ac:spMkLst>
        </pc:spChg>
        <pc:spChg chg="add">
          <ac:chgData name="Yates, Rob A." userId="S::raya228@uky.edu::c4835988-b912-40a4-bf56-31a2afc86d77" providerId="AD" clId="Web-{0CC3DE7B-5279-3B29-9775-114C9D57E971}" dt="2023-07-20T13:25:04.051" v="66"/>
          <ac:spMkLst>
            <pc:docMk/>
            <pc:sldMk cId="0" sldId="257"/>
            <ac:spMk id="54" creationId="{038FCE29-572E-793C-EE30-FCF2D2518E00}"/>
          </ac:spMkLst>
        </pc:spChg>
        <pc:spChg chg="add">
          <ac:chgData name="Yates, Rob A." userId="S::raya228@uky.edu::c4835988-b912-40a4-bf56-31a2afc86d77" providerId="AD" clId="Web-{0CC3DE7B-5279-3B29-9775-114C9D57E971}" dt="2023-07-20T13:25:04.067" v="67"/>
          <ac:spMkLst>
            <pc:docMk/>
            <pc:sldMk cId="0" sldId="257"/>
            <ac:spMk id="56" creationId="{0998544F-342D-CC98-B491-A1DF192A4897}"/>
          </ac:spMkLst>
        </pc:spChg>
        <pc:spChg chg="add">
          <ac:chgData name="Yates, Rob A." userId="S::raya228@uky.edu::c4835988-b912-40a4-bf56-31a2afc86d77" providerId="AD" clId="Web-{0CC3DE7B-5279-3B29-9775-114C9D57E971}" dt="2023-07-20T13:25:04.082" v="68"/>
          <ac:spMkLst>
            <pc:docMk/>
            <pc:sldMk cId="0" sldId="257"/>
            <ac:spMk id="58" creationId="{46522495-E728-DAF1-5C9E-6E4CE8A3C5C9}"/>
          </ac:spMkLst>
        </pc:spChg>
        <pc:spChg chg="add mod">
          <ac:chgData name="Yates, Rob A." userId="S::raya228@uky.edu::c4835988-b912-40a4-bf56-31a2afc86d77" providerId="AD" clId="Web-{0CC3DE7B-5279-3B29-9775-114C9D57E971}" dt="2023-07-20T13:25:29.192" v="71" actId="1076"/>
          <ac:spMkLst>
            <pc:docMk/>
            <pc:sldMk cId="0" sldId="257"/>
            <ac:spMk id="59" creationId="{AAB167D8-E466-D81E-0E99-776036AEAC42}"/>
          </ac:spMkLst>
        </pc:spChg>
      </pc:sldChg>
      <pc:sldChg chg="addSp delSp">
        <pc:chgData name="Yates, Rob A." userId="S::raya228@uky.edu::c4835988-b912-40a4-bf56-31a2afc86d77" providerId="AD" clId="Web-{0CC3DE7B-5279-3B29-9775-114C9D57E971}" dt="2023-07-20T13:26:48.773" v="107"/>
        <pc:sldMkLst>
          <pc:docMk/>
          <pc:sldMk cId="0" sldId="258"/>
        </pc:sldMkLst>
        <pc:spChg chg="del">
          <ac:chgData name="Yates, Rob A." userId="S::raya228@uky.edu::c4835988-b912-40a4-bf56-31a2afc86d77" providerId="AD" clId="Web-{0CC3DE7B-5279-3B29-9775-114C9D57E971}" dt="2023-07-20T13:26:44.460" v="91"/>
          <ac:spMkLst>
            <pc:docMk/>
            <pc:sldMk cId="0" sldId="258"/>
            <ac:spMk id="4" creationId="{00000000-0000-0000-0000-000000000000}"/>
          </ac:spMkLst>
        </pc:spChg>
        <pc:spChg chg="del">
          <ac:chgData name="Yates, Rob A." userId="S::raya228@uky.edu::c4835988-b912-40a4-bf56-31a2afc86d77" providerId="AD" clId="Web-{0CC3DE7B-5279-3B29-9775-114C9D57E971}" dt="2023-07-20T13:26:44.460" v="90"/>
          <ac:spMkLst>
            <pc:docMk/>
            <pc:sldMk cId="0" sldId="258"/>
            <ac:spMk id="5" creationId="{00000000-0000-0000-0000-000000000000}"/>
          </ac:spMkLst>
        </pc:spChg>
        <pc:spChg chg="del">
          <ac:chgData name="Yates, Rob A." userId="S::raya228@uky.edu::c4835988-b912-40a4-bf56-31a2afc86d77" providerId="AD" clId="Web-{0CC3DE7B-5279-3B29-9775-114C9D57E971}" dt="2023-07-20T13:26:44.460" v="89"/>
          <ac:spMkLst>
            <pc:docMk/>
            <pc:sldMk cId="0" sldId="258"/>
            <ac:spMk id="8" creationId="{00000000-0000-0000-0000-000000000000}"/>
          </ac:spMkLst>
        </pc:spChg>
        <pc:spChg chg="del">
          <ac:chgData name="Yates, Rob A." userId="S::raya228@uky.edu::c4835988-b912-40a4-bf56-31a2afc86d77" providerId="AD" clId="Web-{0CC3DE7B-5279-3B29-9775-114C9D57E971}" dt="2023-07-20T13:26:44.460" v="88"/>
          <ac:spMkLst>
            <pc:docMk/>
            <pc:sldMk cId="0" sldId="258"/>
            <ac:spMk id="9" creationId="{00000000-0000-0000-0000-000000000000}"/>
          </ac:spMkLst>
        </pc:spChg>
        <pc:spChg chg="del">
          <ac:chgData name="Yates, Rob A." userId="S::raya228@uky.edu::c4835988-b912-40a4-bf56-31a2afc86d77" providerId="AD" clId="Web-{0CC3DE7B-5279-3B29-9775-114C9D57E971}" dt="2023-07-20T13:26:44.460" v="87"/>
          <ac:spMkLst>
            <pc:docMk/>
            <pc:sldMk cId="0" sldId="258"/>
            <ac:spMk id="13" creationId="{00000000-0000-0000-0000-000000000000}"/>
          </ac:spMkLst>
        </pc:spChg>
        <pc:spChg chg="del">
          <ac:chgData name="Yates, Rob A." userId="S::raya228@uky.edu::c4835988-b912-40a4-bf56-31a2afc86d77" providerId="AD" clId="Web-{0CC3DE7B-5279-3B29-9775-114C9D57E971}" dt="2023-07-20T13:26:44.460" v="86"/>
          <ac:spMkLst>
            <pc:docMk/>
            <pc:sldMk cId="0" sldId="258"/>
            <ac:spMk id="14" creationId="{00000000-0000-0000-0000-000000000000}"/>
          </ac:spMkLst>
        </pc:spChg>
        <pc:spChg chg="del">
          <ac:chgData name="Yates, Rob A." userId="S::raya228@uky.edu::c4835988-b912-40a4-bf56-31a2afc86d77" providerId="AD" clId="Web-{0CC3DE7B-5279-3B29-9775-114C9D57E971}" dt="2023-07-20T13:26:44.460" v="85"/>
          <ac:spMkLst>
            <pc:docMk/>
            <pc:sldMk cId="0" sldId="258"/>
            <ac:spMk id="18" creationId="{00000000-0000-0000-0000-000000000000}"/>
          </ac:spMkLst>
        </pc:spChg>
        <pc:spChg chg="del">
          <ac:chgData name="Yates, Rob A." userId="S::raya228@uky.edu::c4835988-b912-40a4-bf56-31a2afc86d77" providerId="AD" clId="Web-{0CC3DE7B-5279-3B29-9775-114C9D57E971}" dt="2023-07-20T13:26:44.460" v="84"/>
          <ac:spMkLst>
            <pc:docMk/>
            <pc:sldMk cId="0" sldId="258"/>
            <ac:spMk id="19" creationId="{00000000-0000-0000-0000-000000000000}"/>
          </ac:spMkLst>
        </pc:spChg>
        <pc:spChg chg="del">
          <ac:chgData name="Yates, Rob A." userId="S::raya228@uky.edu::c4835988-b912-40a4-bf56-31a2afc86d77" providerId="AD" clId="Web-{0CC3DE7B-5279-3B29-9775-114C9D57E971}" dt="2023-07-20T13:26:44.460" v="83"/>
          <ac:spMkLst>
            <pc:docMk/>
            <pc:sldMk cId="0" sldId="258"/>
            <ac:spMk id="21" creationId="{9D7CB166-D0FE-CBFC-534F-D97DA301F8AD}"/>
          </ac:spMkLst>
        </pc:spChg>
        <pc:spChg chg="del">
          <ac:chgData name="Yates, Rob A." userId="S::raya228@uky.edu::c4835988-b912-40a4-bf56-31a2afc86d77" providerId="AD" clId="Web-{0CC3DE7B-5279-3B29-9775-114C9D57E971}" dt="2023-07-20T13:26:44.460" v="82"/>
          <ac:spMkLst>
            <pc:docMk/>
            <pc:sldMk cId="0" sldId="258"/>
            <ac:spMk id="22" creationId="{E8B5132F-FA42-ABC3-63FE-33BA311EC52F}"/>
          </ac:spMkLst>
        </pc:spChg>
        <pc:spChg chg="del">
          <ac:chgData name="Yates, Rob A." userId="S::raya228@uky.edu::c4835988-b912-40a4-bf56-31a2afc86d77" providerId="AD" clId="Web-{0CC3DE7B-5279-3B29-9775-114C9D57E971}" dt="2023-07-20T13:26:44.460" v="81"/>
          <ac:spMkLst>
            <pc:docMk/>
            <pc:sldMk cId="0" sldId="258"/>
            <ac:spMk id="23" creationId="{8E8AFFAF-1BD6-21D9-A34E-8B07BE21A99A}"/>
          </ac:spMkLst>
        </pc:spChg>
        <pc:spChg chg="del">
          <ac:chgData name="Yates, Rob A." userId="S::raya228@uky.edu::c4835988-b912-40a4-bf56-31a2afc86d77" providerId="AD" clId="Web-{0CC3DE7B-5279-3B29-9775-114C9D57E971}" dt="2023-07-20T13:26:44.460" v="80"/>
          <ac:spMkLst>
            <pc:docMk/>
            <pc:sldMk cId="0" sldId="258"/>
            <ac:spMk id="24" creationId="{6EE37053-DF33-FA25-A457-A205865D28F2}"/>
          </ac:spMkLst>
        </pc:spChg>
        <pc:spChg chg="del">
          <ac:chgData name="Yates, Rob A." userId="S::raya228@uky.edu::c4835988-b912-40a4-bf56-31a2afc86d77" providerId="AD" clId="Web-{0CC3DE7B-5279-3B29-9775-114C9D57E971}" dt="2023-07-20T13:26:44.460" v="79"/>
          <ac:spMkLst>
            <pc:docMk/>
            <pc:sldMk cId="0" sldId="258"/>
            <ac:spMk id="25" creationId="{617B19FA-FEE6-8D35-913D-1BC35904ED68}"/>
          </ac:spMkLst>
        </pc:spChg>
        <pc:spChg chg="del">
          <ac:chgData name="Yates, Rob A." userId="S::raya228@uky.edu::c4835988-b912-40a4-bf56-31a2afc86d77" providerId="AD" clId="Web-{0CC3DE7B-5279-3B29-9775-114C9D57E971}" dt="2023-07-20T13:26:44.444" v="78"/>
          <ac:spMkLst>
            <pc:docMk/>
            <pc:sldMk cId="0" sldId="258"/>
            <ac:spMk id="26" creationId="{3BAE4537-20BE-551A-92D5-400FCFCB8010}"/>
          </ac:spMkLst>
        </pc:spChg>
        <pc:spChg chg="del">
          <ac:chgData name="Yates, Rob A." userId="S::raya228@uky.edu::c4835988-b912-40a4-bf56-31a2afc86d77" providerId="AD" clId="Web-{0CC3DE7B-5279-3B29-9775-114C9D57E971}" dt="2023-07-20T13:26:44.444" v="77"/>
          <ac:spMkLst>
            <pc:docMk/>
            <pc:sldMk cId="0" sldId="258"/>
            <ac:spMk id="27" creationId="{04872468-8331-D9C1-0373-A8C9EF812689}"/>
          </ac:spMkLst>
        </pc:spChg>
        <pc:spChg chg="del">
          <ac:chgData name="Yates, Rob A." userId="S::raya228@uky.edu::c4835988-b912-40a4-bf56-31a2afc86d77" providerId="AD" clId="Web-{0CC3DE7B-5279-3B29-9775-114C9D57E971}" dt="2023-07-20T13:26:44.444" v="76"/>
          <ac:spMkLst>
            <pc:docMk/>
            <pc:sldMk cId="0" sldId="258"/>
            <ac:spMk id="28" creationId="{EFDBA02F-042E-8667-C9F5-B190DAF863FB}"/>
          </ac:spMkLst>
        </pc:spChg>
        <pc:spChg chg="add">
          <ac:chgData name="Yates, Rob A." userId="S::raya228@uky.edu::c4835988-b912-40a4-bf56-31a2afc86d77" providerId="AD" clId="Web-{0CC3DE7B-5279-3B29-9775-114C9D57E971}" dt="2023-07-20T13:26:48.569" v="92"/>
          <ac:spMkLst>
            <pc:docMk/>
            <pc:sldMk cId="0" sldId="258"/>
            <ac:spMk id="30" creationId="{9C72BB0C-1DE7-9C49-BA7B-53032D0D83EC}"/>
          </ac:spMkLst>
        </pc:spChg>
        <pc:spChg chg="add">
          <ac:chgData name="Yates, Rob A." userId="S::raya228@uky.edu::c4835988-b912-40a4-bf56-31a2afc86d77" providerId="AD" clId="Web-{0CC3DE7B-5279-3B29-9775-114C9D57E971}" dt="2023-07-20T13:26:48.585" v="93"/>
          <ac:spMkLst>
            <pc:docMk/>
            <pc:sldMk cId="0" sldId="258"/>
            <ac:spMk id="32" creationId="{B1816331-F7BD-E5EB-A8D3-E0C5B4140EA3}"/>
          </ac:spMkLst>
        </pc:spChg>
        <pc:spChg chg="add">
          <ac:chgData name="Yates, Rob A." userId="S::raya228@uky.edu::c4835988-b912-40a4-bf56-31a2afc86d77" providerId="AD" clId="Web-{0CC3DE7B-5279-3B29-9775-114C9D57E971}" dt="2023-07-20T13:26:48.601" v="94"/>
          <ac:spMkLst>
            <pc:docMk/>
            <pc:sldMk cId="0" sldId="258"/>
            <ac:spMk id="34" creationId="{C6DD68E1-1E8C-B619-C46A-877175FF8680}"/>
          </ac:spMkLst>
        </pc:spChg>
        <pc:spChg chg="add">
          <ac:chgData name="Yates, Rob A." userId="S::raya228@uky.edu::c4835988-b912-40a4-bf56-31a2afc86d77" providerId="AD" clId="Web-{0CC3DE7B-5279-3B29-9775-114C9D57E971}" dt="2023-07-20T13:26:48.601" v="95"/>
          <ac:spMkLst>
            <pc:docMk/>
            <pc:sldMk cId="0" sldId="258"/>
            <ac:spMk id="36" creationId="{DF1661B5-91BE-8130-EC67-B9807CF7A7CD}"/>
          </ac:spMkLst>
        </pc:spChg>
        <pc:spChg chg="add">
          <ac:chgData name="Yates, Rob A." userId="S::raya228@uky.edu::c4835988-b912-40a4-bf56-31a2afc86d77" providerId="AD" clId="Web-{0CC3DE7B-5279-3B29-9775-114C9D57E971}" dt="2023-07-20T13:26:48.616" v="96"/>
          <ac:spMkLst>
            <pc:docMk/>
            <pc:sldMk cId="0" sldId="258"/>
            <ac:spMk id="38" creationId="{C66DB816-7F29-69D1-6CB5-1D139BD4B291}"/>
          </ac:spMkLst>
        </pc:spChg>
        <pc:spChg chg="add">
          <ac:chgData name="Yates, Rob A." userId="S::raya228@uky.edu::c4835988-b912-40a4-bf56-31a2afc86d77" providerId="AD" clId="Web-{0CC3DE7B-5279-3B29-9775-114C9D57E971}" dt="2023-07-20T13:26:48.632" v="97"/>
          <ac:spMkLst>
            <pc:docMk/>
            <pc:sldMk cId="0" sldId="258"/>
            <ac:spMk id="40" creationId="{C0DBDDF2-957D-ACF3-DBF9-19D5251C2E71}"/>
          </ac:spMkLst>
        </pc:spChg>
        <pc:spChg chg="add">
          <ac:chgData name="Yates, Rob A." userId="S::raya228@uky.edu::c4835988-b912-40a4-bf56-31a2afc86d77" providerId="AD" clId="Web-{0CC3DE7B-5279-3B29-9775-114C9D57E971}" dt="2023-07-20T13:26:48.648" v="98"/>
          <ac:spMkLst>
            <pc:docMk/>
            <pc:sldMk cId="0" sldId="258"/>
            <ac:spMk id="42" creationId="{0E7D16CF-114A-AD55-9774-ECD51E3A44CB}"/>
          </ac:spMkLst>
        </pc:spChg>
        <pc:spChg chg="add">
          <ac:chgData name="Yates, Rob A." userId="S::raya228@uky.edu::c4835988-b912-40a4-bf56-31a2afc86d77" providerId="AD" clId="Web-{0CC3DE7B-5279-3B29-9775-114C9D57E971}" dt="2023-07-20T13:26:48.663" v="99"/>
          <ac:spMkLst>
            <pc:docMk/>
            <pc:sldMk cId="0" sldId="258"/>
            <ac:spMk id="44" creationId="{94F48318-ED6A-620C-8665-828F9A40339A}"/>
          </ac:spMkLst>
        </pc:spChg>
        <pc:spChg chg="add">
          <ac:chgData name="Yates, Rob A." userId="S::raya228@uky.edu::c4835988-b912-40a4-bf56-31a2afc86d77" providerId="AD" clId="Web-{0CC3DE7B-5279-3B29-9775-114C9D57E971}" dt="2023-07-20T13:26:48.679" v="100"/>
          <ac:spMkLst>
            <pc:docMk/>
            <pc:sldMk cId="0" sldId="258"/>
            <ac:spMk id="46" creationId="{13C0AFD9-BE1F-F406-17D2-0E6A30F20AC0}"/>
          </ac:spMkLst>
        </pc:spChg>
        <pc:spChg chg="add">
          <ac:chgData name="Yates, Rob A." userId="S::raya228@uky.edu::c4835988-b912-40a4-bf56-31a2afc86d77" providerId="AD" clId="Web-{0CC3DE7B-5279-3B29-9775-114C9D57E971}" dt="2023-07-20T13:26:48.679" v="101"/>
          <ac:spMkLst>
            <pc:docMk/>
            <pc:sldMk cId="0" sldId="258"/>
            <ac:spMk id="48" creationId="{25A9B81D-E520-8944-62E7-EED22887BECF}"/>
          </ac:spMkLst>
        </pc:spChg>
        <pc:spChg chg="add">
          <ac:chgData name="Yates, Rob A." userId="S::raya228@uky.edu::c4835988-b912-40a4-bf56-31a2afc86d77" providerId="AD" clId="Web-{0CC3DE7B-5279-3B29-9775-114C9D57E971}" dt="2023-07-20T13:26:48.694" v="102"/>
          <ac:spMkLst>
            <pc:docMk/>
            <pc:sldMk cId="0" sldId="258"/>
            <ac:spMk id="50" creationId="{52863611-E25B-5F21-6D9D-0FA90257DC32}"/>
          </ac:spMkLst>
        </pc:spChg>
        <pc:spChg chg="add">
          <ac:chgData name="Yates, Rob A." userId="S::raya228@uky.edu::c4835988-b912-40a4-bf56-31a2afc86d77" providerId="AD" clId="Web-{0CC3DE7B-5279-3B29-9775-114C9D57E971}" dt="2023-07-20T13:26:48.710" v="103"/>
          <ac:spMkLst>
            <pc:docMk/>
            <pc:sldMk cId="0" sldId="258"/>
            <ac:spMk id="52" creationId="{E0E258FD-2B77-C2E6-2249-26C7786092B6}"/>
          </ac:spMkLst>
        </pc:spChg>
        <pc:spChg chg="add">
          <ac:chgData name="Yates, Rob A." userId="S::raya228@uky.edu::c4835988-b912-40a4-bf56-31a2afc86d77" providerId="AD" clId="Web-{0CC3DE7B-5279-3B29-9775-114C9D57E971}" dt="2023-07-20T13:26:48.726" v="104"/>
          <ac:spMkLst>
            <pc:docMk/>
            <pc:sldMk cId="0" sldId="258"/>
            <ac:spMk id="54" creationId="{9E8C4212-4AEA-8C1F-7D51-DF07A99C8D40}"/>
          </ac:spMkLst>
        </pc:spChg>
        <pc:spChg chg="add">
          <ac:chgData name="Yates, Rob A." userId="S::raya228@uky.edu::c4835988-b912-40a4-bf56-31a2afc86d77" providerId="AD" clId="Web-{0CC3DE7B-5279-3B29-9775-114C9D57E971}" dt="2023-07-20T13:26:48.741" v="105"/>
          <ac:spMkLst>
            <pc:docMk/>
            <pc:sldMk cId="0" sldId="258"/>
            <ac:spMk id="56" creationId="{CFB1B0DA-E07C-AD57-1049-98E84A578B3D}"/>
          </ac:spMkLst>
        </pc:spChg>
        <pc:spChg chg="add">
          <ac:chgData name="Yates, Rob A." userId="S::raya228@uky.edu::c4835988-b912-40a4-bf56-31a2afc86d77" providerId="AD" clId="Web-{0CC3DE7B-5279-3B29-9775-114C9D57E971}" dt="2023-07-20T13:26:48.757" v="106"/>
          <ac:spMkLst>
            <pc:docMk/>
            <pc:sldMk cId="0" sldId="258"/>
            <ac:spMk id="58" creationId="{BDEDC870-1D81-5492-C84C-B76E632386DE}"/>
          </ac:spMkLst>
        </pc:spChg>
        <pc:spChg chg="add">
          <ac:chgData name="Yates, Rob A." userId="S::raya228@uky.edu::c4835988-b912-40a4-bf56-31a2afc86d77" providerId="AD" clId="Web-{0CC3DE7B-5279-3B29-9775-114C9D57E971}" dt="2023-07-20T13:26:48.773" v="107"/>
          <ac:spMkLst>
            <pc:docMk/>
            <pc:sldMk cId="0" sldId="258"/>
            <ac:spMk id="60" creationId="{5F2577E9-80D1-0332-E247-6EE9E4FC891D}"/>
          </ac:spMkLst>
        </pc:spChg>
      </pc:sldChg>
      <pc:sldChg chg="addSp delSp">
        <pc:chgData name="Yates, Rob A." userId="S::raya228@uky.edu::c4835988-b912-40a4-bf56-31a2afc86d77" providerId="AD" clId="Web-{0CC3DE7B-5279-3B29-9775-114C9D57E971}" dt="2023-07-20T13:45:13.474" v="139"/>
        <pc:sldMkLst>
          <pc:docMk/>
          <pc:sldMk cId="0" sldId="259"/>
        </pc:sldMkLst>
        <pc:spChg chg="del">
          <ac:chgData name="Yates, Rob A." userId="S::raya228@uky.edu::c4835988-b912-40a4-bf56-31a2afc86d77" providerId="AD" clId="Web-{0CC3DE7B-5279-3B29-9775-114C9D57E971}" dt="2023-07-20T13:45:08.661" v="123"/>
          <ac:spMkLst>
            <pc:docMk/>
            <pc:sldMk cId="0" sldId="259"/>
            <ac:spMk id="4" creationId="{00000000-0000-0000-0000-000000000000}"/>
          </ac:spMkLst>
        </pc:spChg>
        <pc:spChg chg="del">
          <ac:chgData name="Yates, Rob A." userId="S::raya228@uky.edu::c4835988-b912-40a4-bf56-31a2afc86d77" providerId="AD" clId="Web-{0CC3DE7B-5279-3B29-9775-114C9D57E971}" dt="2023-07-20T13:45:08.661" v="122"/>
          <ac:spMkLst>
            <pc:docMk/>
            <pc:sldMk cId="0" sldId="259"/>
            <ac:spMk id="5" creationId="{00000000-0000-0000-0000-000000000000}"/>
          </ac:spMkLst>
        </pc:spChg>
        <pc:spChg chg="del">
          <ac:chgData name="Yates, Rob A." userId="S::raya228@uky.edu::c4835988-b912-40a4-bf56-31a2afc86d77" providerId="AD" clId="Web-{0CC3DE7B-5279-3B29-9775-114C9D57E971}" dt="2023-07-20T13:45:08.661" v="121"/>
          <ac:spMkLst>
            <pc:docMk/>
            <pc:sldMk cId="0" sldId="259"/>
            <ac:spMk id="8" creationId="{00000000-0000-0000-0000-000000000000}"/>
          </ac:spMkLst>
        </pc:spChg>
        <pc:spChg chg="del">
          <ac:chgData name="Yates, Rob A." userId="S::raya228@uky.edu::c4835988-b912-40a4-bf56-31a2afc86d77" providerId="AD" clId="Web-{0CC3DE7B-5279-3B29-9775-114C9D57E971}" dt="2023-07-20T13:45:08.661" v="120"/>
          <ac:spMkLst>
            <pc:docMk/>
            <pc:sldMk cId="0" sldId="259"/>
            <ac:spMk id="9" creationId="{00000000-0000-0000-0000-000000000000}"/>
          </ac:spMkLst>
        </pc:spChg>
        <pc:spChg chg="del">
          <ac:chgData name="Yates, Rob A." userId="S::raya228@uky.edu::c4835988-b912-40a4-bf56-31a2afc86d77" providerId="AD" clId="Web-{0CC3DE7B-5279-3B29-9775-114C9D57E971}" dt="2023-07-20T13:45:08.661" v="119"/>
          <ac:spMkLst>
            <pc:docMk/>
            <pc:sldMk cId="0" sldId="259"/>
            <ac:spMk id="13" creationId="{00000000-0000-0000-0000-000000000000}"/>
          </ac:spMkLst>
        </pc:spChg>
        <pc:spChg chg="del">
          <ac:chgData name="Yates, Rob A." userId="S::raya228@uky.edu::c4835988-b912-40a4-bf56-31a2afc86d77" providerId="AD" clId="Web-{0CC3DE7B-5279-3B29-9775-114C9D57E971}" dt="2023-07-20T13:45:08.661" v="118"/>
          <ac:spMkLst>
            <pc:docMk/>
            <pc:sldMk cId="0" sldId="259"/>
            <ac:spMk id="14" creationId="{00000000-0000-0000-0000-000000000000}"/>
          </ac:spMkLst>
        </pc:spChg>
        <pc:spChg chg="del">
          <ac:chgData name="Yates, Rob A." userId="S::raya228@uky.edu::c4835988-b912-40a4-bf56-31a2afc86d77" providerId="AD" clId="Web-{0CC3DE7B-5279-3B29-9775-114C9D57E971}" dt="2023-07-20T13:45:08.661" v="117"/>
          <ac:spMkLst>
            <pc:docMk/>
            <pc:sldMk cId="0" sldId="259"/>
            <ac:spMk id="18" creationId="{00000000-0000-0000-0000-000000000000}"/>
          </ac:spMkLst>
        </pc:spChg>
        <pc:spChg chg="del">
          <ac:chgData name="Yates, Rob A." userId="S::raya228@uky.edu::c4835988-b912-40a4-bf56-31a2afc86d77" providerId="AD" clId="Web-{0CC3DE7B-5279-3B29-9775-114C9D57E971}" dt="2023-07-20T13:45:08.661" v="116"/>
          <ac:spMkLst>
            <pc:docMk/>
            <pc:sldMk cId="0" sldId="259"/>
            <ac:spMk id="19" creationId="{00000000-0000-0000-0000-000000000000}"/>
          </ac:spMkLst>
        </pc:spChg>
        <pc:spChg chg="del">
          <ac:chgData name="Yates, Rob A." userId="S::raya228@uky.edu::c4835988-b912-40a4-bf56-31a2afc86d77" providerId="AD" clId="Web-{0CC3DE7B-5279-3B29-9775-114C9D57E971}" dt="2023-07-20T13:45:08.661" v="115"/>
          <ac:spMkLst>
            <pc:docMk/>
            <pc:sldMk cId="0" sldId="259"/>
            <ac:spMk id="21" creationId="{C5C1F126-0CE5-0AAA-322B-08E91151EA83}"/>
          </ac:spMkLst>
        </pc:spChg>
        <pc:spChg chg="del">
          <ac:chgData name="Yates, Rob A." userId="S::raya228@uky.edu::c4835988-b912-40a4-bf56-31a2afc86d77" providerId="AD" clId="Web-{0CC3DE7B-5279-3B29-9775-114C9D57E971}" dt="2023-07-20T13:45:08.661" v="114"/>
          <ac:spMkLst>
            <pc:docMk/>
            <pc:sldMk cId="0" sldId="259"/>
            <ac:spMk id="22" creationId="{CECF3290-ED6E-F963-8027-B2E2EBF7D984}"/>
          </ac:spMkLst>
        </pc:spChg>
        <pc:spChg chg="del">
          <ac:chgData name="Yates, Rob A." userId="S::raya228@uky.edu::c4835988-b912-40a4-bf56-31a2afc86d77" providerId="AD" clId="Web-{0CC3DE7B-5279-3B29-9775-114C9D57E971}" dt="2023-07-20T13:45:08.661" v="113"/>
          <ac:spMkLst>
            <pc:docMk/>
            <pc:sldMk cId="0" sldId="259"/>
            <ac:spMk id="23" creationId="{7D2A2738-6B70-2803-7DF6-1B1933E1E8B8}"/>
          </ac:spMkLst>
        </pc:spChg>
        <pc:spChg chg="del">
          <ac:chgData name="Yates, Rob A." userId="S::raya228@uky.edu::c4835988-b912-40a4-bf56-31a2afc86d77" providerId="AD" clId="Web-{0CC3DE7B-5279-3B29-9775-114C9D57E971}" dt="2023-07-20T13:45:08.661" v="112"/>
          <ac:spMkLst>
            <pc:docMk/>
            <pc:sldMk cId="0" sldId="259"/>
            <ac:spMk id="24" creationId="{418821AD-E82D-6B62-377B-BC498AF3E829}"/>
          </ac:spMkLst>
        </pc:spChg>
        <pc:spChg chg="del">
          <ac:chgData name="Yates, Rob A." userId="S::raya228@uky.edu::c4835988-b912-40a4-bf56-31a2afc86d77" providerId="AD" clId="Web-{0CC3DE7B-5279-3B29-9775-114C9D57E971}" dt="2023-07-20T13:45:08.661" v="111"/>
          <ac:spMkLst>
            <pc:docMk/>
            <pc:sldMk cId="0" sldId="259"/>
            <ac:spMk id="25" creationId="{31C4162A-407B-2DDC-F6A1-12A6068D5872}"/>
          </ac:spMkLst>
        </pc:spChg>
        <pc:spChg chg="del">
          <ac:chgData name="Yates, Rob A." userId="S::raya228@uky.edu::c4835988-b912-40a4-bf56-31a2afc86d77" providerId="AD" clId="Web-{0CC3DE7B-5279-3B29-9775-114C9D57E971}" dt="2023-07-20T13:45:08.661" v="110"/>
          <ac:spMkLst>
            <pc:docMk/>
            <pc:sldMk cId="0" sldId="259"/>
            <ac:spMk id="26" creationId="{DAD4DF38-D3B3-254A-D5CB-3DC55203C441}"/>
          </ac:spMkLst>
        </pc:spChg>
        <pc:spChg chg="del">
          <ac:chgData name="Yates, Rob A." userId="S::raya228@uky.edu::c4835988-b912-40a4-bf56-31a2afc86d77" providerId="AD" clId="Web-{0CC3DE7B-5279-3B29-9775-114C9D57E971}" dt="2023-07-20T13:45:08.661" v="109"/>
          <ac:spMkLst>
            <pc:docMk/>
            <pc:sldMk cId="0" sldId="259"/>
            <ac:spMk id="27" creationId="{CED5C772-5130-3AFA-6F82-138366785CCC}"/>
          </ac:spMkLst>
        </pc:spChg>
        <pc:spChg chg="del">
          <ac:chgData name="Yates, Rob A." userId="S::raya228@uky.edu::c4835988-b912-40a4-bf56-31a2afc86d77" providerId="AD" clId="Web-{0CC3DE7B-5279-3B29-9775-114C9D57E971}" dt="2023-07-20T13:45:08.661" v="108"/>
          <ac:spMkLst>
            <pc:docMk/>
            <pc:sldMk cId="0" sldId="259"/>
            <ac:spMk id="28" creationId="{47121687-4575-1A8D-4933-E95AED593AF3}"/>
          </ac:spMkLst>
        </pc:spChg>
        <pc:spChg chg="add">
          <ac:chgData name="Yates, Rob A." userId="S::raya228@uky.edu::c4835988-b912-40a4-bf56-31a2afc86d77" providerId="AD" clId="Web-{0CC3DE7B-5279-3B29-9775-114C9D57E971}" dt="2023-07-20T13:45:13.287" v="124"/>
          <ac:spMkLst>
            <pc:docMk/>
            <pc:sldMk cId="0" sldId="259"/>
            <ac:spMk id="30" creationId="{8AD5690E-EC68-9616-D9C2-01966862D19C}"/>
          </ac:spMkLst>
        </pc:spChg>
        <pc:spChg chg="add">
          <ac:chgData name="Yates, Rob A." userId="S::raya228@uky.edu::c4835988-b912-40a4-bf56-31a2afc86d77" providerId="AD" clId="Web-{0CC3DE7B-5279-3B29-9775-114C9D57E971}" dt="2023-07-20T13:45:13.302" v="125"/>
          <ac:spMkLst>
            <pc:docMk/>
            <pc:sldMk cId="0" sldId="259"/>
            <ac:spMk id="32" creationId="{8FEA69AA-3BBD-9DA6-64F1-2C22D7D8E7DC}"/>
          </ac:spMkLst>
        </pc:spChg>
        <pc:spChg chg="add">
          <ac:chgData name="Yates, Rob A." userId="S::raya228@uky.edu::c4835988-b912-40a4-bf56-31a2afc86d77" providerId="AD" clId="Web-{0CC3DE7B-5279-3B29-9775-114C9D57E971}" dt="2023-07-20T13:45:13.318" v="126"/>
          <ac:spMkLst>
            <pc:docMk/>
            <pc:sldMk cId="0" sldId="259"/>
            <ac:spMk id="34" creationId="{AA52CBE8-5F23-31B1-D60C-0D0C1B74C4AF}"/>
          </ac:spMkLst>
        </pc:spChg>
        <pc:spChg chg="add">
          <ac:chgData name="Yates, Rob A." userId="S::raya228@uky.edu::c4835988-b912-40a4-bf56-31a2afc86d77" providerId="AD" clId="Web-{0CC3DE7B-5279-3B29-9775-114C9D57E971}" dt="2023-07-20T13:45:13.318" v="127"/>
          <ac:spMkLst>
            <pc:docMk/>
            <pc:sldMk cId="0" sldId="259"/>
            <ac:spMk id="36" creationId="{118B49BF-51A4-C282-92DF-C04D9E6224D0}"/>
          </ac:spMkLst>
        </pc:spChg>
        <pc:spChg chg="add">
          <ac:chgData name="Yates, Rob A." userId="S::raya228@uky.edu::c4835988-b912-40a4-bf56-31a2afc86d77" providerId="AD" clId="Web-{0CC3DE7B-5279-3B29-9775-114C9D57E971}" dt="2023-07-20T13:45:13.333" v="128"/>
          <ac:spMkLst>
            <pc:docMk/>
            <pc:sldMk cId="0" sldId="259"/>
            <ac:spMk id="38" creationId="{DA4EF882-54B9-9607-BF55-A29AEC6C2EB0}"/>
          </ac:spMkLst>
        </pc:spChg>
        <pc:spChg chg="add">
          <ac:chgData name="Yates, Rob A." userId="S::raya228@uky.edu::c4835988-b912-40a4-bf56-31a2afc86d77" providerId="AD" clId="Web-{0CC3DE7B-5279-3B29-9775-114C9D57E971}" dt="2023-07-20T13:45:13.349" v="129"/>
          <ac:spMkLst>
            <pc:docMk/>
            <pc:sldMk cId="0" sldId="259"/>
            <ac:spMk id="40" creationId="{D93A8445-D74E-BCE7-D033-97EC33C62F58}"/>
          </ac:spMkLst>
        </pc:spChg>
        <pc:spChg chg="add">
          <ac:chgData name="Yates, Rob A." userId="S::raya228@uky.edu::c4835988-b912-40a4-bf56-31a2afc86d77" providerId="AD" clId="Web-{0CC3DE7B-5279-3B29-9775-114C9D57E971}" dt="2023-07-20T13:45:13.349" v="130"/>
          <ac:spMkLst>
            <pc:docMk/>
            <pc:sldMk cId="0" sldId="259"/>
            <ac:spMk id="42" creationId="{44C61D5C-3176-C139-5862-958087D814C5}"/>
          </ac:spMkLst>
        </pc:spChg>
        <pc:spChg chg="add">
          <ac:chgData name="Yates, Rob A." userId="S::raya228@uky.edu::c4835988-b912-40a4-bf56-31a2afc86d77" providerId="AD" clId="Web-{0CC3DE7B-5279-3B29-9775-114C9D57E971}" dt="2023-07-20T13:45:13.365" v="131"/>
          <ac:spMkLst>
            <pc:docMk/>
            <pc:sldMk cId="0" sldId="259"/>
            <ac:spMk id="44" creationId="{D822E3CB-386A-24F3-5D53-9B8C44EA04BD}"/>
          </ac:spMkLst>
        </pc:spChg>
        <pc:spChg chg="add">
          <ac:chgData name="Yates, Rob A." userId="S::raya228@uky.edu::c4835988-b912-40a4-bf56-31a2afc86d77" providerId="AD" clId="Web-{0CC3DE7B-5279-3B29-9775-114C9D57E971}" dt="2023-07-20T13:45:13.380" v="132"/>
          <ac:spMkLst>
            <pc:docMk/>
            <pc:sldMk cId="0" sldId="259"/>
            <ac:spMk id="46" creationId="{29EE3AA9-B50D-A07F-2F25-5AE3EAE7D24F}"/>
          </ac:spMkLst>
        </pc:spChg>
        <pc:spChg chg="add">
          <ac:chgData name="Yates, Rob A." userId="S::raya228@uky.edu::c4835988-b912-40a4-bf56-31a2afc86d77" providerId="AD" clId="Web-{0CC3DE7B-5279-3B29-9775-114C9D57E971}" dt="2023-07-20T13:45:13.396" v="133"/>
          <ac:spMkLst>
            <pc:docMk/>
            <pc:sldMk cId="0" sldId="259"/>
            <ac:spMk id="48" creationId="{DF723855-A96A-DF99-796C-A19A8BD82161}"/>
          </ac:spMkLst>
        </pc:spChg>
        <pc:spChg chg="add">
          <ac:chgData name="Yates, Rob A." userId="S::raya228@uky.edu::c4835988-b912-40a4-bf56-31a2afc86d77" providerId="AD" clId="Web-{0CC3DE7B-5279-3B29-9775-114C9D57E971}" dt="2023-07-20T13:45:13.412" v="134"/>
          <ac:spMkLst>
            <pc:docMk/>
            <pc:sldMk cId="0" sldId="259"/>
            <ac:spMk id="50" creationId="{46C3F68D-45AF-C306-6647-77E14FF0C47D}"/>
          </ac:spMkLst>
        </pc:spChg>
        <pc:spChg chg="add">
          <ac:chgData name="Yates, Rob A." userId="S::raya228@uky.edu::c4835988-b912-40a4-bf56-31a2afc86d77" providerId="AD" clId="Web-{0CC3DE7B-5279-3B29-9775-114C9D57E971}" dt="2023-07-20T13:45:13.427" v="135"/>
          <ac:spMkLst>
            <pc:docMk/>
            <pc:sldMk cId="0" sldId="259"/>
            <ac:spMk id="52" creationId="{78FE9172-BBF9-624A-5F59-F8687ADECE19}"/>
          </ac:spMkLst>
        </pc:spChg>
        <pc:spChg chg="add">
          <ac:chgData name="Yates, Rob A." userId="S::raya228@uky.edu::c4835988-b912-40a4-bf56-31a2afc86d77" providerId="AD" clId="Web-{0CC3DE7B-5279-3B29-9775-114C9D57E971}" dt="2023-07-20T13:45:13.443" v="136"/>
          <ac:spMkLst>
            <pc:docMk/>
            <pc:sldMk cId="0" sldId="259"/>
            <ac:spMk id="54" creationId="{E4045289-C4E1-1A3B-C278-50CA4BA93EEF}"/>
          </ac:spMkLst>
        </pc:spChg>
        <pc:spChg chg="add">
          <ac:chgData name="Yates, Rob A." userId="S::raya228@uky.edu::c4835988-b912-40a4-bf56-31a2afc86d77" providerId="AD" clId="Web-{0CC3DE7B-5279-3B29-9775-114C9D57E971}" dt="2023-07-20T13:45:13.458" v="137"/>
          <ac:spMkLst>
            <pc:docMk/>
            <pc:sldMk cId="0" sldId="259"/>
            <ac:spMk id="56" creationId="{C52F4A03-287A-9430-2B41-61664B10484C}"/>
          </ac:spMkLst>
        </pc:spChg>
        <pc:spChg chg="add">
          <ac:chgData name="Yates, Rob A." userId="S::raya228@uky.edu::c4835988-b912-40a4-bf56-31a2afc86d77" providerId="AD" clId="Web-{0CC3DE7B-5279-3B29-9775-114C9D57E971}" dt="2023-07-20T13:45:13.474" v="138"/>
          <ac:spMkLst>
            <pc:docMk/>
            <pc:sldMk cId="0" sldId="259"/>
            <ac:spMk id="58" creationId="{92F9B11C-BABF-E47F-DEB7-34ECF9F324EB}"/>
          </ac:spMkLst>
        </pc:spChg>
        <pc:spChg chg="add">
          <ac:chgData name="Yates, Rob A." userId="S::raya228@uky.edu::c4835988-b912-40a4-bf56-31a2afc86d77" providerId="AD" clId="Web-{0CC3DE7B-5279-3B29-9775-114C9D57E971}" dt="2023-07-20T13:45:13.474" v="139"/>
          <ac:spMkLst>
            <pc:docMk/>
            <pc:sldMk cId="0" sldId="259"/>
            <ac:spMk id="60" creationId="{86385373-276F-18D4-D0FF-F0515487C9D8}"/>
          </ac:spMkLst>
        </pc:spChg>
      </pc:sldChg>
      <pc:sldChg chg="addSp delSp">
        <pc:chgData name="Yates, Rob A." userId="S::raya228@uky.edu::c4835988-b912-40a4-bf56-31a2afc86d77" providerId="AD" clId="Web-{0CC3DE7B-5279-3B29-9775-114C9D57E971}" dt="2023-07-20T14:08:28.536" v="175"/>
        <pc:sldMkLst>
          <pc:docMk/>
          <pc:sldMk cId="0" sldId="260"/>
        </pc:sldMkLst>
        <pc:spChg chg="del">
          <ac:chgData name="Yates, Rob A." userId="S::raya228@uky.edu::c4835988-b912-40a4-bf56-31a2afc86d77" providerId="AD" clId="Web-{0CC3DE7B-5279-3B29-9775-114C9D57E971}" dt="2023-07-20T14:08:24.349" v="159"/>
          <ac:spMkLst>
            <pc:docMk/>
            <pc:sldMk cId="0" sldId="260"/>
            <ac:spMk id="4" creationId="{00000000-0000-0000-0000-000000000000}"/>
          </ac:spMkLst>
        </pc:spChg>
        <pc:spChg chg="del">
          <ac:chgData name="Yates, Rob A." userId="S::raya228@uky.edu::c4835988-b912-40a4-bf56-31a2afc86d77" providerId="AD" clId="Web-{0CC3DE7B-5279-3B29-9775-114C9D57E971}" dt="2023-07-20T14:08:24.349" v="158"/>
          <ac:spMkLst>
            <pc:docMk/>
            <pc:sldMk cId="0" sldId="260"/>
            <ac:spMk id="5" creationId="{00000000-0000-0000-0000-000000000000}"/>
          </ac:spMkLst>
        </pc:spChg>
        <pc:spChg chg="del">
          <ac:chgData name="Yates, Rob A." userId="S::raya228@uky.edu::c4835988-b912-40a4-bf56-31a2afc86d77" providerId="AD" clId="Web-{0CC3DE7B-5279-3B29-9775-114C9D57E971}" dt="2023-07-20T14:08:24.349" v="157"/>
          <ac:spMkLst>
            <pc:docMk/>
            <pc:sldMk cId="0" sldId="260"/>
            <ac:spMk id="8" creationId="{00000000-0000-0000-0000-000000000000}"/>
          </ac:spMkLst>
        </pc:spChg>
        <pc:spChg chg="del">
          <ac:chgData name="Yates, Rob A." userId="S::raya228@uky.edu::c4835988-b912-40a4-bf56-31a2afc86d77" providerId="AD" clId="Web-{0CC3DE7B-5279-3B29-9775-114C9D57E971}" dt="2023-07-20T14:08:24.349" v="156"/>
          <ac:spMkLst>
            <pc:docMk/>
            <pc:sldMk cId="0" sldId="260"/>
            <ac:spMk id="9" creationId="{00000000-0000-0000-0000-000000000000}"/>
          </ac:spMkLst>
        </pc:spChg>
        <pc:spChg chg="del">
          <ac:chgData name="Yates, Rob A." userId="S::raya228@uky.edu::c4835988-b912-40a4-bf56-31a2afc86d77" providerId="AD" clId="Web-{0CC3DE7B-5279-3B29-9775-114C9D57E971}" dt="2023-07-20T14:08:24.349" v="155"/>
          <ac:spMkLst>
            <pc:docMk/>
            <pc:sldMk cId="0" sldId="260"/>
            <ac:spMk id="13" creationId="{00000000-0000-0000-0000-000000000000}"/>
          </ac:spMkLst>
        </pc:spChg>
        <pc:spChg chg="del">
          <ac:chgData name="Yates, Rob A." userId="S::raya228@uky.edu::c4835988-b912-40a4-bf56-31a2afc86d77" providerId="AD" clId="Web-{0CC3DE7B-5279-3B29-9775-114C9D57E971}" dt="2023-07-20T14:08:24.349" v="154"/>
          <ac:spMkLst>
            <pc:docMk/>
            <pc:sldMk cId="0" sldId="260"/>
            <ac:spMk id="14" creationId="{00000000-0000-0000-0000-000000000000}"/>
          </ac:spMkLst>
        </pc:spChg>
        <pc:spChg chg="del">
          <ac:chgData name="Yates, Rob A." userId="S::raya228@uky.edu::c4835988-b912-40a4-bf56-31a2afc86d77" providerId="AD" clId="Web-{0CC3DE7B-5279-3B29-9775-114C9D57E971}" dt="2023-07-20T14:08:24.349" v="153"/>
          <ac:spMkLst>
            <pc:docMk/>
            <pc:sldMk cId="0" sldId="260"/>
            <ac:spMk id="18" creationId="{00000000-0000-0000-0000-000000000000}"/>
          </ac:spMkLst>
        </pc:spChg>
        <pc:spChg chg="del">
          <ac:chgData name="Yates, Rob A." userId="S::raya228@uky.edu::c4835988-b912-40a4-bf56-31a2afc86d77" providerId="AD" clId="Web-{0CC3DE7B-5279-3B29-9775-114C9D57E971}" dt="2023-07-20T14:08:24.349" v="152"/>
          <ac:spMkLst>
            <pc:docMk/>
            <pc:sldMk cId="0" sldId="260"/>
            <ac:spMk id="19" creationId="{00000000-0000-0000-0000-000000000000}"/>
          </ac:spMkLst>
        </pc:spChg>
        <pc:spChg chg="del">
          <ac:chgData name="Yates, Rob A." userId="S::raya228@uky.edu::c4835988-b912-40a4-bf56-31a2afc86d77" providerId="AD" clId="Web-{0CC3DE7B-5279-3B29-9775-114C9D57E971}" dt="2023-07-20T14:08:24.349" v="151"/>
          <ac:spMkLst>
            <pc:docMk/>
            <pc:sldMk cId="0" sldId="260"/>
            <ac:spMk id="21" creationId="{212DFFF8-3114-1727-7DD9-E233FAD6DB44}"/>
          </ac:spMkLst>
        </pc:spChg>
        <pc:spChg chg="del">
          <ac:chgData name="Yates, Rob A." userId="S::raya228@uky.edu::c4835988-b912-40a4-bf56-31a2afc86d77" providerId="AD" clId="Web-{0CC3DE7B-5279-3B29-9775-114C9D57E971}" dt="2023-07-20T14:08:24.349" v="150"/>
          <ac:spMkLst>
            <pc:docMk/>
            <pc:sldMk cId="0" sldId="260"/>
            <ac:spMk id="22" creationId="{4F2D80F4-54C6-4C48-003D-C95B0F88AB59}"/>
          </ac:spMkLst>
        </pc:spChg>
        <pc:spChg chg="del">
          <ac:chgData name="Yates, Rob A." userId="S::raya228@uky.edu::c4835988-b912-40a4-bf56-31a2afc86d77" providerId="AD" clId="Web-{0CC3DE7B-5279-3B29-9775-114C9D57E971}" dt="2023-07-20T14:08:24.349" v="149"/>
          <ac:spMkLst>
            <pc:docMk/>
            <pc:sldMk cId="0" sldId="260"/>
            <ac:spMk id="23" creationId="{9509469B-A966-B4AE-A6F5-10F9C6E031E9}"/>
          </ac:spMkLst>
        </pc:spChg>
        <pc:spChg chg="del">
          <ac:chgData name="Yates, Rob A." userId="S::raya228@uky.edu::c4835988-b912-40a4-bf56-31a2afc86d77" providerId="AD" clId="Web-{0CC3DE7B-5279-3B29-9775-114C9D57E971}" dt="2023-07-20T14:08:24.349" v="148"/>
          <ac:spMkLst>
            <pc:docMk/>
            <pc:sldMk cId="0" sldId="260"/>
            <ac:spMk id="24" creationId="{CF31514D-44A3-5678-DA15-AD0D5DB9DBE8}"/>
          </ac:spMkLst>
        </pc:spChg>
        <pc:spChg chg="del">
          <ac:chgData name="Yates, Rob A." userId="S::raya228@uky.edu::c4835988-b912-40a4-bf56-31a2afc86d77" providerId="AD" clId="Web-{0CC3DE7B-5279-3B29-9775-114C9D57E971}" dt="2023-07-20T14:08:24.349" v="147"/>
          <ac:spMkLst>
            <pc:docMk/>
            <pc:sldMk cId="0" sldId="260"/>
            <ac:spMk id="25" creationId="{43D2083B-7AA1-CB4E-5657-9F26850F72EF}"/>
          </ac:spMkLst>
        </pc:spChg>
        <pc:spChg chg="del">
          <ac:chgData name="Yates, Rob A." userId="S::raya228@uky.edu::c4835988-b912-40a4-bf56-31a2afc86d77" providerId="AD" clId="Web-{0CC3DE7B-5279-3B29-9775-114C9D57E971}" dt="2023-07-20T14:08:24.349" v="146"/>
          <ac:spMkLst>
            <pc:docMk/>
            <pc:sldMk cId="0" sldId="260"/>
            <ac:spMk id="26" creationId="{7F634E6E-AD42-BEE5-891D-4AABCE4E7F21}"/>
          </ac:spMkLst>
        </pc:spChg>
        <pc:spChg chg="del">
          <ac:chgData name="Yates, Rob A." userId="S::raya228@uky.edu::c4835988-b912-40a4-bf56-31a2afc86d77" providerId="AD" clId="Web-{0CC3DE7B-5279-3B29-9775-114C9D57E971}" dt="2023-07-20T14:08:24.349" v="145"/>
          <ac:spMkLst>
            <pc:docMk/>
            <pc:sldMk cId="0" sldId="260"/>
            <ac:spMk id="27" creationId="{4202AF8C-5699-F824-8103-BE74EBF08FBF}"/>
          </ac:spMkLst>
        </pc:spChg>
        <pc:spChg chg="del">
          <ac:chgData name="Yates, Rob A." userId="S::raya228@uky.edu::c4835988-b912-40a4-bf56-31a2afc86d77" providerId="AD" clId="Web-{0CC3DE7B-5279-3B29-9775-114C9D57E971}" dt="2023-07-20T14:08:24.349" v="144"/>
          <ac:spMkLst>
            <pc:docMk/>
            <pc:sldMk cId="0" sldId="260"/>
            <ac:spMk id="28" creationId="{BC88E782-BE08-92E8-33E5-DDDD5CD71AC5}"/>
          </ac:spMkLst>
        </pc:spChg>
        <pc:spChg chg="add">
          <ac:chgData name="Yates, Rob A." userId="S::raya228@uky.edu::c4835988-b912-40a4-bf56-31a2afc86d77" providerId="AD" clId="Web-{0CC3DE7B-5279-3B29-9775-114C9D57E971}" dt="2023-07-20T14:08:28.318" v="160"/>
          <ac:spMkLst>
            <pc:docMk/>
            <pc:sldMk cId="0" sldId="260"/>
            <ac:spMk id="30" creationId="{6508C7AA-CD5C-5994-4814-7B95FA36BCDA}"/>
          </ac:spMkLst>
        </pc:spChg>
        <pc:spChg chg="add">
          <ac:chgData name="Yates, Rob A." userId="S::raya228@uky.edu::c4835988-b912-40a4-bf56-31a2afc86d77" providerId="AD" clId="Web-{0CC3DE7B-5279-3B29-9775-114C9D57E971}" dt="2023-07-20T14:08:28.333" v="161"/>
          <ac:spMkLst>
            <pc:docMk/>
            <pc:sldMk cId="0" sldId="260"/>
            <ac:spMk id="32" creationId="{3C524506-6709-EBA1-104A-D25B0F9AEDFF}"/>
          </ac:spMkLst>
        </pc:spChg>
        <pc:spChg chg="add">
          <ac:chgData name="Yates, Rob A." userId="S::raya228@uky.edu::c4835988-b912-40a4-bf56-31a2afc86d77" providerId="AD" clId="Web-{0CC3DE7B-5279-3B29-9775-114C9D57E971}" dt="2023-07-20T14:08:28.333" v="162"/>
          <ac:spMkLst>
            <pc:docMk/>
            <pc:sldMk cId="0" sldId="260"/>
            <ac:spMk id="34" creationId="{4DACC92D-A471-5317-945C-E76539D601BD}"/>
          </ac:spMkLst>
        </pc:spChg>
        <pc:spChg chg="add">
          <ac:chgData name="Yates, Rob A." userId="S::raya228@uky.edu::c4835988-b912-40a4-bf56-31a2afc86d77" providerId="AD" clId="Web-{0CC3DE7B-5279-3B29-9775-114C9D57E971}" dt="2023-07-20T14:08:28.349" v="163"/>
          <ac:spMkLst>
            <pc:docMk/>
            <pc:sldMk cId="0" sldId="260"/>
            <ac:spMk id="36" creationId="{2111DF97-F555-F705-F983-5A1FF737FC30}"/>
          </ac:spMkLst>
        </pc:spChg>
        <pc:spChg chg="add">
          <ac:chgData name="Yates, Rob A." userId="S::raya228@uky.edu::c4835988-b912-40a4-bf56-31a2afc86d77" providerId="AD" clId="Web-{0CC3DE7B-5279-3B29-9775-114C9D57E971}" dt="2023-07-20T14:08:28.349" v="164"/>
          <ac:spMkLst>
            <pc:docMk/>
            <pc:sldMk cId="0" sldId="260"/>
            <ac:spMk id="38" creationId="{3605EDDA-9090-92AF-0EF1-3862668E2704}"/>
          </ac:spMkLst>
        </pc:spChg>
        <pc:spChg chg="add">
          <ac:chgData name="Yates, Rob A." userId="S::raya228@uky.edu::c4835988-b912-40a4-bf56-31a2afc86d77" providerId="AD" clId="Web-{0CC3DE7B-5279-3B29-9775-114C9D57E971}" dt="2023-07-20T14:08:28.364" v="165"/>
          <ac:spMkLst>
            <pc:docMk/>
            <pc:sldMk cId="0" sldId="260"/>
            <ac:spMk id="40" creationId="{2D224EE8-C787-AD41-97DD-89D29C386C41}"/>
          </ac:spMkLst>
        </pc:spChg>
        <pc:spChg chg="add">
          <ac:chgData name="Yates, Rob A." userId="S::raya228@uky.edu::c4835988-b912-40a4-bf56-31a2afc86d77" providerId="AD" clId="Web-{0CC3DE7B-5279-3B29-9775-114C9D57E971}" dt="2023-07-20T14:08:28.380" v="166"/>
          <ac:spMkLst>
            <pc:docMk/>
            <pc:sldMk cId="0" sldId="260"/>
            <ac:spMk id="42" creationId="{5234BCC9-BD0A-6BC6-DE7A-3349D67DBE78}"/>
          </ac:spMkLst>
        </pc:spChg>
        <pc:spChg chg="add">
          <ac:chgData name="Yates, Rob A." userId="S::raya228@uky.edu::c4835988-b912-40a4-bf56-31a2afc86d77" providerId="AD" clId="Web-{0CC3DE7B-5279-3B29-9775-114C9D57E971}" dt="2023-07-20T14:08:28.380" v="167"/>
          <ac:spMkLst>
            <pc:docMk/>
            <pc:sldMk cId="0" sldId="260"/>
            <ac:spMk id="44" creationId="{78DF50DE-CFC3-F5EB-DFC0-990576776727}"/>
          </ac:spMkLst>
        </pc:spChg>
        <pc:spChg chg="add">
          <ac:chgData name="Yates, Rob A." userId="S::raya228@uky.edu::c4835988-b912-40a4-bf56-31a2afc86d77" providerId="AD" clId="Web-{0CC3DE7B-5279-3B29-9775-114C9D57E971}" dt="2023-07-20T14:08:28.396" v="168"/>
          <ac:spMkLst>
            <pc:docMk/>
            <pc:sldMk cId="0" sldId="260"/>
            <ac:spMk id="46" creationId="{D882FB8F-859B-8D49-3834-18F5D0EC2800}"/>
          </ac:spMkLst>
        </pc:spChg>
        <pc:spChg chg="add">
          <ac:chgData name="Yates, Rob A." userId="S::raya228@uky.edu::c4835988-b912-40a4-bf56-31a2afc86d77" providerId="AD" clId="Web-{0CC3DE7B-5279-3B29-9775-114C9D57E971}" dt="2023-07-20T14:08:28.411" v="169"/>
          <ac:spMkLst>
            <pc:docMk/>
            <pc:sldMk cId="0" sldId="260"/>
            <ac:spMk id="48" creationId="{63425ACD-990F-BB49-7538-FDE6A0E4E997}"/>
          </ac:spMkLst>
        </pc:spChg>
        <pc:spChg chg="add">
          <ac:chgData name="Yates, Rob A." userId="S::raya228@uky.edu::c4835988-b912-40a4-bf56-31a2afc86d77" providerId="AD" clId="Web-{0CC3DE7B-5279-3B29-9775-114C9D57E971}" dt="2023-07-20T14:08:28.427" v="170"/>
          <ac:spMkLst>
            <pc:docMk/>
            <pc:sldMk cId="0" sldId="260"/>
            <ac:spMk id="50" creationId="{524879EC-58D4-C85C-EF13-86FD7B90A752}"/>
          </ac:spMkLst>
        </pc:spChg>
        <pc:spChg chg="add">
          <ac:chgData name="Yates, Rob A." userId="S::raya228@uky.edu::c4835988-b912-40a4-bf56-31a2afc86d77" providerId="AD" clId="Web-{0CC3DE7B-5279-3B29-9775-114C9D57E971}" dt="2023-07-20T14:08:28.474" v="171"/>
          <ac:spMkLst>
            <pc:docMk/>
            <pc:sldMk cId="0" sldId="260"/>
            <ac:spMk id="52" creationId="{DFE32BAE-BE87-88ED-B993-CDFEDF15EB64}"/>
          </ac:spMkLst>
        </pc:spChg>
        <pc:spChg chg="add">
          <ac:chgData name="Yates, Rob A." userId="S::raya228@uky.edu::c4835988-b912-40a4-bf56-31a2afc86d77" providerId="AD" clId="Web-{0CC3DE7B-5279-3B29-9775-114C9D57E971}" dt="2023-07-20T14:08:28.489" v="172"/>
          <ac:spMkLst>
            <pc:docMk/>
            <pc:sldMk cId="0" sldId="260"/>
            <ac:spMk id="54" creationId="{32D210C6-E268-4772-92F3-4AD51DCE2FA5}"/>
          </ac:spMkLst>
        </pc:spChg>
        <pc:spChg chg="add">
          <ac:chgData name="Yates, Rob A." userId="S::raya228@uky.edu::c4835988-b912-40a4-bf56-31a2afc86d77" providerId="AD" clId="Web-{0CC3DE7B-5279-3B29-9775-114C9D57E971}" dt="2023-07-20T14:08:28.505" v="173"/>
          <ac:spMkLst>
            <pc:docMk/>
            <pc:sldMk cId="0" sldId="260"/>
            <ac:spMk id="56" creationId="{DBF48109-2026-ED61-9E03-FCC6BFEF8382}"/>
          </ac:spMkLst>
        </pc:spChg>
        <pc:spChg chg="add">
          <ac:chgData name="Yates, Rob A." userId="S::raya228@uky.edu::c4835988-b912-40a4-bf56-31a2afc86d77" providerId="AD" clId="Web-{0CC3DE7B-5279-3B29-9775-114C9D57E971}" dt="2023-07-20T14:08:28.521" v="174"/>
          <ac:spMkLst>
            <pc:docMk/>
            <pc:sldMk cId="0" sldId="260"/>
            <ac:spMk id="58" creationId="{8AC5C1DE-1243-B549-9BED-DF71267BA78E}"/>
          </ac:spMkLst>
        </pc:spChg>
        <pc:spChg chg="add">
          <ac:chgData name="Yates, Rob A." userId="S::raya228@uky.edu::c4835988-b912-40a4-bf56-31a2afc86d77" providerId="AD" clId="Web-{0CC3DE7B-5279-3B29-9775-114C9D57E971}" dt="2023-07-20T14:08:28.536" v="175"/>
          <ac:spMkLst>
            <pc:docMk/>
            <pc:sldMk cId="0" sldId="260"/>
            <ac:spMk id="60" creationId="{8E04D54B-0934-BCD0-7381-CE4426365957}"/>
          </ac:spMkLst>
        </pc:spChg>
      </pc:sldChg>
      <pc:sldChg chg="addSp delSp">
        <pc:chgData name="Yates, Rob A." userId="S::raya228@uky.edu::c4835988-b912-40a4-bf56-31a2afc86d77" providerId="AD" clId="Web-{0CC3DE7B-5279-3B29-9775-114C9D57E971}" dt="2023-07-20T14:09:00.350" v="207"/>
        <pc:sldMkLst>
          <pc:docMk/>
          <pc:sldMk cId="0" sldId="261"/>
        </pc:sldMkLst>
        <pc:spChg chg="del">
          <ac:chgData name="Yates, Rob A." userId="S::raya228@uky.edu::c4835988-b912-40a4-bf56-31a2afc86d77" providerId="AD" clId="Web-{0CC3DE7B-5279-3B29-9775-114C9D57E971}" dt="2023-07-20T14:08:56.912" v="191"/>
          <ac:spMkLst>
            <pc:docMk/>
            <pc:sldMk cId="0" sldId="261"/>
            <ac:spMk id="4" creationId="{00000000-0000-0000-0000-000000000000}"/>
          </ac:spMkLst>
        </pc:spChg>
        <pc:spChg chg="del">
          <ac:chgData name="Yates, Rob A." userId="S::raya228@uky.edu::c4835988-b912-40a4-bf56-31a2afc86d77" providerId="AD" clId="Web-{0CC3DE7B-5279-3B29-9775-114C9D57E971}" dt="2023-07-20T14:08:56.912" v="190"/>
          <ac:spMkLst>
            <pc:docMk/>
            <pc:sldMk cId="0" sldId="261"/>
            <ac:spMk id="5" creationId="{00000000-0000-0000-0000-000000000000}"/>
          </ac:spMkLst>
        </pc:spChg>
        <pc:spChg chg="del">
          <ac:chgData name="Yates, Rob A." userId="S::raya228@uky.edu::c4835988-b912-40a4-bf56-31a2afc86d77" providerId="AD" clId="Web-{0CC3DE7B-5279-3B29-9775-114C9D57E971}" dt="2023-07-20T14:08:56.912" v="189"/>
          <ac:spMkLst>
            <pc:docMk/>
            <pc:sldMk cId="0" sldId="261"/>
            <ac:spMk id="8" creationId="{00000000-0000-0000-0000-000000000000}"/>
          </ac:spMkLst>
        </pc:spChg>
        <pc:spChg chg="del">
          <ac:chgData name="Yates, Rob A." userId="S::raya228@uky.edu::c4835988-b912-40a4-bf56-31a2afc86d77" providerId="AD" clId="Web-{0CC3DE7B-5279-3B29-9775-114C9D57E971}" dt="2023-07-20T14:08:56.912" v="188"/>
          <ac:spMkLst>
            <pc:docMk/>
            <pc:sldMk cId="0" sldId="261"/>
            <ac:spMk id="9" creationId="{00000000-0000-0000-0000-000000000000}"/>
          </ac:spMkLst>
        </pc:spChg>
        <pc:spChg chg="del">
          <ac:chgData name="Yates, Rob A." userId="S::raya228@uky.edu::c4835988-b912-40a4-bf56-31a2afc86d77" providerId="AD" clId="Web-{0CC3DE7B-5279-3B29-9775-114C9D57E971}" dt="2023-07-20T14:08:56.912" v="187"/>
          <ac:spMkLst>
            <pc:docMk/>
            <pc:sldMk cId="0" sldId="261"/>
            <ac:spMk id="13" creationId="{00000000-0000-0000-0000-000000000000}"/>
          </ac:spMkLst>
        </pc:spChg>
        <pc:spChg chg="del">
          <ac:chgData name="Yates, Rob A." userId="S::raya228@uky.edu::c4835988-b912-40a4-bf56-31a2afc86d77" providerId="AD" clId="Web-{0CC3DE7B-5279-3B29-9775-114C9D57E971}" dt="2023-07-20T14:08:56.912" v="186"/>
          <ac:spMkLst>
            <pc:docMk/>
            <pc:sldMk cId="0" sldId="261"/>
            <ac:spMk id="14" creationId="{00000000-0000-0000-0000-000000000000}"/>
          </ac:spMkLst>
        </pc:spChg>
        <pc:spChg chg="del">
          <ac:chgData name="Yates, Rob A." userId="S::raya228@uky.edu::c4835988-b912-40a4-bf56-31a2afc86d77" providerId="AD" clId="Web-{0CC3DE7B-5279-3B29-9775-114C9D57E971}" dt="2023-07-20T14:08:56.912" v="185"/>
          <ac:spMkLst>
            <pc:docMk/>
            <pc:sldMk cId="0" sldId="261"/>
            <ac:spMk id="18" creationId="{00000000-0000-0000-0000-000000000000}"/>
          </ac:spMkLst>
        </pc:spChg>
        <pc:spChg chg="del">
          <ac:chgData name="Yates, Rob A." userId="S::raya228@uky.edu::c4835988-b912-40a4-bf56-31a2afc86d77" providerId="AD" clId="Web-{0CC3DE7B-5279-3B29-9775-114C9D57E971}" dt="2023-07-20T14:08:56.912" v="184"/>
          <ac:spMkLst>
            <pc:docMk/>
            <pc:sldMk cId="0" sldId="261"/>
            <ac:spMk id="19" creationId="{00000000-0000-0000-0000-000000000000}"/>
          </ac:spMkLst>
        </pc:spChg>
        <pc:spChg chg="del">
          <ac:chgData name="Yates, Rob A." userId="S::raya228@uky.edu::c4835988-b912-40a4-bf56-31a2afc86d77" providerId="AD" clId="Web-{0CC3DE7B-5279-3B29-9775-114C9D57E971}" dt="2023-07-20T14:08:56.912" v="183"/>
          <ac:spMkLst>
            <pc:docMk/>
            <pc:sldMk cId="0" sldId="261"/>
            <ac:spMk id="21" creationId="{C30CB7DE-8BBB-2DCF-A05F-8D90D23FF32E}"/>
          </ac:spMkLst>
        </pc:spChg>
        <pc:spChg chg="del">
          <ac:chgData name="Yates, Rob A." userId="S::raya228@uky.edu::c4835988-b912-40a4-bf56-31a2afc86d77" providerId="AD" clId="Web-{0CC3DE7B-5279-3B29-9775-114C9D57E971}" dt="2023-07-20T14:08:56.912" v="182"/>
          <ac:spMkLst>
            <pc:docMk/>
            <pc:sldMk cId="0" sldId="261"/>
            <ac:spMk id="22" creationId="{8C7F0E18-4101-D340-1D68-0EAC146241B0}"/>
          </ac:spMkLst>
        </pc:spChg>
        <pc:spChg chg="del">
          <ac:chgData name="Yates, Rob A." userId="S::raya228@uky.edu::c4835988-b912-40a4-bf56-31a2afc86d77" providerId="AD" clId="Web-{0CC3DE7B-5279-3B29-9775-114C9D57E971}" dt="2023-07-20T14:08:56.912" v="181"/>
          <ac:spMkLst>
            <pc:docMk/>
            <pc:sldMk cId="0" sldId="261"/>
            <ac:spMk id="23" creationId="{8C0E0613-3944-F10E-F76E-6CCD60293C7C}"/>
          </ac:spMkLst>
        </pc:spChg>
        <pc:spChg chg="del">
          <ac:chgData name="Yates, Rob A." userId="S::raya228@uky.edu::c4835988-b912-40a4-bf56-31a2afc86d77" providerId="AD" clId="Web-{0CC3DE7B-5279-3B29-9775-114C9D57E971}" dt="2023-07-20T14:08:56.912" v="180"/>
          <ac:spMkLst>
            <pc:docMk/>
            <pc:sldMk cId="0" sldId="261"/>
            <ac:spMk id="24" creationId="{87899D30-49FD-5306-70FA-492C112DE6B2}"/>
          </ac:spMkLst>
        </pc:spChg>
        <pc:spChg chg="del">
          <ac:chgData name="Yates, Rob A." userId="S::raya228@uky.edu::c4835988-b912-40a4-bf56-31a2afc86d77" providerId="AD" clId="Web-{0CC3DE7B-5279-3B29-9775-114C9D57E971}" dt="2023-07-20T14:08:56.912" v="179"/>
          <ac:spMkLst>
            <pc:docMk/>
            <pc:sldMk cId="0" sldId="261"/>
            <ac:spMk id="25" creationId="{7EE20A9F-C055-D504-FE34-15B09EE88BC4}"/>
          </ac:spMkLst>
        </pc:spChg>
        <pc:spChg chg="del">
          <ac:chgData name="Yates, Rob A." userId="S::raya228@uky.edu::c4835988-b912-40a4-bf56-31a2afc86d77" providerId="AD" clId="Web-{0CC3DE7B-5279-3B29-9775-114C9D57E971}" dt="2023-07-20T14:08:56.912" v="178"/>
          <ac:spMkLst>
            <pc:docMk/>
            <pc:sldMk cId="0" sldId="261"/>
            <ac:spMk id="26" creationId="{799DD8AF-5FBC-E82E-5EEB-102FC400A198}"/>
          </ac:spMkLst>
        </pc:spChg>
        <pc:spChg chg="del">
          <ac:chgData name="Yates, Rob A." userId="S::raya228@uky.edu::c4835988-b912-40a4-bf56-31a2afc86d77" providerId="AD" clId="Web-{0CC3DE7B-5279-3B29-9775-114C9D57E971}" dt="2023-07-20T14:08:56.912" v="177"/>
          <ac:spMkLst>
            <pc:docMk/>
            <pc:sldMk cId="0" sldId="261"/>
            <ac:spMk id="27" creationId="{130A111A-F62D-9185-1614-6783EB609F5C}"/>
          </ac:spMkLst>
        </pc:spChg>
        <pc:spChg chg="del">
          <ac:chgData name="Yates, Rob A." userId="S::raya228@uky.edu::c4835988-b912-40a4-bf56-31a2afc86d77" providerId="AD" clId="Web-{0CC3DE7B-5279-3B29-9775-114C9D57E971}" dt="2023-07-20T14:08:56.912" v="176"/>
          <ac:spMkLst>
            <pc:docMk/>
            <pc:sldMk cId="0" sldId="261"/>
            <ac:spMk id="28" creationId="{71BAF801-18BD-0DA2-1E29-01CA0CA62B76}"/>
          </ac:spMkLst>
        </pc:spChg>
        <pc:spChg chg="add">
          <ac:chgData name="Yates, Rob A." userId="S::raya228@uky.edu::c4835988-b912-40a4-bf56-31a2afc86d77" providerId="AD" clId="Web-{0CC3DE7B-5279-3B29-9775-114C9D57E971}" dt="2023-07-20T14:09:00.178" v="192"/>
          <ac:spMkLst>
            <pc:docMk/>
            <pc:sldMk cId="0" sldId="261"/>
            <ac:spMk id="30" creationId="{DEEC29EA-276A-5A5E-2D9C-D8BD182F7C6F}"/>
          </ac:spMkLst>
        </pc:spChg>
        <pc:spChg chg="add">
          <ac:chgData name="Yates, Rob A." userId="S::raya228@uky.edu::c4835988-b912-40a4-bf56-31a2afc86d77" providerId="AD" clId="Web-{0CC3DE7B-5279-3B29-9775-114C9D57E971}" dt="2023-07-20T14:09:00.193" v="193"/>
          <ac:spMkLst>
            <pc:docMk/>
            <pc:sldMk cId="0" sldId="261"/>
            <ac:spMk id="32" creationId="{EA1EF86D-7C71-CE80-EA27-E07D5EB96990}"/>
          </ac:spMkLst>
        </pc:spChg>
        <pc:spChg chg="add">
          <ac:chgData name="Yates, Rob A." userId="S::raya228@uky.edu::c4835988-b912-40a4-bf56-31a2afc86d77" providerId="AD" clId="Web-{0CC3DE7B-5279-3B29-9775-114C9D57E971}" dt="2023-07-20T14:09:00.193" v="194"/>
          <ac:spMkLst>
            <pc:docMk/>
            <pc:sldMk cId="0" sldId="261"/>
            <ac:spMk id="34" creationId="{0A19ED50-3051-8D2C-DB92-DB59AA778647}"/>
          </ac:spMkLst>
        </pc:spChg>
        <pc:spChg chg="add">
          <ac:chgData name="Yates, Rob A." userId="S::raya228@uky.edu::c4835988-b912-40a4-bf56-31a2afc86d77" providerId="AD" clId="Web-{0CC3DE7B-5279-3B29-9775-114C9D57E971}" dt="2023-07-20T14:09:00.209" v="195"/>
          <ac:spMkLst>
            <pc:docMk/>
            <pc:sldMk cId="0" sldId="261"/>
            <ac:spMk id="36" creationId="{5C287E1F-5F19-F930-33BF-31CD5DFBB073}"/>
          </ac:spMkLst>
        </pc:spChg>
        <pc:spChg chg="add">
          <ac:chgData name="Yates, Rob A." userId="S::raya228@uky.edu::c4835988-b912-40a4-bf56-31a2afc86d77" providerId="AD" clId="Web-{0CC3DE7B-5279-3B29-9775-114C9D57E971}" dt="2023-07-20T14:09:00.225" v="196"/>
          <ac:spMkLst>
            <pc:docMk/>
            <pc:sldMk cId="0" sldId="261"/>
            <ac:spMk id="38" creationId="{55DA27D4-F93E-B02B-F414-E5665DB5CEE5}"/>
          </ac:spMkLst>
        </pc:spChg>
        <pc:spChg chg="add">
          <ac:chgData name="Yates, Rob A." userId="S::raya228@uky.edu::c4835988-b912-40a4-bf56-31a2afc86d77" providerId="AD" clId="Web-{0CC3DE7B-5279-3B29-9775-114C9D57E971}" dt="2023-07-20T14:09:00.225" v="197"/>
          <ac:spMkLst>
            <pc:docMk/>
            <pc:sldMk cId="0" sldId="261"/>
            <ac:spMk id="40" creationId="{B05CCC0A-4379-1099-D81B-4821CEBB429B}"/>
          </ac:spMkLst>
        </pc:spChg>
        <pc:spChg chg="add">
          <ac:chgData name="Yates, Rob A." userId="S::raya228@uky.edu::c4835988-b912-40a4-bf56-31a2afc86d77" providerId="AD" clId="Web-{0CC3DE7B-5279-3B29-9775-114C9D57E971}" dt="2023-07-20T14:09:00.240" v="198"/>
          <ac:spMkLst>
            <pc:docMk/>
            <pc:sldMk cId="0" sldId="261"/>
            <ac:spMk id="42" creationId="{59856FFD-5B2F-70D1-52E8-71D2471FBB4F}"/>
          </ac:spMkLst>
        </pc:spChg>
        <pc:spChg chg="add">
          <ac:chgData name="Yates, Rob A." userId="S::raya228@uky.edu::c4835988-b912-40a4-bf56-31a2afc86d77" providerId="AD" clId="Web-{0CC3DE7B-5279-3B29-9775-114C9D57E971}" dt="2023-07-20T14:09:00.240" v="199"/>
          <ac:spMkLst>
            <pc:docMk/>
            <pc:sldMk cId="0" sldId="261"/>
            <ac:spMk id="44" creationId="{99FEFFA9-D063-B0D7-7665-BE5E05A485BC}"/>
          </ac:spMkLst>
        </pc:spChg>
        <pc:spChg chg="add">
          <ac:chgData name="Yates, Rob A." userId="S::raya228@uky.edu::c4835988-b912-40a4-bf56-31a2afc86d77" providerId="AD" clId="Web-{0CC3DE7B-5279-3B29-9775-114C9D57E971}" dt="2023-07-20T14:09:00.256" v="200"/>
          <ac:spMkLst>
            <pc:docMk/>
            <pc:sldMk cId="0" sldId="261"/>
            <ac:spMk id="46" creationId="{8BCE7945-4024-0C42-E4B8-1834C9EAE951}"/>
          </ac:spMkLst>
        </pc:spChg>
        <pc:spChg chg="add">
          <ac:chgData name="Yates, Rob A." userId="S::raya228@uky.edu::c4835988-b912-40a4-bf56-31a2afc86d77" providerId="AD" clId="Web-{0CC3DE7B-5279-3B29-9775-114C9D57E971}" dt="2023-07-20T14:09:00.271" v="201"/>
          <ac:spMkLst>
            <pc:docMk/>
            <pc:sldMk cId="0" sldId="261"/>
            <ac:spMk id="48" creationId="{E919025F-375A-9136-E880-A046BA2DD1B2}"/>
          </ac:spMkLst>
        </pc:spChg>
        <pc:spChg chg="add">
          <ac:chgData name="Yates, Rob A." userId="S::raya228@uky.edu::c4835988-b912-40a4-bf56-31a2afc86d77" providerId="AD" clId="Web-{0CC3DE7B-5279-3B29-9775-114C9D57E971}" dt="2023-07-20T14:09:00.287" v="202"/>
          <ac:spMkLst>
            <pc:docMk/>
            <pc:sldMk cId="0" sldId="261"/>
            <ac:spMk id="50" creationId="{89BD01BB-363D-CE14-98DA-03C85B927C08}"/>
          </ac:spMkLst>
        </pc:spChg>
        <pc:spChg chg="add">
          <ac:chgData name="Yates, Rob A." userId="S::raya228@uky.edu::c4835988-b912-40a4-bf56-31a2afc86d77" providerId="AD" clId="Web-{0CC3DE7B-5279-3B29-9775-114C9D57E971}" dt="2023-07-20T14:09:00.287" v="203"/>
          <ac:spMkLst>
            <pc:docMk/>
            <pc:sldMk cId="0" sldId="261"/>
            <ac:spMk id="52" creationId="{83FBB9AF-4851-0464-9289-86558C53DBE3}"/>
          </ac:spMkLst>
        </pc:spChg>
        <pc:spChg chg="add">
          <ac:chgData name="Yates, Rob A." userId="S::raya228@uky.edu::c4835988-b912-40a4-bf56-31a2afc86d77" providerId="AD" clId="Web-{0CC3DE7B-5279-3B29-9775-114C9D57E971}" dt="2023-07-20T14:09:00.303" v="204"/>
          <ac:spMkLst>
            <pc:docMk/>
            <pc:sldMk cId="0" sldId="261"/>
            <ac:spMk id="54" creationId="{F0378820-BADD-6C8B-1993-0DCCF2CA95CE}"/>
          </ac:spMkLst>
        </pc:spChg>
        <pc:spChg chg="add">
          <ac:chgData name="Yates, Rob A." userId="S::raya228@uky.edu::c4835988-b912-40a4-bf56-31a2afc86d77" providerId="AD" clId="Web-{0CC3DE7B-5279-3B29-9775-114C9D57E971}" dt="2023-07-20T14:09:00.318" v="205"/>
          <ac:spMkLst>
            <pc:docMk/>
            <pc:sldMk cId="0" sldId="261"/>
            <ac:spMk id="56" creationId="{6ABF3366-8172-F6C9-B8BD-4D55C7C6BAC6}"/>
          </ac:spMkLst>
        </pc:spChg>
        <pc:spChg chg="add">
          <ac:chgData name="Yates, Rob A." userId="S::raya228@uky.edu::c4835988-b912-40a4-bf56-31a2afc86d77" providerId="AD" clId="Web-{0CC3DE7B-5279-3B29-9775-114C9D57E971}" dt="2023-07-20T14:09:00.334" v="206"/>
          <ac:spMkLst>
            <pc:docMk/>
            <pc:sldMk cId="0" sldId="261"/>
            <ac:spMk id="58" creationId="{87784FB5-E30E-268F-383D-A1B4C2CFE906}"/>
          </ac:spMkLst>
        </pc:spChg>
        <pc:spChg chg="add">
          <ac:chgData name="Yates, Rob A." userId="S::raya228@uky.edu::c4835988-b912-40a4-bf56-31a2afc86d77" providerId="AD" clId="Web-{0CC3DE7B-5279-3B29-9775-114C9D57E971}" dt="2023-07-20T14:09:00.350" v="207"/>
          <ac:spMkLst>
            <pc:docMk/>
            <pc:sldMk cId="0" sldId="261"/>
            <ac:spMk id="60" creationId="{0233B816-1FB5-4480-2BC0-7F9656D47997}"/>
          </ac:spMkLst>
        </pc:spChg>
      </pc:sldChg>
      <pc:sldChg chg="addSp delSp">
        <pc:chgData name="Yates, Rob A." userId="S::raya228@uky.edu::c4835988-b912-40a4-bf56-31a2afc86d77" providerId="AD" clId="Web-{0CC3DE7B-5279-3B29-9775-114C9D57E971}" dt="2023-07-20T14:09:56.398" v="243"/>
        <pc:sldMkLst>
          <pc:docMk/>
          <pc:sldMk cId="0" sldId="262"/>
        </pc:sldMkLst>
        <pc:spChg chg="del">
          <ac:chgData name="Yates, Rob A." userId="S::raya228@uky.edu::c4835988-b912-40a4-bf56-31a2afc86d77" providerId="AD" clId="Web-{0CC3DE7B-5279-3B29-9775-114C9D57E971}" dt="2023-07-20T14:09:52.226" v="227"/>
          <ac:spMkLst>
            <pc:docMk/>
            <pc:sldMk cId="0" sldId="262"/>
            <ac:spMk id="4" creationId="{00000000-0000-0000-0000-000000000000}"/>
          </ac:spMkLst>
        </pc:spChg>
        <pc:spChg chg="del">
          <ac:chgData name="Yates, Rob A." userId="S::raya228@uky.edu::c4835988-b912-40a4-bf56-31a2afc86d77" providerId="AD" clId="Web-{0CC3DE7B-5279-3B29-9775-114C9D57E971}" dt="2023-07-20T14:09:52.226" v="226"/>
          <ac:spMkLst>
            <pc:docMk/>
            <pc:sldMk cId="0" sldId="262"/>
            <ac:spMk id="5" creationId="{00000000-0000-0000-0000-000000000000}"/>
          </ac:spMkLst>
        </pc:spChg>
        <pc:spChg chg="del">
          <ac:chgData name="Yates, Rob A." userId="S::raya228@uky.edu::c4835988-b912-40a4-bf56-31a2afc86d77" providerId="AD" clId="Web-{0CC3DE7B-5279-3B29-9775-114C9D57E971}" dt="2023-07-20T14:09:52.226" v="225"/>
          <ac:spMkLst>
            <pc:docMk/>
            <pc:sldMk cId="0" sldId="262"/>
            <ac:spMk id="8" creationId="{00000000-0000-0000-0000-000000000000}"/>
          </ac:spMkLst>
        </pc:spChg>
        <pc:spChg chg="del">
          <ac:chgData name="Yates, Rob A." userId="S::raya228@uky.edu::c4835988-b912-40a4-bf56-31a2afc86d77" providerId="AD" clId="Web-{0CC3DE7B-5279-3B29-9775-114C9D57E971}" dt="2023-07-20T14:09:52.226" v="224"/>
          <ac:spMkLst>
            <pc:docMk/>
            <pc:sldMk cId="0" sldId="262"/>
            <ac:spMk id="9" creationId="{00000000-0000-0000-0000-000000000000}"/>
          </ac:spMkLst>
        </pc:spChg>
        <pc:spChg chg="del">
          <ac:chgData name="Yates, Rob A." userId="S::raya228@uky.edu::c4835988-b912-40a4-bf56-31a2afc86d77" providerId="AD" clId="Web-{0CC3DE7B-5279-3B29-9775-114C9D57E971}" dt="2023-07-20T14:09:52.226" v="223"/>
          <ac:spMkLst>
            <pc:docMk/>
            <pc:sldMk cId="0" sldId="262"/>
            <ac:spMk id="13" creationId="{00000000-0000-0000-0000-000000000000}"/>
          </ac:spMkLst>
        </pc:spChg>
        <pc:spChg chg="del">
          <ac:chgData name="Yates, Rob A." userId="S::raya228@uky.edu::c4835988-b912-40a4-bf56-31a2afc86d77" providerId="AD" clId="Web-{0CC3DE7B-5279-3B29-9775-114C9D57E971}" dt="2023-07-20T14:09:52.226" v="222"/>
          <ac:spMkLst>
            <pc:docMk/>
            <pc:sldMk cId="0" sldId="262"/>
            <ac:spMk id="14" creationId="{00000000-0000-0000-0000-000000000000}"/>
          </ac:spMkLst>
        </pc:spChg>
        <pc:spChg chg="del">
          <ac:chgData name="Yates, Rob A." userId="S::raya228@uky.edu::c4835988-b912-40a4-bf56-31a2afc86d77" providerId="AD" clId="Web-{0CC3DE7B-5279-3B29-9775-114C9D57E971}" dt="2023-07-20T14:09:52.226" v="221"/>
          <ac:spMkLst>
            <pc:docMk/>
            <pc:sldMk cId="0" sldId="262"/>
            <ac:spMk id="18" creationId="{00000000-0000-0000-0000-000000000000}"/>
          </ac:spMkLst>
        </pc:spChg>
        <pc:spChg chg="del">
          <ac:chgData name="Yates, Rob A." userId="S::raya228@uky.edu::c4835988-b912-40a4-bf56-31a2afc86d77" providerId="AD" clId="Web-{0CC3DE7B-5279-3B29-9775-114C9D57E971}" dt="2023-07-20T14:09:52.226" v="220"/>
          <ac:spMkLst>
            <pc:docMk/>
            <pc:sldMk cId="0" sldId="262"/>
            <ac:spMk id="19" creationId="{00000000-0000-0000-0000-000000000000}"/>
          </ac:spMkLst>
        </pc:spChg>
        <pc:spChg chg="del">
          <ac:chgData name="Yates, Rob A." userId="S::raya228@uky.edu::c4835988-b912-40a4-bf56-31a2afc86d77" providerId="AD" clId="Web-{0CC3DE7B-5279-3B29-9775-114C9D57E971}" dt="2023-07-20T14:09:52.226" v="219"/>
          <ac:spMkLst>
            <pc:docMk/>
            <pc:sldMk cId="0" sldId="262"/>
            <ac:spMk id="21" creationId="{49F5DCB3-5BFB-9321-1A7C-4DFD5B8A6263}"/>
          </ac:spMkLst>
        </pc:spChg>
        <pc:spChg chg="del">
          <ac:chgData name="Yates, Rob A." userId="S::raya228@uky.edu::c4835988-b912-40a4-bf56-31a2afc86d77" providerId="AD" clId="Web-{0CC3DE7B-5279-3B29-9775-114C9D57E971}" dt="2023-07-20T14:09:52.226" v="218"/>
          <ac:spMkLst>
            <pc:docMk/>
            <pc:sldMk cId="0" sldId="262"/>
            <ac:spMk id="22" creationId="{97C44B81-7FFA-5E57-375C-859486B6271E}"/>
          </ac:spMkLst>
        </pc:spChg>
        <pc:spChg chg="del">
          <ac:chgData name="Yates, Rob A." userId="S::raya228@uky.edu::c4835988-b912-40a4-bf56-31a2afc86d77" providerId="AD" clId="Web-{0CC3DE7B-5279-3B29-9775-114C9D57E971}" dt="2023-07-20T14:09:52.226" v="217"/>
          <ac:spMkLst>
            <pc:docMk/>
            <pc:sldMk cId="0" sldId="262"/>
            <ac:spMk id="23" creationId="{2A14E3A8-9614-D531-C771-BED7EAD4606A}"/>
          </ac:spMkLst>
        </pc:spChg>
        <pc:spChg chg="del">
          <ac:chgData name="Yates, Rob A." userId="S::raya228@uky.edu::c4835988-b912-40a4-bf56-31a2afc86d77" providerId="AD" clId="Web-{0CC3DE7B-5279-3B29-9775-114C9D57E971}" dt="2023-07-20T14:09:52.226" v="216"/>
          <ac:spMkLst>
            <pc:docMk/>
            <pc:sldMk cId="0" sldId="262"/>
            <ac:spMk id="24" creationId="{A332EE83-D13B-216F-7E53-3A3D9CA1240E}"/>
          </ac:spMkLst>
        </pc:spChg>
        <pc:spChg chg="del">
          <ac:chgData name="Yates, Rob A." userId="S::raya228@uky.edu::c4835988-b912-40a4-bf56-31a2afc86d77" providerId="AD" clId="Web-{0CC3DE7B-5279-3B29-9775-114C9D57E971}" dt="2023-07-20T14:09:52.226" v="215"/>
          <ac:spMkLst>
            <pc:docMk/>
            <pc:sldMk cId="0" sldId="262"/>
            <ac:spMk id="25" creationId="{CA2FB3FB-40FB-E31D-070D-690D5BFCA112}"/>
          </ac:spMkLst>
        </pc:spChg>
        <pc:spChg chg="del">
          <ac:chgData name="Yates, Rob A." userId="S::raya228@uky.edu::c4835988-b912-40a4-bf56-31a2afc86d77" providerId="AD" clId="Web-{0CC3DE7B-5279-3B29-9775-114C9D57E971}" dt="2023-07-20T14:09:52.226" v="214"/>
          <ac:spMkLst>
            <pc:docMk/>
            <pc:sldMk cId="0" sldId="262"/>
            <ac:spMk id="26" creationId="{B331DEAD-2AA8-D6F8-184F-445AF2A8DC1A}"/>
          </ac:spMkLst>
        </pc:spChg>
        <pc:spChg chg="del">
          <ac:chgData name="Yates, Rob A." userId="S::raya228@uky.edu::c4835988-b912-40a4-bf56-31a2afc86d77" providerId="AD" clId="Web-{0CC3DE7B-5279-3B29-9775-114C9D57E971}" dt="2023-07-20T14:09:52.226" v="213"/>
          <ac:spMkLst>
            <pc:docMk/>
            <pc:sldMk cId="0" sldId="262"/>
            <ac:spMk id="27" creationId="{0258DE2E-9398-7DF5-9D81-1399E740BA3C}"/>
          </ac:spMkLst>
        </pc:spChg>
        <pc:spChg chg="del">
          <ac:chgData name="Yates, Rob A." userId="S::raya228@uky.edu::c4835988-b912-40a4-bf56-31a2afc86d77" providerId="AD" clId="Web-{0CC3DE7B-5279-3B29-9775-114C9D57E971}" dt="2023-07-20T14:09:52.226" v="212"/>
          <ac:spMkLst>
            <pc:docMk/>
            <pc:sldMk cId="0" sldId="262"/>
            <ac:spMk id="28" creationId="{20D3135C-773E-9A47-859A-2D1B51EE7D36}"/>
          </ac:spMkLst>
        </pc:spChg>
        <pc:spChg chg="add">
          <ac:chgData name="Yates, Rob A." userId="S::raya228@uky.edu::c4835988-b912-40a4-bf56-31a2afc86d77" providerId="AD" clId="Web-{0CC3DE7B-5279-3B29-9775-114C9D57E971}" dt="2023-07-20T14:09:56.241" v="228"/>
          <ac:spMkLst>
            <pc:docMk/>
            <pc:sldMk cId="0" sldId="262"/>
            <ac:spMk id="30" creationId="{597F7069-7C69-F6D4-6FDA-29EFFE9E05C4}"/>
          </ac:spMkLst>
        </pc:spChg>
        <pc:spChg chg="add">
          <ac:chgData name="Yates, Rob A." userId="S::raya228@uky.edu::c4835988-b912-40a4-bf56-31a2afc86d77" providerId="AD" clId="Web-{0CC3DE7B-5279-3B29-9775-114C9D57E971}" dt="2023-07-20T14:09:56.241" v="229"/>
          <ac:spMkLst>
            <pc:docMk/>
            <pc:sldMk cId="0" sldId="262"/>
            <ac:spMk id="32" creationId="{56CDD517-EFCA-A232-F41C-EF8BCF599D56}"/>
          </ac:spMkLst>
        </pc:spChg>
        <pc:spChg chg="add">
          <ac:chgData name="Yates, Rob A." userId="S::raya228@uky.edu::c4835988-b912-40a4-bf56-31a2afc86d77" providerId="AD" clId="Web-{0CC3DE7B-5279-3B29-9775-114C9D57E971}" dt="2023-07-20T14:09:56.257" v="230"/>
          <ac:spMkLst>
            <pc:docMk/>
            <pc:sldMk cId="0" sldId="262"/>
            <ac:spMk id="34" creationId="{05A2A92C-7950-941B-1FD8-31B2C8009569}"/>
          </ac:spMkLst>
        </pc:spChg>
        <pc:spChg chg="add">
          <ac:chgData name="Yates, Rob A." userId="S::raya228@uky.edu::c4835988-b912-40a4-bf56-31a2afc86d77" providerId="AD" clId="Web-{0CC3DE7B-5279-3B29-9775-114C9D57E971}" dt="2023-07-20T14:09:56.257" v="231"/>
          <ac:spMkLst>
            <pc:docMk/>
            <pc:sldMk cId="0" sldId="262"/>
            <ac:spMk id="36" creationId="{D9BB1D03-F25F-0C34-580A-1EC037477BC0}"/>
          </ac:spMkLst>
        </pc:spChg>
        <pc:spChg chg="add">
          <ac:chgData name="Yates, Rob A." userId="S::raya228@uky.edu::c4835988-b912-40a4-bf56-31a2afc86d77" providerId="AD" clId="Web-{0CC3DE7B-5279-3B29-9775-114C9D57E971}" dt="2023-07-20T14:09:56.273" v="232"/>
          <ac:spMkLst>
            <pc:docMk/>
            <pc:sldMk cId="0" sldId="262"/>
            <ac:spMk id="38" creationId="{478D19BD-2A7A-65ED-60CD-0CF4BD92EFE3}"/>
          </ac:spMkLst>
        </pc:spChg>
        <pc:spChg chg="add">
          <ac:chgData name="Yates, Rob A." userId="S::raya228@uky.edu::c4835988-b912-40a4-bf56-31a2afc86d77" providerId="AD" clId="Web-{0CC3DE7B-5279-3B29-9775-114C9D57E971}" dt="2023-07-20T14:09:56.273" v="233"/>
          <ac:spMkLst>
            <pc:docMk/>
            <pc:sldMk cId="0" sldId="262"/>
            <ac:spMk id="40" creationId="{C2BCD4D9-73F4-3AA2-7C93-86BD70C307A3}"/>
          </ac:spMkLst>
        </pc:spChg>
        <pc:spChg chg="add">
          <ac:chgData name="Yates, Rob A." userId="S::raya228@uky.edu::c4835988-b912-40a4-bf56-31a2afc86d77" providerId="AD" clId="Web-{0CC3DE7B-5279-3B29-9775-114C9D57E971}" dt="2023-07-20T14:09:56.288" v="234"/>
          <ac:spMkLst>
            <pc:docMk/>
            <pc:sldMk cId="0" sldId="262"/>
            <ac:spMk id="42" creationId="{290DB391-A07A-1FCE-7168-BD5572B457B7}"/>
          </ac:spMkLst>
        </pc:spChg>
        <pc:spChg chg="add">
          <ac:chgData name="Yates, Rob A." userId="S::raya228@uky.edu::c4835988-b912-40a4-bf56-31a2afc86d77" providerId="AD" clId="Web-{0CC3DE7B-5279-3B29-9775-114C9D57E971}" dt="2023-07-20T14:09:56.304" v="235"/>
          <ac:spMkLst>
            <pc:docMk/>
            <pc:sldMk cId="0" sldId="262"/>
            <ac:spMk id="44" creationId="{D04A826C-DC49-3854-399E-5E44F37D9DC9}"/>
          </ac:spMkLst>
        </pc:spChg>
        <pc:spChg chg="add">
          <ac:chgData name="Yates, Rob A." userId="S::raya228@uky.edu::c4835988-b912-40a4-bf56-31a2afc86d77" providerId="AD" clId="Web-{0CC3DE7B-5279-3B29-9775-114C9D57E971}" dt="2023-07-20T14:09:56.320" v="236"/>
          <ac:spMkLst>
            <pc:docMk/>
            <pc:sldMk cId="0" sldId="262"/>
            <ac:spMk id="46" creationId="{E2222911-C273-211D-12A5-7A585030E075}"/>
          </ac:spMkLst>
        </pc:spChg>
        <pc:spChg chg="add">
          <ac:chgData name="Yates, Rob A." userId="S::raya228@uky.edu::c4835988-b912-40a4-bf56-31a2afc86d77" providerId="AD" clId="Web-{0CC3DE7B-5279-3B29-9775-114C9D57E971}" dt="2023-07-20T14:09:56.320" v="237"/>
          <ac:spMkLst>
            <pc:docMk/>
            <pc:sldMk cId="0" sldId="262"/>
            <ac:spMk id="48" creationId="{381B60CE-9664-D6F1-1C74-6419D9423951}"/>
          </ac:spMkLst>
        </pc:spChg>
        <pc:spChg chg="add">
          <ac:chgData name="Yates, Rob A." userId="S::raya228@uky.edu::c4835988-b912-40a4-bf56-31a2afc86d77" providerId="AD" clId="Web-{0CC3DE7B-5279-3B29-9775-114C9D57E971}" dt="2023-07-20T14:09:56.335" v="238"/>
          <ac:spMkLst>
            <pc:docMk/>
            <pc:sldMk cId="0" sldId="262"/>
            <ac:spMk id="50" creationId="{0D5254E2-BC90-DF98-76EA-7420A24773DF}"/>
          </ac:spMkLst>
        </pc:spChg>
        <pc:spChg chg="add">
          <ac:chgData name="Yates, Rob A." userId="S::raya228@uky.edu::c4835988-b912-40a4-bf56-31a2afc86d77" providerId="AD" clId="Web-{0CC3DE7B-5279-3B29-9775-114C9D57E971}" dt="2023-07-20T14:09:56.351" v="239"/>
          <ac:spMkLst>
            <pc:docMk/>
            <pc:sldMk cId="0" sldId="262"/>
            <ac:spMk id="52" creationId="{8DC52017-CF77-49E4-2916-B556CEF3C294}"/>
          </ac:spMkLst>
        </pc:spChg>
        <pc:spChg chg="add">
          <ac:chgData name="Yates, Rob A." userId="S::raya228@uky.edu::c4835988-b912-40a4-bf56-31a2afc86d77" providerId="AD" clId="Web-{0CC3DE7B-5279-3B29-9775-114C9D57E971}" dt="2023-07-20T14:09:56.366" v="240"/>
          <ac:spMkLst>
            <pc:docMk/>
            <pc:sldMk cId="0" sldId="262"/>
            <ac:spMk id="54" creationId="{BBAC7892-AA7A-CA34-3FED-B415265C16A1}"/>
          </ac:spMkLst>
        </pc:spChg>
        <pc:spChg chg="add">
          <ac:chgData name="Yates, Rob A." userId="S::raya228@uky.edu::c4835988-b912-40a4-bf56-31a2afc86d77" providerId="AD" clId="Web-{0CC3DE7B-5279-3B29-9775-114C9D57E971}" dt="2023-07-20T14:09:56.366" v="241"/>
          <ac:spMkLst>
            <pc:docMk/>
            <pc:sldMk cId="0" sldId="262"/>
            <ac:spMk id="56" creationId="{CB3CB4B4-88D9-A494-7943-29304AB0A4BB}"/>
          </ac:spMkLst>
        </pc:spChg>
        <pc:spChg chg="add">
          <ac:chgData name="Yates, Rob A." userId="S::raya228@uky.edu::c4835988-b912-40a4-bf56-31a2afc86d77" providerId="AD" clId="Web-{0CC3DE7B-5279-3B29-9775-114C9D57E971}" dt="2023-07-20T14:09:56.382" v="242"/>
          <ac:spMkLst>
            <pc:docMk/>
            <pc:sldMk cId="0" sldId="262"/>
            <ac:spMk id="58" creationId="{2208D318-BD26-5F42-66D9-1277E6BFAE1F}"/>
          </ac:spMkLst>
        </pc:spChg>
        <pc:spChg chg="add">
          <ac:chgData name="Yates, Rob A." userId="S::raya228@uky.edu::c4835988-b912-40a4-bf56-31a2afc86d77" providerId="AD" clId="Web-{0CC3DE7B-5279-3B29-9775-114C9D57E971}" dt="2023-07-20T14:09:56.398" v="243"/>
          <ac:spMkLst>
            <pc:docMk/>
            <pc:sldMk cId="0" sldId="262"/>
            <ac:spMk id="60" creationId="{98772210-11FA-C26F-7BE7-DF9AB52DC14E}"/>
          </ac:spMkLst>
        </pc:spChg>
      </pc:sldChg>
      <pc:sldChg chg="addSp delSp">
        <pc:chgData name="Yates, Rob A." userId="S::raya228@uky.edu::c4835988-b912-40a4-bf56-31a2afc86d77" providerId="AD" clId="Web-{0CC3DE7B-5279-3B29-9775-114C9D57E971}" dt="2023-07-20T14:11:01.540" v="275"/>
        <pc:sldMkLst>
          <pc:docMk/>
          <pc:sldMk cId="0" sldId="263"/>
        </pc:sldMkLst>
        <pc:spChg chg="del">
          <ac:chgData name="Yates, Rob A." userId="S::raya228@uky.edu::c4835988-b912-40a4-bf56-31a2afc86d77" providerId="AD" clId="Web-{0CC3DE7B-5279-3B29-9775-114C9D57E971}" dt="2023-07-20T14:10:57.540" v="259"/>
          <ac:spMkLst>
            <pc:docMk/>
            <pc:sldMk cId="0" sldId="263"/>
            <ac:spMk id="4" creationId="{00000000-0000-0000-0000-000000000000}"/>
          </ac:spMkLst>
        </pc:spChg>
        <pc:spChg chg="del">
          <ac:chgData name="Yates, Rob A." userId="S::raya228@uky.edu::c4835988-b912-40a4-bf56-31a2afc86d77" providerId="AD" clId="Web-{0CC3DE7B-5279-3B29-9775-114C9D57E971}" dt="2023-07-20T14:10:57.540" v="258"/>
          <ac:spMkLst>
            <pc:docMk/>
            <pc:sldMk cId="0" sldId="263"/>
            <ac:spMk id="5" creationId="{00000000-0000-0000-0000-000000000000}"/>
          </ac:spMkLst>
        </pc:spChg>
        <pc:spChg chg="del">
          <ac:chgData name="Yates, Rob A." userId="S::raya228@uky.edu::c4835988-b912-40a4-bf56-31a2afc86d77" providerId="AD" clId="Web-{0CC3DE7B-5279-3B29-9775-114C9D57E971}" dt="2023-07-20T14:10:57.540" v="257"/>
          <ac:spMkLst>
            <pc:docMk/>
            <pc:sldMk cId="0" sldId="263"/>
            <ac:spMk id="8" creationId="{00000000-0000-0000-0000-000000000000}"/>
          </ac:spMkLst>
        </pc:spChg>
        <pc:spChg chg="del">
          <ac:chgData name="Yates, Rob A." userId="S::raya228@uky.edu::c4835988-b912-40a4-bf56-31a2afc86d77" providerId="AD" clId="Web-{0CC3DE7B-5279-3B29-9775-114C9D57E971}" dt="2023-07-20T14:10:57.540" v="256"/>
          <ac:spMkLst>
            <pc:docMk/>
            <pc:sldMk cId="0" sldId="263"/>
            <ac:spMk id="9" creationId="{00000000-0000-0000-0000-000000000000}"/>
          </ac:spMkLst>
        </pc:spChg>
        <pc:spChg chg="del">
          <ac:chgData name="Yates, Rob A." userId="S::raya228@uky.edu::c4835988-b912-40a4-bf56-31a2afc86d77" providerId="AD" clId="Web-{0CC3DE7B-5279-3B29-9775-114C9D57E971}" dt="2023-07-20T14:10:57.540" v="255"/>
          <ac:spMkLst>
            <pc:docMk/>
            <pc:sldMk cId="0" sldId="263"/>
            <ac:spMk id="13" creationId="{00000000-0000-0000-0000-000000000000}"/>
          </ac:spMkLst>
        </pc:spChg>
        <pc:spChg chg="del">
          <ac:chgData name="Yates, Rob A." userId="S::raya228@uky.edu::c4835988-b912-40a4-bf56-31a2afc86d77" providerId="AD" clId="Web-{0CC3DE7B-5279-3B29-9775-114C9D57E971}" dt="2023-07-20T14:10:57.540" v="254"/>
          <ac:spMkLst>
            <pc:docMk/>
            <pc:sldMk cId="0" sldId="263"/>
            <ac:spMk id="14" creationId="{00000000-0000-0000-0000-000000000000}"/>
          </ac:spMkLst>
        </pc:spChg>
        <pc:spChg chg="del">
          <ac:chgData name="Yates, Rob A." userId="S::raya228@uky.edu::c4835988-b912-40a4-bf56-31a2afc86d77" providerId="AD" clId="Web-{0CC3DE7B-5279-3B29-9775-114C9D57E971}" dt="2023-07-20T14:10:57.540" v="253"/>
          <ac:spMkLst>
            <pc:docMk/>
            <pc:sldMk cId="0" sldId="263"/>
            <ac:spMk id="18" creationId="{00000000-0000-0000-0000-000000000000}"/>
          </ac:spMkLst>
        </pc:spChg>
        <pc:spChg chg="del">
          <ac:chgData name="Yates, Rob A." userId="S::raya228@uky.edu::c4835988-b912-40a4-bf56-31a2afc86d77" providerId="AD" clId="Web-{0CC3DE7B-5279-3B29-9775-114C9D57E971}" dt="2023-07-20T14:10:57.540" v="252"/>
          <ac:spMkLst>
            <pc:docMk/>
            <pc:sldMk cId="0" sldId="263"/>
            <ac:spMk id="19" creationId="{00000000-0000-0000-0000-000000000000}"/>
          </ac:spMkLst>
        </pc:spChg>
        <pc:spChg chg="del">
          <ac:chgData name="Yates, Rob A." userId="S::raya228@uky.edu::c4835988-b912-40a4-bf56-31a2afc86d77" providerId="AD" clId="Web-{0CC3DE7B-5279-3B29-9775-114C9D57E971}" dt="2023-07-20T14:10:57.540" v="251"/>
          <ac:spMkLst>
            <pc:docMk/>
            <pc:sldMk cId="0" sldId="263"/>
            <ac:spMk id="21" creationId="{E1BFE5E6-C66D-042C-0FFF-A93BD1529AAA}"/>
          </ac:spMkLst>
        </pc:spChg>
        <pc:spChg chg="del">
          <ac:chgData name="Yates, Rob A." userId="S::raya228@uky.edu::c4835988-b912-40a4-bf56-31a2afc86d77" providerId="AD" clId="Web-{0CC3DE7B-5279-3B29-9775-114C9D57E971}" dt="2023-07-20T14:10:57.540" v="250"/>
          <ac:spMkLst>
            <pc:docMk/>
            <pc:sldMk cId="0" sldId="263"/>
            <ac:spMk id="22" creationId="{68D0A085-CE4F-0307-40B2-B2C17DAE1E36}"/>
          </ac:spMkLst>
        </pc:spChg>
        <pc:spChg chg="del">
          <ac:chgData name="Yates, Rob A." userId="S::raya228@uky.edu::c4835988-b912-40a4-bf56-31a2afc86d77" providerId="AD" clId="Web-{0CC3DE7B-5279-3B29-9775-114C9D57E971}" dt="2023-07-20T14:10:57.540" v="249"/>
          <ac:spMkLst>
            <pc:docMk/>
            <pc:sldMk cId="0" sldId="263"/>
            <ac:spMk id="23" creationId="{3B9AC76F-6AD2-2A68-01AC-3962D87E6C51}"/>
          </ac:spMkLst>
        </pc:spChg>
        <pc:spChg chg="del">
          <ac:chgData name="Yates, Rob A." userId="S::raya228@uky.edu::c4835988-b912-40a4-bf56-31a2afc86d77" providerId="AD" clId="Web-{0CC3DE7B-5279-3B29-9775-114C9D57E971}" dt="2023-07-20T14:10:57.540" v="248"/>
          <ac:spMkLst>
            <pc:docMk/>
            <pc:sldMk cId="0" sldId="263"/>
            <ac:spMk id="24" creationId="{EBF21217-580D-D9DB-3BC3-FBD52BBBFC90}"/>
          </ac:spMkLst>
        </pc:spChg>
        <pc:spChg chg="del">
          <ac:chgData name="Yates, Rob A." userId="S::raya228@uky.edu::c4835988-b912-40a4-bf56-31a2afc86d77" providerId="AD" clId="Web-{0CC3DE7B-5279-3B29-9775-114C9D57E971}" dt="2023-07-20T14:10:57.540" v="247"/>
          <ac:spMkLst>
            <pc:docMk/>
            <pc:sldMk cId="0" sldId="263"/>
            <ac:spMk id="25" creationId="{A20FA715-073B-D19F-EA3E-45980D977921}"/>
          </ac:spMkLst>
        </pc:spChg>
        <pc:spChg chg="del">
          <ac:chgData name="Yates, Rob A." userId="S::raya228@uky.edu::c4835988-b912-40a4-bf56-31a2afc86d77" providerId="AD" clId="Web-{0CC3DE7B-5279-3B29-9775-114C9D57E971}" dt="2023-07-20T14:10:57.540" v="246"/>
          <ac:spMkLst>
            <pc:docMk/>
            <pc:sldMk cId="0" sldId="263"/>
            <ac:spMk id="26" creationId="{54CA6CE9-F664-C3BE-0161-ABECB23A56B9}"/>
          </ac:spMkLst>
        </pc:spChg>
        <pc:spChg chg="del">
          <ac:chgData name="Yates, Rob A." userId="S::raya228@uky.edu::c4835988-b912-40a4-bf56-31a2afc86d77" providerId="AD" clId="Web-{0CC3DE7B-5279-3B29-9775-114C9D57E971}" dt="2023-07-20T14:10:57.540" v="245"/>
          <ac:spMkLst>
            <pc:docMk/>
            <pc:sldMk cId="0" sldId="263"/>
            <ac:spMk id="27" creationId="{E02ACDFF-97AE-CF2E-BCBD-BA803A3CC82D}"/>
          </ac:spMkLst>
        </pc:spChg>
        <pc:spChg chg="del">
          <ac:chgData name="Yates, Rob A." userId="S::raya228@uky.edu::c4835988-b912-40a4-bf56-31a2afc86d77" providerId="AD" clId="Web-{0CC3DE7B-5279-3B29-9775-114C9D57E971}" dt="2023-07-20T14:10:57.540" v="244"/>
          <ac:spMkLst>
            <pc:docMk/>
            <pc:sldMk cId="0" sldId="263"/>
            <ac:spMk id="28" creationId="{123AAAAD-F2F8-9E1D-3915-D0CDF419293B}"/>
          </ac:spMkLst>
        </pc:spChg>
        <pc:spChg chg="add">
          <ac:chgData name="Yates, Rob A." userId="S::raya228@uky.edu::c4835988-b912-40a4-bf56-31a2afc86d77" providerId="AD" clId="Web-{0CC3DE7B-5279-3B29-9775-114C9D57E971}" dt="2023-07-20T14:11:01.352" v="260"/>
          <ac:spMkLst>
            <pc:docMk/>
            <pc:sldMk cId="0" sldId="263"/>
            <ac:spMk id="30" creationId="{D4004E63-2412-3773-8D57-D71549369288}"/>
          </ac:spMkLst>
        </pc:spChg>
        <pc:spChg chg="add">
          <ac:chgData name="Yates, Rob A." userId="S::raya228@uky.edu::c4835988-b912-40a4-bf56-31a2afc86d77" providerId="AD" clId="Web-{0CC3DE7B-5279-3B29-9775-114C9D57E971}" dt="2023-07-20T14:11:01.368" v="261"/>
          <ac:spMkLst>
            <pc:docMk/>
            <pc:sldMk cId="0" sldId="263"/>
            <ac:spMk id="32" creationId="{60D4EB16-CE03-3FBF-AE46-5E3AC7F9DAEA}"/>
          </ac:spMkLst>
        </pc:spChg>
        <pc:spChg chg="add">
          <ac:chgData name="Yates, Rob A." userId="S::raya228@uky.edu::c4835988-b912-40a4-bf56-31a2afc86d77" providerId="AD" clId="Web-{0CC3DE7B-5279-3B29-9775-114C9D57E971}" dt="2023-07-20T14:11:01.384" v="262"/>
          <ac:spMkLst>
            <pc:docMk/>
            <pc:sldMk cId="0" sldId="263"/>
            <ac:spMk id="34" creationId="{4FD6C889-8376-0410-162A-AF114696B045}"/>
          </ac:spMkLst>
        </pc:spChg>
        <pc:spChg chg="add">
          <ac:chgData name="Yates, Rob A." userId="S::raya228@uky.edu::c4835988-b912-40a4-bf56-31a2afc86d77" providerId="AD" clId="Web-{0CC3DE7B-5279-3B29-9775-114C9D57E971}" dt="2023-07-20T14:11:01.384" v="263"/>
          <ac:spMkLst>
            <pc:docMk/>
            <pc:sldMk cId="0" sldId="263"/>
            <ac:spMk id="36" creationId="{A36F1C8D-68CF-B7B0-44A6-633F8428A106}"/>
          </ac:spMkLst>
        </pc:spChg>
        <pc:spChg chg="add">
          <ac:chgData name="Yates, Rob A." userId="S::raya228@uky.edu::c4835988-b912-40a4-bf56-31a2afc86d77" providerId="AD" clId="Web-{0CC3DE7B-5279-3B29-9775-114C9D57E971}" dt="2023-07-20T14:11:01.399" v="264"/>
          <ac:spMkLst>
            <pc:docMk/>
            <pc:sldMk cId="0" sldId="263"/>
            <ac:spMk id="38" creationId="{C50DDDC6-9E3C-9AC7-2A8B-9FD93C56E9B9}"/>
          </ac:spMkLst>
        </pc:spChg>
        <pc:spChg chg="add">
          <ac:chgData name="Yates, Rob A." userId="S::raya228@uky.edu::c4835988-b912-40a4-bf56-31a2afc86d77" providerId="AD" clId="Web-{0CC3DE7B-5279-3B29-9775-114C9D57E971}" dt="2023-07-20T14:11:01.415" v="265"/>
          <ac:spMkLst>
            <pc:docMk/>
            <pc:sldMk cId="0" sldId="263"/>
            <ac:spMk id="40" creationId="{5A9299B4-084C-152B-82F7-D4A5A7670788}"/>
          </ac:spMkLst>
        </pc:spChg>
        <pc:spChg chg="add">
          <ac:chgData name="Yates, Rob A." userId="S::raya228@uky.edu::c4835988-b912-40a4-bf56-31a2afc86d77" providerId="AD" clId="Web-{0CC3DE7B-5279-3B29-9775-114C9D57E971}" dt="2023-07-20T14:11:01.430" v="266"/>
          <ac:spMkLst>
            <pc:docMk/>
            <pc:sldMk cId="0" sldId="263"/>
            <ac:spMk id="42" creationId="{A4B20BB7-73F7-40D5-AE39-CFD62FAC3E2D}"/>
          </ac:spMkLst>
        </pc:spChg>
        <pc:spChg chg="add">
          <ac:chgData name="Yates, Rob A." userId="S::raya228@uky.edu::c4835988-b912-40a4-bf56-31a2afc86d77" providerId="AD" clId="Web-{0CC3DE7B-5279-3B29-9775-114C9D57E971}" dt="2023-07-20T14:11:01.430" v="267"/>
          <ac:spMkLst>
            <pc:docMk/>
            <pc:sldMk cId="0" sldId="263"/>
            <ac:spMk id="44" creationId="{FAE987DF-85B7-4618-5D16-8A17A9E19B36}"/>
          </ac:spMkLst>
        </pc:spChg>
        <pc:spChg chg="add">
          <ac:chgData name="Yates, Rob A." userId="S::raya228@uky.edu::c4835988-b912-40a4-bf56-31a2afc86d77" providerId="AD" clId="Web-{0CC3DE7B-5279-3B29-9775-114C9D57E971}" dt="2023-07-20T14:11:01.446" v="268"/>
          <ac:spMkLst>
            <pc:docMk/>
            <pc:sldMk cId="0" sldId="263"/>
            <ac:spMk id="46" creationId="{EAC6C70B-3052-FDF4-8D0F-FA87736450A1}"/>
          </ac:spMkLst>
        </pc:spChg>
        <pc:spChg chg="add">
          <ac:chgData name="Yates, Rob A." userId="S::raya228@uky.edu::c4835988-b912-40a4-bf56-31a2afc86d77" providerId="AD" clId="Web-{0CC3DE7B-5279-3B29-9775-114C9D57E971}" dt="2023-07-20T14:11:01.462" v="269"/>
          <ac:spMkLst>
            <pc:docMk/>
            <pc:sldMk cId="0" sldId="263"/>
            <ac:spMk id="48" creationId="{58D05697-67C7-0683-B33F-979E0D8850B9}"/>
          </ac:spMkLst>
        </pc:spChg>
        <pc:spChg chg="add">
          <ac:chgData name="Yates, Rob A." userId="S::raya228@uky.edu::c4835988-b912-40a4-bf56-31a2afc86d77" providerId="AD" clId="Web-{0CC3DE7B-5279-3B29-9775-114C9D57E971}" dt="2023-07-20T14:11:01.477" v="270"/>
          <ac:spMkLst>
            <pc:docMk/>
            <pc:sldMk cId="0" sldId="263"/>
            <ac:spMk id="50" creationId="{FB404445-AF8C-3997-500C-9E3937CEFB84}"/>
          </ac:spMkLst>
        </pc:spChg>
        <pc:spChg chg="add">
          <ac:chgData name="Yates, Rob A." userId="S::raya228@uky.edu::c4835988-b912-40a4-bf56-31a2afc86d77" providerId="AD" clId="Web-{0CC3DE7B-5279-3B29-9775-114C9D57E971}" dt="2023-07-20T14:11:01.493" v="271"/>
          <ac:spMkLst>
            <pc:docMk/>
            <pc:sldMk cId="0" sldId="263"/>
            <ac:spMk id="52" creationId="{D3124F83-BE2D-A647-7D14-E4C64B75B171}"/>
          </ac:spMkLst>
        </pc:spChg>
        <pc:spChg chg="add">
          <ac:chgData name="Yates, Rob A." userId="S::raya228@uky.edu::c4835988-b912-40a4-bf56-31a2afc86d77" providerId="AD" clId="Web-{0CC3DE7B-5279-3B29-9775-114C9D57E971}" dt="2023-07-20T14:11:01.493" v="272"/>
          <ac:spMkLst>
            <pc:docMk/>
            <pc:sldMk cId="0" sldId="263"/>
            <ac:spMk id="54" creationId="{038BE8CA-723E-EFA7-2952-01DB7AC83150}"/>
          </ac:spMkLst>
        </pc:spChg>
        <pc:spChg chg="add">
          <ac:chgData name="Yates, Rob A." userId="S::raya228@uky.edu::c4835988-b912-40a4-bf56-31a2afc86d77" providerId="AD" clId="Web-{0CC3DE7B-5279-3B29-9775-114C9D57E971}" dt="2023-07-20T14:11:01.509" v="273"/>
          <ac:spMkLst>
            <pc:docMk/>
            <pc:sldMk cId="0" sldId="263"/>
            <ac:spMk id="56" creationId="{3B0C1FAA-946E-4FDE-4469-E10ACFC050C8}"/>
          </ac:spMkLst>
        </pc:spChg>
        <pc:spChg chg="add">
          <ac:chgData name="Yates, Rob A." userId="S::raya228@uky.edu::c4835988-b912-40a4-bf56-31a2afc86d77" providerId="AD" clId="Web-{0CC3DE7B-5279-3B29-9775-114C9D57E971}" dt="2023-07-20T14:11:01.524" v="274"/>
          <ac:spMkLst>
            <pc:docMk/>
            <pc:sldMk cId="0" sldId="263"/>
            <ac:spMk id="58" creationId="{EC9B426E-3A31-878F-C6E2-8539F7ED1AD7}"/>
          </ac:spMkLst>
        </pc:spChg>
        <pc:spChg chg="add">
          <ac:chgData name="Yates, Rob A." userId="S::raya228@uky.edu::c4835988-b912-40a4-bf56-31a2afc86d77" providerId="AD" clId="Web-{0CC3DE7B-5279-3B29-9775-114C9D57E971}" dt="2023-07-20T14:11:01.540" v="275"/>
          <ac:spMkLst>
            <pc:docMk/>
            <pc:sldMk cId="0" sldId="263"/>
            <ac:spMk id="60" creationId="{58AB44DF-F346-7F00-0409-ED3DBC29645A}"/>
          </ac:spMkLst>
        </pc:spChg>
      </pc:sldChg>
      <pc:sldChg chg="addSp delSp">
        <pc:chgData name="Yates, Rob A." userId="S::raya228@uky.edu::c4835988-b912-40a4-bf56-31a2afc86d77" providerId="AD" clId="Web-{0CC3DE7B-5279-3B29-9775-114C9D57E971}" dt="2023-07-20T14:21:15.038" v="582"/>
        <pc:sldMkLst>
          <pc:docMk/>
          <pc:sldMk cId="0" sldId="264"/>
        </pc:sldMkLst>
        <pc:spChg chg="del">
          <ac:chgData name="Yates, Rob A." userId="S::raya228@uky.edu::c4835988-b912-40a4-bf56-31a2afc86d77" providerId="AD" clId="Web-{0CC3DE7B-5279-3B29-9775-114C9D57E971}" dt="2023-07-20T14:20:09.959" v="547"/>
          <ac:spMkLst>
            <pc:docMk/>
            <pc:sldMk cId="0" sldId="264"/>
            <ac:spMk id="4" creationId="{00000000-0000-0000-0000-000000000000}"/>
          </ac:spMkLst>
        </pc:spChg>
        <pc:spChg chg="del">
          <ac:chgData name="Yates, Rob A." userId="S::raya228@uky.edu::c4835988-b912-40a4-bf56-31a2afc86d77" providerId="AD" clId="Web-{0CC3DE7B-5279-3B29-9775-114C9D57E971}" dt="2023-07-20T14:20:09.959" v="546"/>
          <ac:spMkLst>
            <pc:docMk/>
            <pc:sldMk cId="0" sldId="264"/>
            <ac:spMk id="5" creationId="{00000000-0000-0000-0000-000000000000}"/>
          </ac:spMkLst>
        </pc:spChg>
        <pc:spChg chg="del">
          <ac:chgData name="Yates, Rob A." userId="S::raya228@uky.edu::c4835988-b912-40a4-bf56-31a2afc86d77" providerId="AD" clId="Web-{0CC3DE7B-5279-3B29-9775-114C9D57E971}" dt="2023-07-20T14:20:09.959" v="545"/>
          <ac:spMkLst>
            <pc:docMk/>
            <pc:sldMk cId="0" sldId="264"/>
            <ac:spMk id="8" creationId="{00000000-0000-0000-0000-000000000000}"/>
          </ac:spMkLst>
        </pc:spChg>
        <pc:spChg chg="del">
          <ac:chgData name="Yates, Rob A." userId="S::raya228@uky.edu::c4835988-b912-40a4-bf56-31a2afc86d77" providerId="AD" clId="Web-{0CC3DE7B-5279-3B29-9775-114C9D57E971}" dt="2023-07-20T14:20:09.959" v="544"/>
          <ac:spMkLst>
            <pc:docMk/>
            <pc:sldMk cId="0" sldId="264"/>
            <ac:spMk id="9" creationId="{00000000-0000-0000-0000-000000000000}"/>
          </ac:spMkLst>
        </pc:spChg>
        <pc:spChg chg="del">
          <ac:chgData name="Yates, Rob A." userId="S::raya228@uky.edu::c4835988-b912-40a4-bf56-31a2afc86d77" providerId="AD" clId="Web-{0CC3DE7B-5279-3B29-9775-114C9D57E971}" dt="2023-07-20T14:20:09.959" v="543"/>
          <ac:spMkLst>
            <pc:docMk/>
            <pc:sldMk cId="0" sldId="264"/>
            <ac:spMk id="13" creationId="{00000000-0000-0000-0000-000000000000}"/>
          </ac:spMkLst>
        </pc:spChg>
        <pc:spChg chg="del">
          <ac:chgData name="Yates, Rob A." userId="S::raya228@uky.edu::c4835988-b912-40a4-bf56-31a2afc86d77" providerId="AD" clId="Web-{0CC3DE7B-5279-3B29-9775-114C9D57E971}" dt="2023-07-20T14:20:09.959" v="542"/>
          <ac:spMkLst>
            <pc:docMk/>
            <pc:sldMk cId="0" sldId="264"/>
            <ac:spMk id="14" creationId="{00000000-0000-0000-0000-000000000000}"/>
          </ac:spMkLst>
        </pc:spChg>
        <pc:spChg chg="del">
          <ac:chgData name="Yates, Rob A." userId="S::raya228@uky.edu::c4835988-b912-40a4-bf56-31a2afc86d77" providerId="AD" clId="Web-{0CC3DE7B-5279-3B29-9775-114C9D57E971}" dt="2023-07-20T14:20:09.959" v="541"/>
          <ac:spMkLst>
            <pc:docMk/>
            <pc:sldMk cId="0" sldId="264"/>
            <ac:spMk id="18" creationId="{00000000-0000-0000-0000-000000000000}"/>
          </ac:spMkLst>
        </pc:spChg>
        <pc:spChg chg="del">
          <ac:chgData name="Yates, Rob A." userId="S::raya228@uky.edu::c4835988-b912-40a4-bf56-31a2afc86d77" providerId="AD" clId="Web-{0CC3DE7B-5279-3B29-9775-114C9D57E971}" dt="2023-07-20T14:20:09.959" v="540"/>
          <ac:spMkLst>
            <pc:docMk/>
            <pc:sldMk cId="0" sldId="264"/>
            <ac:spMk id="19" creationId="{00000000-0000-0000-0000-000000000000}"/>
          </ac:spMkLst>
        </pc:spChg>
        <pc:spChg chg="add">
          <ac:chgData name="Yates, Rob A." userId="S::raya228@uky.edu::c4835988-b912-40a4-bf56-31a2afc86d77" providerId="AD" clId="Web-{0CC3DE7B-5279-3B29-9775-114C9D57E971}" dt="2023-07-20T14:20:12.693" v="548"/>
          <ac:spMkLst>
            <pc:docMk/>
            <pc:sldMk cId="0" sldId="264"/>
            <ac:spMk id="22" creationId="{13342765-6AF9-28D7-3641-0CED96BFB30C}"/>
          </ac:spMkLst>
        </pc:spChg>
        <pc:spChg chg="add">
          <ac:chgData name="Yates, Rob A." userId="S::raya228@uky.edu::c4835988-b912-40a4-bf56-31a2afc86d77" providerId="AD" clId="Web-{0CC3DE7B-5279-3B29-9775-114C9D57E971}" dt="2023-07-20T14:20:12.709" v="549"/>
          <ac:spMkLst>
            <pc:docMk/>
            <pc:sldMk cId="0" sldId="264"/>
            <ac:spMk id="24" creationId="{D453130E-6CB5-D1AB-5458-495385BFBDD3}"/>
          </ac:spMkLst>
        </pc:spChg>
        <pc:spChg chg="add">
          <ac:chgData name="Yates, Rob A." userId="S::raya228@uky.edu::c4835988-b912-40a4-bf56-31a2afc86d77" providerId="AD" clId="Web-{0CC3DE7B-5279-3B29-9775-114C9D57E971}" dt="2023-07-20T14:20:12.709" v="550"/>
          <ac:spMkLst>
            <pc:docMk/>
            <pc:sldMk cId="0" sldId="264"/>
            <ac:spMk id="26" creationId="{C66F7F05-F9E0-A5C8-1E9D-94E1155F9BA5}"/>
          </ac:spMkLst>
        </pc:spChg>
        <pc:spChg chg="add del">
          <ac:chgData name="Yates, Rob A." userId="S::raya228@uky.edu::c4835988-b912-40a4-bf56-31a2afc86d77" providerId="AD" clId="Web-{0CC3DE7B-5279-3B29-9775-114C9D57E971}" dt="2023-07-20T14:21:11.273" v="580"/>
          <ac:spMkLst>
            <pc:docMk/>
            <pc:sldMk cId="0" sldId="264"/>
            <ac:spMk id="28" creationId="{798F5A3B-BE35-D8F9-9D7C-A96F9A075667}"/>
          </ac:spMkLst>
        </pc:spChg>
        <pc:spChg chg="add">
          <ac:chgData name="Yates, Rob A." userId="S::raya228@uky.edu::c4835988-b912-40a4-bf56-31a2afc86d77" providerId="AD" clId="Web-{0CC3DE7B-5279-3B29-9775-114C9D57E971}" dt="2023-07-20T14:20:12.724" v="552"/>
          <ac:spMkLst>
            <pc:docMk/>
            <pc:sldMk cId="0" sldId="264"/>
            <ac:spMk id="30" creationId="{51C6BB51-319F-C736-A0C8-E012BDE9BAEF}"/>
          </ac:spMkLst>
        </pc:spChg>
        <pc:spChg chg="add del">
          <ac:chgData name="Yates, Rob A." userId="S::raya228@uky.edu::c4835988-b912-40a4-bf56-31a2afc86d77" providerId="AD" clId="Web-{0CC3DE7B-5279-3B29-9775-114C9D57E971}" dt="2023-07-20T14:21:13.585" v="581"/>
          <ac:spMkLst>
            <pc:docMk/>
            <pc:sldMk cId="0" sldId="264"/>
            <ac:spMk id="32" creationId="{979A5453-41B3-6EB2-54A4-1015C5E424CC}"/>
          </ac:spMkLst>
        </pc:spChg>
        <pc:spChg chg="add">
          <ac:chgData name="Yates, Rob A." userId="S::raya228@uky.edu::c4835988-b912-40a4-bf56-31a2afc86d77" providerId="AD" clId="Web-{0CC3DE7B-5279-3B29-9775-114C9D57E971}" dt="2023-07-20T14:20:12.740" v="554"/>
          <ac:spMkLst>
            <pc:docMk/>
            <pc:sldMk cId="0" sldId="264"/>
            <ac:spMk id="34" creationId="{E618FD04-BE78-C985-DC3E-D4F211B363BE}"/>
          </ac:spMkLst>
        </pc:spChg>
        <pc:spChg chg="add del">
          <ac:chgData name="Yates, Rob A." userId="S::raya228@uky.edu::c4835988-b912-40a4-bf56-31a2afc86d77" providerId="AD" clId="Web-{0CC3DE7B-5279-3B29-9775-114C9D57E971}" dt="2023-07-20T14:21:15.038" v="582"/>
          <ac:spMkLst>
            <pc:docMk/>
            <pc:sldMk cId="0" sldId="264"/>
            <ac:spMk id="36" creationId="{77C5C940-34D5-0316-756B-A7727F36EA13}"/>
          </ac:spMkLst>
        </pc:spChg>
        <pc:spChg chg="add">
          <ac:chgData name="Yates, Rob A." userId="S::raya228@uky.edu::c4835988-b912-40a4-bf56-31a2afc86d77" providerId="AD" clId="Web-{0CC3DE7B-5279-3B29-9775-114C9D57E971}" dt="2023-07-20T14:20:12.771" v="556"/>
          <ac:spMkLst>
            <pc:docMk/>
            <pc:sldMk cId="0" sldId="264"/>
            <ac:spMk id="38" creationId="{A5D89DBA-BD36-7FF7-7A7B-0390D813D1AE}"/>
          </ac:spMkLst>
        </pc:spChg>
      </pc:sldChg>
      <pc:sldChg chg="addSp delSp">
        <pc:chgData name="Yates, Rob A." userId="S::raya228@uky.edu::c4835988-b912-40a4-bf56-31a2afc86d77" providerId="AD" clId="Web-{0CC3DE7B-5279-3B29-9775-114C9D57E971}" dt="2023-07-20T14:21:30.070" v="586"/>
        <pc:sldMkLst>
          <pc:docMk/>
          <pc:sldMk cId="0" sldId="265"/>
        </pc:sldMkLst>
        <pc:spChg chg="del">
          <ac:chgData name="Yates, Rob A." userId="S::raya228@uky.edu::c4835988-b912-40a4-bf56-31a2afc86d77" providerId="AD" clId="Web-{0CC3DE7B-5279-3B29-9775-114C9D57E971}" dt="2023-07-20T14:21:22.664" v="583"/>
          <ac:spMkLst>
            <pc:docMk/>
            <pc:sldMk cId="0" sldId="265"/>
            <ac:spMk id="5" creationId="{00000000-0000-0000-0000-000000000000}"/>
          </ac:spMkLst>
        </pc:spChg>
        <pc:spChg chg="del">
          <ac:chgData name="Yates, Rob A." userId="S::raya228@uky.edu::c4835988-b912-40a4-bf56-31a2afc86d77" providerId="AD" clId="Web-{0CC3DE7B-5279-3B29-9775-114C9D57E971}" dt="2023-07-20T14:21:24.664" v="584"/>
          <ac:spMkLst>
            <pc:docMk/>
            <pc:sldMk cId="0" sldId="265"/>
            <ac:spMk id="9" creationId="{00000000-0000-0000-0000-000000000000}"/>
          </ac:spMkLst>
        </pc:spChg>
        <pc:spChg chg="add del">
          <ac:chgData name="Yates, Rob A." userId="S::raya228@uky.edu::c4835988-b912-40a4-bf56-31a2afc86d77" providerId="AD" clId="Web-{0CC3DE7B-5279-3B29-9775-114C9D57E971}" dt="2023-07-20T14:21:30.070" v="586"/>
          <ac:spMkLst>
            <pc:docMk/>
            <pc:sldMk cId="0" sldId="265"/>
            <ac:spMk id="14" creationId="{00000000-0000-0000-0000-000000000000}"/>
          </ac:spMkLst>
        </pc:spChg>
      </pc:sldChg>
      <pc:sldChg chg="addSp delSp">
        <pc:chgData name="Yates, Rob A." userId="S::raya228@uky.edu::c4835988-b912-40a4-bf56-31a2afc86d77" providerId="AD" clId="Web-{0CC3DE7B-5279-3B29-9775-114C9D57E971}" dt="2023-07-20T14:18:54.316" v="533"/>
        <pc:sldMkLst>
          <pc:docMk/>
          <pc:sldMk cId="0" sldId="266"/>
        </pc:sldMkLst>
        <pc:spChg chg="del">
          <ac:chgData name="Yates, Rob A." userId="S::raya228@uky.edu::c4835988-b912-40a4-bf56-31a2afc86d77" providerId="AD" clId="Web-{0CC3DE7B-5279-3B29-9775-114C9D57E971}" dt="2023-07-20T14:18:51.301" v="521"/>
          <ac:spMkLst>
            <pc:docMk/>
            <pc:sldMk cId="0" sldId="266"/>
            <ac:spMk id="4" creationId="{00000000-0000-0000-0000-000000000000}"/>
          </ac:spMkLst>
        </pc:spChg>
        <pc:spChg chg="del">
          <ac:chgData name="Yates, Rob A." userId="S::raya228@uky.edu::c4835988-b912-40a4-bf56-31a2afc86d77" providerId="AD" clId="Web-{0CC3DE7B-5279-3B29-9775-114C9D57E971}" dt="2023-07-20T14:18:51.301" v="520"/>
          <ac:spMkLst>
            <pc:docMk/>
            <pc:sldMk cId="0" sldId="266"/>
            <ac:spMk id="5" creationId="{00000000-0000-0000-0000-000000000000}"/>
          </ac:spMkLst>
        </pc:spChg>
        <pc:spChg chg="del">
          <ac:chgData name="Yates, Rob A." userId="S::raya228@uky.edu::c4835988-b912-40a4-bf56-31a2afc86d77" providerId="AD" clId="Web-{0CC3DE7B-5279-3B29-9775-114C9D57E971}" dt="2023-07-20T14:18:51.301" v="519"/>
          <ac:spMkLst>
            <pc:docMk/>
            <pc:sldMk cId="0" sldId="266"/>
            <ac:spMk id="8" creationId="{00000000-0000-0000-0000-000000000000}"/>
          </ac:spMkLst>
        </pc:spChg>
        <pc:spChg chg="del">
          <ac:chgData name="Yates, Rob A." userId="S::raya228@uky.edu::c4835988-b912-40a4-bf56-31a2afc86d77" providerId="AD" clId="Web-{0CC3DE7B-5279-3B29-9775-114C9D57E971}" dt="2023-07-20T14:18:51.301" v="518"/>
          <ac:spMkLst>
            <pc:docMk/>
            <pc:sldMk cId="0" sldId="266"/>
            <ac:spMk id="9" creationId="{00000000-0000-0000-0000-000000000000}"/>
          </ac:spMkLst>
        </pc:spChg>
        <pc:spChg chg="del">
          <ac:chgData name="Yates, Rob A." userId="S::raya228@uky.edu::c4835988-b912-40a4-bf56-31a2afc86d77" providerId="AD" clId="Web-{0CC3DE7B-5279-3B29-9775-114C9D57E971}" dt="2023-07-20T14:18:51.301" v="517"/>
          <ac:spMkLst>
            <pc:docMk/>
            <pc:sldMk cId="0" sldId="266"/>
            <ac:spMk id="13" creationId="{00000000-0000-0000-0000-000000000000}"/>
          </ac:spMkLst>
        </pc:spChg>
        <pc:spChg chg="del">
          <ac:chgData name="Yates, Rob A." userId="S::raya228@uky.edu::c4835988-b912-40a4-bf56-31a2afc86d77" providerId="AD" clId="Web-{0CC3DE7B-5279-3B29-9775-114C9D57E971}" dt="2023-07-20T14:18:51.301" v="516"/>
          <ac:spMkLst>
            <pc:docMk/>
            <pc:sldMk cId="0" sldId="266"/>
            <ac:spMk id="14" creationId="{00000000-0000-0000-0000-000000000000}"/>
          </ac:spMkLst>
        </pc:spChg>
        <pc:spChg chg="del">
          <ac:chgData name="Yates, Rob A." userId="S::raya228@uky.edu::c4835988-b912-40a4-bf56-31a2afc86d77" providerId="AD" clId="Web-{0CC3DE7B-5279-3B29-9775-114C9D57E971}" dt="2023-07-20T14:18:51.301" v="515"/>
          <ac:spMkLst>
            <pc:docMk/>
            <pc:sldMk cId="0" sldId="266"/>
            <ac:spMk id="18" creationId="{00000000-0000-0000-0000-000000000000}"/>
          </ac:spMkLst>
        </pc:spChg>
        <pc:spChg chg="del">
          <ac:chgData name="Yates, Rob A." userId="S::raya228@uky.edu::c4835988-b912-40a4-bf56-31a2afc86d77" providerId="AD" clId="Web-{0CC3DE7B-5279-3B29-9775-114C9D57E971}" dt="2023-07-20T14:18:51.301" v="514"/>
          <ac:spMkLst>
            <pc:docMk/>
            <pc:sldMk cId="0" sldId="266"/>
            <ac:spMk id="19" creationId="{00000000-0000-0000-0000-000000000000}"/>
          </ac:spMkLst>
        </pc:spChg>
        <pc:spChg chg="del">
          <ac:chgData name="Yates, Rob A." userId="S::raya228@uky.edu::c4835988-b912-40a4-bf56-31a2afc86d77" providerId="AD" clId="Web-{0CC3DE7B-5279-3B29-9775-114C9D57E971}" dt="2023-07-20T14:18:51.301" v="512"/>
          <ac:spMkLst>
            <pc:docMk/>
            <pc:sldMk cId="0" sldId="266"/>
            <ac:spMk id="21" creationId="{3C46DF68-206C-975E-B6E9-2D13CFDE9DAC}"/>
          </ac:spMkLst>
        </pc:spChg>
        <pc:spChg chg="del">
          <ac:chgData name="Yates, Rob A." userId="S::raya228@uky.edu::c4835988-b912-40a4-bf56-31a2afc86d77" providerId="AD" clId="Web-{0CC3DE7B-5279-3B29-9775-114C9D57E971}" dt="2023-07-20T14:18:51.301" v="511"/>
          <ac:spMkLst>
            <pc:docMk/>
            <pc:sldMk cId="0" sldId="266"/>
            <ac:spMk id="23" creationId="{C539655A-0866-DA6D-BE56-19235318A4D0}"/>
          </ac:spMkLst>
        </pc:spChg>
        <pc:spChg chg="add">
          <ac:chgData name="Yates, Rob A." userId="S::raya228@uky.edu::c4835988-b912-40a4-bf56-31a2afc86d77" providerId="AD" clId="Web-{0CC3DE7B-5279-3B29-9775-114C9D57E971}" dt="2023-07-20T14:18:54.160" v="522"/>
          <ac:spMkLst>
            <pc:docMk/>
            <pc:sldMk cId="0" sldId="266"/>
            <ac:spMk id="24" creationId="{AF4BEF62-03C8-6DF2-D485-FC4F04AAB975}"/>
          </ac:spMkLst>
        </pc:spChg>
        <pc:spChg chg="del">
          <ac:chgData name="Yates, Rob A." userId="S::raya228@uky.edu::c4835988-b912-40a4-bf56-31a2afc86d77" providerId="AD" clId="Web-{0CC3DE7B-5279-3B29-9775-114C9D57E971}" dt="2023-07-20T14:18:51.301" v="510"/>
          <ac:spMkLst>
            <pc:docMk/>
            <pc:sldMk cId="0" sldId="266"/>
            <ac:spMk id="25" creationId="{67CDE65E-C0E8-231F-C585-3A761441DE6B}"/>
          </ac:spMkLst>
        </pc:spChg>
        <pc:spChg chg="del">
          <ac:chgData name="Yates, Rob A." userId="S::raya228@uky.edu::c4835988-b912-40a4-bf56-31a2afc86d77" providerId="AD" clId="Web-{0CC3DE7B-5279-3B29-9775-114C9D57E971}" dt="2023-07-20T14:18:51.301" v="513"/>
          <ac:spMkLst>
            <pc:docMk/>
            <pc:sldMk cId="0" sldId="266"/>
            <ac:spMk id="26" creationId="{8D5CA340-99A5-5FEA-C283-752C38D8C231}"/>
          </ac:spMkLst>
        </pc:spChg>
        <pc:spChg chg="add">
          <ac:chgData name="Yates, Rob A." userId="S::raya228@uky.edu::c4835988-b912-40a4-bf56-31a2afc86d77" providerId="AD" clId="Web-{0CC3DE7B-5279-3B29-9775-114C9D57E971}" dt="2023-07-20T14:18:54.160" v="523"/>
          <ac:spMkLst>
            <pc:docMk/>
            <pc:sldMk cId="0" sldId="266"/>
            <ac:spMk id="28" creationId="{6C832B80-7AAA-29A4-22F1-A9D62E314F4B}"/>
          </ac:spMkLst>
        </pc:spChg>
        <pc:spChg chg="add">
          <ac:chgData name="Yates, Rob A." userId="S::raya228@uky.edu::c4835988-b912-40a4-bf56-31a2afc86d77" providerId="AD" clId="Web-{0CC3DE7B-5279-3B29-9775-114C9D57E971}" dt="2023-07-20T14:18:54.176" v="524"/>
          <ac:spMkLst>
            <pc:docMk/>
            <pc:sldMk cId="0" sldId="266"/>
            <ac:spMk id="30" creationId="{ABFB7B87-DC3D-3441-FB3B-94BD5BF14EB6}"/>
          </ac:spMkLst>
        </pc:spChg>
        <pc:spChg chg="add">
          <ac:chgData name="Yates, Rob A." userId="S::raya228@uky.edu::c4835988-b912-40a4-bf56-31a2afc86d77" providerId="AD" clId="Web-{0CC3DE7B-5279-3B29-9775-114C9D57E971}" dt="2023-07-20T14:18:54.191" v="525"/>
          <ac:spMkLst>
            <pc:docMk/>
            <pc:sldMk cId="0" sldId="266"/>
            <ac:spMk id="32" creationId="{94DB5B2E-633F-9153-45B8-7B578239E64C}"/>
          </ac:spMkLst>
        </pc:spChg>
        <pc:spChg chg="add">
          <ac:chgData name="Yates, Rob A." userId="S::raya228@uky.edu::c4835988-b912-40a4-bf56-31a2afc86d77" providerId="AD" clId="Web-{0CC3DE7B-5279-3B29-9775-114C9D57E971}" dt="2023-07-20T14:18:54.191" v="526"/>
          <ac:spMkLst>
            <pc:docMk/>
            <pc:sldMk cId="0" sldId="266"/>
            <ac:spMk id="34" creationId="{D466F9D0-69B4-0F48-BC34-166BB64FDBBA}"/>
          </ac:spMkLst>
        </pc:spChg>
        <pc:spChg chg="add">
          <ac:chgData name="Yates, Rob A." userId="S::raya228@uky.edu::c4835988-b912-40a4-bf56-31a2afc86d77" providerId="AD" clId="Web-{0CC3DE7B-5279-3B29-9775-114C9D57E971}" dt="2023-07-20T14:18:54.207" v="527"/>
          <ac:spMkLst>
            <pc:docMk/>
            <pc:sldMk cId="0" sldId="266"/>
            <ac:spMk id="36" creationId="{E1B7C193-014B-A6F6-6ADE-36C1462EBFD9}"/>
          </ac:spMkLst>
        </pc:spChg>
        <pc:spChg chg="add">
          <ac:chgData name="Yates, Rob A." userId="S::raya228@uky.edu::c4835988-b912-40a4-bf56-31a2afc86d77" providerId="AD" clId="Web-{0CC3DE7B-5279-3B29-9775-114C9D57E971}" dt="2023-07-20T14:18:54.223" v="528"/>
          <ac:spMkLst>
            <pc:docMk/>
            <pc:sldMk cId="0" sldId="266"/>
            <ac:spMk id="38" creationId="{8DB4B07F-53F5-1B41-93A8-FEABEA6FC8C6}"/>
          </ac:spMkLst>
        </pc:spChg>
        <pc:spChg chg="add">
          <ac:chgData name="Yates, Rob A." userId="S::raya228@uky.edu::c4835988-b912-40a4-bf56-31a2afc86d77" providerId="AD" clId="Web-{0CC3DE7B-5279-3B29-9775-114C9D57E971}" dt="2023-07-20T14:18:54.238" v="529"/>
          <ac:spMkLst>
            <pc:docMk/>
            <pc:sldMk cId="0" sldId="266"/>
            <ac:spMk id="40" creationId="{4FDF6408-CFE3-81B3-29DC-2AF2B38CDF89}"/>
          </ac:spMkLst>
        </pc:spChg>
        <pc:spChg chg="add">
          <ac:chgData name="Yates, Rob A." userId="S::raya228@uky.edu::c4835988-b912-40a4-bf56-31a2afc86d77" providerId="AD" clId="Web-{0CC3DE7B-5279-3B29-9775-114C9D57E971}" dt="2023-07-20T14:18:54.270" v="530"/>
          <ac:spMkLst>
            <pc:docMk/>
            <pc:sldMk cId="0" sldId="266"/>
            <ac:spMk id="42" creationId="{F219A61A-CAF0-A53C-B611-653273463E49}"/>
          </ac:spMkLst>
        </pc:spChg>
        <pc:spChg chg="add">
          <ac:chgData name="Yates, Rob A." userId="S::raya228@uky.edu::c4835988-b912-40a4-bf56-31a2afc86d77" providerId="AD" clId="Web-{0CC3DE7B-5279-3B29-9775-114C9D57E971}" dt="2023-07-20T14:18:54.285" v="531"/>
          <ac:spMkLst>
            <pc:docMk/>
            <pc:sldMk cId="0" sldId="266"/>
            <ac:spMk id="44" creationId="{D7A1EAB8-87FF-E071-8F40-ACE5E994079E}"/>
          </ac:spMkLst>
        </pc:spChg>
        <pc:spChg chg="add">
          <ac:chgData name="Yates, Rob A." userId="S::raya228@uky.edu::c4835988-b912-40a4-bf56-31a2afc86d77" providerId="AD" clId="Web-{0CC3DE7B-5279-3B29-9775-114C9D57E971}" dt="2023-07-20T14:18:54.301" v="532"/>
          <ac:spMkLst>
            <pc:docMk/>
            <pc:sldMk cId="0" sldId="266"/>
            <ac:spMk id="46" creationId="{9FCECA0F-2DEC-7680-D202-73247325D851}"/>
          </ac:spMkLst>
        </pc:spChg>
        <pc:spChg chg="add">
          <ac:chgData name="Yates, Rob A." userId="S::raya228@uky.edu::c4835988-b912-40a4-bf56-31a2afc86d77" providerId="AD" clId="Web-{0CC3DE7B-5279-3B29-9775-114C9D57E971}" dt="2023-07-20T14:18:54.316" v="533"/>
          <ac:spMkLst>
            <pc:docMk/>
            <pc:sldMk cId="0" sldId="266"/>
            <ac:spMk id="48" creationId="{917A870A-910F-4EDB-C5E9-F7E965476DCE}"/>
          </ac:spMkLst>
        </pc:spChg>
      </pc:sldChg>
      <pc:sldChg chg="addSp delSp modSp">
        <pc:chgData name="Yates, Rob A." userId="S::raya228@uky.edu::c4835988-b912-40a4-bf56-31a2afc86d77" providerId="AD" clId="Web-{0CC3DE7B-5279-3B29-9775-114C9D57E971}" dt="2023-07-20T14:12:27.511" v="313"/>
        <pc:sldMkLst>
          <pc:docMk/>
          <pc:sldMk cId="0" sldId="267"/>
        </pc:sldMkLst>
        <pc:spChg chg="del mod">
          <ac:chgData name="Yates, Rob A." userId="S::raya228@uky.edu::c4835988-b912-40a4-bf56-31a2afc86d77" providerId="AD" clId="Web-{0CC3DE7B-5279-3B29-9775-114C9D57E971}" dt="2023-07-20T14:12:03.229" v="296"/>
          <ac:spMkLst>
            <pc:docMk/>
            <pc:sldMk cId="0" sldId="267"/>
            <ac:spMk id="4" creationId="{00000000-0000-0000-0000-000000000000}"/>
          </ac:spMkLst>
        </pc:spChg>
        <pc:spChg chg="del">
          <ac:chgData name="Yates, Rob A." userId="S::raya228@uky.edu::c4835988-b912-40a4-bf56-31a2afc86d77" providerId="AD" clId="Web-{0CC3DE7B-5279-3B29-9775-114C9D57E971}" dt="2023-07-20T14:11:56.510" v="293"/>
          <ac:spMkLst>
            <pc:docMk/>
            <pc:sldMk cId="0" sldId="267"/>
            <ac:spMk id="5" creationId="{00000000-0000-0000-0000-000000000000}"/>
          </ac:spMkLst>
        </pc:spChg>
        <pc:spChg chg="del">
          <ac:chgData name="Yates, Rob A." userId="S::raya228@uky.edu::c4835988-b912-40a4-bf56-31a2afc86d77" providerId="AD" clId="Web-{0CC3DE7B-5279-3B29-9775-114C9D57E971}" dt="2023-07-20T14:11:56.510" v="292"/>
          <ac:spMkLst>
            <pc:docMk/>
            <pc:sldMk cId="0" sldId="267"/>
            <ac:spMk id="8" creationId="{00000000-0000-0000-0000-000000000000}"/>
          </ac:spMkLst>
        </pc:spChg>
        <pc:spChg chg="del">
          <ac:chgData name="Yates, Rob A." userId="S::raya228@uky.edu::c4835988-b912-40a4-bf56-31a2afc86d77" providerId="AD" clId="Web-{0CC3DE7B-5279-3B29-9775-114C9D57E971}" dt="2023-07-20T14:11:56.510" v="291"/>
          <ac:spMkLst>
            <pc:docMk/>
            <pc:sldMk cId="0" sldId="267"/>
            <ac:spMk id="9" creationId="{00000000-0000-0000-0000-000000000000}"/>
          </ac:spMkLst>
        </pc:spChg>
        <pc:spChg chg="del">
          <ac:chgData name="Yates, Rob A." userId="S::raya228@uky.edu::c4835988-b912-40a4-bf56-31a2afc86d77" providerId="AD" clId="Web-{0CC3DE7B-5279-3B29-9775-114C9D57E971}" dt="2023-07-20T14:11:56.510" v="290"/>
          <ac:spMkLst>
            <pc:docMk/>
            <pc:sldMk cId="0" sldId="267"/>
            <ac:spMk id="13" creationId="{00000000-0000-0000-0000-000000000000}"/>
          </ac:spMkLst>
        </pc:spChg>
        <pc:spChg chg="del">
          <ac:chgData name="Yates, Rob A." userId="S::raya228@uky.edu::c4835988-b912-40a4-bf56-31a2afc86d77" providerId="AD" clId="Web-{0CC3DE7B-5279-3B29-9775-114C9D57E971}" dt="2023-07-20T14:11:56.510" v="289"/>
          <ac:spMkLst>
            <pc:docMk/>
            <pc:sldMk cId="0" sldId="267"/>
            <ac:spMk id="14" creationId="{00000000-0000-0000-0000-000000000000}"/>
          </ac:spMkLst>
        </pc:spChg>
        <pc:spChg chg="del">
          <ac:chgData name="Yates, Rob A." userId="S::raya228@uky.edu::c4835988-b912-40a4-bf56-31a2afc86d77" providerId="AD" clId="Web-{0CC3DE7B-5279-3B29-9775-114C9D57E971}" dt="2023-07-20T14:12:06.979" v="297"/>
          <ac:spMkLst>
            <pc:docMk/>
            <pc:sldMk cId="0" sldId="267"/>
            <ac:spMk id="18" creationId="{00000000-0000-0000-0000-000000000000}"/>
          </ac:spMkLst>
        </pc:spChg>
        <pc:spChg chg="del">
          <ac:chgData name="Yates, Rob A." userId="S::raya228@uky.edu::c4835988-b912-40a4-bf56-31a2afc86d77" providerId="AD" clId="Web-{0CC3DE7B-5279-3B29-9775-114C9D57E971}" dt="2023-07-20T14:11:56.510" v="288"/>
          <ac:spMkLst>
            <pc:docMk/>
            <pc:sldMk cId="0" sldId="267"/>
            <ac:spMk id="19" creationId="{00000000-0000-0000-0000-000000000000}"/>
          </ac:spMkLst>
        </pc:spChg>
        <pc:spChg chg="del">
          <ac:chgData name="Yates, Rob A." userId="S::raya228@uky.edu::c4835988-b912-40a4-bf56-31a2afc86d77" providerId="AD" clId="Web-{0CC3DE7B-5279-3B29-9775-114C9D57E971}" dt="2023-07-20T14:11:56.510" v="287"/>
          <ac:spMkLst>
            <pc:docMk/>
            <pc:sldMk cId="0" sldId="267"/>
            <ac:spMk id="21" creationId="{E48D6E48-A40D-736F-4EDD-5114987F1AD9}"/>
          </ac:spMkLst>
        </pc:spChg>
        <pc:spChg chg="del">
          <ac:chgData name="Yates, Rob A." userId="S::raya228@uky.edu::c4835988-b912-40a4-bf56-31a2afc86d77" providerId="AD" clId="Web-{0CC3DE7B-5279-3B29-9775-114C9D57E971}" dt="2023-07-20T14:11:56.510" v="286"/>
          <ac:spMkLst>
            <pc:docMk/>
            <pc:sldMk cId="0" sldId="267"/>
            <ac:spMk id="22" creationId="{D5557E3C-32D0-D531-45CD-7E55AB86FB47}"/>
          </ac:spMkLst>
        </pc:spChg>
        <pc:spChg chg="del">
          <ac:chgData name="Yates, Rob A." userId="S::raya228@uky.edu::c4835988-b912-40a4-bf56-31a2afc86d77" providerId="AD" clId="Web-{0CC3DE7B-5279-3B29-9775-114C9D57E971}" dt="2023-07-20T14:11:56.510" v="285"/>
          <ac:spMkLst>
            <pc:docMk/>
            <pc:sldMk cId="0" sldId="267"/>
            <ac:spMk id="23" creationId="{2B44A5F6-12DB-2643-0FBA-F09E9ABA1195}"/>
          </ac:spMkLst>
        </pc:spChg>
        <pc:spChg chg="del">
          <ac:chgData name="Yates, Rob A." userId="S::raya228@uky.edu::c4835988-b912-40a4-bf56-31a2afc86d77" providerId="AD" clId="Web-{0CC3DE7B-5279-3B29-9775-114C9D57E971}" dt="2023-07-20T14:11:56.510" v="284"/>
          <ac:spMkLst>
            <pc:docMk/>
            <pc:sldMk cId="0" sldId="267"/>
            <ac:spMk id="24" creationId="{AED1BA97-1152-F1D1-05CD-4BD09BAE635C}"/>
          </ac:spMkLst>
        </pc:spChg>
        <pc:spChg chg="del">
          <ac:chgData name="Yates, Rob A." userId="S::raya228@uky.edu::c4835988-b912-40a4-bf56-31a2afc86d77" providerId="AD" clId="Web-{0CC3DE7B-5279-3B29-9775-114C9D57E971}" dt="2023-07-20T14:11:56.510" v="283"/>
          <ac:spMkLst>
            <pc:docMk/>
            <pc:sldMk cId="0" sldId="267"/>
            <ac:spMk id="25" creationId="{487276E3-3E27-DC04-4BB8-BACDADEE76B4}"/>
          </ac:spMkLst>
        </pc:spChg>
        <pc:spChg chg="del">
          <ac:chgData name="Yates, Rob A." userId="S::raya228@uky.edu::c4835988-b912-40a4-bf56-31a2afc86d77" providerId="AD" clId="Web-{0CC3DE7B-5279-3B29-9775-114C9D57E971}" dt="2023-07-20T14:11:56.510" v="282"/>
          <ac:spMkLst>
            <pc:docMk/>
            <pc:sldMk cId="0" sldId="267"/>
            <ac:spMk id="26" creationId="{C6A84A27-245B-D258-BF18-7C71B135A325}"/>
          </ac:spMkLst>
        </pc:spChg>
        <pc:spChg chg="del">
          <ac:chgData name="Yates, Rob A." userId="S::raya228@uky.edu::c4835988-b912-40a4-bf56-31a2afc86d77" providerId="AD" clId="Web-{0CC3DE7B-5279-3B29-9775-114C9D57E971}" dt="2023-07-20T14:11:56.510" v="281"/>
          <ac:spMkLst>
            <pc:docMk/>
            <pc:sldMk cId="0" sldId="267"/>
            <ac:spMk id="27" creationId="{B5653DD5-D054-F4A7-B98E-8124474EE4C6}"/>
          </ac:spMkLst>
        </pc:spChg>
        <pc:spChg chg="del">
          <ac:chgData name="Yates, Rob A." userId="S::raya228@uky.edu::c4835988-b912-40a4-bf56-31a2afc86d77" providerId="AD" clId="Web-{0CC3DE7B-5279-3B29-9775-114C9D57E971}" dt="2023-07-20T14:11:56.510" v="280"/>
          <ac:spMkLst>
            <pc:docMk/>
            <pc:sldMk cId="0" sldId="267"/>
            <ac:spMk id="28" creationId="{CC1B70C7-A77C-F11C-BABD-C7284B3471F7}"/>
          </ac:spMkLst>
        </pc:spChg>
        <pc:spChg chg="add">
          <ac:chgData name="Yates, Rob A." userId="S::raya228@uky.edu::c4835988-b912-40a4-bf56-31a2afc86d77" providerId="AD" clId="Web-{0CC3DE7B-5279-3B29-9775-114C9D57E971}" dt="2023-07-20T14:12:11.088" v="298"/>
          <ac:spMkLst>
            <pc:docMk/>
            <pc:sldMk cId="0" sldId="267"/>
            <ac:spMk id="30" creationId="{6F446129-7CE6-F77E-8FD2-BD82349FA8E6}"/>
          </ac:spMkLst>
        </pc:spChg>
        <pc:spChg chg="add">
          <ac:chgData name="Yates, Rob A." userId="S::raya228@uky.edu::c4835988-b912-40a4-bf56-31a2afc86d77" providerId="AD" clId="Web-{0CC3DE7B-5279-3B29-9775-114C9D57E971}" dt="2023-07-20T14:12:11.104" v="299"/>
          <ac:spMkLst>
            <pc:docMk/>
            <pc:sldMk cId="0" sldId="267"/>
            <ac:spMk id="32" creationId="{835F0681-9BF0-97A1-F9A1-4E71B944B4D5}"/>
          </ac:spMkLst>
        </pc:spChg>
        <pc:spChg chg="add">
          <ac:chgData name="Yates, Rob A." userId="S::raya228@uky.edu::c4835988-b912-40a4-bf56-31a2afc86d77" providerId="AD" clId="Web-{0CC3DE7B-5279-3B29-9775-114C9D57E971}" dt="2023-07-20T14:12:11.104" v="300"/>
          <ac:spMkLst>
            <pc:docMk/>
            <pc:sldMk cId="0" sldId="267"/>
            <ac:spMk id="34" creationId="{99742C3B-9630-6B02-BB50-9C9D8262C042}"/>
          </ac:spMkLst>
        </pc:spChg>
        <pc:spChg chg="add">
          <ac:chgData name="Yates, Rob A." userId="S::raya228@uky.edu::c4835988-b912-40a4-bf56-31a2afc86d77" providerId="AD" clId="Web-{0CC3DE7B-5279-3B29-9775-114C9D57E971}" dt="2023-07-20T14:12:11.120" v="301"/>
          <ac:spMkLst>
            <pc:docMk/>
            <pc:sldMk cId="0" sldId="267"/>
            <ac:spMk id="36" creationId="{30D77DFF-AC55-BB19-EC5B-0A685F059218}"/>
          </ac:spMkLst>
        </pc:spChg>
        <pc:spChg chg="add">
          <ac:chgData name="Yates, Rob A." userId="S::raya228@uky.edu::c4835988-b912-40a4-bf56-31a2afc86d77" providerId="AD" clId="Web-{0CC3DE7B-5279-3B29-9775-114C9D57E971}" dt="2023-07-20T14:12:11.120" v="302"/>
          <ac:spMkLst>
            <pc:docMk/>
            <pc:sldMk cId="0" sldId="267"/>
            <ac:spMk id="38" creationId="{2A59E2AB-7194-2873-357E-1511AAB57981}"/>
          </ac:spMkLst>
        </pc:spChg>
        <pc:spChg chg="add">
          <ac:chgData name="Yates, Rob A." userId="S::raya228@uky.edu::c4835988-b912-40a4-bf56-31a2afc86d77" providerId="AD" clId="Web-{0CC3DE7B-5279-3B29-9775-114C9D57E971}" dt="2023-07-20T14:12:11.135" v="303"/>
          <ac:spMkLst>
            <pc:docMk/>
            <pc:sldMk cId="0" sldId="267"/>
            <ac:spMk id="40" creationId="{107100AC-4164-C6B7-C63D-614BF1B77734}"/>
          </ac:spMkLst>
        </pc:spChg>
        <pc:spChg chg="add">
          <ac:chgData name="Yates, Rob A." userId="S::raya228@uky.edu::c4835988-b912-40a4-bf56-31a2afc86d77" providerId="AD" clId="Web-{0CC3DE7B-5279-3B29-9775-114C9D57E971}" dt="2023-07-20T14:12:11.135" v="304"/>
          <ac:spMkLst>
            <pc:docMk/>
            <pc:sldMk cId="0" sldId="267"/>
            <ac:spMk id="42" creationId="{E08BC5EF-1F6D-EC3C-F94A-0C00FA16410E}"/>
          </ac:spMkLst>
        </pc:spChg>
        <pc:spChg chg="add">
          <ac:chgData name="Yates, Rob A." userId="S::raya228@uky.edu::c4835988-b912-40a4-bf56-31a2afc86d77" providerId="AD" clId="Web-{0CC3DE7B-5279-3B29-9775-114C9D57E971}" dt="2023-07-20T14:12:11.151" v="305"/>
          <ac:spMkLst>
            <pc:docMk/>
            <pc:sldMk cId="0" sldId="267"/>
            <ac:spMk id="44" creationId="{3817646C-29CB-1DF4-5E2D-2748D93675A4}"/>
          </ac:spMkLst>
        </pc:spChg>
        <pc:spChg chg="add">
          <ac:chgData name="Yates, Rob A." userId="S::raya228@uky.edu::c4835988-b912-40a4-bf56-31a2afc86d77" providerId="AD" clId="Web-{0CC3DE7B-5279-3B29-9775-114C9D57E971}" dt="2023-07-20T14:12:11.151" v="306"/>
          <ac:spMkLst>
            <pc:docMk/>
            <pc:sldMk cId="0" sldId="267"/>
            <ac:spMk id="46" creationId="{E405E2FD-799C-D7AB-FBCF-2618DEEDF496}"/>
          </ac:spMkLst>
        </pc:spChg>
        <pc:spChg chg="add">
          <ac:chgData name="Yates, Rob A." userId="S::raya228@uky.edu::c4835988-b912-40a4-bf56-31a2afc86d77" providerId="AD" clId="Web-{0CC3DE7B-5279-3B29-9775-114C9D57E971}" dt="2023-07-20T14:12:11.166" v="307"/>
          <ac:spMkLst>
            <pc:docMk/>
            <pc:sldMk cId="0" sldId="267"/>
            <ac:spMk id="48" creationId="{C15DCCC6-8BEF-0BD3-19FC-BD8D642D69A4}"/>
          </ac:spMkLst>
        </pc:spChg>
        <pc:spChg chg="add">
          <ac:chgData name="Yates, Rob A." userId="S::raya228@uky.edu::c4835988-b912-40a4-bf56-31a2afc86d77" providerId="AD" clId="Web-{0CC3DE7B-5279-3B29-9775-114C9D57E971}" dt="2023-07-20T14:12:11.182" v="308"/>
          <ac:spMkLst>
            <pc:docMk/>
            <pc:sldMk cId="0" sldId="267"/>
            <ac:spMk id="50" creationId="{C01D0879-62F8-DB86-6F97-4EFC61A0A0CB}"/>
          </ac:spMkLst>
        </pc:spChg>
        <pc:spChg chg="add">
          <ac:chgData name="Yates, Rob A." userId="S::raya228@uky.edu::c4835988-b912-40a4-bf56-31a2afc86d77" providerId="AD" clId="Web-{0CC3DE7B-5279-3B29-9775-114C9D57E971}" dt="2023-07-20T14:12:11.182" v="309"/>
          <ac:spMkLst>
            <pc:docMk/>
            <pc:sldMk cId="0" sldId="267"/>
            <ac:spMk id="52" creationId="{A959A935-0995-6BAA-68BE-386EC2D03188}"/>
          </ac:spMkLst>
        </pc:spChg>
        <pc:spChg chg="add">
          <ac:chgData name="Yates, Rob A." userId="S::raya228@uky.edu::c4835988-b912-40a4-bf56-31a2afc86d77" providerId="AD" clId="Web-{0CC3DE7B-5279-3B29-9775-114C9D57E971}" dt="2023-07-20T14:12:11.198" v="310"/>
          <ac:spMkLst>
            <pc:docMk/>
            <pc:sldMk cId="0" sldId="267"/>
            <ac:spMk id="54" creationId="{B1A8490D-3EC8-3975-290A-3BD30BAE19ED}"/>
          </ac:spMkLst>
        </pc:spChg>
        <pc:spChg chg="add">
          <ac:chgData name="Yates, Rob A." userId="S::raya228@uky.edu::c4835988-b912-40a4-bf56-31a2afc86d77" providerId="AD" clId="Web-{0CC3DE7B-5279-3B29-9775-114C9D57E971}" dt="2023-07-20T14:12:11.213" v="311"/>
          <ac:spMkLst>
            <pc:docMk/>
            <pc:sldMk cId="0" sldId="267"/>
            <ac:spMk id="56" creationId="{C2A302BB-329A-8916-5464-91D208F1DF10}"/>
          </ac:spMkLst>
        </pc:spChg>
        <pc:spChg chg="add">
          <ac:chgData name="Yates, Rob A." userId="S::raya228@uky.edu::c4835988-b912-40a4-bf56-31a2afc86d77" providerId="AD" clId="Web-{0CC3DE7B-5279-3B29-9775-114C9D57E971}" dt="2023-07-20T14:12:11.229" v="312"/>
          <ac:spMkLst>
            <pc:docMk/>
            <pc:sldMk cId="0" sldId="267"/>
            <ac:spMk id="58" creationId="{5EABE30F-0E56-70CF-F70C-C9F69FE1D1D5}"/>
          </ac:spMkLst>
        </pc:spChg>
        <pc:spChg chg="add">
          <ac:chgData name="Yates, Rob A." userId="S::raya228@uky.edu::c4835988-b912-40a4-bf56-31a2afc86d77" providerId="AD" clId="Web-{0CC3DE7B-5279-3B29-9775-114C9D57E971}" dt="2023-07-20T14:12:27.511" v="313"/>
          <ac:spMkLst>
            <pc:docMk/>
            <pc:sldMk cId="0" sldId="267"/>
            <ac:spMk id="60" creationId="{AB662FC1-0C82-8ACA-0CB4-8FCEF738B8ED}"/>
          </ac:spMkLst>
        </pc:spChg>
      </pc:sldChg>
      <pc:sldChg chg="addSp delSp">
        <pc:chgData name="Yates, Rob A." userId="S::raya228@uky.edu::c4835988-b912-40a4-bf56-31a2afc86d77" providerId="AD" clId="Web-{0CC3DE7B-5279-3B29-9775-114C9D57E971}" dt="2023-07-20T14:13:10.871" v="345"/>
        <pc:sldMkLst>
          <pc:docMk/>
          <pc:sldMk cId="0" sldId="268"/>
        </pc:sldMkLst>
        <pc:spChg chg="del">
          <ac:chgData name="Yates, Rob A." userId="S::raya228@uky.edu::c4835988-b912-40a4-bf56-31a2afc86d77" providerId="AD" clId="Web-{0CC3DE7B-5279-3B29-9775-114C9D57E971}" dt="2023-07-20T14:13:08.246" v="329"/>
          <ac:spMkLst>
            <pc:docMk/>
            <pc:sldMk cId="0" sldId="268"/>
            <ac:spMk id="4" creationId="{00000000-0000-0000-0000-000000000000}"/>
          </ac:spMkLst>
        </pc:spChg>
        <pc:spChg chg="del">
          <ac:chgData name="Yates, Rob A." userId="S::raya228@uky.edu::c4835988-b912-40a4-bf56-31a2afc86d77" providerId="AD" clId="Web-{0CC3DE7B-5279-3B29-9775-114C9D57E971}" dt="2023-07-20T14:13:04.777" v="328"/>
          <ac:spMkLst>
            <pc:docMk/>
            <pc:sldMk cId="0" sldId="268"/>
            <ac:spMk id="5" creationId="{00000000-0000-0000-0000-000000000000}"/>
          </ac:spMkLst>
        </pc:spChg>
        <pc:spChg chg="del">
          <ac:chgData name="Yates, Rob A." userId="S::raya228@uky.edu::c4835988-b912-40a4-bf56-31a2afc86d77" providerId="AD" clId="Web-{0CC3DE7B-5279-3B29-9775-114C9D57E971}" dt="2023-07-20T14:13:04.777" v="327"/>
          <ac:spMkLst>
            <pc:docMk/>
            <pc:sldMk cId="0" sldId="268"/>
            <ac:spMk id="8" creationId="{00000000-0000-0000-0000-000000000000}"/>
          </ac:spMkLst>
        </pc:spChg>
        <pc:spChg chg="del">
          <ac:chgData name="Yates, Rob A." userId="S::raya228@uky.edu::c4835988-b912-40a4-bf56-31a2afc86d77" providerId="AD" clId="Web-{0CC3DE7B-5279-3B29-9775-114C9D57E971}" dt="2023-07-20T14:13:04.777" v="326"/>
          <ac:spMkLst>
            <pc:docMk/>
            <pc:sldMk cId="0" sldId="268"/>
            <ac:spMk id="9" creationId="{00000000-0000-0000-0000-000000000000}"/>
          </ac:spMkLst>
        </pc:spChg>
        <pc:spChg chg="del">
          <ac:chgData name="Yates, Rob A." userId="S::raya228@uky.edu::c4835988-b912-40a4-bf56-31a2afc86d77" providerId="AD" clId="Web-{0CC3DE7B-5279-3B29-9775-114C9D57E971}" dt="2023-07-20T14:13:04.777" v="325"/>
          <ac:spMkLst>
            <pc:docMk/>
            <pc:sldMk cId="0" sldId="268"/>
            <ac:spMk id="13" creationId="{00000000-0000-0000-0000-000000000000}"/>
          </ac:spMkLst>
        </pc:spChg>
        <pc:spChg chg="del">
          <ac:chgData name="Yates, Rob A." userId="S::raya228@uky.edu::c4835988-b912-40a4-bf56-31a2afc86d77" providerId="AD" clId="Web-{0CC3DE7B-5279-3B29-9775-114C9D57E971}" dt="2023-07-20T14:13:04.777" v="324"/>
          <ac:spMkLst>
            <pc:docMk/>
            <pc:sldMk cId="0" sldId="268"/>
            <ac:spMk id="14" creationId="{00000000-0000-0000-0000-000000000000}"/>
          </ac:spMkLst>
        </pc:spChg>
        <pc:spChg chg="del">
          <ac:chgData name="Yates, Rob A." userId="S::raya228@uky.edu::c4835988-b912-40a4-bf56-31a2afc86d77" providerId="AD" clId="Web-{0CC3DE7B-5279-3B29-9775-114C9D57E971}" dt="2023-07-20T14:13:04.777" v="323"/>
          <ac:spMkLst>
            <pc:docMk/>
            <pc:sldMk cId="0" sldId="268"/>
            <ac:spMk id="18" creationId="{00000000-0000-0000-0000-000000000000}"/>
          </ac:spMkLst>
        </pc:spChg>
        <pc:spChg chg="del">
          <ac:chgData name="Yates, Rob A." userId="S::raya228@uky.edu::c4835988-b912-40a4-bf56-31a2afc86d77" providerId="AD" clId="Web-{0CC3DE7B-5279-3B29-9775-114C9D57E971}" dt="2023-07-20T14:13:04.777" v="322"/>
          <ac:spMkLst>
            <pc:docMk/>
            <pc:sldMk cId="0" sldId="268"/>
            <ac:spMk id="19" creationId="{00000000-0000-0000-0000-000000000000}"/>
          </ac:spMkLst>
        </pc:spChg>
        <pc:spChg chg="del">
          <ac:chgData name="Yates, Rob A." userId="S::raya228@uky.edu::c4835988-b912-40a4-bf56-31a2afc86d77" providerId="AD" clId="Web-{0CC3DE7B-5279-3B29-9775-114C9D57E971}" dt="2023-07-20T14:13:04.777" v="321"/>
          <ac:spMkLst>
            <pc:docMk/>
            <pc:sldMk cId="0" sldId="268"/>
            <ac:spMk id="21" creationId="{F6C47EC6-1566-1094-9C53-D2D817A0EA5E}"/>
          </ac:spMkLst>
        </pc:spChg>
        <pc:spChg chg="del">
          <ac:chgData name="Yates, Rob A." userId="S::raya228@uky.edu::c4835988-b912-40a4-bf56-31a2afc86d77" providerId="AD" clId="Web-{0CC3DE7B-5279-3B29-9775-114C9D57E971}" dt="2023-07-20T14:13:04.777" v="320"/>
          <ac:spMkLst>
            <pc:docMk/>
            <pc:sldMk cId="0" sldId="268"/>
            <ac:spMk id="22" creationId="{8BE41F18-D3EB-E4DF-143F-226EFD3EA118}"/>
          </ac:spMkLst>
        </pc:spChg>
        <pc:spChg chg="del">
          <ac:chgData name="Yates, Rob A." userId="S::raya228@uky.edu::c4835988-b912-40a4-bf56-31a2afc86d77" providerId="AD" clId="Web-{0CC3DE7B-5279-3B29-9775-114C9D57E971}" dt="2023-07-20T14:13:04.777" v="319"/>
          <ac:spMkLst>
            <pc:docMk/>
            <pc:sldMk cId="0" sldId="268"/>
            <ac:spMk id="23" creationId="{321663A4-DBAA-6BF2-697C-02ECF5FD76E4}"/>
          </ac:spMkLst>
        </pc:spChg>
        <pc:spChg chg="del">
          <ac:chgData name="Yates, Rob A." userId="S::raya228@uky.edu::c4835988-b912-40a4-bf56-31a2afc86d77" providerId="AD" clId="Web-{0CC3DE7B-5279-3B29-9775-114C9D57E971}" dt="2023-07-20T14:13:04.777" v="318"/>
          <ac:spMkLst>
            <pc:docMk/>
            <pc:sldMk cId="0" sldId="268"/>
            <ac:spMk id="24" creationId="{C03E81ED-B605-1815-FE5A-10EDA085F5FD}"/>
          </ac:spMkLst>
        </pc:spChg>
        <pc:spChg chg="del">
          <ac:chgData name="Yates, Rob A." userId="S::raya228@uky.edu::c4835988-b912-40a4-bf56-31a2afc86d77" providerId="AD" clId="Web-{0CC3DE7B-5279-3B29-9775-114C9D57E971}" dt="2023-07-20T14:13:04.777" v="317"/>
          <ac:spMkLst>
            <pc:docMk/>
            <pc:sldMk cId="0" sldId="268"/>
            <ac:spMk id="25" creationId="{EB285F92-E7E7-9E8D-DE41-2E992D616F28}"/>
          </ac:spMkLst>
        </pc:spChg>
        <pc:spChg chg="del">
          <ac:chgData name="Yates, Rob A." userId="S::raya228@uky.edu::c4835988-b912-40a4-bf56-31a2afc86d77" providerId="AD" clId="Web-{0CC3DE7B-5279-3B29-9775-114C9D57E971}" dt="2023-07-20T14:13:04.777" v="316"/>
          <ac:spMkLst>
            <pc:docMk/>
            <pc:sldMk cId="0" sldId="268"/>
            <ac:spMk id="26" creationId="{CBE89CA2-9948-2D59-8B19-6A9B9C5C58A7}"/>
          </ac:spMkLst>
        </pc:spChg>
        <pc:spChg chg="del">
          <ac:chgData name="Yates, Rob A." userId="S::raya228@uky.edu::c4835988-b912-40a4-bf56-31a2afc86d77" providerId="AD" clId="Web-{0CC3DE7B-5279-3B29-9775-114C9D57E971}" dt="2023-07-20T14:13:04.777" v="315"/>
          <ac:spMkLst>
            <pc:docMk/>
            <pc:sldMk cId="0" sldId="268"/>
            <ac:spMk id="27" creationId="{40F8446F-C30A-684A-8C55-7173D21BC928}"/>
          </ac:spMkLst>
        </pc:spChg>
        <pc:spChg chg="del">
          <ac:chgData name="Yates, Rob A." userId="S::raya228@uky.edu::c4835988-b912-40a4-bf56-31a2afc86d77" providerId="AD" clId="Web-{0CC3DE7B-5279-3B29-9775-114C9D57E971}" dt="2023-07-20T14:13:04.777" v="314"/>
          <ac:spMkLst>
            <pc:docMk/>
            <pc:sldMk cId="0" sldId="268"/>
            <ac:spMk id="28" creationId="{E6271D4B-BB60-3887-2D0C-C2C80F0881E8}"/>
          </ac:spMkLst>
        </pc:spChg>
        <pc:spChg chg="add">
          <ac:chgData name="Yates, Rob A." userId="S::raya228@uky.edu::c4835988-b912-40a4-bf56-31a2afc86d77" providerId="AD" clId="Web-{0CC3DE7B-5279-3B29-9775-114C9D57E971}" dt="2023-07-20T14:13:10.715" v="330"/>
          <ac:spMkLst>
            <pc:docMk/>
            <pc:sldMk cId="0" sldId="268"/>
            <ac:spMk id="30" creationId="{33B066E2-160B-5D93-400D-2397D998207A}"/>
          </ac:spMkLst>
        </pc:spChg>
        <pc:spChg chg="add">
          <ac:chgData name="Yates, Rob A." userId="S::raya228@uky.edu::c4835988-b912-40a4-bf56-31a2afc86d77" providerId="AD" clId="Web-{0CC3DE7B-5279-3B29-9775-114C9D57E971}" dt="2023-07-20T14:13:10.730" v="331"/>
          <ac:spMkLst>
            <pc:docMk/>
            <pc:sldMk cId="0" sldId="268"/>
            <ac:spMk id="32" creationId="{50AC5E3A-5E8B-07AA-21F7-FE21AE6DFDC4}"/>
          </ac:spMkLst>
        </pc:spChg>
        <pc:spChg chg="add">
          <ac:chgData name="Yates, Rob A." userId="S::raya228@uky.edu::c4835988-b912-40a4-bf56-31a2afc86d77" providerId="AD" clId="Web-{0CC3DE7B-5279-3B29-9775-114C9D57E971}" dt="2023-07-20T14:13:10.730" v="332"/>
          <ac:spMkLst>
            <pc:docMk/>
            <pc:sldMk cId="0" sldId="268"/>
            <ac:spMk id="34" creationId="{5892527F-47DC-72EC-3031-AC335EB78164}"/>
          </ac:spMkLst>
        </pc:spChg>
        <pc:spChg chg="add">
          <ac:chgData name="Yates, Rob A." userId="S::raya228@uky.edu::c4835988-b912-40a4-bf56-31a2afc86d77" providerId="AD" clId="Web-{0CC3DE7B-5279-3B29-9775-114C9D57E971}" dt="2023-07-20T14:13:10.746" v="333"/>
          <ac:spMkLst>
            <pc:docMk/>
            <pc:sldMk cId="0" sldId="268"/>
            <ac:spMk id="36" creationId="{4C7E1873-D7D7-C9C2-02BC-413A5B705E18}"/>
          </ac:spMkLst>
        </pc:spChg>
        <pc:spChg chg="add">
          <ac:chgData name="Yates, Rob A." userId="S::raya228@uky.edu::c4835988-b912-40a4-bf56-31a2afc86d77" providerId="AD" clId="Web-{0CC3DE7B-5279-3B29-9775-114C9D57E971}" dt="2023-07-20T14:13:10.746" v="334"/>
          <ac:spMkLst>
            <pc:docMk/>
            <pc:sldMk cId="0" sldId="268"/>
            <ac:spMk id="38" creationId="{E285BE75-0347-0C80-8126-9C8C60D7845F}"/>
          </ac:spMkLst>
        </pc:spChg>
        <pc:spChg chg="add">
          <ac:chgData name="Yates, Rob A." userId="S::raya228@uky.edu::c4835988-b912-40a4-bf56-31a2afc86d77" providerId="AD" clId="Web-{0CC3DE7B-5279-3B29-9775-114C9D57E971}" dt="2023-07-20T14:13:10.762" v="335"/>
          <ac:spMkLst>
            <pc:docMk/>
            <pc:sldMk cId="0" sldId="268"/>
            <ac:spMk id="40" creationId="{728436E2-9CC0-F61C-D8AE-7162E80BA55D}"/>
          </ac:spMkLst>
        </pc:spChg>
        <pc:spChg chg="add">
          <ac:chgData name="Yates, Rob A." userId="S::raya228@uky.edu::c4835988-b912-40a4-bf56-31a2afc86d77" providerId="AD" clId="Web-{0CC3DE7B-5279-3B29-9775-114C9D57E971}" dt="2023-07-20T14:13:10.777" v="336"/>
          <ac:spMkLst>
            <pc:docMk/>
            <pc:sldMk cId="0" sldId="268"/>
            <ac:spMk id="42" creationId="{514E9AF9-02D5-98FD-48F3-F0E9D1535E98}"/>
          </ac:spMkLst>
        </pc:spChg>
        <pc:spChg chg="add">
          <ac:chgData name="Yates, Rob A." userId="S::raya228@uky.edu::c4835988-b912-40a4-bf56-31a2afc86d77" providerId="AD" clId="Web-{0CC3DE7B-5279-3B29-9775-114C9D57E971}" dt="2023-07-20T14:13:10.777" v="337"/>
          <ac:spMkLst>
            <pc:docMk/>
            <pc:sldMk cId="0" sldId="268"/>
            <ac:spMk id="44" creationId="{CF9AEAA4-6402-3023-89D7-CE5CF92BEB30}"/>
          </ac:spMkLst>
        </pc:spChg>
        <pc:spChg chg="add">
          <ac:chgData name="Yates, Rob A." userId="S::raya228@uky.edu::c4835988-b912-40a4-bf56-31a2afc86d77" providerId="AD" clId="Web-{0CC3DE7B-5279-3B29-9775-114C9D57E971}" dt="2023-07-20T14:13:10.793" v="338"/>
          <ac:spMkLst>
            <pc:docMk/>
            <pc:sldMk cId="0" sldId="268"/>
            <ac:spMk id="46" creationId="{BB903990-4029-1E8D-6C6D-B6A67A6BC6C4}"/>
          </ac:spMkLst>
        </pc:spChg>
        <pc:spChg chg="add">
          <ac:chgData name="Yates, Rob A." userId="S::raya228@uky.edu::c4835988-b912-40a4-bf56-31a2afc86d77" providerId="AD" clId="Web-{0CC3DE7B-5279-3B29-9775-114C9D57E971}" dt="2023-07-20T14:13:10.808" v="339"/>
          <ac:spMkLst>
            <pc:docMk/>
            <pc:sldMk cId="0" sldId="268"/>
            <ac:spMk id="48" creationId="{6E58CC5A-9671-FBCA-8252-5675BB9A113D}"/>
          </ac:spMkLst>
        </pc:spChg>
        <pc:spChg chg="add">
          <ac:chgData name="Yates, Rob A." userId="S::raya228@uky.edu::c4835988-b912-40a4-bf56-31a2afc86d77" providerId="AD" clId="Web-{0CC3DE7B-5279-3B29-9775-114C9D57E971}" dt="2023-07-20T14:13:10.808" v="340"/>
          <ac:spMkLst>
            <pc:docMk/>
            <pc:sldMk cId="0" sldId="268"/>
            <ac:spMk id="50" creationId="{D7CE46A2-E6DC-631E-7903-7A0E6A700122}"/>
          </ac:spMkLst>
        </pc:spChg>
        <pc:spChg chg="add">
          <ac:chgData name="Yates, Rob A." userId="S::raya228@uky.edu::c4835988-b912-40a4-bf56-31a2afc86d77" providerId="AD" clId="Web-{0CC3DE7B-5279-3B29-9775-114C9D57E971}" dt="2023-07-20T14:13:10.824" v="341"/>
          <ac:spMkLst>
            <pc:docMk/>
            <pc:sldMk cId="0" sldId="268"/>
            <ac:spMk id="52" creationId="{10B2BE3F-9A22-2823-A278-C60148FD9B2C}"/>
          </ac:spMkLst>
        </pc:spChg>
        <pc:spChg chg="add">
          <ac:chgData name="Yates, Rob A." userId="S::raya228@uky.edu::c4835988-b912-40a4-bf56-31a2afc86d77" providerId="AD" clId="Web-{0CC3DE7B-5279-3B29-9775-114C9D57E971}" dt="2023-07-20T14:13:10.840" v="342"/>
          <ac:spMkLst>
            <pc:docMk/>
            <pc:sldMk cId="0" sldId="268"/>
            <ac:spMk id="54" creationId="{FA5EC4D9-71FB-0F78-FBF9-C9D4EA2D2EB0}"/>
          </ac:spMkLst>
        </pc:spChg>
        <pc:spChg chg="add">
          <ac:chgData name="Yates, Rob A." userId="S::raya228@uky.edu::c4835988-b912-40a4-bf56-31a2afc86d77" providerId="AD" clId="Web-{0CC3DE7B-5279-3B29-9775-114C9D57E971}" dt="2023-07-20T14:13:10.855" v="343"/>
          <ac:spMkLst>
            <pc:docMk/>
            <pc:sldMk cId="0" sldId="268"/>
            <ac:spMk id="56" creationId="{40704526-D665-17D2-8638-5BA9282EDCA0}"/>
          </ac:spMkLst>
        </pc:spChg>
        <pc:spChg chg="add">
          <ac:chgData name="Yates, Rob A." userId="S::raya228@uky.edu::c4835988-b912-40a4-bf56-31a2afc86d77" providerId="AD" clId="Web-{0CC3DE7B-5279-3B29-9775-114C9D57E971}" dt="2023-07-20T14:13:10.855" v="344"/>
          <ac:spMkLst>
            <pc:docMk/>
            <pc:sldMk cId="0" sldId="268"/>
            <ac:spMk id="58" creationId="{852E2C6D-C63D-5603-1356-A0FE9C101B75}"/>
          </ac:spMkLst>
        </pc:spChg>
        <pc:spChg chg="add">
          <ac:chgData name="Yates, Rob A." userId="S::raya228@uky.edu::c4835988-b912-40a4-bf56-31a2afc86d77" providerId="AD" clId="Web-{0CC3DE7B-5279-3B29-9775-114C9D57E971}" dt="2023-07-20T14:13:10.871" v="345"/>
          <ac:spMkLst>
            <pc:docMk/>
            <pc:sldMk cId="0" sldId="268"/>
            <ac:spMk id="60" creationId="{8D858026-7902-C4EB-30C7-FAD7AB77D2C0}"/>
          </ac:spMkLst>
        </pc:spChg>
      </pc:sldChg>
      <pc:sldChg chg="addSp delSp">
        <pc:chgData name="Yates, Rob A." userId="S::raya228@uky.edu::c4835988-b912-40a4-bf56-31a2afc86d77" providerId="AD" clId="Web-{0CC3DE7B-5279-3B29-9775-114C9D57E971}" dt="2023-07-20T14:15:31.124" v="413"/>
        <pc:sldMkLst>
          <pc:docMk/>
          <pc:sldMk cId="0" sldId="269"/>
        </pc:sldMkLst>
        <pc:spChg chg="del">
          <ac:chgData name="Yates, Rob A." userId="S::raya228@uky.edu::c4835988-b912-40a4-bf56-31a2afc86d77" providerId="AD" clId="Web-{0CC3DE7B-5279-3B29-9775-114C9D57E971}" dt="2023-07-20T14:15:27.937" v="397"/>
          <ac:spMkLst>
            <pc:docMk/>
            <pc:sldMk cId="0" sldId="269"/>
            <ac:spMk id="4" creationId="{00000000-0000-0000-0000-000000000000}"/>
          </ac:spMkLst>
        </pc:spChg>
        <pc:spChg chg="del">
          <ac:chgData name="Yates, Rob A." userId="S::raya228@uky.edu::c4835988-b912-40a4-bf56-31a2afc86d77" providerId="AD" clId="Web-{0CC3DE7B-5279-3B29-9775-114C9D57E971}" dt="2023-07-20T14:15:27.937" v="396"/>
          <ac:spMkLst>
            <pc:docMk/>
            <pc:sldMk cId="0" sldId="269"/>
            <ac:spMk id="5" creationId="{00000000-0000-0000-0000-000000000000}"/>
          </ac:spMkLst>
        </pc:spChg>
        <pc:spChg chg="del">
          <ac:chgData name="Yates, Rob A." userId="S::raya228@uky.edu::c4835988-b912-40a4-bf56-31a2afc86d77" providerId="AD" clId="Web-{0CC3DE7B-5279-3B29-9775-114C9D57E971}" dt="2023-07-20T14:15:27.937" v="395"/>
          <ac:spMkLst>
            <pc:docMk/>
            <pc:sldMk cId="0" sldId="269"/>
            <ac:spMk id="8" creationId="{00000000-0000-0000-0000-000000000000}"/>
          </ac:spMkLst>
        </pc:spChg>
        <pc:spChg chg="del">
          <ac:chgData name="Yates, Rob A." userId="S::raya228@uky.edu::c4835988-b912-40a4-bf56-31a2afc86d77" providerId="AD" clId="Web-{0CC3DE7B-5279-3B29-9775-114C9D57E971}" dt="2023-07-20T14:15:27.937" v="394"/>
          <ac:spMkLst>
            <pc:docMk/>
            <pc:sldMk cId="0" sldId="269"/>
            <ac:spMk id="9" creationId="{00000000-0000-0000-0000-000000000000}"/>
          </ac:spMkLst>
        </pc:spChg>
        <pc:spChg chg="del">
          <ac:chgData name="Yates, Rob A." userId="S::raya228@uky.edu::c4835988-b912-40a4-bf56-31a2afc86d77" providerId="AD" clId="Web-{0CC3DE7B-5279-3B29-9775-114C9D57E971}" dt="2023-07-20T14:15:27.937" v="393"/>
          <ac:spMkLst>
            <pc:docMk/>
            <pc:sldMk cId="0" sldId="269"/>
            <ac:spMk id="13" creationId="{00000000-0000-0000-0000-000000000000}"/>
          </ac:spMkLst>
        </pc:spChg>
        <pc:spChg chg="del">
          <ac:chgData name="Yates, Rob A." userId="S::raya228@uky.edu::c4835988-b912-40a4-bf56-31a2afc86d77" providerId="AD" clId="Web-{0CC3DE7B-5279-3B29-9775-114C9D57E971}" dt="2023-07-20T14:15:27.937" v="392"/>
          <ac:spMkLst>
            <pc:docMk/>
            <pc:sldMk cId="0" sldId="269"/>
            <ac:spMk id="14" creationId="{00000000-0000-0000-0000-000000000000}"/>
          </ac:spMkLst>
        </pc:spChg>
        <pc:spChg chg="del">
          <ac:chgData name="Yates, Rob A." userId="S::raya228@uky.edu::c4835988-b912-40a4-bf56-31a2afc86d77" providerId="AD" clId="Web-{0CC3DE7B-5279-3B29-9775-114C9D57E971}" dt="2023-07-20T14:15:27.937" v="391"/>
          <ac:spMkLst>
            <pc:docMk/>
            <pc:sldMk cId="0" sldId="269"/>
            <ac:spMk id="18" creationId="{00000000-0000-0000-0000-000000000000}"/>
          </ac:spMkLst>
        </pc:spChg>
        <pc:spChg chg="del">
          <ac:chgData name="Yates, Rob A." userId="S::raya228@uky.edu::c4835988-b912-40a4-bf56-31a2afc86d77" providerId="AD" clId="Web-{0CC3DE7B-5279-3B29-9775-114C9D57E971}" dt="2023-07-20T14:15:27.937" v="390"/>
          <ac:spMkLst>
            <pc:docMk/>
            <pc:sldMk cId="0" sldId="269"/>
            <ac:spMk id="19" creationId="{00000000-0000-0000-0000-000000000000}"/>
          </ac:spMkLst>
        </pc:spChg>
        <pc:spChg chg="del">
          <ac:chgData name="Yates, Rob A." userId="S::raya228@uky.edu::c4835988-b912-40a4-bf56-31a2afc86d77" providerId="AD" clId="Web-{0CC3DE7B-5279-3B29-9775-114C9D57E971}" dt="2023-07-20T14:15:27.937" v="389"/>
          <ac:spMkLst>
            <pc:docMk/>
            <pc:sldMk cId="0" sldId="269"/>
            <ac:spMk id="21" creationId="{310FDCF2-7A98-43DB-3148-EC5741C10466}"/>
          </ac:spMkLst>
        </pc:spChg>
        <pc:spChg chg="del">
          <ac:chgData name="Yates, Rob A." userId="S::raya228@uky.edu::c4835988-b912-40a4-bf56-31a2afc86d77" providerId="AD" clId="Web-{0CC3DE7B-5279-3B29-9775-114C9D57E971}" dt="2023-07-20T14:15:27.937" v="388"/>
          <ac:spMkLst>
            <pc:docMk/>
            <pc:sldMk cId="0" sldId="269"/>
            <ac:spMk id="22" creationId="{B1B9F620-3522-DFF0-BEF7-4B93BE20EFD1}"/>
          </ac:spMkLst>
        </pc:spChg>
        <pc:spChg chg="del">
          <ac:chgData name="Yates, Rob A." userId="S::raya228@uky.edu::c4835988-b912-40a4-bf56-31a2afc86d77" providerId="AD" clId="Web-{0CC3DE7B-5279-3B29-9775-114C9D57E971}" dt="2023-07-20T14:15:27.937" v="387"/>
          <ac:spMkLst>
            <pc:docMk/>
            <pc:sldMk cId="0" sldId="269"/>
            <ac:spMk id="23" creationId="{436E5165-D667-147F-BB69-7CA95FB57B1B}"/>
          </ac:spMkLst>
        </pc:spChg>
        <pc:spChg chg="del">
          <ac:chgData name="Yates, Rob A." userId="S::raya228@uky.edu::c4835988-b912-40a4-bf56-31a2afc86d77" providerId="AD" clId="Web-{0CC3DE7B-5279-3B29-9775-114C9D57E971}" dt="2023-07-20T14:15:27.937" v="386"/>
          <ac:spMkLst>
            <pc:docMk/>
            <pc:sldMk cId="0" sldId="269"/>
            <ac:spMk id="24" creationId="{14C4E362-F1C4-4663-9944-79BCE0A133EB}"/>
          </ac:spMkLst>
        </pc:spChg>
        <pc:spChg chg="del">
          <ac:chgData name="Yates, Rob A." userId="S::raya228@uky.edu::c4835988-b912-40a4-bf56-31a2afc86d77" providerId="AD" clId="Web-{0CC3DE7B-5279-3B29-9775-114C9D57E971}" dt="2023-07-20T14:15:27.937" v="385"/>
          <ac:spMkLst>
            <pc:docMk/>
            <pc:sldMk cId="0" sldId="269"/>
            <ac:spMk id="25" creationId="{743EA0C2-DA68-8668-216E-11D20A257B17}"/>
          </ac:spMkLst>
        </pc:spChg>
        <pc:spChg chg="del">
          <ac:chgData name="Yates, Rob A." userId="S::raya228@uky.edu::c4835988-b912-40a4-bf56-31a2afc86d77" providerId="AD" clId="Web-{0CC3DE7B-5279-3B29-9775-114C9D57E971}" dt="2023-07-20T14:15:27.937" v="384"/>
          <ac:spMkLst>
            <pc:docMk/>
            <pc:sldMk cId="0" sldId="269"/>
            <ac:spMk id="26" creationId="{BB15AFF9-0033-4CC8-F525-D50D2AC21533}"/>
          </ac:spMkLst>
        </pc:spChg>
        <pc:spChg chg="del">
          <ac:chgData name="Yates, Rob A." userId="S::raya228@uky.edu::c4835988-b912-40a4-bf56-31a2afc86d77" providerId="AD" clId="Web-{0CC3DE7B-5279-3B29-9775-114C9D57E971}" dt="2023-07-20T14:15:27.937" v="383"/>
          <ac:spMkLst>
            <pc:docMk/>
            <pc:sldMk cId="0" sldId="269"/>
            <ac:spMk id="27" creationId="{1A596F21-3311-8C29-9149-BF698195438B}"/>
          </ac:spMkLst>
        </pc:spChg>
        <pc:spChg chg="del">
          <ac:chgData name="Yates, Rob A." userId="S::raya228@uky.edu::c4835988-b912-40a4-bf56-31a2afc86d77" providerId="AD" clId="Web-{0CC3DE7B-5279-3B29-9775-114C9D57E971}" dt="2023-07-20T14:15:27.937" v="382"/>
          <ac:spMkLst>
            <pc:docMk/>
            <pc:sldMk cId="0" sldId="269"/>
            <ac:spMk id="28" creationId="{B81C94B3-2699-FCB4-CF0E-85A4A6009482}"/>
          </ac:spMkLst>
        </pc:spChg>
        <pc:spChg chg="add">
          <ac:chgData name="Yates, Rob A." userId="S::raya228@uky.edu::c4835988-b912-40a4-bf56-31a2afc86d77" providerId="AD" clId="Web-{0CC3DE7B-5279-3B29-9775-114C9D57E971}" dt="2023-07-20T14:15:30.968" v="398"/>
          <ac:spMkLst>
            <pc:docMk/>
            <pc:sldMk cId="0" sldId="269"/>
            <ac:spMk id="30" creationId="{F2E2AAE9-DB88-C767-A4C0-14AF41570265}"/>
          </ac:spMkLst>
        </pc:spChg>
        <pc:spChg chg="add">
          <ac:chgData name="Yates, Rob A." userId="S::raya228@uky.edu::c4835988-b912-40a4-bf56-31a2afc86d77" providerId="AD" clId="Web-{0CC3DE7B-5279-3B29-9775-114C9D57E971}" dt="2023-07-20T14:15:30.968" v="399"/>
          <ac:spMkLst>
            <pc:docMk/>
            <pc:sldMk cId="0" sldId="269"/>
            <ac:spMk id="32" creationId="{44954AFB-1BAF-D06C-A605-8543BF38489D}"/>
          </ac:spMkLst>
        </pc:spChg>
        <pc:spChg chg="add">
          <ac:chgData name="Yates, Rob A." userId="S::raya228@uky.edu::c4835988-b912-40a4-bf56-31a2afc86d77" providerId="AD" clId="Web-{0CC3DE7B-5279-3B29-9775-114C9D57E971}" dt="2023-07-20T14:15:30.984" v="400"/>
          <ac:spMkLst>
            <pc:docMk/>
            <pc:sldMk cId="0" sldId="269"/>
            <ac:spMk id="34" creationId="{C354770A-32CD-E22F-2767-26B9F9AE5321}"/>
          </ac:spMkLst>
        </pc:spChg>
        <pc:spChg chg="add">
          <ac:chgData name="Yates, Rob A." userId="S::raya228@uky.edu::c4835988-b912-40a4-bf56-31a2afc86d77" providerId="AD" clId="Web-{0CC3DE7B-5279-3B29-9775-114C9D57E971}" dt="2023-07-20T14:15:30.984" v="401"/>
          <ac:spMkLst>
            <pc:docMk/>
            <pc:sldMk cId="0" sldId="269"/>
            <ac:spMk id="36" creationId="{5858D5D1-3344-9618-0582-527D62B663B0}"/>
          </ac:spMkLst>
        </pc:spChg>
        <pc:spChg chg="add">
          <ac:chgData name="Yates, Rob A." userId="S::raya228@uky.edu::c4835988-b912-40a4-bf56-31a2afc86d77" providerId="AD" clId="Web-{0CC3DE7B-5279-3B29-9775-114C9D57E971}" dt="2023-07-20T14:15:30.999" v="402"/>
          <ac:spMkLst>
            <pc:docMk/>
            <pc:sldMk cId="0" sldId="269"/>
            <ac:spMk id="38" creationId="{8160DCFA-EE51-0148-EEAF-ED9626BC1498}"/>
          </ac:spMkLst>
        </pc:spChg>
        <pc:spChg chg="add">
          <ac:chgData name="Yates, Rob A." userId="S::raya228@uky.edu::c4835988-b912-40a4-bf56-31a2afc86d77" providerId="AD" clId="Web-{0CC3DE7B-5279-3B29-9775-114C9D57E971}" dt="2023-07-20T14:15:30.999" v="403"/>
          <ac:spMkLst>
            <pc:docMk/>
            <pc:sldMk cId="0" sldId="269"/>
            <ac:spMk id="40" creationId="{08CE5F4B-0FDA-768C-6B8B-E7580B722655}"/>
          </ac:spMkLst>
        </pc:spChg>
        <pc:spChg chg="add">
          <ac:chgData name="Yates, Rob A." userId="S::raya228@uky.edu::c4835988-b912-40a4-bf56-31a2afc86d77" providerId="AD" clId="Web-{0CC3DE7B-5279-3B29-9775-114C9D57E971}" dt="2023-07-20T14:15:31.015" v="404"/>
          <ac:spMkLst>
            <pc:docMk/>
            <pc:sldMk cId="0" sldId="269"/>
            <ac:spMk id="42" creationId="{E61F50F6-6386-52EB-CC18-F132A001D35E}"/>
          </ac:spMkLst>
        </pc:spChg>
        <pc:spChg chg="add">
          <ac:chgData name="Yates, Rob A." userId="S::raya228@uky.edu::c4835988-b912-40a4-bf56-31a2afc86d77" providerId="AD" clId="Web-{0CC3DE7B-5279-3B29-9775-114C9D57E971}" dt="2023-07-20T14:15:31.030" v="405"/>
          <ac:spMkLst>
            <pc:docMk/>
            <pc:sldMk cId="0" sldId="269"/>
            <ac:spMk id="44" creationId="{563CF890-50D7-5875-B362-2B5C82855CCB}"/>
          </ac:spMkLst>
        </pc:spChg>
        <pc:spChg chg="add">
          <ac:chgData name="Yates, Rob A." userId="S::raya228@uky.edu::c4835988-b912-40a4-bf56-31a2afc86d77" providerId="AD" clId="Web-{0CC3DE7B-5279-3B29-9775-114C9D57E971}" dt="2023-07-20T14:15:31.030" v="406"/>
          <ac:spMkLst>
            <pc:docMk/>
            <pc:sldMk cId="0" sldId="269"/>
            <ac:spMk id="46" creationId="{3D725F10-DB46-E806-3231-568D616CF579}"/>
          </ac:spMkLst>
        </pc:spChg>
        <pc:spChg chg="add">
          <ac:chgData name="Yates, Rob A." userId="S::raya228@uky.edu::c4835988-b912-40a4-bf56-31a2afc86d77" providerId="AD" clId="Web-{0CC3DE7B-5279-3B29-9775-114C9D57E971}" dt="2023-07-20T14:15:31.046" v="407"/>
          <ac:spMkLst>
            <pc:docMk/>
            <pc:sldMk cId="0" sldId="269"/>
            <ac:spMk id="48" creationId="{B2F3F02E-713C-CD2B-B4F8-7CEBB079EE3A}"/>
          </ac:spMkLst>
        </pc:spChg>
        <pc:spChg chg="add">
          <ac:chgData name="Yates, Rob A." userId="S::raya228@uky.edu::c4835988-b912-40a4-bf56-31a2afc86d77" providerId="AD" clId="Web-{0CC3DE7B-5279-3B29-9775-114C9D57E971}" dt="2023-07-20T14:15:31.062" v="408"/>
          <ac:spMkLst>
            <pc:docMk/>
            <pc:sldMk cId="0" sldId="269"/>
            <ac:spMk id="50" creationId="{8BD7E0AF-0320-CA41-269D-11EC609463A7}"/>
          </ac:spMkLst>
        </pc:spChg>
        <pc:spChg chg="add">
          <ac:chgData name="Yates, Rob A." userId="S::raya228@uky.edu::c4835988-b912-40a4-bf56-31a2afc86d77" providerId="AD" clId="Web-{0CC3DE7B-5279-3B29-9775-114C9D57E971}" dt="2023-07-20T14:15:31.077" v="409"/>
          <ac:spMkLst>
            <pc:docMk/>
            <pc:sldMk cId="0" sldId="269"/>
            <ac:spMk id="52" creationId="{A7C28D38-B521-4D76-3777-427AB442256C}"/>
          </ac:spMkLst>
        </pc:spChg>
        <pc:spChg chg="add">
          <ac:chgData name="Yates, Rob A." userId="S::raya228@uky.edu::c4835988-b912-40a4-bf56-31a2afc86d77" providerId="AD" clId="Web-{0CC3DE7B-5279-3B29-9775-114C9D57E971}" dt="2023-07-20T14:15:31.077" v="410"/>
          <ac:spMkLst>
            <pc:docMk/>
            <pc:sldMk cId="0" sldId="269"/>
            <ac:spMk id="54" creationId="{B7B55AB6-F3B0-124A-968B-E780626AC44F}"/>
          </ac:spMkLst>
        </pc:spChg>
        <pc:spChg chg="add">
          <ac:chgData name="Yates, Rob A." userId="S::raya228@uky.edu::c4835988-b912-40a4-bf56-31a2afc86d77" providerId="AD" clId="Web-{0CC3DE7B-5279-3B29-9775-114C9D57E971}" dt="2023-07-20T14:15:31.093" v="411"/>
          <ac:spMkLst>
            <pc:docMk/>
            <pc:sldMk cId="0" sldId="269"/>
            <ac:spMk id="56" creationId="{CC8EC5D7-152F-96EE-9F72-62D5911BB222}"/>
          </ac:spMkLst>
        </pc:spChg>
        <pc:spChg chg="add">
          <ac:chgData name="Yates, Rob A." userId="S::raya228@uky.edu::c4835988-b912-40a4-bf56-31a2afc86d77" providerId="AD" clId="Web-{0CC3DE7B-5279-3B29-9775-114C9D57E971}" dt="2023-07-20T14:15:31.109" v="412"/>
          <ac:spMkLst>
            <pc:docMk/>
            <pc:sldMk cId="0" sldId="269"/>
            <ac:spMk id="58" creationId="{7EB79180-F741-908E-BAE8-E4CEF85E5F86}"/>
          </ac:spMkLst>
        </pc:spChg>
        <pc:spChg chg="add">
          <ac:chgData name="Yates, Rob A." userId="S::raya228@uky.edu::c4835988-b912-40a4-bf56-31a2afc86d77" providerId="AD" clId="Web-{0CC3DE7B-5279-3B29-9775-114C9D57E971}" dt="2023-07-20T14:15:31.124" v="413"/>
          <ac:spMkLst>
            <pc:docMk/>
            <pc:sldMk cId="0" sldId="269"/>
            <ac:spMk id="60" creationId="{FBE4AFCB-BBCC-5211-53EA-C5C60BC59DA2}"/>
          </ac:spMkLst>
        </pc:spChg>
      </pc:sldChg>
      <pc:sldChg chg="addSp delSp">
        <pc:chgData name="Yates, Rob A." userId="S::raya228@uky.edu::c4835988-b912-40a4-bf56-31a2afc86d77" providerId="AD" clId="Web-{0CC3DE7B-5279-3B29-9775-114C9D57E971}" dt="2023-07-20T14:14:46.014" v="381"/>
        <pc:sldMkLst>
          <pc:docMk/>
          <pc:sldMk cId="0" sldId="270"/>
        </pc:sldMkLst>
        <pc:spChg chg="del">
          <ac:chgData name="Yates, Rob A." userId="S::raya228@uky.edu::c4835988-b912-40a4-bf56-31a2afc86d77" providerId="AD" clId="Web-{0CC3DE7B-5279-3B29-9775-114C9D57E971}" dt="2023-07-20T14:14:39.826" v="364"/>
          <ac:spMkLst>
            <pc:docMk/>
            <pc:sldMk cId="0" sldId="270"/>
            <ac:spMk id="4" creationId="{00000000-0000-0000-0000-000000000000}"/>
          </ac:spMkLst>
        </pc:spChg>
        <pc:spChg chg="del">
          <ac:chgData name="Yates, Rob A." userId="S::raya228@uky.edu::c4835988-b912-40a4-bf56-31a2afc86d77" providerId="AD" clId="Web-{0CC3DE7B-5279-3B29-9775-114C9D57E971}" dt="2023-07-20T14:14:39.826" v="363"/>
          <ac:spMkLst>
            <pc:docMk/>
            <pc:sldMk cId="0" sldId="270"/>
            <ac:spMk id="5" creationId="{00000000-0000-0000-0000-000000000000}"/>
          </ac:spMkLst>
        </pc:spChg>
        <pc:spChg chg="del">
          <ac:chgData name="Yates, Rob A." userId="S::raya228@uky.edu::c4835988-b912-40a4-bf56-31a2afc86d77" providerId="AD" clId="Web-{0CC3DE7B-5279-3B29-9775-114C9D57E971}" dt="2023-07-20T14:14:39.826" v="362"/>
          <ac:spMkLst>
            <pc:docMk/>
            <pc:sldMk cId="0" sldId="270"/>
            <ac:spMk id="8" creationId="{00000000-0000-0000-0000-000000000000}"/>
          </ac:spMkLst>
        </pc:spChg>
        <pc:spChg chg="del">
          <ac:chgData name="Yates, Rob A." userId="S::raya228@uky.edu::c4835988-b912-40a4-bf56-31a2afc86d77" providerId="AD" clId="Web-{0CC3DE7B-5279-3B29-9775-114C9D57E971}" dt="2023-07-20T14:14:39.826" v="361"/>
          <ac:spMkLst>
            <pc:docMk/>
            <pc:sldMk cId="0" sldId="270"/>
            <ac:spMk id="9" creationId="{00000000-0000-0000-0000-000000000000}"/>
          </ac:spMkLst>
        </pc:spChg>
        <pc:spChg chg="del">
          <ac:chgData name="Yates, Rob A." userId="S::raya228@uky.edu::c4835988-b912-40a4-bf56-31a2afc86d77" providerId="AD" clId="Web-{0CC3DE7B-5279-3B29-9775-114C9D57E971}" dt="2023-07-20T14:14:39.826" v="360"/>
          <ac:spMkLst>
            <pc:docMk/>
            <pc:sldMk cId="0" sldId="270"/>
            <ac:spMk id="13" creationId="{00000000-0000-0000-0000-000000000000}"/>
          </ac:spMkLst>
        </pc:spChg>
        <pc:spChg chg="del">
          <ac:chgData name="Yates, Rob A." userId="S::raya228@uky.edu::c4835988-b912-40a4-bf56-31a2afc86d77" providerId="AD" clId="Web-{0CC3DE7B-5279-3B29-9775-114C9D57E971}" dt="2023-07-20T14:14:39.826" v="359"/>
          <ac:spMkLst>
            <pc:docMk/>
            <pc:sldMk cId="0" sldId="270"/>
            <ac:spMk id="14" creationId="{00000000-0000-0000-0000-000000000000}"/>
          </ac:spMkLst>
        </pc:spChg>
        <pc:spChg chg="del">
          <ac:chgData name="Yates, Rob A." userId="S::raya228@uky.edu::c4835988-b912-40a4-bf56-31a2afc86d77" providerId="AD" clId="Web-{0CC3DE7B-5279-3B29-9775-114C9D57E971}" dt="2023-07-20T14:14:42.264" v="365"/>
          <ac:spMkLst>
            <pc:docMk/>
            <pc:sldMk cId="0" sldId="270"/>
            <ac:spMk id="18" creationId="{00000000-0000-0000-0000-000000000000}"/>
          </ac:spMkLst>
        </pc:spChg>
        <pc:spChg chg="del">
          <ac:chgData name="Yates, Rob A." userId="S::raya228@uky.edu::c4835988-b912-40a4-bf56-31a2afc86d77" providerId="AD" clId="Web-{0CC3DE7B-5279-3B29-9775-114C9D57E971}" dt="2023-07-20T14:14:39.826" v="358"/>
          <ac:spMkLst>
            <pc:docMk/>
            <pc:sldMk cId="0" sldId="270"/>
            <ac:spMk id="19" creationId="{00000000-0000-0000-0000-000000000000}"/>
          </ac:spMkLst>
        </pc:spChg>
        <pc:spChg chg="del">
          <ac:chgData name="Yates, Rob A." userId="S::raya228@uky.edu::c4835988-b912-40a4-bf56-31a2afc86d77" providerId="AD" clId="Web-{0CC3DE7B-5279-3B29-9775-114C9D57E971}" dt="2023-07-20T14:14:39.826" v="357"/>
          <ac:spMkLst>
            <pc:docMk/>
            <pc:sldMk cId="0" sldId="270"/>
            <ac:spMk id="21" creationId="{A5752B08-9D48-F42C-6A8D-04068737BEF6}"/>
          </ac:spMkLst>
        </pc:spChg>
        <pc:spChg chg="del">
          <ac:chgData name="Yates, Rob A." userId="S::raya228@uky.edu::c4835988-b912-40a4-bf56-31a2afc86d77" providerId="AD" clId="Web-{0CC3DE7B-5279-3B29-9775-114C9D57E971}" dt="2023-07-20T14:14:39.826" v="356"/>
          <ac:spMkLst>
            <pc:docMk/>
            <pc:sldMk cId="0" sldId="270"/>
            <ac:spMk id="22" creationId="{DBF67FFE-2DB2-CAD9-400C-7CC4A5283D33}"/>
          </ac:spMkLst>
        </pc:spChg>
        <pc:spChg chg="del">
          <ac:chgData name="Yates, Rob A." userId="S::raya228@uky.edu::c4835988-b912-40a4-bf56-31a2afc86d77" providerId="AD" clId="Web-{0CC3DE7B-5279-3B29-9775-114C9D57E971}" dt="2023-07-20T14:14:39.826" v="355"/>
          <ac:spMkLst>
            <pc:docMk/>
            <pc:sldMk cId="0" sldId="270"/>
            <ac:spMk id="23" creationId="{64721676-08A5-F117-6F12-FAAE68B3CE23}"/>
          </ac:spMkLst>
        </pc:spChg>
        <pc:spChg chg="del">
          <ac:chgData name="Yates, Rob A." userId="S::raya228@uky.edu::c4835988-b912-40a4-bf56-31a2afc86d77" providerId="AD" clId="Web-{0CC3DE7B-5279-3B29-9775-114C9D57E971}" dt="2023-07-20T14:14:39.826" v="354"/>
          <ac:spMkLst>
            <pc:docMk/>
            <pc:sldMk cId="0" sldId="270"/>
            <ac:spMk id="24" creationId="{B867699F-47C2-0C37-B98E-F3BE3C50B244}"/>
          </ac:spMkLst>
        </pc:spChg>
        <pc:spChg chg="del">
          <ac:chgData name="Yates, Rob A." userId="S::raya228@uky.edu::c4835988-b912-40a4-bf56-31a2afc86d77" providerId="AD" clId="Web-{0CC3DE7B-5279-3B29-9775-114C9D57E971}" dt="2023-07-20T14:14:39.826" v="353"/>
          <ac:spMkLst>
            <pc:docMk/>
            <pc:sldMk cId="0" sldId="270"/>
            <ac:spMk id="25" creationId="{84E7709F-E73B-1023-1DAC-84652D61B822}"/>
          </ac:spMkLst>
        </pc:spChg>
        <pc:spChg chg="del">
          <ac:chgData name="Yates, Rob A." userId="S::raya228@uky.edu::c4835988-b912-40a4-bf56-31a2afc86d77" providerId="AD" clId="Web-{0CC3DE7B-5279-3B29-9775-114C9D57E971}" dt="2023-07-20T14:14:39.826" v="352"/>
          <ac:spMkLst>
            <pc:docMk/>
            <pc:sldMk cId="0" sldId="270"/>
            <ac:spMk id="26" creationId="{B04F297E-FBE9-8626-F2CB-535C9A954A91}"/>
          </ac:spMkLst>
        </pc:spChg>
        <pc:spChg chg="del">
          <ac:chgData name="Yates, Rob A." userId="S::raya228@uky.edu::c4835988-b912-40a4-bf56-31a2afc86d77" providerId="AD" clId="Web-{0CC3DE7B-5279-3B29-9775-114C9D57E971}" dt="2023-07-20T14:14:39.826" v="351"/>
          <ac:spMkLst>
            <pc:docMk/>
            <pc:sldMk cId="0" sldId="270"/>
            <ac:spMk id="27" creationId="{92569A45-4069-0C64-F3A8-1CB5FACE509B}"/>
          </ac:spMkLst>
        </pc:spChg>
        <pc:spChg chg="del">
          <ac:chgData name="Yates, Rob A." userId="S::raya228@uky.edu::c4835988-b912-40a4-bf56-31a2afc86d77" providerId="AD" clId="Web-{0CC3DE7B-5279-3B29-9775-114C9D57E971}" dt="2023-07-20T14:14:39.826" v="350"/>
          <ac:spMkLst>
            <pc:docMk/>
            <pc:sldMk cId="0" sldId="270"/>
            <ac:spMk id="28" creationId="{75F84C8D-870D-208D-168E-EA415CC30732}"/>
          </ac:spMkLst>
        </pc:spChg>
        <pc:spChg chg="add">
          <ac:chgData name="Yates, Rob A." userId="S::raya228@uky.edu::c4835988-b912-40a4-bf56-31a2afc86d77" providerId="AD" clId="Web-{0CC3DE7B-5279-3B29-9775-114C9D57E971}" dt="2023-07-20T14:14:45.842" v="366"/>
          <ac:spMkLst>
            <pc:docMk/>
            <pc:sldMk cId="0" sldId="270"/>
            <ac:spMk id="30" creationId="{A3627BD1-53C6-9817-85FD-12055CAAEAE9}"/>
          </ac:spMkLst>
        </pc:spChg>
        <pc:spChg chg="add">
          <ac:chgData name="Yates, Rob A." userId="S::raya228@uky.edu::c4835988-b912-40a4-bf56-31a2afc86d77" providerId="AD" clId="Web-{0CC3DE7B-5279-3B29-9775-114C9D57E971}" dt="2023-07-20T14:14:45.858" v="367"/>
          <ac:spMkLst>
            <pc:docMk/>
            <pc:sldMk cId="0" sldId="270"/>
            <ac:spMk id="32" creationId="{A6567AC3-B7C1-345B-C13C-6BA2034C66BD}"/>
          </ac:spMkLst>
        </pc:spChg>
        <pc:spChg chg="add">
          <ac:chgData name="Yates, Rob A." userId="S::raya228@uky.edu::c4835988-b912-40a4-bf56-31a2afc86d77" providerId="AD" clId="Web-{0CC3DE7B-5279-3B29-9775-114C9D57E971}" dt="2023-07-20T14:14:45.873" v="368"/>
          <ac:spMkLst>
            <pc:docMk/>
            <pc:sldMk cId="0" sldId="270"/>
            <ac:spMk id="34" creationId="{BEB8D54E-9F5D-0B4C-98D4-6D1207CD0212}"/>
          </ac:spMkLst>
        </pc:spChg>
        <pc:spChg chg="add">
          <ac:chgData name="Yates, Rob A." userId="S::raya228@uky.edu::c4835988-b912-40a4-bf56-31a2afc86d77" providerId="AD" clId="Web-{0CC3DE7B-5279-3B29-9775-114C9D57E971}" dt="2023-07-20T14:14:45.873" v="369"/>
          <ac:spMkLst>
            <pc:docMk/>
            <pc:sldMk cId="0" sldId="270"/>
            <ac:spMk id="36" creationId="{99C15B5F-EA77-4667-A4FE-317923E37914}"/>
          </ac:spMkLst>
        </pc:spChg>
        <pc:spChg chg="add">
          <ac:chgData name="Yates, Rob A." userId="S::raya228@uky.edu::c4835988-b912-40a4-bf56-31a2afc86d77" providerId="AD" clId="Web-{0CC3DE7B-5279-3B29-9775-114C9D57E971}" dt="2023-07-20T14:14:45.889" v="370"/>
          <ac:spMkLst>
            <pc:docMk/>
            <pc:sldMk cId="0" sldId="270"/>
            <ac:spMk id="38" creationId="{6BB1562E-2A0E-2ADC-EABB-D11FA582691F}"/>
          </ac:spMkLst>
        </pc:spChg>
        <pc:spChg chg="add">
          <ac:chgData name="Yates, Rob A." userId="S::raya228@uky.edu::c4835988-b912-40a4-bf56-31a2afc86d77" providerId="AD" clId="Web-{0CC3DE7B-5279-3B29-9775-114C9D57E971}" dt="2023-07-20T14:14:45.889" v="371"/>
          <ac:spMkLst>
            <pc:docMk/>
            <pc:sldMk cId="0" sldId="270"/>
            <ac:spMk id="40" creationId="{CF94B4F6-48F8-8D4C-A667-8C19A30FF968}"/>
          </ac:spMkLst>
        </pc:spChg>
        <pc:spChg chg="add">
          <ac:chgData name="Yates, Rob A." userId="S::raya228@uky.edu::c4835988-b912-40a4-bf56-31a2afc86d77" providerId="AD" clId="Web-{0CC3DE7B-5279-3B29-9775-114C9D57E971}" dt="2023-07-20T14:14:45.904" v="372"/>
          <ac:spMkLst>
            <pc:docMk/>
            <pc:sldMk cId="0" sldId="270"/>
            <ac:spMk id="42" creationId="{9DB0136C-87A0-76EA-15AD-5602C4BBE41B}"/>
          </ac:spMkLst>
        </pc:spChg>
        <pc:spChg chg="add">
          <ac:chgData name="Yates, Rob A." userId="S::raya228@uky.edu::c4835988-b912-40a4-bf56-31a2afc86d77" providerId="AD" clId="Web-{0CC3DE7B-5279-3B29-9775-114C9D57E971}" dt="2023-07-20T14:14:45.904" v="373"/>
          <ac:spMkLst>
            <pc:docMk/>
            <pc:sldMk cId="0" sldId="270"/>
            <ac:spMk id="44" creationId="{B0805F32-58D8-4130-6ACF-2624856E0279}"/>
          </ac:spMkLst>
        </pc:spChg>
        <pc:spChg chg="add">
          <ac:chgData name="Yates, Rob A." userId="S::raya228@uky.edu::c4835988-b912-40a4-bf56-31a2afc86d77" providerId="AD" clId="Web-{0CC3DE7B-5279-3B29-9775-114C9D57E971}" dt="2023-07-20T14:14:45.920" v="374"/>
          <ac:spMkLst>
            <pc:docMk/>
            <pc:sldMk cId="0" sldId="270"/>
            <ac:spMk id="46" creationId="{169D1124-5C0E-C82D-B0EE-5C26FB272451}"/>
          </ac:spMkLst>
        </pc:spChg>
        <pc:spChg chg="add">
          <ac:chgData name="Yates, Rob A." userId="S::raya228@uky.edu::c4835988-b912-40a4-bf56-31a2afc86d77" providerId="AD" clId="Web-{0CC3DE7B-5279-3B29-9775-114C9D57E971}" dt="2023-07-20T14:14:45.936" v="375"/>
          <ac:spMkLst>
            <pc:docMk/>
            <pc:sldMk cId="0" sldId="270"/>
            <ac:spMk id="48" creationId="{20B49AB4-0517-E19E-99BB-A046B75304A3}"/>
          </ac:spMkLst>
        </pc:spChg>
        <pc:spChg chg="add">
          <ac:chgData name="Yates, Rob A." userId="S::raya228@uky.edu::c4835988-b912-40a4-bf56-31a2afc86d77" providerId="AD" clId="Web-{0CC3DE7B-5279-3B29-9775-114C9D57E971}" dt="2023-07-20T14:14:45.951" v="376"/>
          <ac:spMkLst>
            <pc:docMk/>
            <pc:sldMk cId="0" sldId="270"/>
            <ac:spMk id="50" creationId="{33847DB0-8BFE-18B8-F540-2A7B1373AB91}"/>
          </ac:spMkLst>
        </pc:spChg>
        <pc:spChg chg="add">
          <ac:chgData name="Yates, Rob A." userId="S::raya228@uky.edu::c4835988-b912-40a4-bf56-31a2afc86d77" providerId="AD" clId="Web-{0CC3DE7B-5279-3B29-9775-114C9D57E971}" dt="2023-07-20T14:14:45.967" v="377"/>
          <ac:spMkLst>
            <pc:docMk/>
            <pc:sldMk cId="0" sldId="270"/>
            <ac:spMk id="52" creationId="{F135670D-14C3-1EA3-4E40-2B0F54A06DD8}"/>
          </ac:spMkLst>
        </pc:spChg>
        <pc:spChg chg="add">
          <ac:chgData name="Yates, Rob A." userId="S::raya228@uky.edu::c4835988-b912-40a4-bf56-31a2afc86d77" providerId="AD" clId="Web-{0CC3DE7B-5279-3B29-9775-114C9D57E971}" dt="2023-07-20T14:14:45.967" v="378"/>
          <ac:spMkLst>
            <pc:docMk/>
            <pc:sldMk cId="0" sldId="270"/>
            <ac:spMk id="54" creationId="{4D8867D4-D430-4ABF-A38B-39CBBBD91A2F}"/>
          </ac:spMkLst>
        </pc:spChg>
        <pc:spChg chg="add">
          <ac:chgData name="Yates, Rob A." userId="S::raya228@uky.edu::c4835988-b912-40a4-bf56-31a2afc86d77" providerId="AD" clId="Web-{0CC3DE7B-5279-3B29-9775-114C9D57E971}" dt="2023-07-20T14:14:45.983" v="379"/>
          <ac:spMkLst>
            <pc:docMk/>
            <pc:sldMk cId="0" sldId="270"/>
            <ac:spMk id="56" creationId="{0768A8E1-9608-F468-93ED-CFB306836D2C}"/>
          </ac:spMkLst>
        </pc:spChg>
        <pc:spChg chg="add">
          <ac:chgData name="Yates, Rob A." userId="S::raya228@uky.edu::c4835988-b912-40a4-bf56-31a2afc86d77" providerId="AD" clId="Web-{0CC3DE7B-5279-3B29-9775-114C9D57E971}" dt="2023-07-20T14:14:45.998" v="380"/>
          <ac:spMkLst>
            <pc:docMk/>
            <pc:sldMk cId="0" sldId="270"/>
            <ac:spMk id="58" creationId="{D0C877B8-8E71-81C6-CD3C-CF6E94D53C7C}"/>
          </ac:spMkLst>
        </pc:spChg>
        <pc:spChg chg="add">
          <ac:chgData name="Yates, Rob A." userId="S::raya228@uky.edu::c4835988-b912-40a4-bf56-31a2afc86d77" providerId="AD" clId="Web-{0CC3DE7B-5279-3B29-9775-114C9D57E971}" dt="2023-07-20T14:14:46.014" v="381"/>
          <ac:spMkLst>
            <pc:docMk/>
            <pc:sldMk cId="0" sldId="270"/>
            <ac:spMk id="60" creationId="{18D18C34-7226-B579-3891-7EA5D5877058}"/>
          </ac:spMkLst>
        </pc:spChg>
      </pc:sldChg>
      <pc:sldChg chg="addSp delSp">
        <pc:chgData name="Yates, Rob A." userId="S::raya228@uky.edu::c4835988-b912-40a4-bf56-31a2afc86d77" providerId="AD" clId="Web-{0CC3DE7B-5279-3B29-9775-114C9D57E971}" dt="2023-07-20T14:16:26.844" v="449"/>
        <pc:sldMkLst>
          <pc:docMk/>
          <pc:sldMk cId="0" sldId="271"/>
        </pc:sldMkLst>
        <pc:spChg chg="del">
          <ac:chgData name="Yates, Rob A." userId="S::raya228@uky.edu::c4835988-b912-40a4-bf56-31a2afc86d77" providerId="AD" clId="Web-{0CC3DE7B-5279-3B29-9775-114C9D57E971}" dt="2023-07-20T14:16:23.516" v="433"/>
          <ac:spMkLst>
            <pc:docMk/>
            <pc:sldMk cId="0" sldId="271"/>
            <ac:spMk id="4" creationId="{00000000-0000-0000-0000-000000000000}"/>
          </ac:spMkLst>
        </pc:spChg>
        <pc:spChg chg="del">
          <ac:chgData name="Yates, Rob A." userId="S::raya228@uky.edu::c4835988-b912-40a4-bf56-31a2afc86d77" providerId="AD" clId="Web-{0CC3DE7B-5279-3B29-9775-114C9D57E971}" dt="2023-07-20T14:16:23.516" v="432"/>
          <ac:spMkLst>
            <pc:docMk/>
            <pc:sldMk cId="0" sldId="271"/>
            <ac:spMk id="5" creationId="{00000000-0000-0000-0000-000000000000}"/>
          </ac:spMkLst>
        </pc:spChg>
        <pc:spChg chg="del">
          <ac:chgData name="Yates, Rob A." userId="S::raya228@uky.edu::c4835988-b912-40a4-bf56-31a2afc86d77" providerId="AD" clId="Web-{0CC3DE7B-5279-3B29-9775-114C9D57E971}" dt="2023-07-20T14:16:23.516" v="431"/>
          <ac:spMkLst>
            <pc:docMk/>
            <pc:sldMk cId="0" sldId="271"/>
            <ac:spMk id="8" creationId="{00000000-0000-0000-0000-000000000000}"/>
          </ac:spMkLst>
        </pc:spChg>
        <pc:spChg chg="del">
          <ac:chgData name="Yates, Rob A." userId="S::raya228@uky.edu::c4835988-b912-40a4-bf56-31a2afc86d77" providerId="AD" clId="Web-{0CC3DE7B-5279-3B29-9775-114C9D57E971}" dt="2023-07-20T14:16:23.516" v="430"/>
          <ac:spMkLst>
            <pc:docMk/>
            <pc:sldMk cId="0" sldId="271"/>
            <ac:spMk id="9" creationId="{00000000-0000-0000-0000-000000000000}"/>
          </ac:spMkLst>
        </pc:spChg>
        <pc:spChg chg="del">
          <ac:chgData name="Yates, Rob A." userId="S::raya228@uky.edu::c4835988-b912-40a4-bf56-31a2afc86d77" providerId="AD" clId="Web-{0CC3DE7B-5279-3B29-9775-114C9D57E971}" dt="2023-07-20T14:16:23.516" v="429"/>
          <ac:spMkLst>
            <pc:docMk/>
            <pc:sldMk cId="0" sldId="271"/>
            <ac:spMk id="13" creationId="{00000000-0000-0000-0000-000000000000}"/>
          </ac:spMkLst>
        </pc:spChg>
        <pc:spChg chg="del">
          <ac:chgData name="Yates, Rob A." userId="S::raya228@uky.edu::c4835988-b912-40a4-bf56-31a2afc86d77" providerId="AD" clId="Web-{0CC3DE7B-5279-3B29-9775-114C9D57E971}" dt="2023-07-20T14:16:23.516" v="428"/>
          <ac:spMkLst>
            <pc:docMk/>
            <pc:sldMk cId="0" sldId="271"/>
            <ac:spMk id="14" creationId="{00000000-0000-0000-0000-000000000000}"/>
          </ac:spMkLst>
        </pc:spChg>
        <pc:spChg chg="del">
          <ac:chgData name="Yates, Rob A." userId="S::raya228@uky.edu::c4835988-b912-40a4-bf56-31a2afc86d77" providerId="AD" clId="Web-{0CC3DE7B-5279-3B29-9775-114C9D57E971}" dt="2023-07-20T14:16:23.516" v="427"/>
          <ac:spMkLst>
            <pc:docMk/>
            <pc:sldMk cId="0" sldId="271"/>
            <ac:spMk id="18" creationId="{00000000-0000-0000-0000-000000000000}"/>
          </ac:spMkLst>
        </pc:spChg>
        <pc:spChg chg="del">
          <ac:chgData name="Yates, Rob A." userId="S::raya228@uky.edu::c4835988-b912-40a4-bf56-31a2afc86d77" providerId="AD" clId="Web-{0CC3DE7B-5279-3B29-9775-114C9D57E971}" dt="2023-07-20T14:16:23.516" v="426"/>
          <ac:spMkLst>
            <pc:docMk/>
            <pc:sldMk cId="0" sldId="271"/>
            <ac:spMk id="19" creationId="{00000000-0000-0000-0000-000000000000}"/>
          </ac:spMkLst>
        </pc:spChg>
        <pc:spChg chg="del">
          <ac:chgData name="Yates, Rob A." userId="S::raya228@uky.edu::c4835988-b912-40a4-bf56-31a2afc86d77" providerId="AD" clId="Web-{0CC3DE7B-5279-3B29-9775-114C9D57E971}" dt="2023-07-20T14:16:23.516" v="425"/>
          <ac:spMkLst>
            <pc:docMk/>
            <pc:sldMk cId="0" sldId="271"/>
            <ac:spMk id="21" creationId="{60B1E531-6411-ED75-B3E0-D428B4EBD009}"/>
          </ac:spMkLst>
        </pc:spChg>
        <pc:spChg chg="del">
          <ac:chgData name="Yates, Rob A." userId="S::raya228@uky.edu::c4835988-b912-40a4-bf56-31a2afc86d77" providerId="AD" clId="Web-{0CC3DE7B-5279-3B29-9775-114C9D57E971}" dt="2023-07-20T14:16:23.516" v="424"/>
          <ac:spMkLst>
            <pc:docMk/>
            <pc:sldMk cId="0" sldId="271"/>
            <ac:spMk id="22" creationId="{B95DBC45-0BAB-8074-E263-7C98461732CE}"/>
          </ac:spMkLst>
        </pc:spChg>
        <pc:spChg chg="del">
          <ac:chgData name="Yates, Rob A." userId="S::raya228@uky.edu::c4835988-b912-40a4-bf56-31a2afc86d77" providerId="AD" clId="Web-{0CC3DE7B-5279-3B29-9775-114C9D57E971}" dt="2023-07-20T14:16:23.516" v="423"/>
          <ac:spMkLst>
            <pc:docMk/>
            <pc:sldMk cId="0" sldId="271"/>
            <ac:spMk id="23" creationId="{35DD32C4-E1FF-0022-0130-A7379390EC6B}"/>
          </ac:spMkLst>
        </pc:spChg>
        <pc:spChg chg="del">
          <ac:chgData name="Yates, Rob A." userId="S::raya228@uky.edu::c4835988-b912-40a4-bf56-31a2afc86d77" providerId="AD" clId="Web-{0CC3DE7B-5279-3B29-9775-114C9D57E971}" dt="2023-07-20T14:16:23.516" v="422"/>
          <ac:spMkLst>
            <pc:docMk/>
            <pc:sldMk cId="0" sldId="271"/>
            <ac:spMk id="24" creationId="{B4057A4A-9572-3F55-5DF1-4306FE255DE7}"/>
          </ac:spMkLst>
        </pc:spChg>
        <pc:spChg chg="del">
          <ac:chgData name="Yates, Rob A." userId="S::raya228@uky.edu::c4835988-b912-40a4-bf56-31a2afc86d77" providerId="AD" clId="Web-{0CC3DE7B-5279-3B29-9775-114C9D57E971}" dt="2023-07-20T14:16:23.516" v="421"/>
          <ac:spMkLst>
            <pc:docMk/>
            <pc:sldMk cId="0" sldId="271"/>
            <ac:spMk id="25" creationId="{34D5C19C-FFAE-5F2B-8B14-981CFCEFE2D5}"/>
          </ac:spMkLst>
        </pc:spChg>
        <pc:spChg chg="del">
          <ac:chgData name="Yates, Rob A." userId="S::raya228@uky.edu::c4835988-b912-40a4-bf56-31a2afc86d77" providerId="AD" clId="Web-{0CC3DE7B-5279-3B29-9775-114C9D57E971}" dt="2023-07-20T14:16:23.516" v="420"/>
          <ac:spMkLst>
            <pc:docMk/>
            <pc:sldMk cId="0" sldId="271"/>
            <ac:spMk id="26" creationId="{E28C29E8-1F04-4850-0831-EE2B4D1961CE}"/>
          </ac:spMkLst>
        </pc:spChg>
        <pc:spChg chg="del">
          <ac:chgData name="Yates, Rob A." userId="S::raya228@uky.edu::c4835988-b912-40a4-bf56-31a2afc86d77" providerId="AD" clId="Web-{0CC3DE7B-5279-3B29-9775-114C9D57E971}" dt="2023-07-20T14:16:23.516" v="419"/>
          <ac:spMkLst>
            <pc:docMk/>
            <pc:sldMk cId="0" sldId="271"/>
            <ac:spMk id="27" creationId="{D9F31AEB-AEC9-C46A-D9F5-E93A0F866669}"/>
          </ac:spMkLst>
        </pc:spChg>
        <pc:spChg chg="del">
          <ac:chgData name="Yates, Rob A." userId="S::raya228@uky.edu::c4835988-b912-40a4-bf56-31a2afc86d77" providerId="AD" clId="Web-{0CC3DE7B-5279-3B29-9775-114C9D57E971}" dt="2023-07-20T14:16:23.516" v="418"/>
          <ac:spMkLst>
            <pc:docMk/>
            <pc:sldMk cId="0" sldId="271"/>
            <ac:spMk id="28" creationId="{1587ADDE-2971-5492-603C-1B7023ABB4DB}"/>
          </ac:spMkLst>
        </pc:spChg>
        <pc:spChg chg="add">
          <ac:chgData name="Yates, Rob A." userId="S::raya228@uky.edu::c4835988-b912-40a4-bf56-31a2afc86d77" providerId="AD" clId="Web-{0CC3DE7B-5279-3B29-9775-114C9D57E971}" dt="2023-07-20T14:16:26.688" v="434"/>
          <ac:spMkLst>
            <pc:docMk/>
            <pc:sldMk cId="0" sldId="271"/>
            <ac:spMk id="30" creationId="{C310374A-C95F-8FA7-1741-7818A0F61962}"/>
          </ac:spMkLst>
        </pc:spChg>
        <pc:spChg chg="add">
          <ac:chgData name="Yates, Rob A." userId="S::raya228@uky.edu::c4835988-b912-40a4-bf56-31a2afc86d77" providerId="AD" clId="Web-{0CC3DE7B-5279-3B29-9775-114C9D57E971}" dt="2023-07-20T14:16:26.704" v="435"/>
          <ac:spMkLst>
            <pc:docMk/>
            <pc:sldMk cId="0" sldId="271"/>
            <ac:spMk id="32" creationId="{705354EF-C946-9AE5-F7FD-3B0692BA3684}"/>
          </ac:spMkLst>
        </pc:spChg>
        <pc:spChg chg="add">
          <ac:chgData name="Yates, Rob A." userId="S::raya228@uky.edu::c4835988-b912-40a4-bf56-31a2afc86d77" providerId="AD" clId="Web-{0CC3DE7B-5279-3B29-9775-114C9D57E971}" dt="2023-07-20T14:16:26.704" v="436"/>
          <ac:spMkLst>
            <pc:docMk/>
            <pc:sldMk cId="0" sldId="271"/>
            <ac:spMk id="34" creationId="{1D2DF002-64DA-BD92-5C25-725D00954680}"/>
          </ac:spMkLst>
        </pc:spChg>
        <pc:spChg chg="add">
          <ac:chgData name="Yates, Rob A." userId="S::raya228@uky.edu::c4835988-b912-40a4-bf56-31a2afc86d77" providerId="AD" clId="Web-{0CC3DE7B-5279-3B29-9775-114C9D57E971}" dt="2023-07-20T14:16:26.719" v="437"/>
          <ac:spMkLst>
            <pc:docMk/>
            <pc:sldMk cId="0" sldId="271"/>
            <ac:spMk id="36" creationId="{F98D95BF-20A2-31BB-9EFA-A6AD47F1F11E}"/>
          </ac:spMkLst>
        </pc:spChg>
        <pc:spChg chg="add">
          <ac:chgData name="Yates, Rob A." userId="S::raya228@uky.edu::c4835988-b912-40a4-bf56-31a2afc86d77" providerId="AD" clId="Web-{0CC3DE7B-5279-3B29-9775-114C9D57E971}" dt="2023-07-20T14:16:26.719" v="438"/>
          <ac:spMkLst>
            <pc:docMk/>
            <pc:sldMk cId="0" sldId="271"/>
            <ac:spMk id="38" creationId="{EEB7C775-8C4E-69D4-9A2F-202B5EB54AB4}"/>
          </ac:spMkLst>
        </pc:spChg>
        <pc:spChg chg="add">
          <ac:chgData name="Yates, Rob A." userId="S::raya228@uky.edu::c4835988-b912-40a4-bf56-31a2afc86d77" providerId="AD" clId="Web-{0CC3DE7B-5279-3B29-9775-114C9D57E971}" dt="2023-07-20T14:16:26.735" v="439"/>
          <ac:spMkLst>
            <pc:docMk/>
            <pc:sldMk cId="0" sldId="271"/>
            <ac:spMk id="40" creationId="{9DA17BE5-298A-F8CE-85F6-34B8F0F0035C}"/>
          </ac:spMkLst>
        </pc:spChg>
        <pc:spChg chg="add">
          <ac:chgData name="Yates, Rob A." userId="S::raya228@uky.edu::c4835988-b912-40a4-bf56-31a2afc86d77" providerId="AD" clId="Web-{0CC3DE7B-5279-3B29-9775-114C9D57E971}" dt="2023-07-20T14:16:26.750" v="440"/>
          <ac:spMkLst>
            <pc:docMk/>
            <pc:sldMk cId="0" sldId="271"/>
            <ac:spMk id="42" creationId="{2CB0E34E-C157-2902-F3C1-91466398B4E8}"/>
          </ac:spMkLst>
        </pc:spChg>
        <pc:spChg chg="add">
          <ac:chgData name="Yates, Rob A." userId="S::raya228@uky.edu::c4835988-b912-40a4-bf56-31a2afc86d77" providerId="AD" clId="Web-{0CC3DE7B-5279-3B29-9775-114C9D57E971}" dt="2023-07-20T14:16:26.750" v="441"/>
          <ac:spMkLst>
            <pc:docMk/>
            <pc:sldMk cId="0" sldId="271"/>
            <ac:spMk id="44" creationId="{53AB0BA7-475E-30CC-633D-53868ED8D8EA}"/>
          </ac:spMkLst>
        </pc:spChg>
        <pc:spChg chg="add">
          <ac:chgData name="Yates, Rob A." userId="S::raya228@uky.edu::c4835988-b912-40a4-bf56-31a2afc86d77" providerId="AD" clId="Web-{0CC3DE7B-5279-3B29-9775-114C9D57E971}" dt="2023-07-20T14:16:26.766" v="442"/>
          <ac:spMkLst>
            <pc:docMk/>
            <pc:sldMk cId="0" sldId="271"/>
            <ac:spMk id="46" creationId="{783E8D4E-C35D-E6F4-F532-BF6141F46A11}"/>
          </ac:spMkLst>
        </pc:spChg>
        <pc:spChg chg="add">
          <ac:chgData name="Yates, Rob A." userId="S::raya228@uky.edu::c4835988-b912-40a4-bf56-31a2afc86d77" providerId="AD" clId="Web-{0CC3DE7B-5279-3B29-9775-114C9D57E971}" dt="2023-07-20T14:16:26.782" v="443"/>
          <ac:spMkLst>
            <pc:docMk/>
            <pc:sldMk cId="0" sldId="271"/>
            <ac:spMk id="48" creationId="{D2745AF4-C295-1562-8EFC-D3C86448D0BB}"/>
          </ac:spMkLst>
        </pc:spChg>
        <pc:spChg chg="add">
          <ac:chgData name="Yates, Rob A." userId="S::raya228@uky.edu::c4835988-b912-40a4-bf56-31a2afc86d77" providerId="AD" clId="Web-{0CC3DE7B-5279-3B29-9775-114C9D57E971}" dt="2023-07-20T14:16:26.782" v="444"/>
          <ac:spMkLst>
            <pc:docMk/>
            <pc:sldMk cId="0" sldId="271"/>
            <ac:spMk id="50" creationId="{683515CA-76D3-25DA-F16F-B6E75F22989B}"/>
          </ac:spMkLst>
        </pc:spChg>
        <pc:spChg chg="add">
          <ac:chgData name="Yates, Rob A." userId="S::raya228@uky.edu::c4835988-b912-40a4-bf56-31a2afc86d77" providerId="AD" clId="Web-{0CC3DE7B-5279-3B29-9775-114C9D57E971}" dt="2023-07-20T14:16:26.797" v="445"/>
          <ac:spMkLst>
            <pc:docMk/>
            <pc:sldMk cId="0" sldId="271"/>
            <ac:spMk id="52" creationId="{E72DF749-7D33-EDBC-7C7A-328ED2840A1E}"/>
          </ac:spMkLst>
        </pc:spChg>
        <pc:spChg chg="add">
          <ac:chgData name="Yates, Rob A." userId="S::raya228@uky.edu::c4835988-b912-40a4-bf56-31a2afc86d77" providerId="AD" clId="Web-{0CC3DE7B-5279-3B29-9775-114C9D57E971}" dt="2023-07-20T14:16:26.813" v="446"/>
          <ac:spMkLst>
            <pc:docMk/>
            <pc:sldMk cId="0" sldId="271"/>
            <ac:spMk id="54" creationId="{511E5E50-2213-F0B2-F4F3-4B23D84C3403}"/>
          </ac:spMkLst>
        </pc:spChg>
        <pc:spChg chg="add">
          <ac:chgData name="Yates, Rob A." userId="S::raya228@uky.edu::c4835988-b912-40a4-bf56-31a2afc86d77" providerId="AD" clId="Web-{0CC3DE7B-5279-3B29-9775-114C9D57E971}" dt="2023-07-20T14:16:26.829" v="447"/>
          <ac:spMkLst>
            <pc:docMk/>
            <pc:sldMk cId="0" sldId="271"/>
            <ac:spMk id="56" creationId="{F66F2C71-7B67-6DDA-72C6-1BDDF9878184}"/>
          </ac:spMkLst>
        </pc:spChg>
        <pc:spChg chg="add">
          <ac:chgData name="Yates, Rob A." userId="S::raya228@uky.edu::c4835988-b912-40a4-bf56-31a2afc86d77" providerId="AD" clId="Web-{0CC3DE7B-5279-3B29-9775-114C9D57E971}" dt="2023-07-20T14:16:26.844" v="448"/>
          <ac:spMkLst>
            <pc:docMk/>
            <pc:sldMk cId="0" sldId="271"/>
            <ac:spMk id="58" creationId="{2DDA67FA-E71A-E2D8-3ED2-E756896DACEC}"/>
          </ac:spMkLst>
        </pc:spChg>
        <pc:spChg chg="add">
          <ac:chgData name="Yates, Rob A." userId="S::raya228@uky.edu::c4835988-b912-40a4-bf56-31a2afc86d77" providerId="AD" clId="Web-{0CC3DE7B-5279-3B29-9775-114C9D57E971}" dt="2023-07-20T14:16:26.844" v="449"/>
          <ac:spMkLst>
            <pc:docMk/>
            <pc:sldMk cId="0" sldId="271"/>
            <ac:spMk id="60" creationId="{B7C74A9D-C13D-0D1A-4E9E-150B4A8ED31C}"/>
          </ac:spMkLst>
        </pc:spChg>
      </pc:sldChg>
      <pc:sldChg chg="addSp delSp">
        <pc:chgData name="Yates, Rob A." userId="S::raya228@uky.edu::c4835988-b912-40a4-bf56-31a2afc86d77" providerId="AD" clId="Web-{0CC3DE7B-5279-3B29-9775-114C9D57E971}" dt="2023-07-20T14:21:05.773" v="579"/>
        <pc:sldMkLst>
          <pc:docMk/>
          <pc:sldMk cId="0" sldId="272"/>
        </pc:sldMkLst>
        <pc:spChg chg="del">
          <ac:chgData name="Yates, Rob A." userId="S::raya228@uky.edu::c4835988-b912-40a4-bf56-31a2afc86d77" providerId="AD" clId="Web-{0CC3DE7B-5279-3B29-9775-114C9D57E971}" dt="2023-07-20T14:20:33.600" v="565"/>
          <ac:spMkLst>
            <pc:docMk/>
            <pc:sldMk cId="0" sldId="272"/>
            <ac:spMk id="4" creationId="{00000000-0000-0000-0000-000000000000}"/>
          </ac:spMkLst>
        </pc:spChg>
        <pc:spChg chg="del">
          <ac:chgData name="Yates, Rob A." userId="S::raya228@uky.edu::c4835988-b912-40a4-bf56-31a2afc86d77" providerId="AD" clId="Web-{0CC3DE7B-5279-3B29-9775-114C9D57E971}" dt="2023-07-20T14:20:33.600" v="564"/>
          <ac:spMkLst>
            <pc:docMk/>
            <pc:sldMk cId="0" sldId="272"/>
            <ac:spMk id="5" creationId="{00000000-0000-0000-0000-000000000000}"/>
          </ac:spMkLst>
        </pc:spChg>
        <pc:spChg chg="del">
          <ac:chgData name="Yates, Rob A." userId="S::raya228@uky.edu::c4835988-b912-40a4-bf56-31a2afc86d77" providerId="AD" clId="Web-{0CC3DE7B-5279-3B29-9775-114C9D57E971}" dt="2023-07-20T14:20:33.600" v="563"/>
          <ac:spMkLst>
            <pc:docMk/>
            <pc:sldMk cId="0" sldId="272"/>
            <ac:spMk id="8" creationId="{00000000-0000-0000-0000-000000000000}"/>
          </ac:spMkLst>
        </pc:spChg>
        <pc:spChg chg="del">
          <ac:chgData name="Yates, Rob A." userId="S::raya228@uky.edu::c4835988-b912-40a4-bf56-31a2afc86d77" providerId="AD" clId="Web-{0CC3DE7B-5279-3B29-9775-114C9D57E971}" dt="2023-07-20T14:20:33.600" v="562"/>
          <ac:spMkLst>
            <pc:docMk/>
            <pc:sldMk cId="0" sldId="272"/>
            <ac:spMk id="9" creationId="{00000000-0000-0000-0000-000000000000}"/>
          </ac:spMkLst>
        </pc:spChg>
        <pc:spChg chg="del">
          <ac:chgData name="Yates, Rob A." userId="S::raya228@uky.edu::c4835988-b912-40a4-bf56-31a2afc86d77" providerId="AD" clId="Web-{0CC3DE7B-5279-3B29-9775-114C9D57E971}" dt="2023-07-20T14:20:33.600" v="561"/>
          <ac:spMkLst>
            <pc:docMk/>
            <pc:sldMk cId="0" sldId="272"/>
            <ac:spMk id="13" creationId="{00000000-0000-0000-0000-000000000000}"/>
          </ac:spMkLst>
        </pc:spChg>
        <pc:spChg chg="del">
          <ac:chgData name="Yates, Rob A." userId="S::raya228@uky.edu::c4835988-b912-40a4-bf56-31a2afc86d77" providerId="AD" clId="Web-{0CC3DE7B-5279-3B29-9775-114C9D57E971}" dt="2023-07-20T14:20:33.600" v="560"/>
          <ac:spMkLst>
            <pc:docMk/>
            <pc:sldMk cId="0" sldId="272"/>
            <ac:spMk id="14" creationId="{00000000-0000-0000-0000-000000000000}"/>
          </ac:spMkLst>
        </pc:spChg>
        <pc:spChg chg="del">
          <ac:chgData name="Yates, Rob A." userId="S::raya228@uky.edu::c4835988-b912-40a4-bf56-31a2afc86d77" providerId="AD" clId="Web-{0CC3DE7B-5279-3B29-9775-114C9D57E971}" dt="2023-07-20T14:20:33.600" v="559"/>
          <ac:spMkLst>
            <pc:docMk/>
            <pc:sldMk cId="0" sldId="272"/>
            <ac:spMk id="18" creationId="{00000000-0000-0000-0000-000000000000}"/>
          </ac:spMkLst>
        </pc:spChg>
        <pc:spChg chg="del">
          <ac:chgData name="Yates, Rob A." userId="S::raya228@uky.edu::c4835988-b912-40a4-bf56-31a2afc86d77" providerId="AD" clId="Web-{0CC3DE7B-5279-3B29-9775-114C9D57E971}" dt="2023-07-20T14:20:33.600" v="558"/>
          <ac:spMkLst>
            <pc:docMk/>
            <pc:sldMk cId="0" sldId="272"/>
            <ac:spMk id="19" creationId="{00000000-0000-0000-0000-000000000000}"/>
          </ac:spMkLst>
        </pc:spChg>
        <pc:spChg chg="add">
          <ac:chgData name="Yates, Rob A." userId="S::raya228@uky.edu::c4835988-b912-40a4-bf56-31a2afc86d77" providerId="AD" clId="Web-{0CC3DE7B-5279-3B29-9775-114C9D57E971}" dt="2023-07-20T14:20:35.600" v="566"/>
          <ac:spMkLst>
            <pc:docMk/>
            <pc:sldMk cId="0" sldId="272"/>
            <ac:spMk id="22" creationId="{5A190FFE-4715-4F13-3C8E-70A6EDB66EEC}"/>
          </ac:spMkLst>
        </pc:spChg>
        <pc:spChg chg="add del">
          <ac:chgData name="Yates, Rob A." userId="S::raya228@uky.edu::c4835988-b912-40a4-bf56-31a2afc86d77" providerId="AD" clId="Web-{0CC3DE7B-5279-3B29-9775-114C9D57E971}" dt="2023-07-20T14:20:55.397" v="576"/>
          <ac:spMkLst>
            <pc:docMk/>
            <pc:sldMk cId="0" sldId="272"/>
            <ac:spMk id="24" creationId="{50FCD462-F845-791F-04A1-703910D65FD6}"/>
          </ac:spMkLst>
        </pc:spChg>
        <pc:spChg chg="del">
          <ac:chgData name="Yates, Rob A." userId="S::raya228@uky.edu::c4835988-b912-40a4-bf56-31a2afc86d77" providerId="AD" clId="Web-{0CC3DE7B-5279-3B29-9775-114C9D57E971}" dt="2023-07-20T14:20:33.600" v="557"/>
          <ac:spMkLst>
            <pc:docMk/>
            <pc:sldMk cId="0" sldId="272"/>
            <ac:spMk id="25" creationId="{B7AA5194-D6E4-30A8-1724-D475B85B3048}"/>
          </ac:spMkLst>
        </pc:spChg>
        <pc:spChg chg="add">
          <ac:chgData name="Yates, Rob A." userId="S::raya228@uky.edu::c4835988-b912-40a4-bf56-31a2afc86d77" providerId="AD" clId="Web-{0CC3DE7B-5279-3B29-9775-114C9D57E971}" dt="2023-07-20T14:20:35.616" v="568"/>
          <ac:spMkLst>
            <pc:docMk/>
            <pc:sldMk cId="0" sldId="272"/>
            <ac:spMk id="27" creationId="{390E5244-8FAA-70AE-776B-1CECB7637ECC}"/>
          </ac:spMkLst>
        </pc:spChg>
        <pc:spChg chg="add del">
          <ac:chgData name="Yates, Rob A." userId="S::raya228@uky.edu::c4835988-b912-40a4-bf56-31a2afc86d77" providerId="AD" clId="Web-{0CC3DE7B-5279-3B29-9775-114C9D57E971}" dt="2023-07-20T14:20:58.772" v="577"/>
          <ac:spMkLst>
            <pc:docMk/>
            <pc:sldMk cId="0" sldId="272"/>
            <ac:spMk id="29" creationId="{D9F37CD5-231B-4AA5-3D38-1CCDB14BFDFF}"/>
          </ac:spMkLst>
        </pc:spChg>
        <pc:spChg chg="add">
          <ac:chgData name="Yates, Rob A." userId="S::raya228@uky.edu::c4835988-b912-40a4-bf56-31a2afc86d77" providerId="AD" clId="Web-{0CC3DE7B-5279-3B29-9775-114C9D57E971}" dt="2023-07-20T14:20:35.631" v="570"/>
          <ac:spMkLst>
            <pc:docMk/>
            <pc:sldMk cId="0" sldId="272"/>
            <ac:spMk id="31" creationId="{BB280096-825A-7B40-8E07-90DECE334E42}"/>
          </ac:spMkLst>
        </pc:spChg>
        <pc:spChg chg="add del">
          <ac:chgData name="Yates, Rob A." userId="S::raya228@uky.edu::c4835988-b912-40a4-bf56-31a2afc86d77" providerId="AD" clId="Web-{0CC3DE7B-5279-3B29-9775-114C9D57E971}" dt="2023-07-20T14:21:03.226" v="578"/>
          <ac:spMkLst>
            <pc:docMk/>
            <pc:sldMk cId="0" sldId="272"/>
            <ac:spMk id="33" creationId="{F707F2E5-1F82-6A07-55A6-B13359136052}"/>
          </ac:spMkLst>
        </pc:spChg>
        <pc:spChg chg="add">
          <ac:chgData name="Yates, Rob A." userId="S::raya228@uky.edu::c4835988-b912-40a4-bf56-31a2afc86d77" providerId="AD" clId="Web-{0CC3DE7B-5279-3B29-9775-114C9D57E971}" dt="2023-07-20T14:20:35.663" v="572"/>
          <ac:spMkLst>
            <pc:docMk/>
            <pc:sldMk cId="0" sldId="272"/>
            <ac:spMk id="35" creationId="{4ED8B57E-E346-7C4F-D926-0C8ACC1FFFEC}"/>
          </ac:spMkLst>
        </pc:spChg>
        <pc:spChg chg="add del">
          <ac:chgData name="Yates, Rob A." userId="S::raya228@uky.edu::c4835988-b912-40a4-bf56-31a2afc86d77" providerId="AD" clId="Web-{0CC3DE7B-5279-3B29-9775-114C9D57E971}" dt="2023-07-20T14:21:05.773" v="579"/>
          <ac:spMkLst>
            <pc:docMk/>
            <pc:sldMk cId="0" sldId="272"/>
            <ac:spMk id="37" creationId="{B62ECBB1-473E-EEB2-FD68-504C148BDC6F}"/>
          </ac:spMkLst>
        </pc:spChg>
      </pc:sldChg>
      <pc:sldChg chg="addSp delSp">
        <pc:chgData name="Yates, Rob A." userId="S::raya228@uky.edu::c4835988-b912-40a4-bf56-31a2afc86d77" providerId="AD" clId="Web-{0CC3DE7B-5279-3B29-9775-114C9D57E971}" dt="2023-07-20T14:17:02.048" v="481"/>
        <pc:sldMkLst>
          <pc:docMk/>
          <pc:sldMk cId="2890828344" sldId="273"/>
        </pc:sldMkLst>
        <pc:spChg chg="del">
          <ac:chgData name="Yates, Rob A." userId="S::raya228@uky.edu::c4835988-b912-40a4-bf56-31a2afc86d77" providerId="AD" clId="Web-{0CC3DE7B-5279-3B29-9775-114C9D57E971}" dt="2023-07-20T14:16:57.814" v="465"/>
          <ac:spMkLst>
            <pc:docMk/>
            <pc:sldMk cId="2890828344" sldId="273"/>
            <ac:spMk id="4" creationId="{00000000-0000-0000-0000-000000000000}"/>
          </ac:spMkLst>
        </pc:spChg>
        <pc:spChg chg="del">
          <ac:chgData name="Yates, Rob A." userId="S::raya228@uky.edu::c4835988-b912-40a4-bf56-31a2afc86d77" providerId="AD" clId="Web-{0CC3DE7B-5279-3B29-9775-114C9D57E971}" dt="2023-07-20T14:16:57.814" v="464"/>
          <ac:spMkLst>
            <pc:docMk/>
            <pc:sldMk cId="2890828344" sldId="273"/>
            <ac:spMk id="5" creationId="{00000000-0000-0000-0000-000000000000}"/>
          </ac:spMkLst>
        </pc:spChg>
        <pc:spChg chg="del">
          <ac:chgData name="Yates, Rob A." userId="S::raya228@uky.edu::c4835988-b912-40a4-bf56-31a2afc86d77" providerId="AD" clId="Web-{0CC3DE7B-5279-3B29-9775-114C9D57E971}" dt="2023-07-20T14:16:57.814" v="463"/>
          <ac:spMkLst>
            <pc:docMk/>
            <pc:sldMk cId="2890828344" sldId="273"/>
            <ac:spMk id="8" creationId="{00000000-0000-0000-0000-000000000000}"/>
          </ac:spMkLst>
        </pc:spChg>
        <pc:spChg chg="del">
          <ac:chgData name="Yates, Rob A." userId="S::raya228@uky.edu::c4835988-b912-40a4-bf56-31a2afc86d77" providerId="AD" clId="Web-{0CC3DE7B-5279-3B29-9775-114C9D57E971}" dt="2023-07-20T14:16:57.814" v="462"/>
          <ac:spMkLst>
            <pc:docMk/>
            <pc:sldMk cId="2890828344" sldId="273"/>
            <ac:spMk id="9" creationId="{00000000-0000-0000-0000-000000000000}"/>
          </ac:spMkLst>
        </pc:spChg>
        <pc:spChg chg="del">
          <ac:chgData name="Yates, Rob A." userId="S::raya228@uky.edu::c4835988-b912-40a4-bf56-31a2afc86d77" providerId="AD" clId="Web-{0CC3DE7B-5279-3B29-9775-114C9D57E971}" dt="2023-07-20T14:16:57.814" v="461"/>
          <ac:spMkLst>
            <pc:docMk/>
            <pc:sldMk cId="2890828344" sldId="273"/>
            <ac:spMk id="13" creationId="{00000000-0000-0000-0000-000000000000}"/>
          </ac:spMkLst>
        </pc:spChg>
        <pc:spChg chg="del">
          <ac:chgData name="Yates, Rob A." userId="S::raya228@uky.edu::c4835988-b912-40a4-bf56-31a2afc86d77" providerId="AD" clId="Web-{0CC3DE7B-5279-3B29-9775-114C9D57E971}" dt="2023-07-20T14:16:57.814" v="460"/>
          <ac:spMkLst>
            <pc:docMk/>
            <pc:sldMk cId="2890828344" sldId="273"/>
            <ac:spMk id="14" creationId="{00000000-0000-0000-0000-000000000000}"/>
          </ac:spMkLst>
        </pc:spChg>
        <pc:spChg chg="del">
          <ac:chgData name="Yates, Rob A." userId="S::raya228@uky.edu::c4835988-b912-40a4-bf56-31a2afc86d77" providerId="AD" clId="Web-{0CC3DE7B-5279-3B29-9775-114C9D57E971}" dt="2023-07-20T14:16:57.814" v="459"/>
          <ac:spMkLst>
            <pc:docMk/>
            <pc:sldMk cId="2890828344" sldId="273"/>
            <ac:spMk id="18" creationId="{00000000-0000-0000-0000-000000000000}"/>
          </ac:spMkLst>
        </pc:spChg>
        <pc:spChg chg="del">
          <ac:chgData name="Yates, Rob A." userId="S::raya228@uky.edu::c4835988-b912-40a4-bf56-31a2afc86d77" providerId="AD" clId="Web-{0CC3DE7B-5279-3B29-9775-114C9D57E971}" dt="2023-07-20T14:16:57.814" v="458"/>
          <ac:spMkLst>
            <pc:docMk/>
            <pc:sldMk cId="2890828344" sldId="273"/>
            <ac:spMk id="19" creationId="{00000000-0000-0000-0000-000000000000}"/>
          </ac:spMkLst>
        </pc:spChg>
        <pc:spChg chg="del">
          <ac:chgData name="Yates, Rob A." userId="S::raya228@uky.edu::c4835988-b912-40a4-bf56-31a2afc86d77" providerId="AD" clId="Web-{0CC3DE7B-5279-3B29-9775-114C9D57E971}" dt="2023-07-20T14:16:57.814" v="457"/>
          <ac:spMkLst>
            <pc:docMk/>
            <pc:sldMk cId="2890828344" sldId="273"/>
            <ac:spMk id="21" creationId="{60B1E531-6411-ED75-B3E0-D428B4EBD009}"/>
          </ac:spMkLst>
        </pc:spChg>
        <pc:spChg chg="del">
          <ac:chgData name="Yates, Rob A." userId="S::raya228@uky.edu::c4835988-b912-40a4-bf56-31a2afc86d77" providerId="AD" clId="Web-{0CC3DE7B-5279-3B29-9775-114C9D57E971}" dt="2023-07-20T14:16:57.814" v="456"/>
          <ac:spMkLst>
            <pc:docMk/>
            <pc:sldMk cId="2890828344" sldId="273"/>
            <ac:spMk id="22" creationId="{B95DBC45-0BAB-8074-E263-7C98461732CE}"/>
          </ac:spMkLst>
        </pc:spChg>
        <pc:spChg chg="del">
          <ac:chgData name="Yates, Rob A." userId="S::raya228@uky.edu::c4835988-b912-40a4-bf56-31a2afc86d77" providerId="AD" clId="Web-{0CC3DE7B-5279-3B29-9775-114C9D57E971}" dt="2023-07-20T14:16:57.814" v="455"/>
          <ac:spMkLst>
            <pc:docMk/>
            <pc:sldMk cId="2890828344" sldId="273"/>
            <ac:spMk id="23" creationId="{35DD32C4-E1FF-0022-0130-A7379390EC6B}"/>
          </ac:spMkLst>
        </pc:spChg>
        <pc:spChg chg="del">
          <ac:chgData name="Yates, Rob A." userId="S::raya228@uky.edu::c4835988-b912-40a4-bf56-31a2afc86d77" providerId="AD" clId="Web-{0CC3DE7B-5279-3B29-9775-114C9D57E971}" dt="2023-07-20T14:16:57.814" v="454"/>
          <ac:spMkLst>
            <pc:docMk/>
            <pc:sldMk cId="2890828344" sldId="273"/>
            <ac:spMk id="24" creationId="{B4057A4A-9572-3F55-5DF1-4306FE255DE7}"/>
          </ac:spMkLst>
        </pc:spChg>
        <pc:spChg chg="del">
          <ac:chgData name="Yates, Rob A." userId="S::raya228@uky.edu::c4835988-b912-40a4-bf56-31a2afc86d77" providerId="AD" clId="Web-{0CC3DE7B-5279-3B29-9775-114C9D57E971}" dt="2023-07-20T14:16:57.814" v="453"/>
          <ac:spMkLst>
            <pc:docMk/>
            <pc:sldMk cId="2890828344" sldId="273"/>
            <ac:spMk id="25" creationId="{34D5C19C-FFAE-5F2B-8B14-981CFCEFE2D5}"/>
          </ac:spMkLst>
        </pc:spChg>
        <pc:spChg chg="del">
          <ac:chgData name="Yates, Rob A." userId="S::raya228@uky.edu::c4835988-b912-40a4-bf56-31a2afc86d77" providerId="AD" clId="Web-{0CC3DE7B-5279-3B29-9775-114C9D57E971}" dt="2023-07-20T14:16:57.814" v="452"/>
          <ac:spMkLst>
            <pc:docMk/>
            <pc:sldMk cId="2890828344" sldId="273"/>
            <ac:spMk id="26" creationId="{E28C29E8-1F04-4850-0831-EE2B4D1961CE}"/>
          </ac:spMkLst>
        </pc:spChg>
        <pc:spChg chg="del">
          <ac:chgData name="Yates, Rob A." userId="S::raya228@uky.edu::c4835988-b912-40a4-bf56-31a2afc86d77" providerId="AD" clId="Web-{0CC3DE7B-5279-3B29-9775-114C9D57E971}" dt="2023-07-20T14:16:57.814" v="451"/>
          <ac:spMkLst>
            <pc:docMk/>
            <pc:sldMk cId="2890828344" sldId="273"/>
            <ac:spMk id="27" creationId="{D9F31AEB-AEC9-C46A-D9F5-E93A0F866669}"/>
          </ac:spMkLst>
        </pc:spChg>
        <pc:spChg chg="del">
          <ac:chgData name="Yates, Rob A." userId="S::raya228@uky.edu::c4835988-b912-40a4-bf56-31a2afc86d77" providerId="AD" clId="Web-{0CC3DE7B-5279-3B29-9775-114C9D57E971}" dt="2023-07-20T14:16:57.814" v="450"/>
          <ac:spMkLst>
            <pc:docMk/>
            <pc:sldMk cId="2890828344" sldId="273"/>
            <ac:spMk id="28" creationId="{1587ADDE-2971-5492-603C-1B7023ABB4DB}"/>
          </ac:spMkLst>
        </pc:spChg>
        <pc:spChg chg="add">
          <ac:chgData name="Yates, Rob A." userId="S::raya228@uky.edu::c4835988-b912-40a4-bf56-31a2afc86d77" providerId="AD" clId="Web-{0CC3DE7B-5279-3B29-9775-114C9D57E971}" dt="2023-07-20T14:17:01.861" v="466"/>
          <ac:spMkLst>
            <pc:docMk/>
            <pc:sldMk cId="2890828344" sldId="273"/>
            <ac:spMk id="30" creationId="{C799CFB3-2F6C-B1B6-5738-371D5ECA1EBC}"/>
          </ac:spMkLst>
        </pc:spChg>
        <pc:spChg chg="add">
          <ac:chgData name="Yates, Rob A." userId="S::raya228@uky.edu::c4835988-b912-40a4-bf56-31a2afc86d77" providerId="AD" clId="Web-{0CC3DE7B-5279-3B29-9775-114C9D57E971}" dt="2023-07-20T14:17:01.876" v="467"/>
          <ac:spMkLst>
            <pc:docMk/>
            <pc:sldMk cId="2890828344" sldId="273"/>
            <ac:spMk id="32" creationId="{E3425DC7-64E4-1DBF-ACD6-19B412264484}"/>
          </ac:spMkLst>
        </pc:spChg>
        <pc:spChg chg="add">
          <ac:chgData name="Yates, Rob A." userId="S::raya228@uky.edu::c4835988-b912-40a4-bf56-31a2afc86d77" providerId="AD" clId="Web-{0CC3DE7B-5279-3B29-9775-114C9D57E971}" dt="2023-07-20T14:17:01.892" v="468"/>
          <ac:spMkLst>
            <pc:docMk/>
            <pc:sldMk cId="2890828344" sldId="273"/>
            <ac:spMk id="34" creationId="{33A52072-4077-4C21-E095-08B2C0245BE6}"/>
          </ac:spMkLst>
        </pc:spChg>
        <pc:spChg chg="add">
          <ac:chgData name="Yates, Rob A." userId="S::raya228@uky.edu::c4835988-b912-40a4-bf56-31a2afc86d77" providerId="AD" clId="Web-{0CC3DE7B-5279-3B29-9775-114C9D57E971}" dt="2023-07-20T14:17:01.892" v="469"/>
          <ac:spMkLst>
            <pc:docMk/>
            <pc:sldMk cId="2890828344" sldId="273"/>
            <ac:spMk id="36" creationId="{568C4038-8211-611C-7C60-8DA663760FD4}"/>
          </ac:spMkLst>
        </pc:spChg>
        <pc:spChg chg="add">
          <ac:chgData name="Yates, Rob A." userId="S::raya228@uky.edu::c4835988-b912-40a4-bf56-31a2afc86d77" providerId="AD" clId="Web-{0CC3DE7B-5279-3B29-9775-114C9D57E971}" dt="2023-07-20T14:17:01.908" v="470"/>
          <ac:spMkLst>
            <pc:docMk/>
            <pc:sldMk cId="2890828344" sldId="273"/>
            <ac:spMk id="38" creationId="{AFFBFD8F-AA0A-62D2-D492-18C93F018984}"/>
          </ac:spMkLst>
        </pc:spChg>
        <pc:spChg chg="add">
          <ac:chgData name="Yates, Rob A." userId="S::raya228@uky.edu::c4835988-b912-40a4-bf56-31a2afc86d77" providerId="AD" clId="Web-{0CC3DE7B-5279-3B29-9775-114C9D57E971}" dt="2023-07-20T14:17:01.923" v="471"/>
          <ac:spMkLst>
            <pc:docMk/>
            <pc:sldMk cId="2890828344" sldId="273"/>
            <ac:spMk id="40" creationId="{3FC3FD05-51DA-8A27-C67A-BA0854B86BD5}"/>
          </ac:spMkLst>
        </pc:spChg>
        <pc:spChg chg="add">
          <ac:chgData name="Yates, Rob A." userId="S::raya228@uky.edu::c4835988-b912-40a4-bf56-31a2afc86d77" providerId="AD" clId="Web-{0CC3DE7B-5279-3B29-9775-114C9D57E971}" dt="2023-07-20T14:17:01.939" v="472"/>
          <ac:spMkLst>
            <pc:docMk/>
            <pc:sldMk cId="2890828344" sldId="273"/>
            <ac:spMk id="42" creationId="{4727776B-2DE4-E8EA-D2AD-B0423A80CC1A}"/>
          </ac:spMkLst>
        </pc:spChg>
        <pc:spChg chg="add">
          <ac:chgData name="Yates, Rob A." userId="S::raya228@uky.edu::c4835988-b912-40a4-bf56-31a2afc86d77" providerId="AD" clId="Web-{0CC3DE7B-5279-3B29-9775-114C9D57E971}" dt="2023-07-20T14:17:01.939" v="473"/>
          <ac:spMkLst>
            <pc:docMk/>
            <pc:sldMk cId="2890828344" sldId="273"/>
            <ac:spMk id="44" creationId="{5B36EBDC-21F5-ECCE-541C-0FE1844E9EA1}"/>
          </ac:spMkLst>
        </pc:spChg>
        <pc:spChg chg="add">
          <ac:chgData name="Yates, Rob A." userId="S::raya228@uky.edu::c4835988-b912-40a4-bf56-31a2afc86d77" providerId="AD" clId="Web-{0CC3DE7B-5279-3B29-9775-114C9D57E971}" dt="2023-07-20T14:17:01.954" v="474"/>
          <ac:spMkLst>
            <pc:docMk/>
            <pc:sldMk cId="2890828344" sldId="273"/>
            <ac:spMk id="46" creationId="{99D630E1-7EBE-5616-3C6B-B5A7B9583F4B}"/>
          </ac:spMkLst>
        </pc:spChg>
        <pc:spChg chg="add">
          <ac:chgData name="Yates, Rob A." userId="S::raya228@uky.edu::c4835988-b912-40a4-bf56-31a2afc86d77" providerId="AD" clId="Web-{0CC3DE7B-5279-3B29-9775-114C9D57E971}" dt="2023-07-20T14:17:01.970" v="475"/>
          <ac:spMkLst>
            <pc:docMk/>
            <pc:sldMk cId="2890828344" sldId="273"/>
            <ac:spMk id="48" creationId="{B44C336D-DD7D-C5E3-98EA-DD166F977C43}"/>
          </ac:spMkLst>
        </pc:spChg>
        <pc:spChg chg="add">
          <ac:chgData name="Yates, Rob A." userId="S::raya228@uky.edu::c4835988-b912-40a4-bf56-31a2afc86d77" providerId="AD" clId="Web-{0CC3DE7B-5279-3B29-9775-114C9D57E971}" dt="2023-07-20T14:17:01.986" v="476"/>
          <ac:spMkLst>
            <pc:docMk/>
            <pc:sldMk cId="2890828344" sldId="273"/>
            <ac:spMk id="50" creationId="{9FEAC011-AF91-BC6F-9381-566F32062916}"/>
          </ac:spMkLst>
        </pc:spChg>
        <pc:spChg chg="add">
          <ac:chgData name="Yates, Rob A." userId="S::raya228@uky.edu::c4835988-b912-40a4-bf56-31a2afc86d77" providerId="AD" clId="Web-{0CC3DE7B-5279-3B29-9775-114C9D57E971}" dt="2023-07-20T14:17:02.001" v="477"/>
          <ac:spMkLst>
            <pc:docMk/>
            <pc:sldMk cId="2890828344" sldId="273"/>
            <ac:spMk id="52" creationId="{41B24A27-AFBE-2822-5607-B92F899B290B}"/>
          </ac:spMkLst>
        </pc:spChg>
        <pc:spChg chg="add">
          <ac:chgData name="Yates, Rob A." userId="S::raya228@uky.edu::c4835988-b912-40a4-bf56-31a2afc86d77" providerId="AD" clId="Web-{0CC3DE7B-5279-3B29-9775-114C9D57E971}" dt="2023-07-20T14:17:02.001" v="478"/>
          <ac:spMkLst>
            <pc:docMk/>
            <pc:sldMk cId="2890828344" sldId="273"/>
            <ac:spMk id="54" creationId="{CF61DA7E-1AB3-965C-FA38-99350976D50D}"/>
          </ac:spMkLst>
        </pc:spChg>
        <pc:spChg chg="add">
          <ac:chgData name="Yates, Rob A." userId="S::raya228@uky.edu::c4835988-b912-40a4-bf56-31a2afc86d77" providerId="AD" clId="Web-{0CC3DE7B-5279-3B29-9775-114C9D57E971}" dt="2023-07-20T14:17:02.017" v="479"/>
          <ac:spMkLst>
            <pc:docMk/>
            <pc:sldMk cId="2890828344" sldId="273"/>
            <ac:spMk id="56" creationId="{97B72527-68DF-2D6A-B1BE-863B05B8707B}"/>
          </ac:spMkLst>
        </pc:spChg>
        <pc:spChg chg="add">
          <ac:chgData name="Yates, Rob A." userId="S::raya228@uky.edu::c4835988-b912-40a4-bf56-31a2afc86d77" providerId="AD" clId="Web-{0CC3DE7B-5279-3B29-9775-114C9D57E971}" dt="2023-07-20T14:17:02.033" v="480"/>
          <ac:spMkLst>
            <pc:docMk/>
            <pc:sldMk cId="2890828344" sldId="273"/>
            <ac:spMk id="58" creationId="{91BA6D28-ADF5-69A6-D9AC-1BAEE5EB43A2}"/>
          </ac:spMkLst>
        </pc:spChg>
        <pc:spChg chg="add">
          <ac:chgData name="Yates, Rob A." userId="S::raya228@uky.edu::c4835988-b912-40a4-bf56-31a2afc86d77" providerId="AD" clId="Web-{0CC3DE7B-5279-3B29-9775-114C9D57E971}" dt="2023-07-20T14:17:02.048" v="481"/>
          <ac:spMkLst>
            <pc:docMk/>
            <pc:sldMk cId="2890828344" sldId="273"/>
            <ac:spMk id="60" creationId="{F84D1E66-FA00-3543-DDDB-0C2570E12968}"/>
          </ac:spMkLst>
        </pc:spChg>
      </pc:sldChg>
      <pc:sldChg chg="addSp delSp">
        <pc:chgData name="Yates, Rob A." userId="S::raya228@uky.edu::c4835988-b912-40a4-bf56-31a2afc86d77" providerId="AD" clId="Web-{0CC3DE7B-5279-3B29-9775-114C9D57E971}" dt="2023-07-20T14:18:27.441" v="509"/>
        <pc:sldMkLst>
          <pc:docMk/>
          <pc:sldMk cId="768398678" sldId="274"/>
        </pc:sldMkLst>
        <pc:spChg chg="del">
          <ac:chgData name="Yates, Rob A." userId="S::raya228@uky.edu::c4835988-b912-40a4-bf56-31a2afc86d77" providerId="AD" clId="Web-{0CC3DE7B-5279-3B29-9775-114C9D57E971}" dt="2023-07-20T14:18:24.784" v="497"/>
          <ac:spMkLst>
            <pc:docMk/>
            <pc:sldMk cId="768398678" sldId="274"/>
            <ac:spMk id="4" creationId="{00000000-0000-0000-0000-000000000000}"/>
          </ac:spMkLst>
        </pc:spChg>
        <pc:spChg chg="del">
          <ac:chgData name="Yates, Rob A." userId="S::raya228@uky.edu::c4835988-b912-40a4-bf56-31a2afc86d77" providerId="AD" clId="Web-{0CC3DE7B-5279-3B29-9775-114C9D57E971}" dt="2023-07-20T14:18:24.784" v="496"/>
          <ac:spMkLst>
            <pc:docMk/>
            <pc:sldMk cId="768398678" sldId="274"/>
            <ac:spMk id="5" creationId="{00000000-0000-0000-0000-000000000000}"/>
          </ac:spMkLst>
        </pc:spChg>
        <pc:spChg chg="del">
          <ac:chgData name="Yates, Rob A." userId="S::raya228@uky.edu::c4835988-b912-40a4-bf56-31a2afc86d77" providerId="AD" clId="Web-{0CC3DE7B-5279-3B29-9775-114C9D57E971}" dt="2023-07-20T14:18:24.784" v="495"/>
          <ac:spMkLst>
            <pc:docMk/>
            <pc:sldMk cId="768398678" sldId="274"/>
            <ac:spMk id="8" creationId="{00000000-0000-0000-0000-000000000000}"/>
          </ac:spMkLst>
        </pc:spChg>
        <pc:spChg chg="del">
          <ac:chgData name="Yates, Rob A." userId="S::raya228@uky.edu::c4835988-b912-40a4-bf56-31a2afc86d77" providerId="AD" clId="Web-{0CC3DE7B-5279-3B29-9775-114C9D57E971}" dt="2023-07-20T14:18:24.784" v="494"/>
          <ac:spMkLst>
            <pc:docMk/>
            <pc:sldMk cId="768398678" sldId="274"/>
            <ac:spMk id="9" creationId="{00000000-0000-0000-0000-000000000000}"/>
          </ac:spMkLst>
        </pc:spChg>
        <pc:spChg chg="del">
          <ac:chgData name="Yates, Rob A." userId="S::raya228@uky.edu::c4835988-b912-40a4-bf56-31a2afc86d77" providerId="AD" clId="Web-{0CC3DE7B-5279-3B29-9775-114C9D57E971}" dt="2023-07-20T14:18:24.784" v="493"/>
          <ac:spMkLst>
            <pc:docMk/>
            <pc:sldMk cId="768398678" sldId="274"/>
            <ac:spMk id="13" creationId="{00000000-0000-0000-0000-000000000000}"/>
          </ac:spMkLst>
        </pc:spChg>
        <pc:spChg chg="del">
          <ac:chgData name="Yates, Rob A." userId="S::raya228@uky.edu::c4835988-b912-40a4-bf56-31a2afc86d77" providerId="AD" clId="Web-{0CC3DE7B-5279-3B29-9775-114C9D57E971}" dt="2023-07-20T14:18:24.784" v="492"/>
          <ac:spMkLst>
            <pc:docMk/>
            <pc:sldMk cId="768398678" sldId="274"/>
            <ac:spMk id="14" creationId="{00000000-0000-0000-0000-000000000000}"/>
          </ac:spMkLst>
        </pc:spChg>
        <pc:spChg chg="del">
          <ac:chgData name="Yates, Rob A." userId="S::raya228@uky.edu::c4835988-b912-40a4-bf56-31a2afc86d77" providerId="AD" clId="Web-{0CC3DE7B-5279-3B29-9775-114C9D57E971}" dt="2023-07-20T14:18:24.784" v="491"/>
          <ac:spMkLst>
            <pc:docMk/>
            <pc:sldMk cId="768398678" sldId="274"/>
            <ac:spMk id="18" creationId="{00000000-0000-0000-0000-000000000000}"/>
          </ac:spMkLst>
        </pc:spChg>
        <pc:spChg chg="del">
          <ac:chgData name="Yates, Rob A." userId="S::raya228@uky.edu::c4835988-b912-40a4-bf56-31a2afc86d77" providerId="AD" clId="Web-{0CC3DE7B-5279-3B29-9775-114C9D57E971}" dt="2023-07-20T14:18:24.784" v="490"/>
          <ac:spMkLst>
            <pc:docMk/>
            <pc:sldMk cId="768398678" sldId="274"/>
            <ac:spMk id="19" creationId="{00000000-0000-0000-0000-000000000000}"/>
          </ac:spMkLst>
        </pc:spChg>
        <pc:spChg chg="add">
          <ac:chgData name="Yates, Rob A." userId="S::raya228@uky.edu::c4835988-b912-40a4-bf56-31a2afc86d77" providerId="AD" clId="Web-{0CC3DE7B-5279-3B29-9775-114C9D57E971}" dt="2023-07-20T14:18:27.269" v="498"/>
          <ac:spMkLst>
            <pc:docMk/>
            <pc:sldMk cId="768398678" sldId="274"/>
            <ac:spMk id="22" creationId="{EA8A2DF6-B259-F336-789B-AB697ED4BEB3}"/>
          </ac:spMkLst>
        </pc:spChg>
        <pc:spChg chg="del">
          <ac:chgData name="Yates, Rob A." userId="S::raya228@uky.edu::c4835988-b912-40a4-bf56-31a2afc86d77" providerId="AD" clId="Web-{0CC3DE7B-5279-3B29-9775-114C9D57E971}" dt="2023-07-20T14:18:24.784" v="489"/>
          <ac:spMkLst>
            <pc:docMk/>
            <pc:sldMk cId="768398678" sldId="274"/>
            <ac:spMk id="23" creationId="{C4FF2EDC-D6A3-674E-6ECE-557A8AA15B0C}"/>
          </ac:spMkLst>
        </pc:spChg>
        <pc:spChg chg="add">
          <ac:chgData name="Yates, Rob A." userId="S::raya228@uky.edu::c4835988-b912-40a4-bf56-31a2afc86d77" providerId="AD" clId="Web-{0CC3DE7B-5279-3B29-9775-114C9D57E971}" dt="2023-07-20T14:18:27.285" v="499"/>
          <ac:spMkLst>
            <pc:docMk/>
            <pc:sldMk cId="768398678" sldId="274"/>
            <ac:spMk id="25" creationId="{526C9A2D-C86B-6FE6-1450-0BC8C4CF6A32}"/>
          </ac:spMkLst>
        </pc:spChg>
        <pc:spChg chg="del">
          <ac:chgData name="Yates, Rob A." userId="S::raya228@uky.edu::c4835988-b912-40a4-bf56-31a2afc86d77" providerId="AD" clId="Web-{0CC3DE7B-5279-3B29-9775-114C9D57E971}" dt="2023-07-20T14:18:24.784" v="488"/>
          <ac:spMkLst>
            <pc:docMk/>
            <pc:sldMk cId="768398678" sldId="274"/>
            <ac:spMk id="27" creationId="{AB43F744-E489-19CF-E258-5C156943B87B}"/>
          </ac:spMkLst>
        </pc:spChg>
        <pc:spChg chg="add">
          <ac:chgData name="Yates, Rob A." userId="S::raya228@uky.edu::c4835988-b912-40a4-bf56-31a2afc86d77" providerId="AD" clId="Web-{0CC3DE7B-5279-3B29-9775-114C9D57E971}" dt="2023-07-20T14:18:27.300" v="500"/>
          <ac:spMkLst>
            <pc:docMk/>
            <pc:sldMk cId="768398678" sldId="274"/>
            <ac:spMk id="28" creationId="{4BE7FD6F-6F2D-FFF2-35B8-A5F84F13AE7B}"/>
          </ac:spMkLst>
        </pc:spChg>
        <pc:spChg chg="del">
          <ac:chgData name="Yates, Rob A." userId="S::raya228@uky.edu::c4835988-b912-40a4-bf56-31a2afc86d77" providerId="AD" clId="Web-{0CC3DE7B-5279-3B29-9775-114C9D57E971}" dt="2023-07-20T14:18:24.784" v="487"/>
          <ac:spMkLst>
            <pc:docMk/>
            <pc:sldMk cId="768398678" sldId="274"/>
            <ac:spMk id="30" creationId="{1583B9A0-CB9B-0A47-11F1-49138FF19F3C}"/>
          </ac:spMkLst>
        </pc:spChg>
        <pc:spChg chg="add">
          <ac:chgData name="Yates, Rob A." userId="S::raya228@uky.edu::c4835988-b912-40a4-bf56-31a2afc86d77" providerId="AD" clId="Web-{0CC3DE7B-5279-3B29-9775-114C9D57E971}" dt="2023-07-20T14:18:27.300" v="501"/>
          <ac:spMkLst>
            <pc:docMk/>
            <pc:sldMk cId="768398678" sldId="274"/>
            <ac:spMk id="31" creationId="{B57A427B-7357-4DD7-64CA-C1E57CB197F4}"/>
          </ac:spMkLst>
        </pc:spChg>
        <pc:spChg chg="del">
          <ac:chgData name="Yates, Rob A." userId="S::raya228@uky.edu::c4835988-b912-40a4-bf56-31a2afc86d77" providerId="AD" clId="Web-{0CC3DE7B-5279-3B29-9775-114C9D57E971}" dt="2023-07-20T14:18:24.784" v="486"/>
          <ac:spMkLst>
            <pc:docMk/>
            <pc:sldMk cId="768398678" sldId="274"/>
            <ac:spMk id="32" creationId="{D5361EB9-1BB6-CCEE-FC79-2FF791826E71}"/>
          </ac:spMkLst>
        </pc:spChg>
        <pc:spChg chg="add">
          <ac:chgData name="Yates, Rob A." userId="S::raya228@uky.edu::c4835988-b912-40a4-bf56-31a2afc86d77" providerId="AD" clId="Web-{0CC3DE7B-5279-3B29-9775-114C9D57E971}" dt="2023-07-20T14:18:27.316" v="502"/>
          <ac:spMkLst>
            <pc:docMk/>
            <pc:sldMk cId="768398678" sldId="274"/>
            <ac:spMk id="34" creationId="{C7AD297C-288A-43B3-CB4A-0CAFF37DCA59}"/>
          </ac:spMkLst>
        </pc:spChg>
        <pc:spChg chg="add">
          <ac:chgData name="Yates, Rob A." userId="S::raya228@uky.edu::c4835988-b912-40a4-bf56-31a2afc86d77" providerId="AD" clId="Web-{0CC3DE7B-5279-3B29-9775-114C9D57E971}" dt="2023-07-20T14:18:27.331" v="503"/>
          <ac:spMkLst>
            <pc:docMk/>
            <pc:sldMk cId="768398678" sldId="274"/>
            <ac:spMk id="36" creationId="{07718A0E-677B-4135-C7B0-0965468A46C2}"/>
          </ac:spMkLst>
        </pc:spChg>
        <pc:spChg chg="add">
          <ac:chgData name="Yates, Rob A." userId="S::raya228@uky.edu::c4835988-b912-40a4-bf56-31a2afc86d77" providerId="AD" clId="Web-{0CC3DE7B-5279-3B29-9775-114C9D57E971}" dt="2023-07-20T14:18:27.347" v="504"/>
          <ac:spMkLst>
            <pc:docMk/>
            <pc:sldMk cId="768398678" sldId="274"/>
            <ac:spMk id="38" creationId="{D6AD9A39-9B61-11BD-01E5-CF5F369B0935}"/>
          </ac:spMkLst>
        </pc:spChg>
        <pc:spChg chg="add">
          <ac:chgData name="Yates, Rob A." userId="S::raya228@uky.edu::c4835988-b912-40a4-bf56-31a2afc86d77" providerId="AD" clId="Web-{0CC3DE7B-5279-3B29-9775-114C9D57E971}" dt="2023-07-20T14:18:27.363" v="505"/>
          <ac:spMkLst>
            <pc:docMk/>
            <pc:sldMk cId="768398678" sldId="274"/>
            <ac:spMk id="40" creationId="{1B7DE750-D2EB-C1EE-F829-5F4CA261A557}"/>
          </ac:spMkLst>
        </pc:spChg>
        <pc:spChg chg="add">
          <ac:chgData name="Yates, Rob A." userId="S::raya228@uky.edu::c4835988-b912-40a4-bf56-31a2afc86d77" providerId="AD" clId="Web-{0CC3DE7B-5279-3B29-9775-114C9D57E971}" dt="2023-07-20T14:18:27.378" v="506"/>
          <ac:spMkLst>
            <pc:docMk/>
            <pc:sldMk cId="768398678" sldId="274"/>
            <ac:spMk id="42" creationId="{1F74B639-0330-3065-2E0D-E87912F06E39}"/>
          </ac:spMkLst>
        </pc:spChg>
        <pc:spChg chg="add">
          <ac:chgData name="Yates, Rob A." userId="S::raya228@uky.edu::c4835988-b912-40a4-bf56-31a2afc86d77" providerId="AD" clId="Web-{0CC3DE7B-5279-3B29-9775-114C9D57E971}" dt="2023-07-20T14:18:27.394" v="507"/>
          <ac:spMkLst>
            <pc:docMk/>
            <pc:sldMk cId="768398678" sldId="274"/>
            <ac:spMk id="44" creationId="{7EC579EE-2351-41BB-4C9C-5F2A86022ABB}"/>
          </ac:spMkLst>
        </pc:spChg>
        <pc:spChg chg="add">
          <ac:chgData name="Yates, Rob A." userId="S::raya228@uky.edu::c4835988-b912-40a4-bf56-31a2afc86d77" providerId="AD" clId="Web-{0CC3DE7B-5279-3B29-9775-114C9D57E971}" dt="2023-07-20T14:18:27.425" v="508"/>
          <ac:spMkLst>
            <pc:docMk/>
            <pc:sldMk cId="768398678" sldId="274"/>
            <ac:spMk id="46" creationId="{242663B2-380E-267E-9907-8AF2E0D17CB3}"/>
          </ac:spMkLst>
        </pc:spChg>
        <pc:spChg chg="add">
          <ac:chgData name="Yates, Rob A." userId="S::raya228@uky.edu::c4835988-b912-40a4-bf56-31a2afc86d77" providerId="AD" clId="Web-{0CC3DE7B-5279-3B29-9775-114C9D57E971}" dt="2023-07-20T14:18:27.441" v="509"/>
          <ac:spMkLst>
            <pc:docMk/>
            <pc:sldMk cId="768398678" sldId="274"/>
            <ac:spMk id="48" creationId="{8AF1EC26-B53D-6E91-DB43-63E4AB8ACB07}"/>
          </ac:spMkLst>
        </pc:spChg>
      </pc:sldChg>
      <pc:sldChg chg="add del replId">
        <pc:chgData name="Yates, Rob A." userId="S::raya228@uky.edu::c4835988-b912-40a4-bf56-31a2afc86d77" providerId="AD" clId="Web-{0CC3DE7B-5279-3B29-9775-114C9D57E971}" dt="2023-07-20T14:20:39.834" v="574"/>
        <pc:sldMkLst>
          <pc:docMk/>
          <pc:sldMk cId="635432183" sldId="275"/>
        </pc:sldMkLst>
      </pc:sldChg>
      <pc:sldChg chg="add del replId">
        <pc:chgData name="Yates, Rob A." userId="S::raya228@uky.edu::c4835988-b912-40a4-bf56-31a2afc86d77" providerId="AD" clId="Web-{0CC3DE7B-5279-3B29-9775-114C9D57E971}" dt="2023-07-20T14:15:35.749" v="414"/>
        <pc:sldMkLst>
          <pc:docMk/>
          <pc:sldMk cId="851941830" sldId="275"/>
        </pc:sldMkLst>
      </pc:sldChg>
      <pc:sldChg chg="add del replId">
        <pc:chgData name="Yates, Rob A." userId="S::raya228@uky.edu::c4835988-b912-40a4-bf56-31a2afc86d77" providerId="AD" clId="Web-{0CC3DE7B-5279-3B29-9775-114C9D57E971}" dt="2023-07-20T13:45:23.427" v="140"/>
        <pc:sldMkLst>
          <pc:docMk/>
          <pc:sldMk cId="1639109988" sldId="275"/>
        </pc:sldMkLst>
      </pc:sldChg>
      <pc:sldChg chg="add del replId">
        <pc:chgData name="Yates, Rob A." userId="S::raya228@uky.edu::c4835988-b912-40a4-bf56-31a2afc86d77" providerId="AD" clId="Web-{0CC3DE7B-5279-3B29-9775-114C9D57E971}" dt="2023-07-20T14:13:18.215" v="346"/>
        <pc:sldMkLst>
          <pc:docMk/>
          <pc:sldMk cId="1942810703" sldId="275"/>
        </pc:sldMkLst>
      </pc:sldChg>
      <pc:sldChg chg="add del replId">
        <pc:chgData name="Yates, Rob A." userId="S::raya228@uky.edu::c4835988-b912-40a4-bf56-31a2afc86d77" providerId="AD" clId="Web-{0CC3DE7B-5279-3B29-9775-114C9D57E971}" dt="2023-07-20T13:25:36.552" v="72"/>
        <pc:sldMkLst>
          <pc:docMk/>
          <pc:sldMk cId="2345579523" sldId="275"/>
        </pc:sldMkLst>
      </pc:sldChg>
      <pc:sldChg chg="new del">
        <pc:chgData name="Yates, Rob A." userId="S::raya228@uky.edu::c4835988-b912-40a4-bf56-31a2afc86d77" providerId="AD" clId="Web-{0CC3DE7B-5279-3B29-9775-114C9D57E971}" dt="2023-07-20T14:19:32.630" v="537"/>
        <pc:sldMkLst>
          <pc:docMk/>
          <pc:sldMk cId="2905581793" sldId="275"/>
        </pc:sldMkLst>
      </pc:sldChg>
      <pc:sldChg chg="add del replId">
        <pc:chgData name="Yates, Rob A." userId="S::raya228@uky.edu::c4835988-b912-40a4-bf56-31a2afc86d77" providerId="AD" clId="Web-{0CC3DE7B-5279-3B29-9775-114C9D57E971}" dt="2023-07-20T14:17:14.798" v="482"/>
        <pc:sldMkLst>
          <pc:docMk/>
          <pc:sldMk cId="2906295263" sldId="275"/>
        </pc:sldMkLst>
      </pc:sldChg>
      <pc:sldChg chg="add del replId">
        <pc:chgData name="Yates, Rob A." userId="S::raya228@uky.edu::c4835988-b912-40a4-bf56-31a2afc86d77" providerId="AD" clId="Web-{0CC3DE7B-5279-3B29-9775-114C9D57E971}" dt="2023-07-20T14:18:59.692" v="534"/>
        <pc:sldMkLst>
          <pc:docMk/>
          <pc:sldMk cId="3628107197" sldId="275"/>
        </pc:sldMkLst>
      </pc:sldChg>
      <pc:sldChg chg="add del replId">
        <pc:chgData name="Yates, Rob A." userId="S::raya228@uky.edu::c4835988-b912-40a4-bf56-31a2afc86d77" providerId="AD" clId="Web-{0CC3DE7B-5279-3B29-9775-114C9D57E971}" dt="2023-07-20T14:09:09.100" v="208"/>
        <pc:sldMkLst>
          <pc:docMk/>
          <pc:sldMk cId="3750936938" sldId="275"/>
        </pc:sldMkLst>
      </pc:sldChg>
      <pc:sldChg chg="add del replId">
        <pc:chgData name="Yates, Rob A." userId="S::raya228@uky.edu::c4835988-b912-40a4-bf56-31a2afc86d77" providerId="AD" clId="Web-{0CC3DE7B-5279-3B29-9775-114C9D57E971}" dt="2023-07-20T14:11:03.212" v="276"/>
        <pc:sldMkLst>
          <pc:docMk/>
          <pc:sldMk cId="4051209760" sldId="275"/>
        </pc:sldMkLst>
      </pc:sldChg>
      <pc:sldChg chg="add del replId">
        <pc:chgData name="Yates, Rob A." userId="S::raya228@uky.edu::c4835988-b912-40a4-bf56-31a2afc86d77" providerId="AD" clId="Web-{0CC3DE7B-5279-3B29-9775-114C9D57E971}" dt="2023-07-20T14:15:39.031" v="415"/>
        <pc:sldMkLst>
          <pc:docMk/>
          <pc:sldMk cId="585246369" sldId="276"/>
        </pc:sldMkLst>
      </pc:sldChg>
      <pc:sldChg chg="add del replId">
        <pc:chgData name="Yates, Rob A." userId="S::raya228@uky.edu::c4835988-b912-40a4-bf56-31a2afc86d77" providerId="AD" clId="Web-{0CC3DE7B-5279-3B29-9775-114C9D57E971}" dt="2023-07-20T13:45:26.568" v="141"/>
        <pc:sldMkLst>
          <pc:docMk/>
          <pc:sldMk cId="629835643" sldId="276"/>
        </pc:sldMkLst>
      </pc:sldChg>
      <pc:sldChg chg="add del replId">
        <pc:chgData name="Yates, Rob A." userId="S::raya228@uky.edu::c4835988-b912-40a4-bf56-31a2afc86d77" providerId="AD" clId="Web-{0CC3DE7B-5279-3B29-9775-114C9D57E971}" dt="2023-07-20T14:19:03.551" v="535"/>
        <pc:sldMkLst>
          <pc:docMk/>
          <pc:sldMk cId="1241910061" sldId="276"/>
        </pc:sldMkLst>
      </pc:sldChg>
      <pc:sldChg chg="add del replId">
        <pc:chgData name="Yates, Rob A." userId="S::raya228@uky.edu::c4835988-b912-40a4-bf56-31a2afc86d77" providerId="AD" clId="Web-{0CC3DE7B-5279-3B29-9775-114C9D57E971}" dt="2023-07-20T14:17:18.720" v="483"/>
        <pc:sldMkLst>
          <pc:docMk/>
          <pc:sldMk cId="1453476451" sldId="276"/>
        </pc:sldMkLst>
      </pc:sldChg>
      <pc:sldChg chg="add del replId">
        <pc:chgData name="Yates, Rob A." userId="S::raya228@uky.edu::c4835988-b912-40a4-bf56-31a2afc86d77" providerId="AD" clId="Web-{0CC3DE7B-5279-3B29-9775-114C9D57E971}" dt="2023-07-20T14:09:13.741" v="209"/>
        <pc:sldMkLst>
          <pc:docMk/>
          <pc:sldMk cId="1750772578" sldId="276"/>
        </pc:sldMkLst>
      </pc:sldChg>
      <pc:sldChg chg="add del replId">
        <pc:chgData name="Yates, Rob A." userId="S::raya228@uky.edu::c4835988-b912-40a4-bf56-31a2afc86d77" providerId="AD" clId="Web-{0CC3DE7B-5279-3B29-9775-114C9D57E971}" dt="2023-07-20T14:20:43.522" v="575"/>
        <pc:sldMkLst>
          <pc:docMk/>
          <pc:sldMk cId="1983100829" sldId="276"/>
        </pc:sldMkLst>
      </pc:sldChg>
      <pc:sldChg chg="add del replId">
        <pc:chgData name="Yates, Rob A." userId="S::raya228@uky.edu::c4835988-b912-40a4-bf56-31a2afc86d77" providerId="AD" clId="Web-{0CC3DE7B-5279-3B29-9775-114C9D57E971}" dt="2023-07-20T14:11:08.556" v="277"/>
        <pc:sldMkLst>
          <pc:docMk/>
          <pc:sldMk cId="3421362317" sldId="276"/>
        </pc:sldMkLst>
      </pc:sldChg>
      <pc:sldChg chg="add del replId">
        <pc:chgData name="Yates, Rob A." userId="S::raya228@uky.edu::c4835988-b912-40a4-bf56-31a2afc86d77" providerId="AD" clId="Web-{0CC3DE7B-5279-3B29-9775-114C9D57E971}" dt="2023-07-20T13:25:47.490" v="73"/>
        <pc:sldMkLst>
          <pc:docMk/>
          <pc:sldMk cId="4234699125" sldId="276"/>
        </pc:sldMkLst>
      </pc:sldChg>
      <pc:sldChg chg="add del replId">
        <pc:chgData name="Yates, Rob A." userId="S::raya228@uky.edu::c4835988-b912-40a4-bf56-31a2afc86d77" providerId="AD" clId="Web-{0CC3DE7B-5279-3B29-9775-114C9D57E971}" dt="2023-07-20T14:13:22.762" v="347"/>
        <pc:sldMkLst>
          <pc:docMk/>
          <pc:sldMk cId="4287905837" sldId="276"/>
        </pc:sldMkLst>
      </pc:sldChg>
    </pc:docChg>
  </pc:docChgLst>
  <pc:docChgLst>
    <pc:chgData name="Twist, Katherine E." userId="S::ketwis2@uky.edu::45331757-1fa0-4e4d-9a75-655a060dde67" providerId="AD" clId="Web-{9CE19E66-945B-E8E2-2608-944A76F90909}"/>
    <pc:docChg chg="modSld">
      <pc:chgData name="Twist, Katherine E." userId="S::ketwis2@uky.edu::45331757-1fa0-4e4d-9a75-655a060dde67" providerId="AD" clId="Web-{9CE19E66-945B-E8E2-2608-944A76F90909}" dt="2023-07-20T13:09:23.380" v="149" actId="20577"/>
      <pc:docMkLst>
        <pc:docMk/>
      </pc:docMkLst>
      <pc:sldChg chg="modSp">
        <pc:chgData name="Twist, Katherine E." userId="S::ketwis2@uky.edu::45331757-1fa0-4e4d-9a75-655a060dde67" providerId="AD" clId="Web-{9CE19E66-945B-E8E2-2608-944A76F90909}" dt="2023-07-20T13:08:43.223" v="135" actId="20577"/>
        <pc:sldMkLst>
          <pc:docMk/>
          <pc:sldMk cId="0" sldId="266"/>
        </pc:sldMkLst>
        <pc:spChg chg="mod">
          <ac:chgData name="Twist, Katherine E." userId="S::ketwis2@uky.edu::45331757-1fa0-4e4d-9a75-655a060dde67" providerId="AD" clId="Web-{9CE19E66-945B-E8E2-2608-944A76F90909}" dt="2023-07-20T13:08:29.722" v="127" actId="14100"/>
          <ac:spMkLst>
            <pc:docMk/>
            <pc:sldMk cId="0" sldId="266"/>
            <ac:spMk id="2" creationId="{00000000-0000-0000-0000-000000000000}"/>
          </ac:spMkLst>
        </pc:spChg>
        <pc:spChg chg="mod">
          <ac:chgData name="Twist, Katherine E." userId="S::ketwis2@uky.edu::45331757-1fa0-4e4d-9a75-655a060dde67" providerId="AD" clId="Web-{9CE19E66-945B-E8E2-2608-944A76F90909}" dt="2023-07-20T13:04:14.077" v="34" actId="20577"/>
          <ac:spMkLst>
            <pc:docMk/>
            <pc:sldMk cId="0" sldId="266"/>
            <ac:spMk id="6" creationId="{00000000-0000-0000-0000-000000000000}"/>
          </ac:spMkLst>
        </pc:spChg>
        <pc:spChg chg="mod">
          <ac:chgData name="Twist, Katherine E." userId="S::ketwis2@uky.edu::45331757-1fa0-4e4d-9a75-655a060dde67" providerId="AD" clId="Web-{9CE19E66-945B-E8E2-2608-944A76F90909}" dt="2023-07-20T13:08:37.082" v="132" actId="14100"/>
          <ac:spMkLst>
            <pc:docMk/>
            <pc:sldMk cId="0" sldId="266"/>
            <ac:spMk id="11" creationId="{00000000-0000-0000-0000-000000000000}"/>
          </ac:spMkLst>
        </pc:spChg>
        <pc:spChg chg="mod">
          <ac:chgData name="Twist, Katherine E." userId="S::ketwis2@uky.edu::45331757-1fa0-4e4d-9a75-655a060dde67" providerId="AD" clId="Web-{9CE19E66-945B-E8E2-2608-944A76F90909}" dt="2023-07-20T13:08:43.223" v="135" actId="20577"/>
          <ac:spMkLst>
            <pc:docMk/>
            <pc:sldMk cId="0" sldId="266"/>
            <ac:spMk id="16" creationId="{00000000-0000-0000-0000-000000000000}"/>
          </ac:spMkLst>
        </pc:spChg>
        <pc:spChg chg="mod">
          <ac:chgData name="Twist, Katherine E." userId="S::ketwis2@uky.edu::45331757-1fa0-4e4d-9a75-655a060dde67" providerId="AD" clId="Web-{9CE19E66-945B-E8E2-2608-944A76F90909}" dt="2023-07-20T13:07:40.549" v="122" actId="20577"/>
          <ac:spMkLst>
            <pc:docMk/>
            <pc:sldMk cId="0" sldId="266"/>
            <ac:spMk id="26" creationId="{8D5CA340-99A5-5FEA-C283-752C38D8C231}"/>
          </ac:spMkLst>
        </pc:spChg>
      </pc:sldChg>
      <pc:sldChg chg="modSp">
        <pc:chgData name="Twist, Katherine E." userId="S::ketwis2@uky.edu::45331757-1fa0-4e4d-9a75-655a060dde67" providerId="AD" clId="Web-{9CE19E66-945B-E8E2-2608-944A76F90909}" dt="2023-07-20T13:09:23.380" v="149" actId="20577"/>
        <pc:sldMkLst>
          <pc:docMk/>
          <pc:sldMk cId="0" sldId="272"/>
        </pc:sldMkLst>
        <pc:spChg chg="mod">
          <ac:chgData name="Twist, Katherine E." userId="S::ketwis2@uky.edu::45331757-1fa0-4e4d-9a75-655a060dde67" providerId="AD" clId="Web-{9CE19E66-945B-E8E2-2608-944A76F90909}" dt="2023-07-20T13:09:23.380" v="149" actId="20577"/>
          <ac:spMkLst>
            <pc:docMk/>
            <pc:sldMk cId="0" sldId="272"/>
            <ac:spMk id="2" creationId="{00000000-0000-0000-0000-000000000000}"/>
          </ac:spMkLst>
        </pc:spChg>
      </pc:sldChg>
      <pc:sldChg chg="modSp">
        <pc:chgData name="Twist, Katherine E." userId="S::ketwis2@uky.edu::45331757-1fa0-4e4d-9a75-655a060dde67" providerId="AD" clId="Web-{9CE19E66-945B-E8E2-2608-944A76F90909}" dt="2023-07-20T13:08:51.941" v="146" actId="20577"/>
        <pc:sldMkLst>
          <pc:docMk/>
          <pc:sldMk cId="768398678" sldId="274"/>
        </pc:sldMkLst>
        <pc:spChg chg="mod">
          <ac:chgData name="Twist, Katherine E." userId="S::ketwis2@uky.edu::45331757-1fa0-4e4d-9a75-655a060dde67" providerId="AD" clId="Web-{9CE19E66-945B-E8E2-2608-944A76F90909}" dt="2023-07-20T13:08:46.926" v="138" actId="20577"/>
          <ac:spMkLst>
            <pc:docMk/>
            <pc:sldMk cId="768398678" sldId="274"/>
            <ac:spMk id="2" creationId="{00000000-0000-0000-0000-000000000000}"/>
          </ac:spMkLst>
        </pc:spChg>
        <pc:spChg chg="mod">
          <ac:chgData name="Twist, Katherine E." userId="S::ketwis2@uky.edu::45331757-1fa0-4e4d-9a75-655a060dde67" providerId="AD" clId="Web-{9CE19E66-945B-E8E2-2608-944A76F90909}" dt="2023-07-20T13:08:48.848" v="140" actId="20577"/>
          <ac:spMkLst>
            <pc:docMk/>
            <pc:sldMk cId="768398678" sldId="274"/>
            <ac:spMk id="6" creationId="{00000000-0000-0000-0000-000000000000}"/>
          </ac:spMkLst>
        </pc:spChg>
        <pc:spChg chg="mod">
          <ac:chgData name="Twist, Katherine E." userId="S::ketwis2@uky.edu::45331757-1fa0-4e4d-9a75-655a060dde67" providerId="AD" clId="Web-{9CE19E66-945B-E8E2-2608-944A76F90909}" dt="2023-07-20T13:08:50.504" v="143" actId="20577"/>
          <ac:spMkLst>
            <pc:docMk/>
            <pc:sldMk cId="768398678" sldId="274"/>
            <ac:spMk id="11" creationId="{00000000-0000-0000-0000-000000000000}"/>
          </ac:spMkLst>
        </pc:spChg>
        <pc:spChg chg="mod">
          <ac:chgData name="Twist, Katherine E." userId="S::ketwis2@uky.edu::45331757-1fa0-4e4d-9a75-655a060dde67" providerId="AD" clId="Web-{9CE19E66-945B-E8E2-2608-944A76F90909}" dt="2023-07-20T13:08:51.941" v="146" actId="20577"/>
          <ac:spMkLst>
            <pc:docMk/>
            <pc:sldMk cId="768398678" sldId="274"/>
            <ac:spMk id="16" creationId="{00000000-0000-0000-0000-000000000000}"/>
          </ac:spMkLst>
        </pc:spChg>
      </pc:sldChg>
    </pc:docChg>
  </pc:docChgLst>
  <pc:docChgLst>
    <pc:chgData name="Yates, Rob A." userId="S::raya228@uky.edu::c4835988-b912-40a4-bf56-31a2afc86d77" providerId="AD" clId="Web-{E30D171D-EFF4-ED4B-9D70-E0580DA69565}"/>
    <pc:docChg chg="addSld modSld sldOrd">
      <pc:chgData name="Yates, Rob A." userId="S::raya228@uky.edu::c4835988-b912-40a4-bf56-31a2afc86d77" providerId="AD" clId="Web-{E30D171D-EFF4-ED4B-9D70-E0580DA69565}" dt="2023-06-30T20:28:43.785" v="539" actId="1076"/>
      <pc:docMkLst>
        <pc:docMk/>
      </pc:docMkLst>
      <pc:sldChg chg="modSp">
        <pc:chgData name="Yates, Rob A." userId="S::raya228@uky.edu::c4835988-b912-40a4-bf56-31a2afc86d77" providerId="AD" clId="Web-{E30D171D-EFF4-ED4B-9D70-E0580DA69565}" dt="2023-06-30T19:43:19.654" v="20" actId="20577"/>
        <pc:sldMkLst>
          <pc:docMk/>
          <pc:sldMk cId="0" sldId="256"/>
        </pc:sldMkLst>
        <pc:spChg chg="mod">
          <ac:chgData name="Yates, Rob A." userId="S::raya228@uky.edu::c4835988-b912-40a4-bf56-31a2afc86d77" providerId="AD" clId="Web-{E30D171D-EFF4-ED4B-9D70-E0580DA69565}" dt="2023-06-30T19:42:59.622" v="9" actId="20577"/>
          <ac:spMkLst>
            <pc:docMk/>
            <pc:sldMk cId="0" sldId="256"/>
            <ac:spMk id="2" creationId="{00000000-0000-0000-0000-000000000000}"/>
          </ac:spMkLst>
        </pc:spChg>
        <pc:spChg chg="mod">
          <ac:chgData name="Yates, Rob A." userId="S::raya228@uky.edu::c4835988-b912-40a4-bf56-31a2afc86d77" providerId="AD" clId="Web-{E30D171D-EFF4-ED4B-9D70-E0580DA69565}" dt="2023-06-30T19:43:19.654" v="20" actId="20577"/>
          <ac:spMkLst>
            <pc:docMk/>
            <pc:sldMk cId="0" sldId="256"/>
            <ac:spMk id="6" creationId="{00000000-0000-0000-0000-000000000000}"/>
          </ac:spMkLst>
        </pc:spChg>
      </pc:sldChg>
      <pc:sldChg chg="modSp">
        <pc:chgData name="Yates, Rob A." userId="S::raya228@uky.edu::c4835988-b912-40a4-bf56-31a2afc86d77" providerId="AD" clId="Web-{E30D171D-EFF4-ED4B-9D70-E0580DA69565}" dt="2023-06-30T19:45:14.283" v="32" actId="20577"/>
        <pc:sldMkLst>
          <pc:docMk/>
          <pc:sldMk cId="0" sldId="259"/>
        </pc:sldMkLst>
        <pc:spChg chg="mod">
          <ac:chgData name="Yates, Rob A." userId="S::raya228@uky.edu::c4835988-b912-40a4-bf56-31a2afc86d77" providerId="AD" clId="Web-{E30D171D-EFF4-ED4B-9D70-E0580DA69565}" dt="2023-06-30T19:44:51.313" v="27" actId="20577"/>
          <ac:spMkLst>
            <pc:docMk/>
            <pc:sldMk cId="0" sldId="259"/>
            <ac:spMk id="6" creationId="{00000000-0000-0000-0000-000000000000}"/>
          </ac:spMkLst>
        </pc:spChg>
        <pc:spChg chg="mod">
          <ac:chgData name="Yates, Rob A." userId="S::raya228@uky.edu::c4835988-b912-40a4-bf56-31a2afc86d77" providerId="AD" clId="Web-{E30D171D-EFF4-ED4B-9D70-E0580DA69565}" dt="2023-06-30T19:45:14.283" v="32" actId="20577"/>
          <ac:spMkLst>
            <pc:docMk/>
            <pc:sldMk cId="0" sldId="259"/>
            <ac:spMk id="11" creationId="{00000000-0000-0000-0000-000000000000}"/>
          </ac:spMkLst>
        </pc:spChg>
      </pc:sldChg>
      <pc:sldChg chg="modSp">
        <pc:chgData name="Yates, Rob A." userId="S::raya228@uky.edu::c4835988-b912-40a4-bf56-31a2afc86d77" providerId="AD" clId="Web-{E30D171D-EFF4-ED4B-9D70-E0580DA69565}" dt="2023-06-30T19:45:52.503" v="36" actId="20577"/>
        <pc:sldMkLst>
          <pc:docMk/>
          <pc:sldMk cId="0" sldId="261"/>
        </pc:sldMkLst>
        <pc:spChg chg="mod">
          <ac:chgData name="Yates, Rob A." userId="S::raya228@uky.edu::c4835988-b912-40a4-bf56-31a2afc86d77" providerId="AD" clId="Web-{E30D171D-EFF4-ED4B-9D70-E0580DA69565}" dt="2023-06-30T19:45:52.503" v="36" actId="20577"/>
          <ac:spMkLst>
            <pc:docMk/>
            <pc:sldMk cId="0" sldId="261"/>
            <ac:spMk id="11" creationId="{00000000-0000-0000-0000-000000000000}"/>
          </ac:spMkLst>
        </pc:spChg>
      </pc:sldChg>
      <pc:sldChg chg="modSp">
        <pc:chgData name="Yates, Rob A." userId="S::raya228@uky.edu::c4835988-b912-40a4-bf56-31a2afc86d77" providerId="AD" clId="Web-{E30D171D-EFF4-ED4B-9D70-E0580DA69565}" dt="2023-06-30T19:46:34.333" v="40"/>
        <pc:sldMkLst>
          <pc:docMk/>
          <pc:sldMk cId="0" sldId="262"/>
        </pc:sldMkLst>
        <pc:spChg chg="mod">
          <ac:chgData name="Yates, Rob A." userId="S::raya228@uky.edu::c4835988-b912-40a4-bf56-31a2afc86d77" providerId="AD" clId="Web-{E30D171D-EFF4-ED4B-9D70-E0580DA69565}" dt="2023-06-30T19:46:23.895" v="37"/>
          <ac:spMkLst>
            <pc:docMk/>
            <pc:sldMk cId="0" sldId="262"/>
            <ac:spMk id="2" creationId="{00000000-0000-0000-0000-000000000000}"/>
          </ac:spMkLst>
        </pc:spChg>
        <pc:spChg chg="mod">
          <ac:chgData name="Yates, Rob A." userId="S::raya228@uky.edu::c4835988-b912-40a4-bf56-31a2afc86d77" providerId="AD" clId="Web-{E30D171D-EFF4-ED4B-9D70-E0580DA69565}" dt="2023-06-30T19:46:27.176" v="38"/>
          <ac:spMkLst>
            <pc:docMk/>
            <pc:sldMk cId="0" sldId="262"/>
            <ac:spMk id="6" creationId="{00000000-0000-0000-0000-000000000000}"/>
          </ac:spMkLst>
        </pc:spChg>
        <pc:spChg chg="mod">
          <ac:chgData name="Yates, Rob A." userId="S::raya228@uky.edu::c4835988-b912-40a4-bf56-31a2afc86d77" providerId="AD" clId="Web-{E30D171D-EFF4-ED4B-9D70-E0580DA69565}" dt="2023-06-30T19:46:31.504" v="39"/>
          <ac:spMkLst>
            <pc:docMk/>
            <pc:sldMk cId="0" sldId="262"/>
            <ac:spMk id="11" creationId="{00000000-0000-0000-0000-000000000000}"/>
          </ac:spMkLst>
        </pc:spChg>
        <pc:spChg chg="mod">
          <ac:chgData name="Yates, Rob A." userId="S::raya228@uky.edu::c4835988-b912-40a4-bf56-31a2afc86d77" providerId="AD" clId="Web-{E30D171D-EFF4-ED4B-9D70-E0580DA69565}" dt="2023-06-30T19:46:34.333" v="40"/>
          <ac:spMkLst>
            <pc:docMk/>
            <pc:sldMk cId="0" sldId="262"/>
            <ac:spMk id="16" creationId="{00000000-0000-0000-0000-000000000000}"/>
          </ac:spMkLst>
        </pc:spChg>
      </pc:sldChg>
      <pc:sldChg chg="modSp">
        <pc:chgData name="Yates, Rob A." userId="S::raya228@uky.edu::c4835988-b912-40a4-bf56-31a2afc86d77" providerId="AD" clId="Web-{E30D171D-EFF4-ED4B-9D70-E0580DA69565}" dt="2023-06-30T20:25:19.918" v="506" actId="1076"/>
        <pc:sldMkLst>
          <pc:docMk/>
          <pc:sldMk cId="0" sldId="264"/>
        </pc:sldMkLst>
        <pc:spChg chg="mod">
          <ac:chgData name="Yates, Rob A." userId="S::raya228@uky.edu::c4835988-b912-40a4-bf56-31a2afc86d77" providerId="AD" clId="Web-{E30D171D-EFF4-ED4B-9D70-E0580DA69565}" dt="2023-06-30T20:25:12.934" v="505" actId="1076"/>
          <ac:spMkLst>
            <pc:docMk/>
            <pc:sldMk cId="0" sldId="264"/>
            <ac:spMk id="2" creationId="{00000000-0000-0000-0000-000000000000}"/>
          </ac:spMkLst>
        </pc:spChg>
        <pc:spChg chg="mod">
          <ac:chgData name="Yates, Rob A." userId="S::raya228@uky.edu::c4835988-b912-40a4-bf56-31a2afc86d77" providerId="AD" clId="Web-{E30D171D-EFF4-ED4B-9D70-E0580DA69565}" dt="2023-06-30T20:25:19.918" v="506" actId="1076"/>
          <ac:spMkLst>
            <pc:docMk/>
            <pc:sldMk cId="0" sldId="264"/>
            <ac:spMk id="6" creationId="{00000000-0000-0000-0000-000000000000}"/>
          </ac:spMkLst>
        </pc:spChg>
        <pc:spChg chg="mod">
          <ac:chgData name="Yates, Rob A." userId="S::raya228@uky.edu::c4835988-b912-40a4-bf56-31a2afc86d77" providerId="AD" clId="Web-{E30D171D-EFF4-ED4B-9D70-E0580DA69565}" dt="2023-06-30T20:24:55.761" v="503" actId="1076"/>
          <ac:spMkLst>
            <pc:docMk/>
            <pc:sldMk cId="0" sldId="264"/>
            <ac:spMk id="11" creationId="{00000000-0000-0000-0000-000000000000}"/>
          </ac:spMkLst>
        </pc:spChg>
        <pc:spChg chg="mod">
          <ac:chgData name="Yates, Rob A." userId="S::raya228@uky.edu::c4835988-b912-40a4-bf56-31a2afc86d77" providerId="AD" clId="Web-{E30D171D-EFF4-ED4B-9D70-E0580DA69565}" dt="2023-06-30T20:25:04.996" v="504" actId="1076"/>
          <ac:spMkLst>
            <pc:docMk/>
            <pc:sldMk cId="0" sldId="264"/>
            <ac:spMk id="16" creationId="{00000000-0000-0000-0000-000000000000}"/>
          </ac:spMkLst>
        </pc:spChg>
      </pc:sldChg>
      <pc:sldChg chg="delSp modSp ord">
        <pc:chgData name="Yates, Rob A." userId="S::raya228@uky.edu::c4835988-b912-40a4-bf56-31a2afc86d77" providerId="AD" clId="Web-{E30D171D-EFF4-ED4B-9D70-E0580DA69565}" dt="2023-06-30T20:26:22.858" v="515" actId="1076"/>
        <pc:sldMkLst>
          <pc:docMk/>
          <pc:sldMk cId="0" sldId="265"/>
        </pc:sldMkLst>
        <pc:spChg chg="mod">
          <ac:chgData name="Yates, Rob A." userId="S::raya228@uky.edu::c4835988-b912-40a4-bf56-31a2afc86d77" providerId="AD" clId="Web-{E30D171D-EFF4-ED4B-9D70-E0580DA69565}" dt="2023-06-30T20:26:10.186" v="514" actId="1076"/>
          <ac:spMkLst>
            <pc:docMk/>
            <pc:sldMk cId="0" sldId="265"/>
            <ac:spMk id="2" creationId="{00000000-0000-0000-0000-000000000000}"/>
          </ac:spMkLst>
        </pc:spChg>
        <pc:spChg chg="mod">
          <ac:chgData name="Yates, Rob A." userId="S::raya228@uky.edu::c4835988-b912-40a4-bf56-31a2afc86d77" providerId="AD" clId="Web-{E30D171D-EFF4-ED4B-9D70-E0580DA69565}" dt="2023-06-30T20:26:22.858" v="515" actId="1076"/>
          <ac:spMkLst>
            <pc:docMk/>
            <pc:sldMk cId="0" sldId="265"/>
            <ac:spMk id="6" creationId="{00000000-0000-0000-0000-000000000000}"/>
          </ac:spMkLst>
        </pc:spChg>
        <pc:spChg chg="mod">
          <ac:chgData name="Yates, Rob A." userId="S::raya228@uky.edu::c4835988-b912-40a4-bf56-31a2afc86d77" providerId="AD" clId="Web-{E30D171D-EFF4-ED4B-9D70-E0580DA69565}" dt="2023-06-30T20:25:46.982" v="511" actId="1076"/>
          <ac:spMkLst>
            <pc:docMk/>
            <pc:sldMk cId="0" sldId="265"/>
            <ac:spMk id="11" creationId="{00000000-0000-0000-0000-000000000000}"/>
          </ac:spMkLst>
        </pc:spChg>
        <pc:spChg chg="del">
          <ac:chgData name="Yates, Rob A." userId="S::raya228@uky.edu::c4835988-b912-40a4-bf56-31a2afc86d77" providerId="AD" clId="Web-{E30D171D-EFF4-ED4B-9D70-E0580DA69565}" dt="2023-06-30T19:56:56.106" v="157"/>
          <ac:spMkLst>
            <pc:docMk/>
            <pc:sldMk cId="0" sldId="265"/>
            <ac:spMk id="13" creationId="{00000000-0000-0000-0000-000000000000}"/>
          </ac:spMkLst>
        </pc:spChg>
        <pc:spChg chg="mod">
          <ac:chgData name="Yates, Rob A." userId="S::raya228@uky.edu::c4835988-b912-40a4-bf56-31a2afc86d77" providerId="AD" clId="Web-{E30D171D-EFF4-ED4B-9D70-E0580DA69565}" dt="2023-06-30T20:25:52.763" v="512" actId="1076"/>
          <ac:spMkLst>
            <pc:docMk/>
            <pc:sldMk cId="0" sldId="265"/>
            <ac:spMk id="16" creationId="{00000000-0000-0000-0000-000000000000}"/>
          </ac:spMkLst>
        </pc:spChg>
        <pc:spChg chg="del">
          <ac:chgData name="Yates, Rob A." userId="S::raya228@uky.edu::c4835988-b912-40a4-bf56-31a2afc86d77" providerId="AD" clId="Web-{E30D171D-EFF4-ED4B-9D70-E0580DA69565}" dt="2023-06-30T19:57:03.856" v="158"/>
          <ac:spMkLst>
            <pc:docMk/>
            <pc:sldMk cId="0" sldId="265"/>
            <ac:spMk id="18" creationId="{00000000-0000-0000-0000-000000000000}"/>
          </ac:spMkLst>
        </pc:spChg>
      </pc:sldChg>
      <pc:sldChg chg="delSp modSp ord">
        <pc:chgData name="Yates, Rob A." userId="S::raya228@uky.edu::c4835988-b912-40a4-bf56-31a2afc86d77" providerId="AD" clId="Web-{E30D171D-EFF4-ED4B-9D70-E0580DA69565}" dt="2023-06-30T20:27:13.485" v="523" actId="20577"/>
        <pc:sldMkLst>
          <pc:docMk/>
          <pc:sldMk cId="0" sldId="266"/>
        </pc:sldMkLst>
        <pc:spChg chg="mod">
          <ac:chgData name="Yates, Rob A." userId="S::raya228@uky.edu::c4835988-b912-40a4-bf56-31a2afc86d77" providerId="AD" clId="Web-{E30D171D-EFF4-ED4B-9D70-E0580DA69565}" dt="2023-06-30T20:05:10.296" v="262"/>
          <ac:spMkLst>
            <pc:docMk/>
            <pc:sldMk cId="0" sldId="266"/>
            <ac:spMk id="2" creationId="{00000000-0000-0000-0000-000000000000}"/>
          </ac:spMkLst>
        </pc:spChg>
        <pc:spChg chg="mod">
          <ac:chgData name="Yates, Rob A." userId="S::raya228@uky.edu::c4835988-b912-40a4-bf56-31a2afc86d77" providerId="AD" clId="Web-{E30D171D-EFF4-ED4B-9D70-E0580DA69565}" dt="2023-06-30T20:05:13.733" v="263" actId="1076"/>
          <ac:spMkLst>
            <pc:docMk/>
            <pc:sldMk cId="0" sldId="266"/>
            <ac:spMk id="4" creationId="{00000000-0000-0000-0000-000000000000}"/>
          </ac:spMkLst>
        </pc:spChg>
        <pc:spChg chg="mod">
          <ac:chgData name="Yates, Rob A." userId="S::raya228@uky.edu::c4835988-b912-40a4-bf56-31a2afc86d77" providerId="AD" clId="Web-{E30D171D-EFF4-ED4B-9D70-E0580DA69565}" dt="2023-06-30T20:09:24.586" v="325" actId="20577"/>
          <ac:spMkLst>
            <pc:docMk/>
            <pc:sldMk cId="0" sldId="266"/>
            <ac:spMk id="6" creationId="{00000000-0000-0000-0000-000000000000}"/>
          </ac:spMkLst>
        </pc:spChg>
        <pc:spChg chg="mod">
          <ac:chgData name="Yates, Rob A." userId="S::raya228@uky.edu::c4835988-b912-40a4-bf56-31a2afc86d77" providerId="AD" clId="Web-{E30D171D-EFF4-ED4B-9D70-E0580DA69565}" dt="2023-06-30T20:15:02.052" v="399" actId="1076"/>
          <ac:spMkLst>
            <pc:docMk/>
            <pc:sldMk cId="0" sldId="266"/>
            <ac:spMk id="8" creationId="{00000000-0000-0000-0000-000000000000}"/>
          </ac:spMkLst>
        </pc:spChg>
        <pc:spChg chg="mod">
          <ac:chgData name="Yates, Rob A." userId="S::raya228@uky.edu::c4835988-b912-40a4-bf56-31a2afc86d77" providerId="AD" clId="Web-{E30D171D-EFF4-ED4B-9D70-E0580DA69565}" dt="2023-06-30T20:11:57.607" v="360"/>
          <ac:spMkLst>
            <pc:docMk/>
            <pc:sldMk cId="0" sldId="266"/>
            <ac:spMk id="11" creationId="{00000000-0000-0000-0000-000000000000}"/>
          </ac:spMkLst>
        </pc:spChg>
        <pc:spChg chg="mod">
          <ac:chgData name="Yates, Rob A." userId="S::raya228@uky.edu::c4835988-b912-40a4-bf56-31a2afc86d77" providerId="AD" clId="Web-{E30D171D-EFF4-ED4B-9D70-E0580DA69565}" dt="2023-06-30T20:14:58.302" v="398" actId="1076"/>
          <ac:spMkLst>
            <pc:docMk/>
            <pc:sldMk cId="0" sldId="266"/>
            <ac:spMk id="13" creationId="{00000000-0000-0000-0000-000000000000}"/>
          </ac:spMkLst>
        </pc:spChg>
        <pc:spChg chg="mod">
          <ac:chgData name="Yates, Rob A." userId="S::raya228@uky.edu::c4835988-b912-40a4-bf56-31a2afc86d77" providerId="AD" clId="Web-{E30D171D-EFF4-ED4B-9D70-E0580DA69565}" dt="2023-06-30T20:27:13.485" v="523" actId="20577"/>
          <ac:spMkLst>
            <pc:docMk/>
            <pc:sldMk cId="0" sldId="266"/>
            <ac:spMk id="16" creationId="{00000000-0000-0000-0000-000000000000}"/>
          </ac:spMkLst>
        </pc:spChg>
        <pc:spChg chg="mod">
          <ac:chgData name="Yates, Rob A." userId="S::raya228@uky.edu::c4835988-b912-40a4-bf56-31a2afc86d77" providerId="AD" clId="Web-{E30D171D-EFF4-ED4B-9D70-E0580DA69565}" dt="2023-06-30T20:14:51.911" v="397" actId="1076"/>
          <ac:spMkLst>
            <pc:docMk/>
            <pc:sldMk cId="0" sldId="266"/>
            <ac:spMk id="18" creationId="{00000000-0000-0000-0000-000000000000}"/>
          </ac:spMkLst>
        </pc:spChg>
        <pc:spChg chg="del">
          <ac:chgData name="Yates, Rob A." userId="S::raya228@uky.edu::c4835988-b912-40a4-bf56-31a2afc86d77" providerId="AD" clId="Web-{E30D171D-EFF4-ED4B-9D70-E0580DA69565}" dt="2023-06-30T20:12:06.623" v="362"/>
          <ac:spMkLst>
            <pc:docMk/>
            <pc:sldMk cId="0" sldId="266"/>
            <ac:spMk id="23" creationId="{01181FA6-6C5D-7F14-A19E-3A0A261CC265}"/>
          </ac:spMkLst>
        </pc:spChg>
        <pc:spChg chg="del">
          <ac:chgData name="Yates, Rob A." userId="S::raya228@uky.edu::c4835988-b912-40a4-bf56-31a2afc86d77" providerId="AD" clId="Web-{E30D171D-EFF4-ED4B-9D70-E0580DA69565}" dt="2023-06-30T20:12:01.108" v="361"/>
          <ac:spMkLst>
            <pc:docMk/>
            <pc:sldMk cId="0" sldId="266"/>
            <ac:spMk id="24" creationId="{CB419B91-A407-4BAC-4E2D-CC823F634C3C}"/>
          </ac:spMkLst>
        </pc:spChg>
        <pc:spChg chg="del">
          <ac:chgData name="Yates, Rob A." userId="S::raya228@uky.edu::c4835988-b912-40a4-bf56-31a2afc86d77" providerId="AD" clId="Web-{E30D171D-EFF4-ED4B-9D70-E0580DA69565}" dt="2023-06-30T20:13:56.174" v="388"/>
          <ac:spMkLst>
            <pc:docMk/>
            <pc:sldMk cId="0" sldId="266"/>
            <ac:spMk id="27" creationId="{4927B290-3CB5-81EF-AC81-A7EAFC6BC317}"/>
          </ac:spMkLst>
        </pc:spChg>
        <pc:spChg chg="del">
          <ac:chgData name="Yates, Rob A." userId="S::raya228@uky.edu::c4835988-b912-40a4-bf56-31a2afc86d77" providerId="AD" clId="Web-{E30D171D-EFF4-ED4B-9D70-E0580DA69565}" dt="2023-06-30T20:13:53.502" v="387"/>
          <ac:spMkLst>
            <pc:docMk/>
            <pc:sldMk cId="0" sldId="266"/>
            <ac:spMk id="28" creationId="{B949200E-07DC-8596-4B78-A901D02EEB2B}"/>
          </ac:spMkLst>
        </pc:spChg>
      </pc:sldChg>
      <pc:sldChg chg="ord">
        <pc:chgData name="Yates, Rob A." userId="S::raya228@uky.edu::c4835988-b912-40a4-bf56-31a2afc86d77" providerId="AD" clId="Web-{E30D171D-EFF4-ED4B-9D70-E0580DA69565}" dt="2023-06-30T19:47:02.396" v="43"/>
        <pc:sldMkLst>
          <pc:docMk/>
          <pc:sldMk cId="0" sldId="267"/>
        </pc:sldMkLst>
      </pc:sldChg>
      <pc:sldChg chg="ord">
        <pc:chgData name="Yates, Rob A." userId="S::raya228@uky.edu::c4835988-b912-40a4-bf56-31a2afc86d77" providerId="AD" clId="Web-{E30D171D-EFF4-ED4B-9D70-E0580DA69565}" dt="2023-06-30T19:47:17.147" v="46"/>
        <pc:sldMkLst>
          <pc:docMk/>
          <pc:sldMk cId="0" sldId="268"/>
        </pc:sldMkLst>
      </pc:sldChg>
      <pc:sldChg chg="ord">
        <pc:chgData name="Yates, Rob A." userId="S::raya228@uky.edu::c4835988-b912-40a4-bf56-31a2afc86d77" providerId="AD" clId="Web-{E30D171D-EFF4-ED4B-9D70-E0580DA69565}" dt="2023-06-30T19:47:26.928" v="48"/>
        <pc:sldMkLst>
          <pc:docMk/>
          <pc:sldMk cId="0" sldId="269"/>
        </pc:sldMkLst>
      </pc:sldChg>
      <pc:sldChg chg="ord">
        <pc:chgData name="Yates, Rob A." userId="S::raya228@uky.edu::c4835988-b912-40a4-bf56-31a2afc86d77" providerId="AD" clId="Web-{E30D171D-EFF4-ED4B-9D70-E0580DA69565}" dt="2023-06-30T19:47:45.882" v="51"/>
        <pc:sldMkLst>
          <pc:docMk/>
          <pc:sldMk cId="0" sldId="270"/>
        </pc:sldMkLst>
      </pc:sldChg>
      <pc:sldChg chg="modSp ord">
        <pc:chgData name="Yates, Rob A." userId="S::raya228@uky.edu::c4835988-b912-40a4-bf56-31a2afc86d77" providerId="AD" clId="Web-{E30D171D-EFF4-ED4B-9D70-E0580DA69565}" dt="2023-06-30T19:48:20.508" v="55" actId="1076"/>
        <pc:sldMkLst>
          <pc:docMk/>
          <pc:sldMk cId="0" sldId="271"/>
        </pc:sldMkLst>
        <pc:spChg chg="mod">
          <ac:chgData name="Yates, Rob A." userId="S::raya228@uky.edu::c4835988-b912-40a4-bf56-31a2afc86d77" providerId="AD" clId="Web-{E30D171D-EFF4-ED4B-9D70-E0580DA69565}" dt="2023-06-30T19:48:16.758" v="54" actId="1076"/>
          <ac:spMkLst>
            <pc:docMk/>
            <pc:sldMk cId="0" sldId="271"/>
            <ac:spMk id="4" creationId="{00000000-0000-0000-0000-000000000000}"/>
          </ac:spMkLst>
        </pc:spChg>
        <pc:spChg chg="mod">
          <ac:chgData name="Yates, Rob A." userId="S::raya228@uky.edu::c4835988-b912-40a4-bf56-31a2afc86d77" providerId="AD" clId="Web-{E30D171D-EFF4-ED4B-9D70-E0580DA69565}" dt="2023-06-30T19:48:20.508" v="55" actId="1076"/>
          <ac:spMkLst>
            <pc:docMk/>
            <pc:sldMk cId="0" sldId="271"/>
            <ac:spMk id="8" creationId="{00000000-0000-0000-0000-000000000000}"/>
          </ac:spMkLst>
        </pc:spChg>
      </pc:sldChg>
      <pc:sldChg chg="delSp modSp ord">
        <pc:chgData name="Yates, Rob A." userId="S::raya228@uky.edu::c4835988-b912-40a4-bf56-31a2afc86d77" providerId="AD" clId="Web-{E30D171D-EFF4-ED4B-9D70-E0580DA69565}" dt="2023-06-30T20:27:00.188" v="519"/>
        <pc:sldMkLst>
          <pc:docMk/>
          <pc:sldMk cId="0" sldId="272"/>
        </pc:sldMkLst>
        <pc:spChg chg="mod">
          <ac:chgData name="Yates, Rob A." userId="S::raya228@uky.edu::c4835988-b912-40a4-bf56-31a2afc86d77" providerId="AD" clId="Web-{E30D171D-EFF4-ED4B-9D70-E0580DA69565}" dt="2023-06-30T20:26:47.718" v="516"/>
          <ac:spMkLst>
            <pc:docMk/>
            <pc:sldMk cId="0" sldId="272"/>
            <ac:spMk id="2" creationId="{00000000-0000-0000-0000-000000000000}"/>
          </ac:spMkLst>
        </pc:spChg>
        <pc:spChg chg="mod">
          <ac:chgData name="Yates, Rob A." userId="S::raya228@uky.edu::c4835988-b912-40a4-bf56-31a2afc86d77" providerId="AD" clId="Web-{E30D171D-EFF4-ED4B-9D70-E0580DA69565}" dt="2023-06-30T20:23:22.445" v="492" actId="1076"/>
          <ac:spMkLst>
            <pc:docMk/>
            <pc:sldMk cId="0" sldId="272"/>
            <ac:spMk id="4" creationId="{00000000-0000-0000-0000-000000000000}"/>
          </ac:spMkLst>
        </pc:spChg>
        <pc:spChg chg="mod">
          <ac:chgData name="Yates, Rob A." userId="S::raya228@uky.edu::c4835988-b912-40a4-bf56-31a2afc86d77" providerId="AD" clId="Web-{E30D171D-EFF4-ED4B-9D70-E0580DA69565}" dt="2023-06-30T20:26:50.437" v="517"/>
          <ac:spMkLst>
            <pc:docMk/>
            <pc:sldMk cId="0" sldId="272"/>
            <ac:spMk id="6" creationId="{00000000-0000-0000-0000-000000000000}"/>
          </ac:spMkLst>
        </pc:spChg>
        <pc:spChg chg="mod">
          <ac:chgData name="Yates, Rob A." userId="S::raya228@uky.edu::c4835988-b912-40a4-bf56-31a2afc86d77" providerId="AD" clId="Web-{E30D171D-EFF4-ED4B-9D70-E0580DA69565}" dt="2023-06-30T20:26:54.719" v="518"/>
          <ac:spMkLst>
            <pc:docMk/>
            <pc:sldMk cId="0" sldId="272"/>
            <ac:spMk id="11" creationId="{00000000-0000-0000-0000-000000000000}"/>
          </ac:spMkLst>
        </pc:spChg>
        <pc:spChg chg="mod">
          <ac:chgData name="Yates, Rob A." userId="S::raya228@uky.edu::c4835988-b912-40a4-bf56-31a2afc86d77" providerId="AD" clId="Web-{E30D171D-EFF4-ED4B-9D70-E0580DA69565}" dt="2023-06-30T20:27:00.188" v="519"/>
          <ac:spMkLst>
            <pc:docMk/>
            <pc:sldMk cId="0" sldId="272"/>
            <ac:spMk id="16" creationId="{00000000-0000-0000-0000-000000000000}"/>
          </ac:spMkLst>
        </pc:spChg>
        <pc:spChg chg="del">
          <ac:chgData name="Yates, Rob A." userId="S::raya228@uky.edu::c4835988-b912-40a4-bf56-31a2afc86d77" providerId="AD" clId="Web-{E30D171D-EFF4-ED4B-9D70-E0580DA69565}" dt="2023-06-30T20:22:48.272" v="480"/>
          <ac:spMkLst>
            <pc:docMk/>
            <pc:sldMk cId="0" sldId="272"/>
            <ac:spMk id="21" creationId="{98440995-8718-5C4B-CE30-AB28317AC1EE}"/>
          </ac:spMkLst>
        </pc:spChg>
        <pc:spChg chg="del">
          <ac:chgData name="Yates, Rob A." userId="S::raya228@uky.edu::c4835988-b912-40a4-bf56-31a2afc86d77" providerId="AD" clId="Web-{E30D171D-EFF4-ED4B-9D70-E0580DA69565}" dt="2023-06-30T20:22:39.319" v="479"/>
          <ac:spMkLst>
            <pc:docMk/>
            <pc:sldMk cId="0" sldId="272"/>
            <ac:spMk id="22" creationId="{8ED9A9C2-B316-2866-55C3-0825D50D50AA}"/>
          </ac:spMkLst>
        </pc:spChg>
      </pc:sldChg>
      <pc:sldChg chg="addSp delSp modSp add replId">
        <pc:chgData name="Yates, Rob A." userId="S::raya228@uky.edu::c4835988-b912-40a4-bf56-31a2afc86d77" providerId="AD" clId="Web-{E30D171D-EFF4-ED4B-9D70-E0580DA69565}" dt="2023-06-30T20:28:43.785" v="539" actId="1076"/>
        <pc:sldMkLst>
          <pc:docMk/>
          <pc:sldMk cId="2890828344" sldId="273"/>
        </pc:sldMkLst>
        <pc:spChg chg="mod">
          <ac:chgData name="Yates, Rob A." userId="S::raya228@uky.edu::c4835988-b912-40a4-bf56-31a2afc86d77" providerId="AD" clId="Web-{E30D171D-EFF4-ED4B-9D70-E0580DA69565}" dt="2023-06-30T20:28:14.972" v="537" actId="20577"/>
          <ac:spMkLst>
            <pc:docMk/>
            <pc:sldMk cId="2890828344" sldId="273"/>
            <ac:spMk id="2" creationId="{00000000-0000-0000-0000-000000000000}"/>
          </ac:spMkLst>
        </pc:spChg>
        <pc:spChg chg="mod">
          <ac:chgData name="Yates, Rob A." userId="S::raya228@uky.edu::c4835988-b912-40a4-bf56-31a2afc86d77" providerId="AD" clId="Web-{E30D171D-EFF4-ED4B-9D70-E0580DA69565}" dt="2023-06-30T19:53:22.738" v="120" actId="20577"/>
          <ac:spMkLst>
            <pc:docMk/>
            <pc:sldMk cId="2890828344" sldId="273"/>
            <ac:spMk id="4" creationId="{00000000-0000-0000-0000-000000000000}"/>
          </ac:spMkLst>
        </pc:spChg>
        <pc:spChg chg="del mod">
          <ac:chgData name="Yates, Rob A." userId="S::raya228@uky.edu::c4835988-b912-40a4-bf56-31a2afc86d77" providerId="AD" clId="Web-{E30D171D-EFF4-ED4B-9D70-E0580DA69565}" dt="2023-06-30T19:55:36.571" v="144"/>
          <ac:spMkLst>
            <pc:docMk/>
            <pc:sldMk cId="2890828344" sldId="273"/>
            <ac:spMk id="6" creationId="{00000000-0000-0000-0000-000000000000}"/>
          </ac:spMkLst>
        </pc:spChg>
        <pc:spChg chg="mod">
          <ac:chgData name="Yates, Rob A." userId="S::raya228@uky.edu::c4835988-b912-40a4-bf56-31a2afc86d77" providerId="AD" clId="Web-{E30D171D-EFF4-ED4B-9D70-E0580DA69565}" dt="2023-06-30T19:56:01.979" v="153" actId="20577"/>
          <ac:spMkLst>
            <pc:docMk/>
            <pc:sldMk cId="2890828344" sldId="273"/>
            <ac:spMk id="8" creationId="{00000000-0000-0000-0000-000000000000}"/>
          </ac:spMkLst>
        </pc:spChg>
        <pc:spChg chg="mod">
          <ac:chgData name="Yates, Rob A." userId="S::raya228@uky.edu::c4835988-b912-40a4-bf56-31a2afc86d77" providerId="AD" clId="Web-{E30D171D-EFF4-ED4B-9D70-E0580DA69565}" dt="2023-06-30T20:28:43.785" v="539" actId="1076"/>
          <ac:spMkLst>
            <pc:docMk/>
            <pc:sldMk cId="2890828344" sldId="273"/>
            <ac:spMk id="11" creationId="{00000000-0000-0000-0000-000000000000}"/>
          </ac:spMkLst>
        </pc:spChg>
        <pc:spChg chg="mod">
          <ac:chgData name="Yates, Rob A." userId="S::raya228@uky.edu::c4835988-b912-40a4-bf56-31a2afc86d77" providerId="AD" clId="Web-{E30D171D-EFF4-ED4B-9D70-E0580DA69565}" dt="2023-06-30T19:49:52.512" v="62" actId="1076"/>
          <ac:spMkLst>
            <pc:docMk/>
            <pc:sldMk cId="2890828344" sldId="273"/>
            <ac:spMk id="13" creationId="{00000000-0000-0000-0000-000000000000}"/>
          </ac:spMkLst>
        </pc:spChg>
        <pc:spChg chg="mod">
          <ac:chgData name="Yates, Rob A." userId="S::raya228@uky.edu::c4835988-b912-40a4-bf56-31a2afc86d77" providerId="AD" clId="Web-{E30D171D-EFF4-ED4B-9D70-E0580DA69565}" dt="2023-06-30T19:56:09.557" v="155" actId="20577"/>
          <ac:spMkLst>
            <pc:docMk/>
            <pc:sldMk cId="2890828344" sldId="273"/>
            <ac:spMk id="16" creationId="{00000000-0000-0000-0000-000000000000}"/>
          </ac:spMkLst>
        </pc:spChg>
        <pc:spChg chg="add del mod">
          <ac:chgData name="Yates, Rob A." userId="S::raya228@uky.edu::c4835988-b912-40a4-bf56-31a2afc86d77" providerId="AD" clId="Web-{E30D171D-EFF4-ED4B-9D70-E0580DA69565}" dt="2023-06-30T19:56:09.682" v="156" actId="20577"/>
          <ac:spMkLst>
            <pc:docMk/>
            <pc:sldMk cId="2890828344" sldId="273"/>
            <ac:spMk id="18" creationId="{00000000-0000-0000-0000-000000000000}"/>
          </ac:spMkLst>
        </pc:spChg>
        <pc:spChg chg="add mod">
          <ac:chgData name="Yates, Rob A." userId="S::raya228@uky.edu::c4835988-b912-40a4-bf56-31a2afc86d77" providerId="AD" clId="Web-{E30D171D-EFF4-ED4B-9D70-E0580DA69565}" dt="2023-06-30T20:28:37.379" v="538" actId="1076"/>
          <ac:spMkLst>
            <pc:docMk/>
            <pc:sldMk cId="2890828344" sldId="273"/>
            <ac:spMk id="29" creationId="{FA6936DC-BE50-1D99-BCC9-15CD03F3F9AF}"/>
          </ac:spMkLst>
        </pc:spChg>
      </pc:sldChg>
      <pc:sldChg chg="modSp add ord replId">
        <pc:chgData name="Yates, Rob A." userId="S::raya228@uky.edu::c4835988-b912-40a4-bf56-31a2afc86d77" providerId="AD" clId="Web-{E30D171D-EFF4-ED4B-9D70-E0580DA69565}" dt="2023-06-30T20:24:14.353" v="496"/>
        <pc:sldMkLst>
          <pc:docMk/>
          <pc:sldMk cId="768398678" sldId="274"/>
        </pc:sldMkLst>
        <pc:spChg chg="mod">
          <ac:chgData name="Yates, Rob A." userId="S::raya228@uky.edu::c4835988-b912-40a4-bf56-31a2afc86d77" providerId="AD" clId="Web-{E30D171D-EFF4-ED4B-9D70-E0580DA69565}" dt="2023-06-30T20:15:48.038" v="404" actId="20577"/>
          <ac:spMkLst>
            <pc:docMk/>
            <pc:sldMk cId="768398678" sldId="274"/>
            <ac:spMk id="2" creationId="{00000000-0000-0000-0000-000000000000}"/>
          </ac:spMkLst>
        </pc:spChg>
        <pc:spChg chg="mod">
          <ac:chgData name="Yates, Rob A." userId="S::raya228@uky.edu::c4835988-b912-40a4-bf56-31a2afc86d77" providerId="AD" clId="Web-{E30D171D-EFF4-ED4B-9D70-E0580DA69565}" dt="2023-06-30T20:16:44.868" v="416" actId="20577"/>
          <ac:spMkLst>
            <pc:docMk/>
            <pc:sldMk cId="768398678" sldId="274"/>
            <ac:spMk id="4" creationId="{00000000-0000-0000-0000-000000000000}"/>
          </ac:spMkLst>
        </pc:spChg>
        <pc:spChg chg="mod">
          <ac:chgData name="Yates, Rob A." userId="S::raya228@uky.edu::c4835988-b912-40a4-bf56-31a2afc86d77" providerId="AD" clId="Web-{E30D171D-EFF4-ED4B-9D70-E0580DA69565}" dt="2023-06-30T20:17:28.510" v="423" actId="20577"/>
          <ac:spMkLst>
            <pc:docMk/>
            <pc:sldMk cId="768398678" sldId="274"/>
            <ac:spMk id="6" creationId="{00000000-0000-0000-0000-000000000000}"/>
          </ac:spMkLst>
        </pc:spChg>
        <pc:spChg chg="mod">
          <ac:chgData name="Yates, Rob A." userId="S::raya228@uky.edu::c4835988-b912-40a4-bf56-31a2afc86d77" providerId="AD" clId="Web-{E30D171D-EFF4-ED4B-9D70-E0580DA69565}" dt="2023-06-30T20:18:03.996" v="429" actId="1076"/>
          <ac:spMkLst>
            <pc:docMk/>
            <pc:sldMk cId="768398678" sldId="274"/>
            <ac:spMk id="8" creationId="{00000000-0000-0000-0000-000000000000}"/>
          </ac:spMkLst>
        </pc:spChg>
        <pc:spChg chg="mod">
          <ac:chgData name="Yates, Rob A." userId="S::raya228@uky.edu::c4835988-b912-40a4-bf56-31a2afc86d77" providerId="AD" clId="Web-{E30D171D-EFF4-ED4B-9D70-E0580DA69565}" dt="2023-06-30T20:18:47.044" v="438" actId="20577"/>
          <ac:spMkLst>
            <pc:docMk/>
            <pc:sldMk cId="768398678" sldId="274"/>
            <ac:spMk id="11" creationId="{00000000-0000-0000-0000-000000000000}"/>
          </ac:spMkLst>
        </pc:spChg>
        <pc:spChg chg="mod">
          <ac:chgData name="Yates, Rob A." userId="S::raya228@uky.edu::c4835988-b912-40a4-bf56-31a2afc86d77" providerId="AD" clId="Web-{E30D171D-EFF4-ED4B-9D70-E0580DA69565}" dt="2023-06-30T20:19:20.827" v="444" actId="1076"/>
          <ac:spMkLst>
            <pc:docMk/>
            <pc:sldMk cId="768398678" sldId="274"/>
            <ac:spMk id="13" creationId="{00000000-0000-0000-0000-000000000000}"/>
          </ac:spMkLst>
        </pc:spChg>
        <pc:spChg chg="mod">
          <ac:chgData name="Yates, Rob A." userId="S::raya228@uky.edu::c4835988-b912-40a4-bf56-31a2afc86d77" providerId="AD" clId="Web-{E30D171D-EFF4-ED4B-9D70-E0580DA69565}" dt="2023-06-30T20:20:08.422" v="451" actId="20577"/>
          <ac:spMkLst>
            <pc:docMk/>
            <pc:sldMk cId="768398678" sldId="274"/>
            <ac:spMk id="16" creationId="{00000000-0000-0000-0000-000000000000}"/>
          </ac:spMkLst>
        </pc:spChg>
        <pc:spChg chg="mod">
          <ac:chgData name="Yates, Rob A." userId="S::raya228@uky.edu::c4835988-b912-40a4-bf56-31a2afc86d77" providerId="AD" clId="Web-{E30D171D-EFF4-ED4B-9D70-E0580DA69565}" dt="2023-06-30T20:21:28.910" v="464" actId="1076"/>
          <ac:spMkLst>
            <pc:docMk/>
            <pc:sldMk cId="768398678" sldId="274"/>
            <ac:spMk id="18" creationId="{00000000-0000-0000-0000-000000000000}"/>
          </ac:spMkLst>
        </pc:spChg>
      </pc:sldChg>
    </pc:docChg>
  </pc:docChgLst>
  <pc:docChgLst>
    <pc:chgData name="Twist, Katherine E." userId="S::ketwis2@uky.edu::45331757-1fa0-4e4d-9a75-655a060dde67" providerId="AD" clId="Web-{7D25F2B9-8433-8119-F53A-BB61B3568F60}"/>
    <pc:docChg chg="mod">
      <pc:chgData name="Twist, Katherine E." userId="S::ketwis2@uky.edu::45331757-1fa0-4e4d-9a75-655a060dde67" providerId="AD" clId="Web-{7D25F2B9-8433-8119-F53A-BB61B3568F60}" dt="2023-07-13T13:15:33.154" v="1"/>
      <pc:docMkLst>
        <pc:docMk/>
      </pc:docMkLst>
      <pc:sldChg chg="addCm">
        <pc:chgData name="Twist, Katherine E." userId="S::ketwis2@uky.edu::45331757-1fa0-4e4d-9a75-655a060dde67" providerId="AD" clId="Web-{7D25F2B9-8433-8119-F53A-BB61B3568F60}" dt="2023-07-13T13:15:33.154" v="1"/>
        <pc:sldMkLst>
          <pc:docMk/>
          <pc:sldMk cId="0" sldId="256"/>
        </pc:sldMkLst>
        <pc:extLst>
          <p:ext xmlns:p="http://schemas.openxmlformats.org/presentationml/2006/main" uri="{D6D511B9-2390-475A-947B-AFAB55BFBCF1}">
            <pc226:cmChg xmlns:pc226="http://schemas.microsoft.com/office/powerpoint/2022/06/main/command" chg="add">
              <pc226:chgData name="Twist, Katherine E." userId="S::ketwis2@uky.edu::45331757-1fa0-4e4d-9a75-655a060dde67" providerId="AD" clId="Web-{7D25F2B9-8433-8119-F53A-BB61B3568F60}" dt="2023-07-13T13:15:33.154" v="1"/>
              <pc2:cmMkLst xmlns:pc2="http://schemas.microsoft.com/office/powerpoint/2019/9/main/command">
                <pc:docMk/>
                <pc:sldMk cId="0" sldId="256"/>
                <pc2:cmMk id="{4682E7CF-56D5-491E-984E-5F6D6E124E0E}"/>
              </pc2:cmMkLst>
            </pc226:cmChg>
          </p:ext>
        </pc:ext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Tree>
    <p:extLst>
      <p:ext uri="{BB962C8B-B14F-4D97-AF65-F5344CB8AC3E}">
        <p14:creationId xmlns:p14="http://schemas.microsoft.com/office/powerpoint/2010/main" val="382594454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extLst>
      <p:ext uri="{BB962C8B-B14F-4D97-AF65-F5344CB8AC3E}">
        <p14:creationId xmlns:p14="http://schemas.microsoft.com/office/powerpoint/2010/main" val="193466936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extLst>
      <p:ext uri="{BB962C8B-B14F-4D97-AF65-F5344CB8AC3E}">
        <p14:creationId xmlns:p14="http://schemas.microsoft.com/office/powerpoint/2010/main" val="3017805398"/>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Notes Placeholder"/>
          <p:cNvSpPr>
            <a:spLocks noGrp="1"/>
          </p:cNvSpPr>
          <p:nvPr>
            <p:ph type="body" idx="1"/>
          </p:nvPr>
        </p:nvSpPr>
        <p:spPr/>
        <p:txBody>
          <a:bodyPr>
            <a:normAutofit fontScale="25000" lnSpcReduction="20000"/>
          </a:bodyPr>
          <a:lstStyle/>
          <a:p>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obj" preserve="1">
  <p:cSld name="Title Slide">
    <p:spTree>
      <p:nvGrpSpPr>
        <p:cNvPr id="1" name=""/>
        <p:cNvGrpSpPr/>
        <p:nvPr/>
      </p:nvGrpSpPr>
      <p:grpSpPr>
        <a:xfrm>
          <a:off x="0" y="0"/>
          <a:ext cx="0" cy="0"/>
          <a:chOff x="0" y="0"/>
          <a:chExt cx="0" cy="0"/>
        </a:xfrm>
      </p:grpSpPr>
      <p:sp>
        <p:nvSpPr>
          <p:cNvPr id="2" name="Holder 2"/>
          <p:cNvSpPr>
            <a:spLocks noGrp="1"/>
          </p:cNvSpPr>
          <p:nvPr>
            <p:ph type="ctrTitle"/>
          </p:nvPr>
        </p:nvSpPr>
        <p:spPr>
          <a:xfrm>
            <a:off x="582930" y="3118104"/>
            <a:ext cx="6606540" cy="2112264"/>
          </a:xfrm>
          <a:prstGeom prst="rect">
            <a:avLst/>
          </a:prstGeom>
        </p:spPr>
        <p:txBody>
          <a:bodyPr wrap="square" lIns="0" tIns="0" rIns="0" bIns="0">
            <a:spAutoFit/>
          </a:bodyPr>
          <a:lstStyle>
            <a:lvl1pPr>
              <a:defRPr/>
            </a:lvl1pPr>
          </a:lstStyle>
          <a:p>
            <a:endParaRPr/>
          </a:p>
        </p:txBody>
      </p:sp>
      <p:sp>
        <p:nvSpPr>
          <p:cNvPr id="3" name="Holder 3"/>
          <p:cNvSpPr>
            <a:spLocks noGrp="1"/>
          </p:cNvSpPr>
          <p:nvPr>
            <p:ph type="subTitle" idx="4"/>
          </p:nvPr>
        </p:nvSpPr>
        <p:spPr>
          <a:xfrm>
            <a:off x="1165860" y="5632704"/>
            <a:ext cx="5440680" cy="2514600"/>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7/20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b="0" i="0">
                <a:solidFill>
                  <a:schemeClr val="tx1"/>
                </a:solidFill>
              </a:defRPr>
            </a:lvl1pPr>
          </a:lstStyle>
          <a:p>
            <a:endParaRPr/>
          </a:p>
        </p:txBody>
      </p:sp>
      <p:sp>
        <p:nvSpPr>
          <p:cNvPr id="3" name="Holder 3"/>
          <p:cNvSpPr>
            <a:spLocks noGrp="1"/>
          </p:cNvSpPr>
          <p:nvPr>
            <p:ph type="body" idx="1"/>
          </p:nvPr>
        </p:nvSpPr>
        <p:spPr/>
        <p:txBody>
          <a:bodyPr lIns="0" tIns="0" rIns="0" bIns="0"/>
          <a:lstStyle>
            <a:lvl1pPr>
              <a:defRPr/>
            </a:lvl1pPr>
          </a:lstStyle>
          <a:p>
            <a:endParaRPr/>
          </a:p>
        </p:txBody>
      </p:sp>
      <p:sp>
        <p:nvSpPr>
          <p:cNvPr id="4" name="Holder 4"/>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5" name="Holder 5"/>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7/2023</a:t>
            </a:fld>
            <a:endParaRPr lang="en-US"/>
          </a:p>
        </p:txBody>
      </p:sp>
      <p:sp>
        <p:nvSpPr>
          <p:cNvPr id="6" name="Holder 6"/>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wo Content">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b="0" i="0">
                <a:solidFill>
                  <a:schemeClr val="tx1"/>
                </a:solidFill>
              </a:defRPr>
            </a:lvl1pPr>
          </a:lstStyle>
          <a:p>
            <a:endParaRPr/>
          </a:p>
        </p:txBody>
      </p:sp>
      <p:sp>
        <p:nvSpPr>
          <p:cNvPr id="3" name="Holder 3"/>
          <p:cNvSpPr>
            <a:spLocks noGrp="1"/>
          </p:cNvSpPr>
          <p:nvPr>
            <p:ph sz="half" idx="2"/>
          </p:nvPr>
        </p:nvSpPr>
        <p:spPr>
          <a:xfrm>
            <a:off x="388620" y="2313432"/>
            <a:ext cx="3380994"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sz="half" idx="3"/>
          </p:nvPr>
        </p:nvSpPr>
        <p:spPr>
          <a:xfrm>
            <a:off x="4002786" y="2313432"/>
            <a:ext cx="3380994" cy="6638544"/>
          </a:xfrm>
          <a:prstGeom prst="rect">
            <a:avLst/>
          </a:prstGeom>
        </p:spPr>
        <p:txBody>
          <a:bodyPr wrap="square" lIns="0" tIns="0" rIns="0" bIns="0">
            <a:spAutoFit/>
          </a:bodyPr>
          <a:lstStyle>
            <a:lvl1pPr>
              <a:defRPr/>
            </a:lvl1pPr>
          </a:lstStyle>
          <a:p>
            <a:endParaRPr/>
          </a:p>
        </p:txBody>
      </p:sp>
      <p:sp>
        <p:nvSpPr>
          <p:cNvPr id="5" name="Holder 5"/>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6" name="Holder 6"/>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7/2023</a:t>
            </a:fld>
            <a:endParaRPr lang="en-US"/>
          </a:p>
        </p:txBody>
      </p:sp>
      <p:sp>
        <p:nvSpPr>
          <p:cNvPr id="7" name="Holder 7"/>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obj" preserve="1">
  <p:cSld name="Title Only">
    <p:spTree>
      <p:nvGrpSpPr>
        <p:cNvPr id="1" name=""/>
        <p:cNvGrpSpPr/>
        <p:nvPr/>
      </p:nvGrpSpPr>
      <p:grpSpPr>
        <a:xfrm>
          <a:off x="0" y="0"/>
          <a:ext cx="0" cy="0"/>
          <a:chOff x="0" y="0"/>
          <a:chExt cx="0" cy="0"/>
        </a:xfrm>
      </p:grpSpPr>
      <p:sp>
        <p:nvSpPr>
          <p:cNvPr id="2" name="Holder 2"/>
          <p:cNvSpPr>
            <a:spLocks noGrp="1"/>
          </p:cNvSpPr>
          <p:nvPr>
            <p:ph type="title"/>
          </p:nvPr>
        </p:nvSpPr>
        <p:spPr/>
        <p:txBody>
          <a:bodyPr lIns="0" tIns="0" rIns="0" bIns="0"/>
          <a:lstStyle>
            <a:lvl1pPr>
              <a:defRPr b="0" i="0">
                <a:solidFill>
                  <a:schemeClr val="tx1"/>
                </a:solidFill>
              </a:defRPr>
            </a:lvl1pPr>
          </a:lstStyle>
          <a:p>
            <a:endParaRPr/>
          </a:p>
        </p:txBody>
      </p:sp>
      <p:sp>
        <p:nvSpPr>
          <p:cNvPr id="3" name="Holder 3"/>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4" name="Holder 4"/>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7/2023</a:t>
            </a:fld>
            <a:endParaRPr lang="en-US"/>
          </a:p>
        </p:txBody>
      </p:sp>
      <p:sp>
        <p:nvSpPr>
          <p:cNvPr id="5" name="Holder 5"/>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obj" preserve="1">
  <p:cSld name="Blank">
    <p:spTree>
      <p:nvGrpSpPr>
        <p:cNvPr id="1" name=""/>
        <p:cNvGrpSpPr/>
        <p:nvPr/>
      </p:nvGrpSpPr>
      <p:grpSpPr>
        <a:xfrm>
          <a:off x="0" y="0"/>
          <a:ext cx="0" cy="0"/>
          <a:chOff x="0" y="0"/>
          <a:chExt cx="0" cy="0"/>
        </a:xfrm>
      </p:grpSpPr>
      <p:sp>
        <p:nvSpPr>
          <p:cNvPr id="2" name="Holder 2"/>
          <p:cNvSpPr>
            <a:spLocks noGrp="1"/>
          </p:cNvSpPr>
          <p:nvPr>
            <p:ph type="ftr" sz="quarter" idx="5"/>
          </p:nvPr>
        </p:nvSpPr>
        <p:spPr/>
        <p:txBody>
          <a:bodyPr lIns="0" tIns="0" rIns="0" bIns="0"/>
          <a:lstStyle>
            <a:lvl1pPr algn="ctr">
              <a:defRPr>
                <a:solidFill>
                  <a:schemeClr val="tx1">
                    <a:tint val="75000"/>
                  </a:schemeClr>
                </a:solidFill>
              </a:defRPr>
            </a:lvl1pPr>
          </a:lstStyle>
          <a:p>
            <a:endParaRPr/>
          </a:p>
        </p:txBody>
      </p:sp>
      <p:sp>
        <p:nvSpPr>
          <p:cNvPr id="3" name="Holder 3"/>
          <p:cNvSpPr>
            <a:spLocks noGrp="1"/>
          </p:cNvSpPr>
          <p:nvPr>
            <p:ph type="dt" sz="half" idx="6"/>
          </p:nvPr>
        </p:nvSpPr>
        <p:spPr/>
        <p:txBody>
          <a:bodyPr lIns="0" tIns="0" rIns="0" bIns="0"/>
          <a:lstStyle>
            <a:lvl1pPr algn="l">
              <a:defRPr>
                <a:solidFill>
                  <a:schemeClr val="tx1">
                    <a:tint val="75000"/>
                  </a:schemeClr>
                </a:solidFill>
              </a:defRPr>
            </a:lvl1pPr>
          </a:lstStyle>
          <a:p>
            <a:fld id="{1D8BD707-D9CF-40AE-B4C6-C98DA3205C09}" type="datetimeFigureOut">
              <a:rPr lang="en-US"/>
              <a:t>8/7/2023</a:t>
            </a:fld>
            <a:endParaRPr lang="en-US"/>
          </a:p>
        </p:txBody>
      </p:sp>
      <p:sp>
        <p:nvSpPr>
          <p:cNvPr id="4" name="Holder 4"/>
          <p:cNvSpPr>
            <a:spLocks noGrp="1"/>
          </p:cNvSpPr>
          <p:nvPr>
            <p:ph type="sldNum" sz="quarter" idx="7"/>
          </p:nvPr>
        </p:nvSpPr>
        <p:spPr/>
        <p:txBody>
          <a:bodyPr lIns="0" tIns="0" rIns="0" bIns="0"/>
          <a:lstStyle>
            <a:lvl1pPr algn="r">
              <a:defRPr>
                <a:solidFill>
                  <a:schemeClr val="tx1">
                    <a:tint val="75000"/>
                  </a:schemeClr>
                </a:solidFill>
              </a:defRPr>
            </a:lvl1pPr>
          </a:lstStyle>
          <a:p>
            <a:fld id="{B6F15528-21DE-4FAA-801E-634DDDAF4B2B}" type="slidenum">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theme" Target="../theme/theme1.xml"/><Relationship Id="rId5" Type="http://schemas.openxmlformats.org/officeDocument/2006/relationships/slideLayout" Target="../slideLayouts/slideLayout5.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6" name="bk object 16"/>
          <p:cNvSpPr/>
          <p:nvPr/>
        </p:nvSpPr>
        <p:spPr>
          <a:xfrm>
            <a:off x="3886200" y="228600"/>
            <a:ext cx="0" cy="9601200"/>
          </a:xfrm>
          <a:custGeom>
            <a:avLst/>
            <a:gdLst/>
            <a:ahLst/>
            <a:cxnLst/>
            <a:rect l="l" t="t" r="r" b="b"/>
            <a:pathLst>
              <a:path h="9601200">
                <a:moveTo>
                  <a:pt x="0" y="0"/>
                </a:moveTo>
                <a:lnTo>
                  <a:pt x="0" y="9601200"/>
                </a:lnTo>
              </a:path>
            </a:pathLst>
          </a:custGeom>
          <a:ln w="12700">
            <a:solidFill>
              <a:srgbClr val="000000"/>
            </a:solidFill>
            <a:prstDash val="lgDash"/>
          </a:ln>
        </p:spPr>
        <p:txBody>
          <a:bodyPr wrap="square" lIns="0" tIns="0" rIns="0" bIns="0" rtlCol="0"/>
          <a:lstStyle/>
          <a:p>
            <a:endParaRPr/>
          </a:p>
        </p:txBody>
      </p:sp>
      <p:sp>
        <p:nvSpPr>
          <p:cNvPr id="2" name="Holder 2"/>
          <p:cNvSpPr>
            <a:spLocks noGrp="1"/>
          </p:cNvSpPr>
          <p:nvPr>
            <p:ph type="title"/>
          </p:nvPr>
        </p:nvSpPr>
        <p:spPr>
          <a:xfrm>
            <a:off x="457200" y="457200"/>
            <a:ext cx="6858000" cy="1943100"/>
          </a:xfrm>
          <a:prstGeom prst="rect">
            <a:avLst/>
          </a:prstGeom>
        </p:spPr>
        <p:txBody>
          <a:bodyPr wrap="square" lIns="0" tIns="0" rIns="0" bIns="0">
            <a:spAutoFit/>
          </a:bodyPr>
          <a:lstStyle>
            <a:lvl1pPr>
              <a:defRPr b="0" i="0">
                <a:solidFill>
                  <a:schemeClr val="tx1"/>
                </a:solidFill>
              </a:defRPr>
            </a:lvl1pPr>
          </a:lstStyle>
          <a:p>
            <a:endParaRPr/>
          </a:p>
        </p:txBody>
      </p:sp>
      <p:sp>
        <p:nvSpPr>
          <p:cNvPr id="3" name="Holder 3"/>
          <p:cNvSpPr>
            <a:spLocks noGrp="1"/>
          </p:cNvSpPr>
          <p:nvPr>
            <p:ph type="body" idx="1"/>
          </p:nvPr>
        </p:nvSpPr>
        <p:spPr>
          <a:xfrm>
            <a:off x="388620" y="2313432"/>
            <a:ext cx="6995160" cy="6638544"/>
          </a:xfrm>
          <a:prstGeom prst="rect">
            <a:avLst/>
          </a:prstGeom>
        </p:spPr>
        <p:txBody>
          <a:bodyPr wrap="square" lIns="0" tIns="0" rIns="0" bIns="0">
            <a:spAutoFit/>
          </a:bodyPr>
          <a:lstStyle>
            <a:lvl1pPr>
              <a:defRPr/>
            </a:lvl1pPr>
          </a:lstStyle>
          <a:p>
            <a:endParaRPr/>
          </a:p>
        </p:txBody>
      </p:sp>
      <p:sp>
        <p:nvSpPr>
          <p:cNvPr id="4" name="Holder 4"/>
          <p:cNvSpPr>
            <a:spLocks noGrp="1"/>
          </p:cNvSpPr>
          <p:nvPr>
            <p:ph type="ftr" sz="quarter" idx="5"/>
          </p:nvPr>
        </p:nvSpPr>
        <p:spPr>
          <a:xfrm>
            <a:off x="2642616" y="9354312"/>
            <a:ext cx="2487168" cy="502920"/>
          </a:xfrm>
          <a:prstGeom prst="rect">
            <a:avLst/>
          </a:prstGeom>
        </p:spPr>
        <p:txBody>
          <a:bodyPr wrap="square" lIns="0" tIns="0" rIns="0" bIns="0">
            <a:spAutoFit/>
          </a:bodyPr>
          <a:lstStyle>
            <a:lvl1pPr algn="ctr">
              <a:defRPr>
                <a:solidFill>
                  <a:schemeClr val="tx1">
                    <a:tint val="75000"/>
                  </a:schemeClr>
                </a:solidFill>
              </a:defRPr>
            </a:lvl1pPr>
          </a:lstStyle>
          <a:p>
            <a:endParaRPr/>
          </a:p>
        </p:txBody>
      </p:sp>
      <p:sp>
        <p:nvSpPr>
          <p:cNvPr id="5" name="Holder 5"/>
          <p:cNvSpPr>
            <a:spLocks noGrp="1"/>
          </p:cNvSpPr>
          <p:nvPr>
            <p:ph type="dt" sz="half" idx="6"/>
          </p:nvPr>
        </p:nvSpPr>
        <p:spPr>
          <a:xfrm>
            <a:off x="388620" y="9354312"/>
            <a:ext cx="1787652" cy="502920"/>
          </a:xfrm>
          <a:prstGeom prst="rect">
            <a:avLst/>
          </a:prstGeom>
        </p:spPr>
        <p:txBody>
          <a:bodyPr wrap="square" lIns="0" tIns="0" rIns="0" bIns="0">
            <a:spAutoFit/>
          </a:bodyPr>
          <a:lstStyle>
            <a:lvl1pPr algn="l">
              <a:defRPr>
                <a:solidFill>
                  <a:schemeClr val="tx1">
                    <a:tint val="75000"/>
                  </a:schemeClr>
                </a:solidFill>
              </a:defRPr>
            </a:lvl1pPr>
          </a:lstStyle>
          <a:p>
            <a:fld id="{1D8BD707-D9CF-40AE-B4C6-C98DA3205C09}" type="datetimeFigureOut">
              <a:rPr lang="en-US"/>
              <a:t>8/7/2023</a:t>
            </a:fld>
            <a:endParaRPr lang="en-US"/>
          </a:p>
        </p:txBody>
      </p:sp>
      <p:sp>
        <p:nvSpPr>
          <p:cNvPr id="6" name="Holder 6"/>
          <p:cNvSpPr>
            <a:spLocks noGrp="1"/>
          </p:cNvSpPr>
          <p:nvPr>
            <p:ph type="sldNum" sz="quarter" idx="7"/>
          </p:nvPr>
        </p:nvSpPr>
        <p:spPr>
          <a:xfrm>
            <a:off x="5596128" y="9354312"/>
            <a:ext cx="1787652" cy="502920"/>
          </a:xfrm>
          <a:prstGeom prst="rect">
            <a:avLst/>
          </a:prstGeom>
        </p:spPr>
        <p:txBody>
          <a:bodyPr wrap="square" lIns="0" tIns="0" rIns="0" bIns="0">
            <a:spAutoFit/>
          </a:bodyPr>
          <a:lstStyle>
            <a:lvl1pPr algn="r">
              <a:defRPr>
                <a:solidFill>
                  <a:schemeClr val="tx1">
                    <a:tint val="75000"/>
                  </a:schemeClr>
                </a:solidFill>
              </a:defRPr>
            </a:lvl1pPr>
          </a:lstStyle>
          <a:p>
            <a:fld id="{B6F15528-21DE-4FAA-801E-634DDDAF4B2B}" type="slidenum">
              <a:t>‹#›</a:t>
            </a:fld>
            <a:endParaRPr/>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Lst>
  <p:txStyles>
    <p:titleStyle>
      <a:lvl1pPr>
        <a:defRPr>
          <a:latin typeface="+mj-lt"/>
          <a:ea typeface="+mj-ea"/>
          <a:cs typeface="+mj-cs"/>
        </a:defRPr>
      </a:lvl1pPr>
    </p:titleStyle>
    <p:body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bodyStyle>
    <p:otherStyle>
      <a:lvl1pPr marL="0">
        <a:defRPr>
          <a:latin typeface="+mn-lt"/>
          <a:ea typeface="+mn-ea"/>
          <a:cs typeface="+mn-cs"/>
        </a:defRPr>
      </a:lvl1pPr>
      <a:lvl2pPr marL="457200">
        <a:defRPr>
          <a:latin typeface="+mn-lt"/>
          <a:ea typeface="+mn-ea"/>
          <a:cs typeface="+mn-cs"/>
        </a:defRPr>
      </a:lvl2pPr>
      <a:lvl3pPr marL="914400">
        <a:defRPr>
          <a:latin typeface="+mn-lt"/>
          <a:ea typeface="+mn-ea"/>
          <a:cs typeface="+mn-cs"/>
        </a:defRPr>
      </a:lvl3pPr>
      <a:lvl4pPr marL="1371600">
        <a:defRPr>
          <a:latin typeface="+mn-lt"/>
          <a:ea typeface="+mn-ea"/>
          <a:cs typeface="+mn-cs"/>
        </a:defRPr>
      </a:lvl4pPr>
      <a:lvl5pPr marL="1828800">
        <a:defRPr>
          <a:latin typeface="+mn-lt"/>
          <a:ea typeface="+mn-ea"/>
          <a:cs typeface="+mn-cs"/>
        </a:defRPr>
      </a:lvl5pPr>
      <a:lvl6pPr marL="2286000">
        <a:defRPr>
          <a:latin typeface="+mn-lt"/>
          <a:ea typeface="+mn-ea"/>
          <a:cs typeface="+mn-cs"/>
        </a:defRPr>
      </a:lvl6pPr>
      <a:lvl7pPr marL="2743200">
        <a:defRPr>
          <a:latin typeface="+mn-lt"/>
          <a:ea typeface="+mn-ea"/>
          <a:cs typeface="+mn-cs"/>
        </a:defRPr>
      </a:lvl7pPr>
      <a:lvl8pPr marL="3200400">
        <a:defRPr>
          <a:latin typeface="+mn-lt"/>
          <a:ea typeface="+mn-ea"/>
          <a:cs typeface="+mn-cs"/>
        </a:defRPr>
      </a:lvl8pPr>
      <a:lvl9pPr marL="3657600">
        <a:defRPr>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5.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5.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5.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5.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5.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5.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5.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5.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5.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5.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5.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5.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538883"/>
          </a:xfrm>
          <a:prstGeom prst="rect">
            <a:avLst/>
          </a:prstGeom>
          <a:ln w="6350">
            <a:noFill/>
          </a:ln>
        </p:spPr>
        <p:txBody>
          <a:bodyPr vert="horz" wrap="square" lIns="0" tIns="0" rIns="0" bIns="0" rtlCol="0" anchor="t">
            <a:spAutoFit/>
          </a:bodyPr>
          <a:lstStyle/>
          <a:p>
            <a:pPr marL="173990" marR="166370" algn="ctr">
              <a:lnSpc>
                <a:spcPts val="2400"/>
              </a:lnSpc>
            </a:pPr>
            <a:r>
              <a:rPr lang="en-US" sz="2200">
                <a:latin typeface="Helvetica"/>
                <a:cs typeface="Helvetica"/>
              </a:rPr>
              <a:t>33yo female with</a:t>
            </a:r>
            <a:r>
              <a:rPr sz="2200">
                <a:latin typeface="Helvetica"/>
                <a:cs typeface="Helvetica"/>
              </a:rPr>
              <a:t> weakness, muscle pain after "found down," Urine</a:t>
            </a:r>
          </a:p>
          <a:p>
            <a:pPr algn="ctr">
              <a:lnSpc>
                <a:spcPts val="2400"/>
              </a:lnSpc>
            </a:pPr>
            <a:r>
              <a:rPr sz="2200">
                <a:latin typeface="Helvetica"/>
                <a:cs typeface="Helvetica"/>
              </a:rPr>
              <a:t>+blood/-RBC, CK high</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974900"/>
          </a:xfrm>
          <a:prstGeom prst="rect">
            <a:avLst/>
          </a:prstGeom>
          <a:ln w="6350">
            <a:noFill/>
          </a:ln>
        </p:spPr>
        <p:txBody>
          <a:bodyPr vert="horz" wrap="square" lIns="0" tIns="0" rIns="0" bIns="0" rtlCol="0" anchor="t">
            <a:spAutoFit/>
          </a:bodyPr>
          <a:lstStyle/>
          <a:p>
            <a:pPr marL="82550" marR="74930" algn="ctr">
              <a:lnSpc>
                <a:spcPts val="2200"/>
              </a:lnSpc>
            </a:pPr>
            <a:r>
              <a:rPr lang="en-US" sz="2200">
                <a:latin typeface="Helvetica"/>
                <a:cs typeface="Helvetica"/>
              </a:rPr>
              <a:t>47yo man with</a:t>
            </a:r>
            <a:r>
              <a:rPr sz="2200">
                <a:latin typeface="Helvetica"/>
                <a:cs typeface="Helvetica"/>
              </a:rPr>
              <a:t> confusion and fever, on antipsychotic meds. T102, HR 124,</a:t>
            </a:r>
          </a:p>
          <a:p>
            <a:pPr marL="168275" marR="160655" indent="-635" algn="ctr">
              <a:lnSpc>
                <a:spcPts val="2200"/>
              </a:lnSpc>
            </a:pPr>
            <a:r>
              <a:rPr sz="2200">
                <a:latin typeface="Helvetica"/>
                <a:cs typeface="Helvetica"/>
              </a:rPr>
              <a:t>BP 144/95, altered mental status and general muscle rigidity.</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795428"/>
          </a:xfrm>
          <a:prstGeom prst="rect">
            <a:avLst/>
          </a:prstGeom>
          <a:ln w="6350">
            <a:noFill/>
          </a:ln>
        </p:spPr>
        <p:txBody>
          <a:bodyPr vert="horz" wrap="square" lIns="0" tIns="0" rIns="0" bIns="0" rtlCol="0">
            <a:spAutoFit/>
          </a:bodyPr>
          <a:lstStyle/>
          <a:p>
            <a:pPr marL="135890" marR="128270" algn="ctr">
              <a:lnSpc>
                <a:spcPts val="2000"/>
              </a:lnSpc>
            </a:pPr>
            <a:r>
              <a:rPr sz="2200">
                <a:latin typeface="Helvetica"/>
                <a:cs typeface="Helvetica"/>
              </a:rPr>
              <a:t>40yo woman with fatigue and MSK pain and tenderness overlying muscles. No inflammatory features. +pain on palpation of muscles</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43100"/>
          </a:xfrm>
          <a:prstGeom prst="rect">
            <a:avLst/>
          </a:prstGeom>
          <a:ln w="6350">
            <a:noFill/>
          </a:ln>
        </p:spPr>
        <p:txBody>
          <a:bodyPr vert="horz" wrap="square" lIns="0" tIns="0" rIns="0" bIns="0" rtlCol="0">
            <a:spAutoFit/>
          </a:bodyPr>
          <a:lstStyle/>
          <a:p>
            <a:pPr marL="137160" marR="129539" indent="-635" algn="ctr">
              <a:lnSpc>
                <a:spcPts val="2200"/>
              </a:lnSpc>
            </a:pPr>
            <a:r>
              <a:rPr sz="2200">
                <a:latin typeface="Helvetica"/>
                <a:cs typeface="Helvetica"/>
              </a:rPr>
              <a:t>72yo with muscle pain, worse with raising arms overhead and rising from seated position.</a:t>
            </a:r>
          </a:p>
          <a:p>
            <a:pPr marL="168275" marR="160655" algn="ctr">
              <a:lnSpc>
                <a:spcPts val="2200"/>
              </a:lnSpc>
            </a:pPr>
            <a:r>
              <a:rPr sz="2200">
                <a:latin typeface="Helvetica"/>
                <a:cs typeface="Helvetica"/>
              </a:rPr>
              <a:t>Normal vitals, strength, ROM. ESR is high.</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6A453729-E544-96C5-C0A4-5DCCE8958456}"/>
              </a:ext>
            </a:extLst>
          </p:cNvPr>
          <p:cNvSpPr txBox="1"/>
          <p:nvPr/>
        </p:nvSpPr>
        <p:spPr>
          <a:xfrm>
            <a:off x="4114800" y="997863"/>
            <a:ext cx="3200400" cy="430887"/>
          </a:xfrm>
          <a:prstGeom prst="rect">
            <a:avLst/>
          </a:prstGeom>
          <a:ln w="6350">
            <a:noFill/>
          </a:ln>
        </p:spPr>
        <p:txBody>
          <a:bodyPr vert="horz" wrap="square" lIns="0" tIns="0" rIns="0" bIns="0" rtlCol="0">
            <a:spAutoFit/>
          </a:bodyPr>
          <a:lstStyle/>
          <a:p>
            <a:pPr marL="80010" algn="ctr">
              <a:lnSpc>
                <a:spcPct val="100000"/>
              </a:lnSpc>
            </a:pPr>
            <a:r>
              <a:rPr sz="2800">
                <a:latin typeface="Helvetica"/>
                <a:cs typeface="Helvetica"/>
              </a:rPr>
              <a:t>Polymyositis</a:t>
            </a:r>
          </a:p>
        </p:txBody>
      </p:sp>
      <p:sp>
        <p:nvSpPr>
          <p:cNvPr id="32" name="object 5">
            <a:extLst>
              <a:ext uri="{FF2B5EF4-FFF2-40B4-BE49-F238E27FC236}">
                <a16:creationId xmlns:a16="http://schemas.microsoft.com/office/drawing/2014/main" id="{DAD15EDB-5BE7-A223-E499-181410EA76AD}"/>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C0825FE2-37E0-EFA4-A3ED-CB095371E647}"/>
              </a:ext>
            </a:extLst>
          </p:cNvPr>
          <p:cNvSpPr txBox="1"/>
          <p:nvPr/>
        </p:nvSpPr>
        <p:spPr>
          <a:xfrm>
            <a:off x="4114800" y="3398163"/>
            <a:ext cx="3200400" cy="430887"/>
          </a:xfrm>
          <a:prstGeom prst="rect">
            <a:avLst/>
          </a:prstGeom>
          <a:ln w="6350">
            <a:noFill/>
          </a:ln>
        </p:spPr>
        <p:txBody>
          <a:bodyPr vert="horz" wrap="square" lIns="0" tIns="0" rIns="0" bIns="0" rtlCol="0">
            <a:spAutoFit/>
          </a:bodyPr>
          <a:lstStyle/>
          <a:p>
            <a:pPr marL="83820" algn="ctr">
              <a:lnSpc>
                <a:spcPct val="100000"/>
              </a:lnSpc>
            </a:pPr>
            <a:r>
              <a:rPr sz="2800">
                <a:latin typeface="Helvetica"/>
                <a:cs typeface="Helvetica"/>
              </a:rPr>
              <a:t>Dermatomyositis</a:t>
            </a:r>
          </a:p>
        </p:txBody>
      </p:sp>
      <p:sp>
        <p:nvSpPr>
          <p:cNvPr id="36" name="object 9">
            <a:extLst>
              <a:ext uri="{FF2B5EF4-FFF2-40B4-BE49-F238E27FC236}">
                <a16:creationId xmlns:a16="http://schemas.microsoft.com/office/drawing/2014/main" id="{337066DE-AA85-0009-E3DC-6A6A24E2D4F8}"/>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27D23C0A-415D-8C38-ABB3-F960219047C0}"/>
              </a:ext>
            </a:extLst>
          </p:cNvPr>
          <p:cNvSpPr txBox="1"/>
          <p:nvPr/>
        </p:nvSpPr>
        <p:spPr>
          <a:xfrm>
            <a:off x="4114800" y="5334000"/>
            <a:ext cx="3200400" cy="1136530"/>
          </a:xfrm>
          <a:prstGeom prst="rect">
            <a:avLst/>
          </a:prstGeom>
          <a:ln w="6350">
            <a:noFill/>
          </a:ln>
        </p:spPr>
        <p:txBody>
          <a:bodyPr vert="horz" wrap="square" lIns="0" tIns="0" rIns="0" bIns="0" rtlCol="0">
            <a:spAutoFit/>
          </a:bodyPr>
          <a:lstStyle/>
          <a:p>
            <a:pPr marL="419100" marR="411480" algn="ctr">
              <a:lnSpc>
                <a:spcPts val="4700"/>
              </a:lnSpc>
            </a:pPr>
            <a:r>
              <a:rPr sz="2800">
                <a:latin typeface="Helvetica"/>
                <a:cs typeface="Helvetica"/>
              </a:rPr>
              <a:t>Inclusion body myositis</a:t>
            </a:r>
          </a:p>
        </p:txBody>
      </p:sp>
      <p:sp>
        <p:nvSpPr>
          <p:cNvPr id="40" name="object 14">
            <a:extLst>
              <a:ext uri="{FF2B5EF4-FFF2-40B4-BE49-F238E27FC236}">
                <a16:creationId xmlns:a16="http://schemas.microsoft.com/office/drawing/2014/main" id="{E1A9D038-2DDF-FCCD-7313-BD08849D4DF7}"/>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6FD025C7-5110-171D-4DB1-5310E3237452}"/>
              </a:ext>
            </a:extLst>
          </p:cNvPr>
          <p:cNvSpPr txBox="1"/>
          <p:nvPr/>
        </p:nvSpPr>
        <p:spPr>
          <a:xfrm>
            <a:off x="4114800" y="7658100"/>
            <a:ext cx="3200400" cy="745397"/>
          </a:xfrm>
          <a:prstGeom prst="rect">
            <a:avLst/>
          </a:prstGeom>
          <a:ln w="6350">
            <a:noFill/>
          </a:ln>
        </p:spPr>
        <p:txBody>
          <a:bodyPr vert="horz" wrap="square" lIns="0" tIns="0" rIns="0" bIns="0" rtlCol="0">
            <a:spAutoFit/>
          </a:bodyPr>
          <a:lstStyle/>
          <a:p>
            <a:pPr marL="233045" marR="225425" indent="121285" algn="ctr">
              <a:lnSpc>
                <a:spcPts val="6900"/>
              </a:lnSpc>
            </a:pPr>
            <a:r>
              <a:rPr sz="2800">
                <a:latin typeface="Helvetica"/>
                <a:cs typeface="Helvetica"/>
              </a:rPr>
              <a:t>Ehlers Danlos</a:t>
            </a:r>
          </a:p>
        </p:txBody>
      </p:sp>
      <p:sp>
        <p:nvSpPr>
          <p:cNvPr id="44" name="object 19">
            <a:extLst>
              <a:ext uri="{FF2B5EF4-FFF2-40B4-BE49-F238E27FC236}">
                <a16:creationId xmlns:a16="http://schemas.microsoft.com/office/drawing/2014/main" id="{623C15F0-281F-17C7-7523-5F3027F395F9}"/>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7FCF4D5E-FBF3-4E95-E017-19A34E50C19B}"/>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3C69B040-E852-52B7-2574-5B8A6EF50617}"/>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DD45CC03-B71C-E0C9-AC7A-5FFCCD4869EA}"/>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EA727DD7-0A72-10EF-EB87-811B38B7666D}"/>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16D7147A-6EB5-B4E5-71DE-A630A1B428B4}"/>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072D6F00-2BA2-5B4D-BBC9-5E1FCC84F448}"/>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B7DD68B1-D4C8-682D-C5C0-31A50D776171}"/>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CC374905-17B6-442B-98DA-AF368EC756E8}"/>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769780"/>
          </a:xfrm>
          <a:prstGeom prst="rect">
            <a:avLst/>
          </a:prstGeom>
          <a:ln w="6350">
            <a:noFill/>
          </a:ln>
        </p:spPr>
        <p:txBody>
          <a:bodyPr vert="horz" wrap="square" lIns="0" tIns="0" rIns="0" bIns="0" rtlCol="0">
            <a:spAutoFit/>
          </a:bodyPr>
          <a:lstStyle/>
          <a:p>
            <a:pPr marL="144145" marR="136525" indent="-635" algn="ctr">
              <a:lnSpc>
                <a:spcPts val="2800"/>
              </a:lnSpc>
            </a:pPr>
            <a:r>
              <a:rPr sz="2200">
                <a:latin typeface="Helvetica"/>
                <a:cs typeface="Helvetica"/>
              </a:rPr>
              <a:t>27yo with anterior shoulder pain. Full ROM but pain overlying bicipital groove.</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333698"/>
          </a:xfrm>
          <a:prstGeom prst="rect">
            <a:avLst/>
          </a:prstGeom>
          <a:ln w="6350">
            <a:noFill/>
          </a:ln>
        </p:spPr>
        <p:txBody>
          <a:bodyPr vert="horz" wrap="square" lIns="0" tIns="0" rIns="0" bIns="0" rtlCol="0">
            <a:spAutoFit/>
          </a:bodyPr>
          <a:lstStyle/>
          <a:p>
            <a:pPr marL="92075" marR="84455" algn="ctr">
              <a:lnSpc>
                <a:spcPts val="2600"/>
              </a:lnSpc>
            </a:pPr>
            <a:r>
              <a:rPr sz="2200">
                <a:latin typeface="Helvetica"/>
                <a:cs typeface="Helvetica"/>
              </a:rPr>
              <a:t>28yo in 3rd trimester pregnancy with bilateral numbness in 1st 3 digits, worst at night</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333698"/>
          </a:xfrm>
          <a:prstGeom prst="rect">
            <a:avLst/>
          </a:prstGeom>
          <a:ln w="6350">
            <a:noFill/>
          </a:ln>
        </p:spPr>
        <p:txBody>
          <a:bodyPr vert="horz" wrap="square" lIns="0" tIns="0" rIns="0" bIns="0" rtlCol="0">
            <a:spAutoFit/>
          </a:bodyPr>
          <a:lstStyle/>
          <a:p>
            <a:pPr marL="165100" marR="157480" algn="ctr">
              <a:lnSpc>
                <a:spcPts val="2600"/>
              </a:lnSpc>
            </a:pPr>
            <a:r>
              <a:rPr sz="2200">
                <a:latin typeface="Helvetica"/>
                <a:cs typeface="Helvetica"/>
              </a:rPr>
              <a:t>Hot/red joint, tap shows rhomboid shape, weakly positive birefringent crystals</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410707"/>
          </a:xfrm>
          <a:prstGeom prst="rect">
            <a:avLst/>
          </a:prstGeom>
          <a:ln w="6350">
            <a:noFill/>
          </a:ln>
        </p:spPr>
        <p:txBody>
          <a:bodyPr vert="horz" wrap="square" lIns="0" tIns="0" rIns="0" bIns="0" rtlCol="0">
            <a:spAutoFit/>
          </a:bodyPr>
          <a:lstStyle/>
          <a:p>
            <a:pPr marL="144145" marR="136525" indent="-635" algn="ctr">
              <a:lnSpc>
                <a:spcPts val="2800"/>
              </a:lnSpc>
            </a:pPr>
            <a:r>
              <a:rPr sz="2200">
                <a:latin typeface="Helvetica"/>
                <a:cs typeface="Helvetica"/>
              </a:rPr>
              <a:t>45yo man with acute onset of exquisitely painful, red 1st MTP joint</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33B066E2-160B-5D93-400D-2397D998207A}"/>
              </a:ext>
            </a:extLst>
          </p:cNvPr>
          <p:cNvSpPr txBox="1"/>
          <p:nvPr/>
        </p:nvSpPr>
        <p:spPr>
          <a:xfrm>
            <a:off x="3505200" y="457200"/>
            <a:ext cx="3962400" cy="553037"/>
          </a:xfrm>
          <a:prstGeom prst="rect">
            <a:avLst/>
          </a:prstGeom>
          <a:ln w="6350">
            <a:noFill/>
          </a:ln>
        </p:spPr>
        <p:txBody>
          <a:bodyPr vert="horz" wrap="square" lIns="0" tIns="0" rIns="0" bIns="0" rtlCol="0">
            <a:spAutoFit/>
          </a:bodyPr>
          <a:lstStyle/>
          <a:p>
            <a:pPr marL="109855" marR="102235" indent="760095">
              <a:lnSpc>
                <a:spcPts val="4900"/>
              </a:lnSpc>
            </a:pPr>
            <a:r>
              <a:rPr sz="2800">
                <a:latin typeface="Helvetica"/>
                <a:cs typeface="Helvetica"/>
              </a:rPr>
              <a:t>Bone</a:t>
            </a:r>
            <a:r>
              <a:rPr lang="en-US" sz="2800">
                <a:latin typeface="Helvetica"/>
                <a:cs typeface="Helvetica"/>
              </a:rPr>
              <a:t> </a:t>
            </a:r>
            <a:r>
              <a:rPr sz="2800">
                <a:latin typeface="Helvetica"/>
                <a:cs typeface="Helvetica"/>
              </a:rPr>
              <a:t>metast</a:t>
            </a:r>
            <a:r>
              <a:rPr lang="en-US" sz="2800">
                <a:latin typeface="Helvetica"/>
                <a:cs typeface="Helvetica"/>
              </a:rPr>
              <a:t>asi</a:t>
            </a:r>
            <a:r>
              <a:rPr sz="2800">
                <a:latin typeface="Helvetica"/>
                <a:cs typeface="Helvetica"/>
              </a:rPr>
              <a:t>s</a:t>
            </a:r>
          </a:p>
        </p:txBody>
      </p:sp>
      <p:sp>
        <p:nvSpPr>
          <p:cNvPr id="32" name="object 5">
            <a:extLst>
              <a:ext uri="{FF2B5EF4-FFF2-40B4-BE49-F238E27FC236}">
                <a16:creationId xmlns:a16="http://schemas.microsoft.com/office/drawing/2014/main" id="{50AC5E3A-5E8B-07AA-21F7-FE21AE6DFDC4}"/>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5892527F-47DC-72EC-3031-AC335EB78164}"/>
              </a:ext>
            </a:extLst>
          </p:cNvPr>
          <p:cNvSpPr txBox="1"/>
          <p:nvPr/>
        </p:nvSpPr>
        <p:spPr>
          <a:xfrm>
            <a:off x="4114800" y="2857500"/>
            <a:ext cx="3200400" cy="1292662"/>
          </a:xfrm>
          <a:prstGeom prst="rect">
            <a:avLst/>
          </a:prstGeom>
          <a:ln w="6350">
            <a:noFill/>
          </a:ln>
        </p:spPr>
        <p:txBody>
          <a:bodyPr vert="horz" wrap="square" lIns="0" tIns="0" rIns="0" bIns="0" rtlCol="0">
            <a:spAutoFit/>
          </a:bodyPr>
          <a:lstStyle/>
          <a:p>
            <a:pPr marL="121285" marR="113664" indent="-635" algn="ctr"/>
            <a:r>
              <a:rPr sz="2800">
                <a:latin typeface="Helvetica"/>
                <a:cs typeface="Helvetica"/>
              </a:rPr>
              <a:t>Vertebral compression fracture</a:t>
            </a:r>
          </a:p>
        </p:txBody>
      </p:sp>
      <p:sp>
        <p:nvSpPr>
          <p:cNvPr id="36" name="object 9">
            <a:extLst>
              <a:ext uri="{FF2B5EF4-FFF2-40B4-BE49-F238E27FC236}">
                <a16:creationId xmlns:a16="http://schemas.microsoft.com/office/drawing/2014/main" id="{4C7E1873-D7D7-C9C2-02BC-413A5B705E18}"/>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E285BE75-0347-0C80-8126-9C8C60D7845F}"/>
              </a:ext>
            </a:extLst>
          </p:cNvPr>
          <p:cNvSpPr txBox="1"/>
          <p:nvPr/>
        </p:nvSpPr>
        <p:spPr>
          <a:xfrm>
            <a:off x="4114800" y="5257800"/>
            <a:ext cx="3200400" cy="745397"/>
          </a:xfrm>
          <a:prstGeom prst="rect">
            <a:avLst/>
          </a:prstGeom>
          <a:ln w="6350">
            <a:noFill/>
          </a:ln>
        </p:spPr>
        <p:txBody>
          <a:bodyPr vert="horz" wrap="square" lIns="0" tIns="0" rIns="0" bIns="0" rtlCol="0">
            <a:spAutoFit/>
          </a:bodyPr>
          <a:lstStyle/>
          <a:p>
            <a:pPr marL="281305" marR="273685" indent="24130" algn="ctr">
              <a:lnSpc>
                <a:spcPts val="6900"/>
              </a:lnSpc>
            </a:pPr>
            <a:r>
              <a:rPr sz="2800">
                <a:latin typeface="Helvetica"/>
                <a:cs typeface="Helvetica"/>
              </a:rPr>
              <a:t>Cauda equina</a:t>
            </a:r>
          </a:p>
        </p:txBody>
      </p:sp>
      <p:sp>
        <p:nvSpPr>
          <p:cNvPr id="40" name="object 14">
            <a:extLst>
              <a:ext uri="{FF2B5EF4-FFF2-40B4-BE49-F238E27FC236}">
                <a16:creationId xmlns:a16="http://schemas.microsoft.com/office/drawing/2014/main" id="{728436E2-9CC0-F61C-D8AE-7162E80BA55D}"/>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514E9AF9-02D5-98FD-48F3-F0E9D1535E98}"/>
              </a:ext>
            </a:extLst>
          </p:cNvPr>
          <p:cNvSpPr txBox="1"/>
          <p:nvPr/>
        </p:nvSpPr>
        <p:spPr>
          <a:xfrm>
            <a:off x="3928806" y="7658100"/>
            <a:ext cx="3505200" cy="495328"/>
          </a:xfrm>
          <a:prstGeom prst="rect">
            <a:avLst/>
          </a:prstGeom>
          <a:ln w="6350">
            <a:noFill/>
          </a:ln>
        </p:spPr>
        <p:txBody>
          <a:bodyPr vert="horz" wrap="square" lIns="0" tIns="0" rIns="0" bIns="0" rtlCol="0">
            <a:spAutoFit/>
          </a:bodyPr>
          <a:lstStyle/>
          <a:p>
            <a:pPr marL="732155" marR="71755" indent="-652780" algn="ctr">
              <a:lnSpc>
                <a:spcPts val="4300"/>
              </a:lnSpc>
            </a:pPr>
            <a:r>
              <a:rPr sz="2800">
                <a:latin typeface="Helvetica"/>
                <a:cs typeface="Helvetica"/>
              </a:rPr>
              <a:t>Trochanteric</a:t>
            </a:r>
            <a:r>
              <a:rPr lang="en-US" sz="2800">
                <a:latin typeface="Helvetica"/>
                <a:cs typeface="Helvetica"/>
              </a:rPr>
              <a:t> </a:t>
            </a:r>
            <a:r>
              <a:rPr sz="2800">
                <a:latin typeface="Helvetica"/>
                <a:cs typeface="Helvetica"/>
              </a:rPr>
              <a:t>bursitis</a:t>
            </a:r>
          </a:p>
        </p:txBody>
      </p:sp>
      <p:sp>
        <p:nvSpPr>
          <p:cNvPr id="44" name="object 19">
            <a:extLst>
              <a:ext uri="{FF2B5EF4-FFF2-40B4-BE49-F238E27FC236}">
                <a16:creationId xmlns:a16="http://schemas.microsoft.com/office/drawing/2014/main" id="{CF9AEAA4-6402-3023-89D7-CE5CF92BEB30}"/>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BB903990-4029-1E8D-6C6D-B6A67A6BC6C4}"/>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6E58CC5A-9671-FBCA-8252-5675BB9A113D}"/>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D7CE46A2-E6DC-631E-7903-7A0E6A700122}"/>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10B2BE3F-9A22-2823-A278-C60148FD9B2C}"/>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FA5EC4D9-71FB-0F78-FBF9-C9D4EA2D2EB0}"/>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40704526-D665-17D2-8638-5BA9282EDCA0}"/>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852E2C6D-C63D-5603-1356-A0FE9C101B75}"/>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8D858026-7902-C4EB-30C7-FAD7AB77D2C0}"/>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795428"/>
          </a:xfrm>
          <a:prstGeom prst="rect">
            <a:avLst/>
          </a:prstGeom>
          <a:ln w="6350">
            <a:noFill/>
          </a:ln>
        </p:spPr>
        <p:txBody>
          <a:bodyPr vert="horz" wrap="square" lIns="0" tIns="0" rIns="0" bIns="0" rtlCol="0">
            <a:spAutoFit/>
          </a:bodyPr>
          <a:lstStyle/>
          <a:p>
            <a:pPr marL="170815" marR="163195" algn="ctr">
              <a:lnSpc>
                <a:spcPts val="2000"/>
              </a:lnSpc>
            </a:pPr>
            <a:r>
              <a:rPr sz="2200">
                <a:latin typeface="Helvetica"/>
                <a:cs typeface="Helvetica"/>
              </a:rPr>
              <a:t>44yo woman with chronic fatigue, polyarticular joint pain in hands/wrists with swelling, muscle weakness.</a:t>
            </a:r>
          </a:p>
          <a:p>
            <a:pPr algn="ctr">
              <a:lnSpc>
                <a:spcPts val="2000"/>
              </a:lnSpc>
            </a:pPr>
            <a:r>
              <a:rPr sz="2200">
                <a:latin typeface="Helvetica"/>
                <a:cs typeface="Helvetica"/>
              </a:rPr>
              <a:t>+Raynauds/GERD</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943100"/>
          </a:xfrm>
          <a:prstGeom prst="rect">
            <a:avLst/>
          </a:prstGeom>
          <a:ln w="6350">
            <a:noFill/>
          </a:ln>
        </p:spPr>
        <p:txBody>
          <a:bodyPr vert="horz" wrap="square" lIns="0" tIns="0" rIns="0" bIns="0" rtlCol="0">
            <a:spAutoFit/>
          </a:bodyPr>
          <a:lstStyle/>
          <a:p>
            <a:pPr marL="98425" marR="90805" algn="ctr">
              <a:lnSpc>
                <a:spcPts val="2200"/>
              </a:lnSpc>
            </a:pPr>
            <a:r>
              <a:rPr sz="2200">
                <a:latin typeface="Helvetica"/>
                <a:cs typeface="Helvetica"/>
              </a:rPr>
              <a:t>62yo M with chronic knee pain, worse with use/movement. Morning stiff 10 minutes. No erythema. +crepitus</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2051908"/>
          </a:xfrm>
          <a:prstGeom prst="rect">
            <a:avLst/>
          </a:prstGeom>
          <a:ln w="6350">
            <a:noFill/>
          </a:ln>
        </p:spPr>
        <p:txBody>
          <a:bodyPr vert="horz" wrap="square" lIns="0" tIns="0" rIns="0" bIns="0" rtlCol="0">
            <a:spAutoFit/>
          </a:bodyPr>
          <a:lstStyle/>
          <a:p>
            <a:pPr marL="255904" marR="248285" algn="ctr">
              <a:lnSpc>
                <a:spcPts val="2000"/>
              </a:lnSpc>
            </a:pPr>
            <a:r>
              <a:rPr sz="2200">
                <a:latin typeface="Helvetica"/>
                <a:cs typeface="Helvetica"/>
              </a:rPr>
              <a:t>64yo with muscle weak, bone tenderness, and recent bone fracture.</a:t>
            </a:r>
          </a:p>
          <a:p>
            <a:pPr marL="135255" marR="127635" indent="99060" algn="ctr">
              <a:lnSpc>
                <a:spcPts val="2000"/>
              </a:lnSpc>
            </a:pPr>
            <a:r>
              <a:rPr sz="2200">
                <a:latin typeface="Helvetica"/>
                <a:cs typeface="Helvetica"/>
              </a:rPr>
              <a:t>Lactose</a:t>
            </a:r>
            <a:r>
              <a:rPr lang="en-US" sz="2200">
                <a:latin typeface="Helvetica"/>
                <a:cs typeface="Helvetica"/>
              </a:rPr>
              <a:t> </a:t>
            </a:r>
            <a:r>
              <a:rPr sz="2200">
                <a:latin typeface="Helvetica"/>
                <a:cs typeface="Helvetica"/>
              </a:rPr>
              <a:t>intolerant, picky eater eats few foods, and does not go outside ofte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263231"/>
          </a:xfrm>
          <a:prstGeom prst="rect">
            <a:avLst/>
          </a:prstGeom>
          <a:ln w="6350">
            <a:noFill/>
          </a:ln>
        </p:spPr>
        <p:txBody>
          <a:bodyPr vert="horz" wrap="square" lIns="0" tIns="0" rIns="0" bIns="0" rtlCol="0">
            <a:spAutoFit/>
          </a:bodyPr>
          <a:lstStyle/>
          <a:p>
            <a:pPr marL="73025" marR="65405" algn="ctr">
              <a:lnSpc>
                <a:spcPts val="3400"/>
              </a:lnSpc>
            </a:pPr>
            <a:r>
              <a:rPr sz="2200">
                <a:latin typeface="Helvetica"/>
                <a:cs typeface="Helvetica"/>
              </a:rPr>
              <a:t>65yo woman with hip fracture after a fall from standing</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F2E2AAE9-DB88-C767-A4C0-14AF41570265}"/>
              </a:ext>
            </a:extLst>
          </p:cNvPr>
          <p:cNvSpPr txBox="1"/>
          <p:nvPr/>
        </p:nvSpPr>
        <p:spPr>
          <a:xfrm>
            <a:off x="4127090" y="647700"/>
            <a:ext cx="3200400" cy="1136530"/>
          </a:xfrm>
          <a:prstGeom prst="rect">
            <a:avLst/>
          </a:prstGeom>
          <a:ln w="6350">
            <a:noFill/>
          </a:ln>
        </p:spPr>
        <p:txBody>
          <a:bodyPr vert="horz" wrap="square" lIns="0" tIns="0" rIns="0" bIns="0" rtlCol="0">
            <a:spAutoFit/>
          </a:bodyPr>
          <a:lstStyle/>
          <a:p>
            <a:pPr marL="236220" marR="228600" algn="ctr">
              <a:lnSpc>
                <a:spcPts val="4700"/>
              </a:lnSpc>
              <a:tabLst>
                <a:tab pos="2459355" algn="l"/>
              </a:tabLst>
            </a:pPr>
            <a:r>
              <a:rPr sz="2800">
                <a:latin typeface="Helvetica"/>
                <a:cs typeface="Helvetica"/>
              </a:rPr>
              <a:t>Paget's disease</a:t>
            </a:r>
            <a:r>
              <a:rPr lang="en-US" sz="2800">
                <a:latin typeface="Helvetica"/>
                <a:cs typeface="Helvetica"/>
              </a:rPr>
              <a:t> </a:t>
            </a:r>
            <a:r>
              <a:rPr sz="2800">
                <a:latin typeface="Helvetica"/>
                <a:cs typeface="Helvetica"/>
              </a:rPr>
              <a:t>of</a:t>
            </a:r>
            <a:r>
              <a:rPr lang="en-US" sz="2800">
                <a:latin typeface="Helvetica"/>
                <a:cs typeface="Helvetica"/>
              </a:rPr>
              <a:t> </a:t>
            </a:r>
            <a:r>
              <a:rPr sz="2800">
                <a:latin typeface="Helvetica"/>
                <a:cs typeface="Helvetica"/>
              </a:rPr>
              <a:t>bone</a:t>
            </a:r>
          </a:p>
        </p:txBody>
      </p:sp>
      <p:sp>
        <p:nvSpPr>
          <p:cNvPr id="32" name="object 5">
            <a:extLst>
              <a:ext uri="{FF2B5EF4-FFF2-40B4-BE49-F238E27FC236}">
                <a16:creationId xmlns:a16="http://schemas.microsoft.com/office/drawing/2014/main" id="{44954AFB-1BAF-D06C-A605-8543BF38489D}"/>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C354770A-32CD-E22F-2767-26B9F9AE5321}"/>
              </a:ext>
            </a:extLst>
          </p:cNvPr>
          <p:cNvSpPr txBox="1"/>
          <p:nvPr/>
        </p:nvSpPr>
        <p:spPr>
          <a:xfrm>
            <a:off x="4127090" y="3048000"/>
            <a:ext cx="3200400" cy="678071"/>
          </a:xfrm>
          <a:prstGeom prst="rect">
            <a:avLst/>
          </a:prstGeom>
          <a:ln w="6350">
            <a:noFill/>
          </a:ln>
        </p:spPr>
        <p:txBody>
          <a:bodyPr vert="horz" wrap="square" lIns="0" tIns="0" rIns="0" bIns="0" rtlCol="0">
            <a:spAutoFit/>
          </a:bodyPr>
          <a:lstStyle/>
          <a:p>
            <a:pPr marL="306070" marR="79375" indent="-219075" algn="ctr">
              <a:lnSpc>
                <a:spcPts val="6200"/>
              </a:lnSpc>
            </a:pPr>
            <a:r>
              <a:rPr sz="2800">
                <a:latin typeface="Helvetica"/>
                <a:cs typeface="Helvetica"/>
              </a:rPr>
              <a:t>Psoriatic arthritis</a:t>
            </a:r>
          </a:p>
        </p:txBody>
      </p:sp>
      <p:sp>
        <p:nvSpPr>
          <p:cNvPr id="36" name="object 9">
            <a:extLst>
              <a:ext uri="{FF2B5EF4-FFF2-40B4-BE49-F238E27FC236}">
                <a16:creationId xmlns:a16="http://schemas.microsoft.com/office/drawing/2014/main" id="{5858D5D1-3344-9618-0582-527D62B663B0}"/>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8160DCFA-EE51-0148-EEAF-ED9626BC1498}"/>
              </a:ext>
            </a:extLst>
          </p:cNvPr>
          <p:cNvSpPr txBox="1"/>
          <p:nvPr/>
        </p:nvSpPr>
        <p:spPr>
          <a:xfrm>
            <a:off x="4127090" y="5448300"/>
            <a:ext cx="3200400" cy="658835"/>
          </a:xfrm>
          <a:prstGeom prst="rect">
            <a:avLst/>
          </a:prstGeom>
          <a:ln w="6350">
            <a:noFill/>
          </a:ln>
        </p:spPr>
        <p:txBody>
          <a:bodyPr vert="horz" wrap="square" lIns="0" tIns="0" rIns="0" bIns="0" rtlCol="0">
            <a:spAutoFit/>
          </a:bodyPr>
          <a:lstStyle/>
          <a:p>
            <a:pPr marL="347980" marR="107950" indent="-233679" algn="ctr">
              <a:lnSpc>
                <a:spcPts val="6000"/>
              </a:lnSpc>
            </a:pPr>
            <a:r>
              <a:rPr sz="2800">
                <a:latin typeface="Helvetica"/>
                <a:cs typeface="Helvetica"/>
              </a:rPr>
              <a:t>Reactive arthritis</a:t>
            </a:r>
          </a:p>
        </p:txBody>
      </p:sp>
      <p:sp>
        <p:nvSpPr>
          <p:cNvPr id="40" name="object 14">
            <a:extLst>
              <a:ext uri="{FF2B5EF4-FFF2-40B4-BE49-F238E27FC236}">
                <a16:creationId xmlns:a16="http://schemas.microsoft.com/office/drawing/2014/main" id="{08CE5F4B-0FDA-768C-6B8B-E7580B722655}"/>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E61F50F6-6386-52EB-CC18-F132A001D35E}"/>
              </a:ext>
            </a:extLst>
          </p:cNvPr>
          <p:cNvSpPr txBox="1"/>
          <p:nvPr/>
        </p:nvSpPr>
        <p:spPr>
          <a:xfrm>
            <a:off x="3923890" y="7848600"/>
            <a:ext cx="3505200" cy="495328"/>
          </a:xfrm>
          <a:prstGeom prst="rect">
            <a:avLst/>
          </a:prstGeom>
          <a:ln w="6350">
            <a:noFill/>
          </a:ln>
        </p:spPr>
        <p:txBody>
          <a:bodyPr vert="horz" wrap="square" lIns="0" tIns="0" rIns="0" bIns="0" rtlCol="0">
            <a:spAutoFit/>
          </a:bodyPr>
          <a:lstStyle/>
          <a:p>
            <a:pPr marL="701675" marR="116839" indent="-577215" algn="ctr">
              <a:lnSpc>
                <a:spcPts val="4300"/>
              </a:lnSpc>
            </a:pPr>
            <a:r>
              <a:rPr sz="2800">
                <a:latin typeface="Helvetica"/>
                <a:cs typeface="Helvetica"/>
              </a:rPr>
              <a:t>Rheumatoid</a:t>
            </a:r>
            <a:r>
              <a:rPr lang="en-US" sz="2800">
                <a:latin typeface="Helvetica"/>
                <a:cs typeface="Helvetica"/>
              </a:rPr>
              <a:t> </a:t>
            </a:r>
            <a:r>
              <a:rPr sz="2800">
                <a:latin typeface="Helvetica"/>
                <a:cs typeface="Helvetica"/>
              </a:rPr>
              <a:t>arthritis</a:t>
            </a:r>
          </a:p>
        </p:txBody>
      </p:sp>
      <p:sp>
        <p:nvSpPr>
          <p:cNvPr id="44" name="object 19">
            <a:extLst>
              <a:ext uri="{FF2B5EF4-FFF2-40B4-BE49-F238E27FC236}">
                <a16:creationId xmlns:a16="http://schemas.microsoft.com/office/drawing/2014/main" id="{563CF890-50D7-5875-B362-2B5C82855CCB}"/>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3D725F10-DB46-E806-3231-568D616CF579}"/>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B2F3F02E-713C-CD2B-B4F8-7CEBB079EE3A}"/>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8BD7E0AF-0320-CA41-269D-11EC609463A7}"/>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A7C28D38-B521-4D76-3777-427AB442256C}"/>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B7B55AB6-F3B0-124A-968B-E780626AC44F}"/>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CC8EC5D7-152F-96EE-9F72-62D5911BB222}"/>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7EB79180-F741-908E-BAE8-E4CEF85E5F86}"/>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FBE4AFCB-BBCC-5211-53EA-C5C60BC59DA2}"/>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538883"/>
          </a:xfrm>
          <a:prstGeom prst="rect">
            <a:avLst/>
          </a:prstGeom>
          <a:ln w="6350">
            <a:noFill/>
          </a:ln>
        </p:spPr>
        <p:txBody>
          <a:bodyPr vert="horz" wrap="square" lIns="0" tIns="0" rIns="0" bIns="0" rtlCol="0">
            <a:spAutoFit/>
          </a:bodyPr>
          <a:lstStyle/>
          <a:p>
            <a:pPr marL="131445" marR="123825" algn="ctr">
              <a:lnSpc>
                <a:spcPts val="2400"/>
              </a:lnSpc>
            </a:pPr>
            <a:r>
              <a:rPr sz="2200">
                <a:latin typeface="Helvetica"/>
                <a:cs typeface="Helvetica"/>
              </a:rPr>
              <a:t>57yo man incidentally found to have increased alkaline phosphatase, xray is abnormal</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410707"/>
          </a:xfrm>
          <a:prstGeom prst="rect">
            <a:avLst/>
          </a:prstGeom>
          <a:ln w="6350">
            <a:noFill/>
          </a:ln>
        </p:spPr>
        <p:txBody>
          <a:bodyPr vert="horz" wrap="square" lIns="0" tIns="0" rIns="0" bIns="0" rtlCol="0">
            <a:spAutoFit/>
          </a:bodyPr>
          <a:lstStyle/>
          <a:p>
            <a:pPr marL="178435" marR="170815" indent="-635" algn="ctr">
              <a:lnSpc>
                <a:spcPts val="2800"/>
              </a:lnSpc>
            </a:pPr>
            <a:r>
              <a:rPr sz="2200">
                <a:latin typeface="Helvetica"/>
                <a:cs typeface="Helvetica"/>
              </a:rPr>
              <a:t>41yo with asymmetric oligoarthritis of large and small joints. +nail pitting</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943100"/>
          </a:xfrm>
          <a:prstGeom prst="rect">
            <a:avLst/>
          </a:prstGeom>
          <a:ln w="6350">
            <a:noFill/>
          </a:ln>
        </p:spPr>
        <p:txBody>
          <a:bodyPr vert="horz" wrap="square" lIns="0" tIns="0" rIns="0" bIns="0" rtlCol="0">
            <a:spAutoFit/>
          </a:bodyPr>
          <a:lstStyle/>
          <a:p>
            <a:pPr marL="90170" marR="82550" algn="ctr">
              <a:lnSpc>
                <a:spcPts val="2200"/>
              </a:lnSpc>
            </a:pPr>
            <a:r>
              <a:rPr sz="2200">
                <a:latin typeface="Helvetica"/>
                <a:cs typeface="Helvetica"/>
              </a:rPr>
              <a:t>31yo M with acute onset of back pain and asymmetric oligoarthritis and swelling in knee and ankle. GI infection recently. +Dactylitis</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506887"/>
          </a:xfrm>
          <a:prstGeom prst="rect">
            <a:avLst/>
          </a:prstGeom>
          <a:ln w="6350">
            <a:noFill/>
          </a:ln>
        </p:spPr>
        <p:txBody>
          <a:bodyPr vert="horz" wrap="square" lIns="0" tIns="0" rIns="0" bIns="0" rtlCol="0">
            <a:spAutoFit/>
          </a:bodyPr>
          <a:lstStyle/>
          <a:p>
            <a:pPr marL="82550" marR="74930" indent="-635" algn="ctr">
              <a:lnSpc>
                <a:spcPts val="3000"/>
              </a:lnSpc>
            </a:pPr>
            <a:r>
              <a:rPr sz="2200">
                <a:latin typeface="Helvetica"/>
                <a:cs typeface="Helvetica"/>
              </a:rPr>
              <a:t>34yo F with chronic MCP joint pain and swelling. Morning stiff &gt;1hr</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A3627BD1-53C6-9817-85FD-12055CAAEAE9}"/>
              </a:ext>
            </a:extLst>
          </p:cNvPr>
          <p:cNvSpPr txBox="1"/>
          <p:nvPr/>
        </p:nvSpPr>
        <p:spPr>
          <a:xfrm>
            <a:off x="4112342" y="800100"/>
            <a:ext cx="3200400" cy="912109"/>
          </a:xfrm>
          <a:prstGeom prst="rect">
            <a:avLst/>
          </a:prstGeom>
          <a:ln w="6350">
            <a:noFill/>
          </a:ln>
        </p:spPr>
        <p:txBody>
          <a:bodyPr vert="horz" wrap="square" lIns="0" tIns="0" rIns="0" bIns="0" rtlCol="0">
            <a:spAutoFit/>
          </a:bodyPr>
          <a:lstStyle/>
          <a:p>
            <a:pPr marL="107950" marR="100330" algn="ctr">
              <a:lnSpc>
                <a:spcPts val="3700"/>
              </a:lnSpc>
              <a:tabLst>
                <a:tab pos="1466215" algn="l"/>
              </a:tabLst>
            </a:pPr>
            <a:r>
              <a:rPr sz="2800">
                <a:latin typeface="Helvetica"/>
                <a:cs typeface="Helvetica"/>
              </a:rPr>
              <a:t>Mixed connective tissue</a:t>
            </a:r>
            <a:r>
              <a:rPr lang="en-US" sz="2800">
                <a:latin typeface="Helvetica"/>
                <a:cs typeface="Helvetica"/>
              </a:rPr>
              <a:t> </a:t>
            </a:r>
            <a:r>
              <a:rPr sz="2800">
                <a:latin typeface="Helvetica"/>
                <a:cs typeface="Helvetica"/>
              </a:rPr>
              <a:t>disease</a:t>
            </a:r>
          </a:p>
        </p:txBody>
      </p:sp>
      <p:sp>
        <p:nvSpPr>
          <p:cNvPr id="32" name="object 5">
            <a:extLst>
              <a:ext uri="{FF2B5EF4-FFF2-40B4-BE49-F238E27FC236}">
                <a16:creationId xmlns:a16="http://schemas.microsoft.com/office/drawing/2014/main" id="{A6567AC3-B7C1-345B-C13C-6BA2034C66BD}"/>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BEB8D54E-9F5D-0B4C-98D4-6D1207CD0212}"/>
              </a:ext>
            </a:extLst>
          </p:cNvPr>
          <p:cNvSpPr txBox="1"/>
          <p:nvPr/>
        </p:nvSpPr>
        <p:spPr>
          <a:xfrm>
            <a:off x="4112342" y="3200400"/>
            <a:ext cx="3200400" cy="430887"/>
          </a:xfrm>
          <a:prstGeom prst="rect">
            <a:avLst/>
          </a:prstGeom>
          <a:ln w="6350">
            <a:noFill/>
          </a:ln>
        </p:spPr>
        <p:txBody>
          <a:bodyPr vert="horz" wrap="square" lIns="0" tIns="0" rIns="0" bIns="0" rtlCol="0">
            <a:spAutoFit/>
          </a:bodyPr>
          <a:lstStyle/>
          <a:p>
            <a:pPr marL="124460" algn="ctr">
              <a:lnSpc>
                <a:spcPct val="100000"/>
              </a:lnSpc>
            </a:pPr>
            <a:r>
              <a:rPr sz="2800">
                <a:latin typeface="Helvetica"/>
                <a:cs typeface="Helvetica"/>
              </a:rPr>
              <a:t>Osteoarthritis</a:t>
            </a:r>
          </a:p>
        </p:txBody>
      </p:sp>
      <p:sp>
        <p:nvSpPr>
          <p:cNvPr id="36" name="object 9">
            <a:extLst>
              <a:ext uri="{FF2B5EF4-FFF2-40B4-BE49-F238E27FC236}">
                <a16:creationId xmlns:a16="http://schemas.microsoft.com/office/drawing/2014/main" id="{99C15B5F-EA77-4667-A4FE-317923E37914}"/>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6BB1562E-2A0E-2ADC-EABB-D11FA582691F}"/>
              </a:ext>
            </a:extLst>
          </p:cNvPr>
          <p:cNvSpPr txBox="1"/>
          <p:nvPr/>
        </p:nvSpPr>
        <p:spPr>
          <a:xfrm>
            <a:off x="4112342" y="5600700"/>
            <a:ext cx="3200400" cy="430887"/>
          </a:xfrm>
          <a:prstGeom prst="rect">
            <a:avLst/>
          </a:prstGeom>
          <a:ln w="6350">
            <a:noFill/>
          </a:ln>
        </p:spPr>
        <p:txBody>
          <a:bodyPr vert="horz" wrap="square" lIns="0" tIns="0" rIns="0" bIns="0" rtlCol="0">
            <a:spAutoFit/>
          </a:bodyPr>
          <a:lstStyle/>
          <a:p>
            <a:pPr marL="83185" algn="ctr">
              <a:lnSpc>
                <a:spcPct val="100000"/>
              </a:lnSpc>
            </a:pPr>
            <a:r>
              <a:rPr sz="2800">
                <a:latin typeface="Helvetica"/>
                <a:cs typeface="Helvetica"/>
              </a:rPr>
              <a:t>Osteomalacia</a:t>
            </a:r>
          </a:p>
        </p:txBody>
      </p:sp>
      <p:sp>
        <p:nvSpPr>
          <p:cNvPr id="40" name="object 14">
            <a:extLst>
              <a:ext uri="{FF2B5EF4-FFF2-40B4-BE49-F238E27FC236}">
                <a16:creationId xmlns:a16="http://schemas.microsoft.com/office/drawing/2014/main" id="{CF94B4F6-48F8-8D4C-A667-8C19A30FF968}"/>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9DB0136C-87A0-76EA-15AD-5602C4BBE41B}"/>
              </a:ext>
            </a:extLst>
          </p:cNvPr>
          <p:cNvSpPr txBox="1"/>
          <p:nvPr/>
        </p:nvSpPr>
        <p:spPr>
          <a:xfrm>
            <a:off x="4112342" y="8001000"/>
            <a:ext cx="3200400" cy="430887"/>
          </a:xfrm>
          <a:prstGeom prst="rect">
            <a:avLst/>
          </a:prstGeom>
          <a:ln w="6350">
            <a:noFill/>
          </a:ln>
        </p:spPr>
        <p:txBody>
          <a:bodyPr vert="horz" wrap="square" lIns="0" tIns="0" rIns="0" bIns="0" rtlCol="0">
            <a:spAutoFit/>
          </a:bodyPr>
          <a:lstStyle/>
          <a:p>
            <a:pPr marL="137795" algn="ctr">
              <a:lnSpc>
                <a:spcPct val="100000"/>
              </a:lnSpc>
            </a:pPr>
            <a:r>
              <a:rPr sz="2800">
                <a:latin typeface="Helvetica"/>
                <a:cs typeface="Helvetica"/>
              </a:rPr>
              <a:t>Osteoporosis</a:t>
            </a:r>
          </a:p>
        </p:txBody>
      </p:sp>
      <p:sp>
        <p:nvSpPr>
          <p:cNvPr id="44" name="object 19">
            <a:extLst>
              <a:ext uri="{FF2B5EF4-FFF2-40B4-BE49-F238E27FC236}">
                <a16:creationId xmlns:a16="http://schemas.microsoft.com/office/drawing/2014/main" id="{B0805F32-58D8-4130-6ACF-2624856E0279}"/>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169D1124-5C0E-C82D-B0EE-5C26FB272451}"/>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20B49AB4-0517-E19E-99BB-A046B75304A3}"/>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33847DB0-8BFE-18B8-F540-2A7B1373AB91}"/>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F135670D-14C3-1EA3-4E40-2B0F54A06DD8}"/>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4D8867D4-D430-4ABF-A38B-39CBBBD91A2F}"/>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0768A8E1-9608-F468-93ED-CFB306836D2C}"/>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D0C877B8-8E71-81C6-CD3C-CF6E94D53C7C}"/>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18D18C34-7226-B579-3891-7EA5D5877058}"/>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538883"/>
          </a:xfrm>
          <a:prstGeom prst="rect">
            <a:avLst/>
          </a:prstGeom>
          <a:ln w="6350">
            <a:noFill/>
          </a:ln>
        </p:spPr>
        <p:txBody>
          <a:bodyPr vert="horz" wrap="square" lIns="0" tIns="0" rIns="0" bIns="0" rtlCol="0">
            <a:spAutoFit/>
          </a:bodyPr>
          <a:lstStyle/>
          <a:p>
            <a:pPr marL="122555" marR="114935" algn="ctr">
              <a:lnSpc>
                <a:spcPts val="2400"/>
              </a:lnSpc>
            </a:pPr>
            <a:r>
              <a:rPr sz="2200">
                <a:latin typeface="Helvetica"/>
                <a:cs typeface="Helvetica"/>
              </a:rPr>
              <a:t>37yo F with chronic, worsening stiff hands, Raynauds, and GERD. Exam: tight skin over fingers</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410707"/>
          </a:xfrm>
          <a:prstGeom prst="rect">
            <a:avLst/>
          </a:prstGeom>
          <a:ln w="6350">
            <a:noFill/>
          </a:ln>
        </p:spPr>
        <p:txBody>
          <a:bodyPr vert="horz" wrap="square" lIns="0" tIns="0" rIns="0" bIns="0" rtlCol="0">
            <a:spAutoFit/>
          </a:bodyPr>
          <a:lstStyle/>
          <a:p>
            <a:pPr marL="114300" marR="106680" algn="ctr">
              <a:lnSpc>
                <a:spcPts val="2800"/>
              </a:lnSpc>
            </a:pPr>
            <a:r>
              <a:rPr sz="2200">
                <a:latin typeface="Helvetica"/>
                <a:cs typeface="Helvetica"/>
              </a:rPr>
              <a:t>46yo F with chronic dry eyes and mouth, trouble swallowing dry food</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231106"/>
          </a:xfrm>
          <a:prstGeom prst="rect">
            <a:avLst/>
          </a:prstGeom>
          <a:ln w="6350">
            <a:noFill/>
          </a:ln>
        </p:spPr>
        <p:txBody>
          <a:bodyPr vert="horz" wrap="square" lIns="0" tIns="0" rIns="0" bIns="0" rtlCol="0" anchor="t">
            <a:spAutoFit/>
          </a:bodyPr>
          <a:lstStyle/>
          <a:p>
            <a:pPr marL="97790" marR="90170" algn="ctr">
              <a:lnSpc>
                <a:spcPts val="2400"/>
              </a:lnSpc>
            </a:pPr>
            <a:r>
              <a:rPr sz="2200">
                <a:latin typeface="Helvetica"/>
                <a:cs typeface="Helvetica"/>
              </a:rPr>
              <a:t>48yo with hemoptysis, nosebleeds, and </a:t>
            </a:r>
            <a:r>
              <a:rPr lang="en-US" sz="2200">
                <a:latin typeface="Helvetica"/>
                <a:cs typeface="Helvetica"/>
              </a:rPr>
              <a:t>Urinary analysis </a:t>
            </a:r>
            <a:r>
              <a:rPr sz="2200">
                <a:latin typeface="Helvetica"/>
                <a:cs typeface="Helvetica"/>
              </a:rPr>
              <a:t>shows proteinuria/hematuria</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2119234"/>
          </a:xfrm>
          <a:prstGeom prst="rect">
            <a:avLst/>
          </a:prstGeom>
          <a:ln w="6350">
            <a:noFill/>
          </a:ln>
        </p:spPr>
        <p:txBody>
          <a:bodyPr vert="horz" wrap="square" lIns="0" tIns="0" rIns="0" bIns="0" rtlCol="0" anchor="t">
            <a:spAutoFit/>
          </a:bodyPr>
          <a:lstStyle/>
          <a:p>
            <a:pPr marL="381000" marR="373380" indent="-635" algn="ctr">
              <a:lnSpc>
                <a:spcPts val="2800"/>
              </a:lnSpc>
            </a:pPr>
            <a:r>
              <a:rPr sz="2200">
                <a:latin typeface="Helvetica"/>
                <a:cs typeface="Helvetica"/>
              </a:rPr>
              <a:t>56yo with headache, </a:t>
            </a:r>
            <a:r>
              <a:rPr lang="en-US" sz="2200">
                <a:latin typeface="Helvetica"/>
                <a:cs typeface="Helvetica"/>
              </a:rPr>
              <a:t>tender to palpation </a:t>
            </a:r>
            <a:r>
              <a:rPr sz="2200">
                <a:latin typeface="Helvetica"/>
                <a:cs typeface="Helvetica"/>
              </a:rPr>
              <a:t>over temple.</a:t>
            </a:r>
          </a:p>
          <a:p>
            <a:pPr algn="ctr">
              <a:lnSpc>
                <a:spcPts val="2520"/>
              </a:lnSpc>
            </a:pPr>
            <a:r>
              <a:rPr sz="2200">
                <a:latin typeface="Helvetica"/>
                <a:cs typeface="Helvetica"/>
              </a:rPr>
              <a:t>Shoulder/hip stiff.</a:t>
            </a:r>
          </a:p>
          <a:p>
            <a:pPr algn="ctr">
              <a:lnSpc>
                <a:spcPts val="3080"/>
              </a:lnSpc>
            </a:pPr>
            <a:r>
              <a:rPr sz="2200">
                <a:latin typeface="Helvetica"/>
                <a:cs typeface="Helvetica"/>
              </a:rPr>
              <a:t>ESR high</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C310374A-C95F-8FA7-1741-7818A0F61962}"/>
              </a:ext>
            </a:extLst>
          </p:cNvPr>
          <p:cNvSpPr txBox="1"/>
          <p:nvPr/>
        </p:nvSpPr>
        <p:spPr>
          <a:xfrm>
            <a:off x="4114800" y="808074"/>
            <a:ext cx="3200400" cy="630622"/>
          </a:xfrm>
          <a:prstGeom prst="rect">
            <a:avLst/>
          </a:prstGeom>
          <a:ln w="6350">
            <a:noFill/>
          </a:ln>
        </p:spPr>
        <p:txBody>
          <a:bodyPr vert="horz" wrap="square" lIns="0" tIns="0" rIns="0" bIns="0" rtlCol="0" anchor="t">
            <a:spAutoFit/>
          </a:bodyPr>
          <a:lstStyle/>
          <a:p>
            <a:pPr marL="1003935" marR="90170" indent="-905510" algn="ctr">
              <a:lnSpc>
                <a:spcPts val="2400"/>
              </a:lnSpc>
            </a:pPr>
            <a:r>
              <a:rPr lang="en-US" sz="2800">
                <a:latin typeface="Helvetica"/>
                <a:cs typeface="Helvetica"/>
              </a:rPr>
              <a:t>Systemic lupus </a:t>
            </a:r>
            <a:endParaRPr lang="en-US">
              <a:latin typeface="Calibri"/>
              <a:cs typeface="Calibri"/>
            </a:endParaRPr>
          </a:p>
          <a:p>
            <a:pPr marL="1003935" marR="90170" indent="-905510" algn="ctr">
              <a:lnSpc>
                <a:spcPts val="2400"/>
              </a:lnSpc>
            </a:pPr>
            <a:r>
              <a:rPr lang="en-US" sz="2800" err="1">
                <a:latin typeface="Helvetica"/>
                <a:cs typeface="Helvetica"/>
              </a:rPr>
              <a:t>erythematosis</a:t>
            </a:r>
            <a:endParaRPr lang="en-US" err="1">
              <a:cs typeface="Calibri"/>
            </a:endParaRPr>
          </a:p>
        </p:txBody>
      </p:sp>
      <p:sp>
        <p:nvSpPr>
          <p:cNvPr id="32" name="object 5">
            <a:extLst>
              <a:ext uri="{FF2B5EF4-FFF2-40B4-BE49-F238E27FC236}">
                <a16:creationId xmlns:a16="http://schemas.microsoft.com/office/drawing/2014/main" id="{705354EF-C946-9AE5-F7FD-3B0692BA3684}"/>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1D2DF002-64DA-BD92-5C25-725D00954680}"/>
              </a:ext>
            </a:extLst>
          </p:cNvPr>
          <p:cNvSpPr txBox="1"/>
          <p:nvPr/>
        </p:nvSpPr>
        <p:spPr>
          <a:xfrm>
            <a:off x="4114800" y="3021241"/>
            <a:ext cx="3200400" cy="430887"/>
          </a:xfrm>
          <a:prstGeom prst="rect">
            <a:avLst/>
          </a:prstGeom>
          <a:ln w="6350">
            <a:noFill/>
          </a:ln>
        </p:spPr>
        <p:txBody>
          <a:bodyPr vert="horz" wrap="square" lIns="0" tIns="0" rIns="0" bIns="0" rtlCol="0" anchor="t">
            <a:spAutoFit/>
          </a:bodyPr>
          <a:lstStyle/>
          <a:p>
            <a:pPr marL="91440" marR="83820" indent="86360" algn="ctr"/>
            <a:r>
              <a:rPr lang="en-US" sz="2800">
                <a:latin typeface="Helvetica"/>
                <a:cs typeface="Helvetica"/>
              </a:rPr>
              <a:t>Pseudogout</a:t>
            </a:r>
          </a:p>
        </p:txBody>
      </p:sp>
      <p:sp>
        <p:nvSpPr>
          <p:cNvPr id="36" name="object 9">
            <a:extLst>
              <a:ext uri="{FF2B5EF4-FFF2-40B4-BE49-F238E27FC236}">
                <a16:creationId xmlns:a16="http://schemas.microsoft.com/office/drawing/2014/main" id="{F98D95BF-20A2-31BB-9EFA-A6AD47F1F11E}"/>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EEB7C775-8C4E-69D4-9A2F-202B5EB54AB4}"/>
              </a:ext>
            </a:extLst>
          </p:cNvPr>
          <p:cNvSpPr txBox="1"/>
          <p:nvPr/>
        </p:nvSpPr>
        <p:spPr>
          <a:xfrm>
            <a:off x="4114800" y="5390353"/>
            <a:ext cx="3200400" cy="855042"/>
          </a:xfrm>
          <a:prstGeom prst="rect">
            <a:avLst/>
          </a:prstGeom>
          <a:ln w="6350">
            <a:noFill/>
          </a:ln>
        </p:spPr>
        <p:txBody>
          <a:bodyPr vert="horz" wrap="square" lIns="0" tIns="0" rIns="0" bIns="0" rtlCol="0" anchor="t">
            <a:spAutoFit/>
          </a:bodyPr>
          <a:lstStyle/>
          <a:p>
            <a:pPr marL="120650" marR="113030" algn="ctr">
              <a:lnSpc>
                <a:spcPts val="3400"/>
              </a:lnSpc>
            </a:pPr>
            <a:r>
              <a:rPr lang="en-US" sz="2800">
                <a:latin typeface="Helvetica"/>
                <a:cs typeface="Helvetica"/>
              </a:rPr>
              <a:t>Baker's (popliteal) cyst</a:t>
            </a:r>
            <a:endParaRPr lang="en-US"/>
          </a:p>
        </p:txBody>
      </p:sp>
      <p:sp>
        <p:nvSpPr>
          <p:cNvPr id="40" name="object 14">
            <a:extLst>
              <a:ext uri="{FF2B5EF4-FFF2-40B4-BE49-F238E27FC236}">
                <a16:creationId xmlns:a16="http://schemas.microsoft.com/office/drawing/2014/main" id="{9DA17BE5-298A-F8CE-85F6-34B8F0F0035C}"/>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2CB0E34E-C157-2902-F3C1-91466398B4E8}"/>
              </a:ext>
            </a:extLst>
          </p:cNvPr>
          <p:cNvSpPr txBox="1"/>
          <p:nvPr/>
        </p:nvSpPr>
        <p:spPr>
          <a:xfrm>
            <a:off x="4013455" y="8008974"/>
            <a:ext cx="3200400" cy="430887"/>
          </a:xfrm>
          <a:prstGeom prst="rect">
            <a:avLst/>
          </a:prstGeom>
          <a:ln w="6350">
            <a:noFill/>
          </a:ln>
        </p:spPr>
        <p:txBody>
          <a:bodyPr vert="horz" wrap="square" lIns="0" tIns="0" rIns="0" bIns="0" rtlCol="0" anchor="t">
            <a:spAutoFit/>
          </a:bodyPr>
          <a:lstStyle/>
          <a:p>
            <a:pPr marL="236220" marR="229235" algn="ctr">
              <a:tabLst>
                <a:tab pos="1829435" algn="l"/>
              </a:tabLst>
            </a:pPr>
            <a:endParaRPr lang="en-US" sz="2800">
              <a:latin typeface="Helvetica"/>
              <a:cs typeface="Helvetica"/>
            </a:endParaRPr>
          </a:p>
        </p:txBody>
      </p:sp>
      <p:sp>
        <p:nvSpPr>
          <p:cNvPr id="44" name="object 19">
            <a:extLst>
              <a:ext uri="{FF2B5EF4-FFF2-40B4-BE49-F238E27FC236}">
                <a16:creationId xmlns:a16="http://schemas.microsoft.com/office/drawing/2014/main" id="{53AB0BA7-475E-30CC-633D-53868ED8D8EA}"/>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783E8D4E-C35D-E6F4-F532-BF6141F46A11}"/>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D2745AF4-C295-1562-8EFC-D3C86448D0BB}"/>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683515CA-76D3-25DA-F16F-B6E75F22989B}"/>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E72DF749-7D33-EDBC-7C7A-328ED2840A1E}"/>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511E5E50-2213-F0B2-F4F3-4B23D84C3403}"/>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F66F2C71-7B67-6DDA-72C6-1BDDF9878184}"/>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2DDA67FA-E71A-E2D8-3ED2-E756896DACEC}"/>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B7C74A9D-C13D-0D1A-4E9E-150B4A8ED31C}"/>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2060051"/>
          </a:xfrm>
          <a:prstGeom prst="rect">
            <a:avLst/>
          </a:prstGeom>
          <a:ln w="6350">
            <a:noFill/>
          </a:ln>
        </p:spPr>
        <p:txBody>
          <a:bodyPr vert="horz" wrap="square" lIns="0" tIns="0" rIns="0" bIns="0" rtlCol="0" anchor="t">
            <a:spAutoFit/>
          </a:bodyPr>
          <a:lstStyle/>
          <a:p>
            <a:pPr marL="156845" marR="150495" algn="ctr">
              <a:lnSpc>
                <a:spcPts val="2000"/>
              </a:lnSpc>
            </a:pPr>
            <a:r>
              <a:rPr lang="en-US" sz="2200">
                <a:latin typeface="Helvetica"/>
                <a:cs typeface="Helvetica"/>
              </a:rPr>
              <a:t>35yo with fatigue and symmetric </a:t>
            </a:r>
            <a:endParaRPr lang="en-US" sz="2200">
              <a:latin typeface="Helvetica"/>
              <a:cs typeface="Calibri"/>
            </a:endParaRPr>
          </a:p>
          <a:p>
            <a:pPr marL="156845" marR="150495" algn="ctr">
              <a:lnSpc>
                <a:spcPts val="2000"/>
              </a:lnSpc>
            </a:pPr>
            <a:r>
              <a:rPr lang="en-US" sz="2200" err="1">
                <a:latin typeface="Helvetica"/>
                <a:cs typeface="Helvetica"/>
              </a:rPr>
              <a:t>polyarthralgias</a:t>
            </a:r>
            <a:r>
              <a:rPr lang="en-US" sz="2200">
                <a:latin typeface="Helvetica"/>
                <a:cs typeface="Helvetica"/>
              </a:rPr>
              <a:t> of </a:t>
            </a:r>
            <a:endParaRPr lang="en-US" sz="2200">
              <a:latin typeface="Helvetica"/>
              <a:cs typeface="Calibri"/>
            </a:endParaRPr>
          </a:p>
          <a:p>
            <a:pPr marL="156845" marR="150495" algn="ctr">
              <a:lnSpc>
                <a:spcPts val="2000"/>
              </a:lnSpc>
            </a:pPr>
            <a:r>
              <a:rPr lang="en-US" sz="2200">
                <a:latin typeface="Helvetica"/>
                <a:cs typeface="Helvetica"/>
              </a:rPr>
              <a:t>MCP/PIP/wrist. Erythema of cheek/nose and upper chest. +anemia,</a:t>
            </a:r>
            <a:endParaRPr lang="en-US" sz="2200">
              <a:latin typeface="Helvetica"/>
              <a:cs typeface="Calibri"/>
            </a:endParaRPr>
          </a:p>
          <a:p>
            <a:pPr algn="ctr">
              <a:lnSpc>
                <a:spcPts val="2000"/>
              </a:lnSpc>
            </a:pPr>
            <a:r>
              <a:rPr lang="en-US" sz="2200">
                <a:latin typeface="Helvetica"/>
                <a:cs typeface="Helvetica"/>
              </a:rPr>
              <a:t>+blood/protein on UA</a:t>
            </a:r>
            <a:endParaRPr sz="2200">
              <a:cs typeface="Calibri"/>
            </a:endParaRP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390353"/>
            <a:ext cx="3200400" cy="1538883"/>
          </a:xfrm>
          <a:prstGeom prst="rect">
            <a:avLst/>
          </a:prstGeom>
          <a:ln w="6350">
            <a:noFill/>
          </a:ln>
        </p:spPr>
        <p:txBody>
          <a:bodyPr vert="horz" wrap="square" lIns="0" tIns="0" rIns="0" bIns="0" rtlCol="0" anchor="t">
            <a:spAutoFit/>
          </a:bodyPr>
          <a:lstStyle/>
          <a:p>
            <a:pPr marL="97790" marR="90170" algn="ctr">
              <a:lnSpc>
                <a:spcPts val="2400"/>
              </a:lnSpc>
            </a:pPr>
            <a:r>
              <a:rPr lang="en-US" sz="2200">
                <a:latin typeface="Helvetica"/>
                <a:cs typeface="Helvetica"/>
              </a:rPr>
              <a:t>39yo with several weeks of unilateral knee pain with flexion and stiffness. +swelling on posterior knee</a:t>
            </a:r>
            <a:endParaRPr lang="en-US"/>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333489"/>
          </a:xfrm>
          <a:prstGeom prst="rect">
            <a:avLst/>
          </a:prstGeom>
          <a:ln w="6350">
            <a:noFill/>
          </a:ln>
        </p:spPr>
        <p:txBody>
          <a:bodyPr vert="horz" wrap="square" lIns="0" tIns="0" rIns="0" bIns="0" rtlCol="0" anchor="t">
            <a:spAutoFit/>
          </a:bodyPr>
          <a:lstStyle/>
          <a:p>
            <a:pPr marL="381000" marR="373380" indent="-635" algn="ctr">
              <a:lnSpc>
                <a:spcPts val="2800"/>
              </a:lnSpc>
            </a:pPr>
            <a:endParaRPr lang="en-US" sz="2200">
              <a:latin typeface="Helvetica"/>
              <a:cs typeface="Helvetica"/>
            </a:endParaRP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29" name="object 16">
            <a:extLst>
              <a:ext uri="{FF2B5EF4-FFF2-40B4-BE49-F238E27FC236}">
                <a16:creationId xmlns:a16="http://schemas.microsoft.com/office/drawing/2014/main" id="{FA6936DC-BE50-1D99-BCC9-15CD03F3F9AF}"/>
              </a:ext>
            </a:extLst>
          </p:cNvPr>
          <p:cNvSpPr txBox="1"/>
          <p:nvPr/>
        </p:nvSpPr>
        <p:spPr>
          <a:xfrm>
            <a:off x="355964" y="2940787"/>
            <a:ext cx="3200400" cy="1777923"/>
          </a:xfrm>
          <a:prstGeom prst="rect">
            <a:avLst/>
          </a:prstGeom>
          <a:ln w="6350">
            <a:noFill/>
          </a:ln>
        </p:spPr>
        <p:txBody>
          <a:bodyPr vert="horz" wrap="square" lIns="0" tIns="0" rIns="0" bIns="0" rtlCol="0" anchor="t">
            <a:spAutoFit/>
          </a:bodyPr>
          <a:lstStyle/>
          <a:p>
            <a:pPr marL="381000" marR="373380" indent="-635" algn="ctr">
              <a:lnSpc>
                <a:spcPts val="2800"/>
              </a:lnSpc>
            </a:pPr>
            <a:r>
              <a:rPr lang="en-US" sz="2200">
                <a:latin typeface="Helvetica"/>
                <a:cs typeface="Helvetica"/>
              </a:rPr>
              <a:t>88yo with acutely hot, red knee after an illness. Xray shows chondrocalcinosis</a:t>
            </a:r>
          </a:p>
        </p:txBody>
      </p:sp>
      <p:sp>
        <p:nvSpPr>
          <p:cNvPr id="30" name="object 4">
            <a:extLst>
              <a:ext uri="{FF2B5EF4-FFF2-40B4-BE49-F238E27FC236}">
                <a16:creationId xmlns:a16="http://schemas.microsoft.com/office/drawing/2014/main" id="{C799CFB3-2F6C-B1B6-5738-371D5ECA1EBC}"/>
              </a:ext>
            </a:extLst>
          </p:cNvPr>
          <p:cNvSpPr txBox="1"/>
          <p:nvPr/>
        </p:nvSpPr>
        <p:spPr>
          <a:xfrm>
            <a:off x="4114800" y="808074"/>
            <a:ext cx="3200400" cy="620363"/>
          </a:xfrm>
          <a:prstGeom prst="rect">
            <a:avLst/>
          </a:prstGeom>
          <a:ln w="6350">
            <a:noFill/>
          </a:ln>
        </p:spPr>
        <p:txBody>
          <a:bodyPr vert="horz" wrap="square" lIns="0" tIns="0" rIns="0" bIns="0" rtlCol="0">
            <a:spAutoFit/>
          </a:bodyPr>
          <a:lstStyle/>
          <a:p>
            <a:pPr marL="1003935" marR="90170" indent="-906144" algn="ctr">
              <a:lnSpc>
                <a:spcPts val="2400"/>
              </a:lnSpc>
            </a:pPr>
            <a:r>
              <a:rPr sz="2800">
                <a:latin typeface="Helvetica"/>
                <a:cs typeface="Helvetica"/>
              </a:rPr>
              <a:t>Scleroderma/</a:t>
            </a:r>
            <a:endParaRPr lang="en-US" sz="2800">
              <a:latin typeface="Helvetica"/>
              <a:cs typeface="Helvetica"/>
            </a:endParaRPr>
          </a:p>
          <a:p>
            <a:pPr marL="1003935" marR="90170" indent="-906144" algn="ctr">
              <a:lnSpc>
                <a:spcPts val="2400"/>
              </a:lnSpc>
            </a:pPr>
            <a:r>
              <a:rPr sz="2800">
                <a:latin typeface="Helvetica"/>
                <a:cs typeface="Helvetica"/>
              </a:rPr>
              <a:t>systemic sclerosis</a:t>
            </a:r>
          </a:p>
        </p:txBody>
      </p:sp>
      <p:sp>
        <p:nvSpPr>
          <p:cNvPr id="32" name="object 5">
            <a:extLst>
              <a:ext uri="{FF2B5EF4-FFF2-40B4-BE49-F238E27FC236}">
                <a16:creationId xmlns:a16="http://schemas.microsoft.com/office/drawing/2014/main" id="{E3425DC7-64E4-1DBF-ACD6-19B412264484}"/>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33A52072-4077-4C21-E095-08B2C0245BE6}"/>
              </a:ext>
            </a:extLst>
          </p:cNvPr>
          <p:cNvSpPr txBox="1"/>
          <p:nvPr/>
        </p:nvSpPr>
        <p:spPr>
          <a:xfrm>
            <a:off x="4114800" y="3021241"/>
            <a:ext cx="3200400" cy="861774"/>
          </a:xfrm>
          <a:prstGeom prst="rect">
            <a:avLst/>
          </a:prstGeom>
          <a:ln w="6350">
            <a:noFill/>
          </a:ln>
        </p:spPr>
        <p:txBody>
          <a:bodyPr vert="horz" wrap="square" lIns="0" tIns="0" rIns="0" bIns="0" rtlCol="0">
            <a:spAutoFit/>
          </a:bodyPr>
          <a:lstStyle/>
          <a:p>
            <a:pPr marL="91440" marR="83820" indent="86360" algn="ctr"/>
            <a:r>
              <a:rPr sz="2800">
                <a:latin typeface="Helvetica"/>
                <a:cs typeface="Helvetica"/>
              </a:rPr>
              <a:t>Sjogren's syndrome</a:t>
            </a:r>
          </a:p>
        </p:txBody>
      </p:sp>
      <p:sp>
        <p:nvSpPr>
          <p:cNvPr id="36" name="object 9">
            <a:extLst>
              <a:ext uri="{FF2B5EF4-FFF2-40B4-BE49-F238E27FC236}">
                <a16:creationId xmlns:a16="http://schemas.microsoft.com/office/drawing/2014/main" id="{568C4038-8211-611C-7C60-8DA663760FD4}"/>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AFFBFD8F-AA0A-62D2-D492-18C93F018984}"/>
              </a:ext>
            </a:extLst>
          </p:cNvPr>
          <p:cNvSpPr txBox="1"/>
          <p:nvPr/>
        </p:nvSpPr>
        <p:spPr>
          <a:xfrm>
            <a:off x="4114800" y="5257800"/>
            <a:ext cx="3200400" cy="1280800"/>
          </a:xfrm>
          <a:prstGeom prst="rect">
            <a:avLst/>
          </a:prstGeom>
          <a:ln w="6350">
            <a:noFill/>
          </a:ln>
        </p:spPr>
        <p:txBody>
          <a:bodyPr vert="horz" wrap="square" lIns="0" tIns="0" rIns="0" bIns="0" rtlCol="0">
            <a:spAutoFit/>
          </a:bodyPr>
          <a:lstStyle/>
          <a:p>
            <a:pPr marL="120650" marR="113030" algn="ctr">
              <a:lnSpc>
                <a:spcPts val="3400"/>
              </a:lnSpc>
            </a:pPr>
            <a:r>
              <a:rPr sz="2800">
                <a:latin typeface="Helvetica"/>
                <a:cs typeface="Helvetica"/>
              </a:rPr>
              <a:t>Granulomatous polyangiitis (Wegeners)</a:t>
            </a:r>
          </a:p>
        </p:txBody>
      </p:sp>
      <p:sp>
        <p:nvSpPr>
          <p:cNvPr id="40" name="object 14">
            <a:extLst>
              <a:ext uri="{FF2B5EF4-FFF2-40B4-BE49-F238E27FC236}">
                <a16:creationId xmlns:a16="http://schemas.microsoft.com/office/drawing/2014/main" id="{3FC3FD05-51DA-8A27-C67A-BA0854B86BD5}"/>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4727776B-2DE4-E8EA-D2AD-B0423A80CC1A}"/>
              </a:ext>
            </a:extLst>
          </p:cNvPr>
          <p:cNvSpPr txBox="1"/>
          <p:nvPr/>
        </p:nvSpPr>
        <p:spPr>
          <a:xfrm>
            <a:off x="4114800" y="7658100"/>
            <a:ext cx="3200400" cy="1292662"/>
          </a:xfrm>
          <a:prstGeom prst="rect">
            <a:avLst/>
          </a:prstGeom>
          <a:ln w="6350">
            <a:noFill/>
          </a:ln>
        </p:spPr>
        <p:txBody>
          <a:bodyPr vert="horz" wrap="square" lIns="0" tIns="0" rIns="0" bIns="0" rtlCol="0">
            <a:spAutoFit/>
          </a:bodyPr>
          <a:lstStyle/>
          <a:p>
            <a:pPr marL="236854" marR="229235" algn="ctr">
              <a:tabLst>
                <a:tab pos="1829435" algn="l"/>
              </a:tabLst>
            </a:pPr>
            <a:r>
              <a:rPr sz="2800">
                <a:latin typeface="Helvetica"/>
                <a:cs typeface="Helvetica"/>
              </a:rPr>
              <a:t>Giant</a:t>
            </a:r>
            <a:r>
              <a:rPr lang="en-US" sz="2800">
                <a:latin typeface="Helvetica"/>
                <a:cs typeface="Helvetica"/>
              </a:rPr>
              <a:t> </a:t>
            </a:r>
            <a:r>
              <a:rPr sz="2800">
                <a:latin typeface="Helvetica"/>
                <a:cs typeface="Helvetica"/>
              </a:rPr>
              <a:t>cell (temporal)</a:t>
            </a:r>
            <a:r>
              <a:rPr lang="en-US" sz="2800">
                <a:latin typeface="Helvetica"/>
                <a:cs typeface="Helvetica"/>
              </a:rPr>
              <a:t> </a:t>
            </a:r>
            <a:r>
              <a:rPr sz="2800">
                <a:latin typeface="Helvetica"/>
                <a:cs typeface="Helvetica"/>
              </a:rPr>
              <a:t>arteritis</a:t>
            </a:r>
          </a:p>
        </p:txBody>
      </p:sp>
      <p:sp>
        <p:nvSpPr>
          <p:cNvPr id="44" name="object 19">
            <a:extLst>
              <a:ext uri="{FF2B5EF4-FFF2-40B4-BE49-F238E27FC236}">
                <a16:creationId xmlns:a16="http://schemas.microsoft.com/office/drawing/2014/main" id="{5B36EBDC-21F5-ECCE-541C-0FE1844E9EA1}"/>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99D630E1-7EBE-5616-3C6B-B5A7B9583F4B}"/>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B44C336D-DD7D-C5E3-98EA-DD166F977C43}"/>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9FEAC011-AF91-BC6F-9381-566F32062916}"/>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41B24A27-AFBE-2822-5607-B92F899B290B}"/>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CF61DA7E-1AB3-965C-FA38-99350976D50D}"/>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97B72527-68DF-2D6A-B1BE-863B05B8707B}"/>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91BA6D28-ADF5-69A6-D9AC-1BAEE5EB43A2}"/>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F84D1E66-FA00-3543-DDDB-0C2570E12968}"/>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extLst>
      <p:ext uri="{BB962C8B-B14F-4D97-AF65-F5344CB8AC3E}">
        <p14:creationId xmlns:p14="http://schemas.microsoft.com/office/powerpoint/2010/main" val="289082834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356633" y="457200"/>
            <a:ext cx="3300967" cy="2215991"/>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 (all players answer):</a:t>
            </a:r>
            <a:endParaRPr lang="en-US" sz="1600">
              <a:latin typeface="Helvetica"/>
              <a:cs typeface="Helvetica"/>
            </a:endParaRPr>
          </a:p>
          <a:p>
            <a:pPr marL="103505" marR="96520" algn="ctr"/>
            <a:r>
              <a:rPr lang="en-US" sz="1600">
                <a:latin typeface="Helvetica"/>
                <a:cs typeface="Helvetica"/>
              </a:rPr>
              <a:t>A 43 </a:t>
            </a:r>
            <a:r>
              <a:rPr lang="en-US" sz="1600" err="1">
                <a:latin typeface="Helvetica"/>
                <a:cs typeface="Helvetica"/>
              </a:rPr>
              <a:t>yo</a:t>
            </a:r>
            <a:r>
              <a:rPr lang="en-US" sz="1600">
                <a:latin typeface="Helvetica"/>
                <a:cs typeface="Helvetica"/>
              </a:rPr>
              <a:t> woman develops HR 124/min and Temp 102.4 F after she was given isoflurane. Exam showed muscular rigidity. What is the mechanism of action of the drug most appropriate for treatment?</a:t>
            </a:r>
            <a:endParaRPr lang="en-US" sz="1600">
              <a:cs typeface="Calibri"/>
            </a:endParaRP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355856" y="2857500"/>
            <a:ext cx="3403089" cy="2185214"/>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 (all players answer):</a:t>
            </a:r>
            <a:endParaRPr lang="en-US" sz="1600">
              <a:latin typeface="Helvetica"/>
              <a:cs typeface="Helvetica"/>
            </a:endParaRPr>
          </a:p>
          <a:p>
            <a:pPr marL="103505" marR="96520" algn="ctr"/>
            <a:r>
              <a:rPr lang="en-US" sz="1400">
                <a:latin typeface="Helvetica"/>
                <a:cs typeface="Calibri"/>
              </a:rPr>
              <a:t>24yo woman with 1y history of worsening hand and knee pain, facial rash and oral ulcers. PE shows an erythematous malar rash. Lab shows positive ANA, normocytic anemia and leukopenia. Urinalysis and creatinine are normal. What is the mechanism of action of the drug most appropriate for treatment?</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356633" y="5257800"/>
            <a:ext cx="3300967" cy="2215991"/>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 (all players answer):</a:t>
            </a:r>
            <a:endParaRPr lang="en-US" sz="1600">
              <a:latin typeface="Helvetica"/>
              <a:cs typeface="Helvetica"/>
            </a:endParaRPr>
          </a:p>
          <a:p>
            <a:pPr marL="103505" marR="96520" algn="ctr"/>
            <a:r>
              <a:rPr lang="en-US" sz="1600">
                <a:latin typeface="Helvetica"/>
                <a:cs typeface="Helvetica"/>
              </a:rPr>
              <a:t>A 73yo M presents with muscle pain when raising arms overhead and rising from seated position. Normal vitals, strength, ROM. ESR is elevated. What is the mechanism of action for the drug this man should be prescribed?</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2339102"/>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2000">
                <a:latin typeface="Helvetica"/>
                <a:cs typeface="Helvetica"/>
              </a:rPr>
              <a:t>Adult with weakness, muscle pain after "found down," Urine +blood/-RBC, CK high. What treatment is most appropriate?</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24" name="object 4">
            <a:extLst>
              <a:ext uri="{FF2B5EF4-FFF2-40B4-BE49-F238E27FC236}">
                <a16:creationId xmlns:a16="http://schemas.microsoft.com/office/drawing/2014/main" id="{AF4BEF62-03C8-6DF2-D485-FC4F04AAB975}"/>
              </a:ext>
            </a:extLst>
          </p:cNvPr>
          <p:cNvSpPr txBox="1"/>
          <p:nvPr/>
        </p:nvSpPr>
        <p:spPr>
          <a:xfrm>
            <a:off x="4114800" y="581955"/>
            <a:ext cx="3200400" cy="1261884"/>
          </a:xfrm>
          <a:prstGeom prst="rect">
            <a:avLst/>
          </a:prstGeom>
          <a:ln w="6350">
            <a:noFill/>
          </a:ln>
        </p:spPr>
        <p:txBody>
          <a:bodyPr vert="horz" wrap="square" lIns="0" tIns="0" rIns="0" bIns="0" rtlCol="0" anchor="t">
            <a:spAutoFit/>
          </a:bodyPr>
          <a:lstStyle/>
          <a:p>
            <a:pPr algn="ctr"/>
            <a:r>
              <a:rPr lang="en-US" sz="2200">
                <a:latin typeface="Helvetica"/>
                <a:cs typeface="Helvetica"/>
              </a:rPr>
              <a:t> </a:t>
            </a:r>
            <a:r>
              <a:rPr lang="en-US" sz="1600">
                <a:latin typeface="Helvetica"/>
                <a:cs typeface="Helvetica"/>
              </a:rPr>
              <a:t>Inhibits </a:t>
            </a:r>
            <a:r>
              <a:rPr lang="en-US" sz="1600" err="1">
                <a:latin typeface="Helvetica"/>
                <a:cs typeface="Helvetica"/>
              </a:rPr>
              <a:t>transglycosylases</a:t>
            </a:r>
            <a:r>
              <a:rPr lang="en-US" sz="1600">
                <a:latin typeface="Helvetica"/>
                <a:cs typeface="Helvetica"/>
              </a:rPr>
              <a:t> activity and peptidoglycan crosslinking</a:t>
            </a:r>
          </a:p>
          <a:p>
            <a:pPr algn="ctr"/>
            <a:r>
              <a:rPr lang="en-US" sz="1600">
                <a:latin typeface="Helvetica"/>
                <a:cs typeface="Helvetica"/>
              </a:rPr>
              <a:t>(Vancomycin)</a:t>
            </a:r>
          </a:p>
          <a:p>
            <a:pPr marL="86995" algn="ctr"/>
            <a:endParaRPr lang="en-US" sz="2800">
              <a:latin typeface="Helvetica"/>
              <a:cs typeface="Helvetica"/>
            </a:endParaRPr>
          </a:p>
        </p:txBody>
      </p:sp>
      <p:sp>
        <p:nvSpPr>
          <p:cNvPr id="28" name="object 5">
            <a:extLst>
              <a:ext uri="{FF2B5EF4-FFF2-40B4-BE49-F238E27FC236}">
                <a16:creationId xmlns:a16="http://schemas.microsoft.com/office/drawing/2014/main" id="{6C832B80-7AAA-29A4-22F1-A9D62E314F4B}"/>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0" name="object 8">
            <a:extLst>
              <a:ext uri="{FF2B5EF4-FFF2-40B4-BE49-F238E27FC236}">
                <a16:creationId xmlns:a16="http://schemas.microsoft.com/office/drawing/2014/main" id="{ABFB7B87-DC3D-3441-FB3B-94BD5BF14EB6}"/>
              </a:ext>
            </a:extLst>
          </p:cNvPr>
          <p:cNvSpPr txBox="1"/>
          <p:nvPr/>
        </p:nvSpPr>
        <p:spPr>
          <a:xfrm>
            <a:off x="4114800" y="3013444"/>
            <a:ext cx="3200400" cy="1292662"/>
          </a:xfrm>
          <a:prstGeom prst="rect">
            <a:avLst/>
          </a:prstGeom>
          <a:ln w="6350">
            <a:noFill/>
          </a:ln>
        </p:spPr>
        <p:txBody>
          <a:bodyPr vert="horz" wrap="square" lIns="0" tIns="0" rIns="0" bIns="0" rtlCol="0" anchor="t">
            <a:spAutoFit/>
          </a:bodyPr>
          <a:lstStyle/>
          <a:p>
            <a:pPr algn="ctr"/>
            <a:r>
              <a:rPr lang="en-US" sz="2800">
                <a:latin typeface="Helvetica"/>
                <a:cs typeface="Calibri"/>
              </a:rPr>
              <a:t> NSAIDs, Colchicine</a:t>
            </a:r>
          </a:p>
          <a:p>
            <a:pPr marL="74930"/>
            <a:endParaRPr lang="en-US" sz="2800">
              <a:latin typeface="Helvetica"/>
              <a:cs typeface="Helvetica"/>
            </a:endParaRPr>
          </a:p>
        </p:txBody>
      </p:sp>
      <p:sp>
        <p:nvSpPr>
          <p:cNvPr id="32" name="object 9">
            <a:extLst>
              <a:ext uri="{FF2B5EF4-FFF2-40B4-BE49-F238E27FC236}">
                <a16:creationId xmlns:a16="http://schemas.microsoft.com/office/drawing/2014/main" id="{94DB5B2E-633F-9153-45B8-7B578239E64C}"/>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13">
            <a:extLst>
              <a:ext uri="{FF2B5EF4-FFF2-40B4-BE49-F238E27FC236}">
                <a16:creationId xmlns:a16="http://schemas.microsoft.com/office/drawing/2014/main" id="{D466F9D0-69B4-0F48-BC34-166BB64FDBBA}"/>
              </a:ext>
            </a:extLst>
          </p:cNvPr>
          <p:cNvSpPr txBox="1"/>
          <p:nvPr/>
        </p:nvSpPr>
        <p:spPr>
          <a:xfrm>
            <a:off x="4114800" y="5452730"/>
            <a:ext cx="3200400" cy="1395575"/>
          </a:xfrm>
          <a:prstGeom prst="rect">
            <a:avLst/>
          </a:prstGeom>
          <a:ln w="6350">
            <a:noFill/>
          </a:ln>
        </p:spPr>
        <p:txBody>
          <a:bodyPr vert="horz" wrap="square" lIns="0" tIns="0" rIns="0" bIns="0" rtlCol="0" anchor="t">
            <a:spAutoFit/>
          </a:bodyPr>
          <a:lstStyle/>
          <a:p>
            <a:pPr algn="ctr"/>
            <a:r>
              <a:rPr lang="en-US" sz="2800">
                <a:latin typeface="Helvetica"/>
                <a:cs typeface="Calibri"/>
              </a:rPr>
              <a:t> Xanthine Oxidase inhibitor</a:t>
            </a:r>
          </a:p>
          <a:p>
            <a:pPr marL="286385" marR="278765" algn="ctr">
              <a:lnSpc>
                <a:spcPts val="4700"/>
              </a:lnSpc>
            </a:pPr>
            <a:endParaRPr sz="2800">
              <a:latin typeface="Helvetica"/>
              <a:cs typeface="Helvetica"/>
            </a:endParaRPr>
          </a:p>
        </p:txBody>
      </p:sp>
      <p:sp>
        <p:nvSpPr>
          <p:cNvPr id="36" name="object 14">
            <a:extLst>
              <a:ext uri="{FF2B5EF4-FFF2-40B4-BE49-F238E27FC236}">
                <a16:creationId xmlns:a16="http://schemas.microsoft.com/office/drawing/2014/main" id="{E1B7C193-014B-A6F6-6ADE-36C1462EBFD9}"/>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8">
            <a:extLst>
              <a:ext uri="{FF2B5EF4-FFF2-40B4-BE49-F238E27FC236}">
                <a16:creationId xmlns:a16="http://schemas.microsoft.com/office/drawing/2014/main" id="{8DB4B07F-53F5-1B41-93A8-FEABEA6FC8C6}"/>
              </a:ext>
            </a:extLst>
          </p:cNvPr>
          <p:cNvSpPr txBox="1"/>
          <p:nvPr/>
        </p:nvSpPr>
        <p:spPr>
          <a:xfrm>
            <a:off x="4114800" y="7655190"/>
            <a:ext cx="3200400" cy="830997"/>
          </a:xfrm>
          <a:prstGeom prst="rect">
            <a:avLst/>
          </a:prstGeom>
          <a:ln w="6350">
            <a:noFill/>
          </a:ln>
        </p:spPr>
        <p:txBody>
          <a:bodyPr vert="horz" wrap="square" lIns="0" tIns="0" rIns="0" bIns="0" rtlCol="0" anchor="t">
            <a:spAutoFit/>
          </a:bodyPr>
          <a:lstStyle/>
          <a:p>
            <a:pPr marL="139700" algn="ctr"/>
            <a:r>
              <a:rPr lang="en-US">
                <a:latin typeface="Helvetica"/>
                <a:cs typeface="Calibri"/>
              </a:rPr>
              <a:t>Monoclonal antibody that binds RANK Ligand, Inhibiting osteoclasts (Denosumab)</a:t>
            </a:r>
          </a:p>
        </p:txBody>
      </p:sp>
      <p:sp>
        <p:nvSpPr>
          <p:cNvPr id="40" name="object 19">
            <a:extLst>
              <a:ext uri="{FF2B5EF4-FFF2-40B4-BE49-F238E27FC236}">
                <a16:creationId xmlns:a16="http://schemas.microsoft.com/office/drawing/2014/main" id="{4FDF6408-CFE3-81B3-29DC-2AF2B38CDF89}"/>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TextBox 41">
            <a:extLst>
              <a:ext uri="{FF2B5EF4-FFF2-40B4-BE49-F238E27FC236}">
                <a16:creationId xmlns:a16="http://schemas.microsoft.com/office/drawing/2014/main" id="{F219A61A-CAF0-A53C-B611-653273463E49}"/>
              </a:ext>
            </a:extLst>
          </p:cNvPr>
          <p:cNvSpPr txBox="1"/>
          <p:nvPr/>
        </p:nvSpPr>
        <p:spPr>
          <a:xfrm>
            <a:off x="4110420" y="4122059"/>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4" name="TextBox 43">
            <a:extLst>
              <a:ext uri="{FF2B5EF4-FFF2-40B4-BE49-F238E27FC236}">
                <a16:creationId xmlns:a16="http://schemas.microsoft.com/office/drawing/2014/main" id="{D7A1EAB8-87FF-E071-8F40-ACE5E994079E}"/>
              </a:ext>
            </a:extLst>
          </p:cNvPr>
          <p:cNvSpPr txBox="1"/>
          <p:nvPr/>
        </p:nvSpPr>
        <p:spPr>
          <a:xfrm>
            <a:off x="4048829" y="1619154"/>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6" name="TextBox 45">
            <a:extLst>
              <a:ext uri="{FF2B5EF4-FFF2-40B4-BE49-F238E27FC236}">
                <a16:creationId xmlns:a16="http://schemas.microsoft.com/office/drawing/2014/main" id="{9FCECA0F-2DEC-7680-D202-73247325D851}"/>
              </a:ext>
            </a:extLst>
          </p:cNvPr>
          <p:cNvSpPr txBox="1"/>
          <p:nvPr/>
        </p:nvSpPr>
        <p:spPr>
          <a:xfrm>
            <a:off x="4080037" y="6445627"/>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8" name="TextBox 47">
            <a:extLst>
              <a:ext uri="{FF2B5EF4-FFF2-40B4-BE49-F238E27FC236}">
                <a16:creationId xmlns:a16="http://schemas.microsoft.com/office/drawing/2014/main" id="{917A870A-910F-4EDB-C5E9-F7E965476DCE}"/>
              </a:ext>
            </a:extLst>
          </p:cNvPr>
          <p:cNvSpPr txBox="1"/>
          <p:nvPr/>
        </p:nvSpPr>
        <p:spPr>
          <a:xfrm>
            <a:off x="4111220" y="8831573"/>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2215991"/>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1400">
                <a:latin typeface="Helvetica"/>
                <a:cs typeface="Calibri"/>
              </a:rPr>
              <a:t> A 64 </a:t>
            </a:r>
            <a:r>
              <a:rPr lang="en-US" sz="1400" err="1">
                <a:latin typeface="Helvetica"/>
                <a:cs typeface="Calibri"/>
              </a:rPr>
              <a:t>yo</a:t>
            </a:r>
            <a:r>
              <a:rPr lang="en-US" sz="1400">
                <a:latin typeface="Helvetica"/>
                <a:cs typeface="Calibri"/>
              </a:rPr>
              <a:t> man with history of diabetes mellitus presents with a red, hot, swollen knee for a duration for one day. +fever/chills. Synovial Fluid shows 140,000 WBC/mm3 mostly PMNs. Gram stain found a gram-positive organism in clusters. What is the MOA of medication to treat?</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355856" y="2857500"/>
            <a:ext cx="3403089" cy="1969770"/>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1600">
                <a:latin typeface="Helvetica"/>
                <a:cs typeface="Calibri"/>
              </a:rPr>
              <a:t>A</a:t>
            </a:r>
            <a:r>
              <a:rPr lang="en-US" sz="1600" u="sng">
                <a:solidFill>
                  <a:srgbClr val="0078D4"/>
                </a:solidFill>
                <a:latin typeface="Helvetica"/>
                <a:cs typeface="Calibri"/>
              </a:rPr>
              <a:t> </a:t>
            </a:r>
            <a:r>
              <a:rPr lang="en-US" sz="1600">
                <a:latin typeface="Helvetica"/>
                <a:cs typeface="Calibri"/>
              </a:rPr>
              <a:t>50yo man with acute onset of exquisitely painful red 1</a:t>
            </a:r>
            <a:r>
              <a:rPr lang="en-US" sz="1600" baseline="30000">
                <a:latin typeface="Helvetica"/>
                <a:cs typeface="Calibri"/>
              </a:rPr>
              <a:t>st</a:t>
            </a:r>
            <a:r>
              <a:rPr lang="en-US" sz="1600">
                <a:latin typeface="Helvetica"/>
                <a:cs typeface="Calibri"/>
              </a:rPr>
              <a:t> MTP joint. Exam shows erythema, warmth, tenderness to palpation. Joint tap showed strong negative birefringence. What treatment is most appropriate?</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2031325"/>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2000">
                <a:latin typeface="Helvetica"/>
                <a:cs typeface="Calibri"/>
              </a:rPr>
              <a:t>Adult presents with recurrent painful red 1</a:t>
            </a:r>
            <a:r>
              <a:rPr lang="en-US" sz="2000" baseline="30000">
                <a:latin typeface="Helvetica"/>
                <a:cs typeface="Calibri"/>
              </a:rPr>
              <a:t>st</a:t>
            </a:r>
            <a:r>
              <a:rPr lang="en-US" sz="2000">
                <a:latin typeface="Helvetica"/>
                <a:cs typeface="Calibri"/>
              </a:rPr>
              <a:t> MTP joint. What is the MOA of the medications to prevent these episodes?</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2215991"/>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1400">
                <a:latin typeface="Helvetica"/>
                <a:cs typeface="Calibri"/>
              </a:rPr>
              <a:t>A 75 </a:t>
            </a:r>
            <a:r>
              <a:rPr lang="en-US" sz="1400" err="1">
                <a:latin typeface="Helvetica"/>
                <a:cs typeface="Calibri"/>
              </a:rPr>
              <a:t>yo</a:t>
            </a:r>
            <a:r>
              <a:rPr lang="en-US" sz="1400">
                <a:latin typeface="Helvetica"/>
                <a:cs typeface="Calibri"/>
              </a:rPr>
              <a:t> woman presents 2 months after right femoral fracture neck fracture. Routine lab work shows reduced renal function. DXA scan shows a total hip T-score of –2.8 and a lumbar spine T-score of 3.0. What is the MOA of the medication you should prescribe for this patient?</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22" name="object 4">
            <a:extLst>
              <a:ext uri="{FF2B5EF4-FFF2-40B4-BE49-F238E27FC236}">
                <a16:creationId xmlns:a16="http://schemas.microsoft.com/office/drawing/2014/main" id="{EA8A2DF6-B259-F336-789B-AB697ED4BEB3}"/>
              </a:ext>
            </a:extLst>
          </p:cNvPr>
          <p:cNvSpPr txBox="1"/>
          <p:nvPr/>
        </p:nvSpPr>
        <p:spPr>
          <a:xfrm>
            <a:off x="4114800" y="581955"/>
            <a:ext cx="3200400" cy="923330"/>
          </a:xfrm>
          <a:prstGeom prst="rect">
            <a:avLst/>
          </a:prstGeom>
          <a:ln w="6350">
            <a:noFill/>
          </a:ln>
        </p:spPr>
        <p:txBody>
          <a:bodyPr vert="horz" wrap="square" lIns="0" tIns="0" rIns="0" bIns="0" rtlCol="0" anchor="t">
            <a:spAutoFit/>
          </a:bodyPr>
          <a:lstStyle/>
          <a:p>
            <a:pPr marL="86995" algn="ctr"/>
            <a:r>
              <a:rPr lang="en-US" sz="2000">
                <a:latin typeface="Helvetica"/>
                <a:cs typeface="Helvetica"/>
              </a:rPr>
              <a:t>Binds to ryanodine receptors blocking calcium release (Dantrolene) </a:t>
            </a:r>
            <a:endParaRPr lang="en-US" sz="2000"/>
          </a:p>
        </p:txBody>
      </p:sp>
      <p:sp>
        <p:nvSpPr>
          <p:cNvPr id="25" name="object 5">
            <a:extLst>
              <a:ext uri="{FF2B5EF4-FFF2-40B4-BE49-F238E27FC236}">
                <a16:creationId xmlns:a16="http://schemas.microsoft.com/office/drawing/2014/main" id="{526C9A2D-C86B-6FE6-1450-0BC8C4CF6A32}"/>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8" name="object 8">
            <a:extLst>
              <a:ext uri="{FF2B5EF4-FFF2-40B4-BE49-F238E27FC236}">
                <a16:creationId xmlns:a16="http://schemas.microsoft.com/office/drawing/2014/main" id="{4BE7FD6F-6F2D-FFF2-35B8-A5F84F13AE7B}"/>
              </a:ext>
            </a:extLst>
          </p:cNvPr>
          <p:cNvSpPr txBox="1"/>
          <p:nvPr/>
        </p:nvSpPr>
        <p:spPr>
          <a:xfrm>
            <a:off x="4114800" y="2966661"/>
            <a:ext cx="3200400" cy="1538883"/>
          </a:xfrm>
          <a:prstGeom prst="rect">
            <a:avLst/>
          </a:prstGeom>
          <a:ln w="6350">
            <a:noFill/>
          </a:ln>
        </p:spPr>
        <p:txBody>
          <a:bodyPr vert="horz" wrap="square" lIns="0" tIns="0" rIns="0" bIns="0" rtlCol="0" anchor="t">
            <a:spAutoFit/>
          </a:bodyPr>
          <a:lstStyle/>
          <a:p>
            <a:pPr algn="ctr"/>
            <a:r>
              <a:rPr lang="en-US">
                <a:latin typeface="Helvetica"/>
                <a:cs typeface="Helvetica"/>
              </a:rPr>
              <a:t>Block stimulation of the B-cell antigen receptors through inhibition of toll-like receptors</a:t>
            </a:r>
            <a:endParaRPr lang="en-US">
              <a:latin typeface="Helvetica"/>
              <a:cs typeface="Calibri"/>
            </a:endParaRPr>
          </a:p>
          <a:p>
            <a:pPr algn="ctr"/>
            <a:r>
              <a:rPr lang="en-US">
                <a:latin typeface="Helvetica"/>
                <a:cs typeface="Helvetica"/>
              </a:rPr>
              <a:t>(Hydroxychloroquine)</a:t>
            </a:r>
          </a:p>
          <a:p>
            <a:pPr marL="74930"/>
            <a:endParaRPr lang="en-US" sz="2800">
              <a:latin typeface="Helvetica"/>
              <a:cs typeface="Helvetica"/>
            </a:endParaRPr>
          </a:p>
        </p:txBody>
      </p:sp>
      <p:sp>
        <p:nvSpPr>
          <p:cNvPr id="31" name="object 9">
            <a:extLst>
              <a:ext uri="{FF2B5EF4-FFF2-40B4-BE49-F238E27FC236}">
                <a16:creationId xmlns:a16="http://schemas.microsoft.com/office/drawing/2014/main" id="{B57A427B-7357-4DD7-64CA-C1E57CB197F4}"/>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13">
            <a:extLst>
              <a:ext uri="{FF2B5EF4-FFF2-40B4-BE49-F238E27FC236}">
                <a16:creationId xmlns:a16="http://schemas.microsoft.com/office/drawing/2014/main" id="{C7AD297C-288A-43B3-CB4A-0CAFF37DCA59}"/>
              </a:ext>
            </a:extLst>
          </p:cNvPr>
          <p:cNvSpPr txBox="1"/>
          <p:nvPr/>
        </p:nvSpPr>
        <p:spPr>
          <a:xfrm>
            <a:off x="4114800" y="5327975"/>
            <a:ext cx="3200400" cy="1641796"/>
          </a:xfrm>
          <a:prstGeom prst="rect">
            <a:avLst/>
          </a:prstGeom>
          <a:ln w="6350">
            <a:noFill/>
          </a:ln>
        </p:spPr>
        <p:txBody>
          <a:bodyPr vert="horz" wrap="square" lIns="0" tIns="0" rIns="0" bIns="0" rtlCol="0" anchor="t">
            <a:spAutoFit/>
          </a:bodyPr>
          <a:lstStyle/>
          <a:p>
            <a:pPr algn="ctr"/>
            <a:r>
              <a:rPr lang="en-US">
                <a:latin typeface="Helvetica"/>
                <a:cs typeface="Helvetica"/>
              </a:rPr>
              <a:t>Glucocorticoid receptor agonist to inhibit the inflammatory response  </a:t>
            </a:r>
          </a:p>
          <a:p>
            <a:pPr algn="ctr"/>
            <a:r>
              <a:rPr lang="en-US">
                <a:latin typeface="Helvetica"/>
                <a:cs typeface="Helvetica"/>
              </a:rPr>
              <a:t>(Low dose Glucocorticoids)</a:t>
            </a:r>
          </a:p>
          <a:p>
            <a:pPr marL="286385" marR="278765" algn="ctr">
              <a:lnSpc>
                <a:spcPts val="4700"/>
              </a:lnSpc>
            </a:pPr>
            <a:endParaRPr sz="2800">
              <a:latin typeface="Helvetica"/>
              <a:cs typeface="Helvetica"/>
            </a:endParaRPr>
          </a:p>
        </p:txBody>
      </p:sp>
      <p:sp>
        <p:nvSpPr>
          <p:cNvPr id="36" name="object 14">
            <a:extLst>
              <a:ext uri="{FF2B5EF4-FFF2-40B4-BE49-F238E27FC236}">
                <a16:creationId xmlns:a16="http://schemas.microsoft.com/office/drawing/2014/main" id="{07718A0E-677B-4135-C7B0-0965468A46C2}"/>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8">
            <a:extLst>
              <a:ext uri="{FF2B5EF4-FFF2-40B4-BE49-F238E27FC236}">
                <a16:creationId xmlns:a16="http://schemas.microsoft.com/office/drawing/2014/main" id="{D6AD9A39-9B61-11BD-01E5-CF5F369B0935}"/>
              </a:ext>
            </a:extLst>
          </p:cNvPr>
          <p:cNvSpPr txBox="1"/>
          <p:nvPr/>
        </p:nvSpPr>
        <p:spPr>
          <a:xfrm>
            <a:off x="4114800" y="7920296"/>
            <a:ext cx="3200400" cy="430887"/>
          </a:xfrm>
          <a:prstGeom prst="rect">
            <a:avLst/>
          </a:prstGeom>
          <a:ln w="6350">
            <a:noFill/>
          </a:ln>
        </p:spPr>
        <p:txBody>
          <a:bodyPr vert="horz" wrap="square" lIns="0" tIns="0" rIns="0" bIns="0" rtlCol="0" anchor="t">
            <a:spAutoFit/>
          </a:bodyPr>
          <a:lstStyle/>
          <a:p>
            <a:pPr marL="139700" algn="ctr"/>
            <a:r>
              <a:rPr lang="en-US" sz="2800">
                <a:latin typeface="Helvetica"/>
                <a:cs typeface="Helvetica"/>
              </a:rPr>
              <a:t>IV Fluids</a:t>
            </a:r>
          </a:p>
        </p:txBody>
      </p:sp>
      <p:sp>
        <p:nvSpPr>
          <p:cNvPr id="40" name="object 19">
            <a:extLst>
              <a:ext uri="{FF2B5EF4-FFF2-40B4-BE49-F238E27FC236}">
                <a16:creationId xmlns:a16="http://schemas.microsoft.com/office/drawing/2014/main" id="{1B7DE750-D2EB-C1EE-F829-5F4CA261A557}"/>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TextBox 41">
            <a:extLst>
              <a:ext uri="{FF2B5EF4-FFF2-40B4-BE49-F238E27FC236}">
                <a16:creationId xmlns:a16="http://schemas.microsoft.com/office/drawing/2014/main" id="{1F74B639-0330-3065-2E0D-E87912F06E39}"/>
              </a:ext>
            </a:extLst>
          </p:cNvPr>
          <p:cNvSpPr txBox="1"/>
          <p:nvPr/>
        </p:nvSpPr>
        <p:spPr>
          <a:xfrm>
            <a:off x="4110420" y="4122059"/>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4" name="TextBox 43">
            <a:extLst>
              <a:ext uri="{FF2B5EF4-FFF2-40B4-BE49-F238E27FC236}">
                <a16:creationId xmlns:a16="http://schemas.microsoft.com/office/drawing/2014/main" id="{7EC579EE-2351-41BB-4C9C-5F2A86022ABB}"/>
              </a:ext>
            </a:extLst>
          </p:cNvPr>
          <p:cNvSpPr txBox="1"/>
          <p:nvPr/>
        </p:nvSpPr>
        <p:spPr>
          <a:xfrm>
            <a:off x="4048829" y="1619154"/>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6" name="TextBox 45">
            <a:extLst>
              <a:ext uri="{FF2B5EF4-FFF2-40B4-BE49-F238E27FC236}">
                <a16:creationId xmlns:a16="http://schemas.microsoft.com/office/drawing/2014/main" id="{242663B2-380E-267E-9907-8AF2E0D17CB3}"/>
              </a:ext>
            </a:extLst>
          </p:cNvPr>
          <p:cNvSpPr txBox="1"/>
          <p:nvPr/>
        </p:nvSpPr>
        <p:spPr>
          <a:xfrm>
            <a:off x="4080037" y="6445627"/>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
        <p:nvSpPr>
          <p:cNvPr id="48" name="TextBox 47">
            <a:extLst>
              <a:ext uri="{FF2B5EF4-FFF2-40B4-BE49-F238E27FC236}">
                <a16:creationId xmlns:a16="http://schemas.microsoft.com/office/drawing/2014/main" id="{8AF1EC26-B53D-6E91-DB43-63E4AB8ACB07}"/>
              </a:ext>
            </a:extLst>
          </p:cNvPr>
          <p:cNvSpPr txBox="1"/>
          <p:nvPr/>
        </p:nvSpPr>
        <p:spPr>
          <a:xfrm>
            <a:off x="4111220" y="8831573"/>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Tree>
    <p:extLst>
      <p:ext uri="{BB962C8B-B14F-4D97-AF65-F5344CB8AC3E}">
        <p14:creationId xmlns:p14="http://schemas.microsoft.com/office/powerpoint/2010/main" val="768398678"/>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2215991"/>
          </a:xfrm>
          <a:prstGeom prst="rect">
            <a:avLst/>
          </a:prstGeom>
          <a:ln w="6350">
            <a:noFill/>
          </a:ln>
        </p:spPr>
        <p:txBody>
          <a:bodyPr vert="horz" wrap="square" lIns="0" tIns="0" rIns="0" bIns="0" rtlCol="0" anchor="t">
            <a:spAutoFit/>
          </a:bodyPr>
          <a:lstStyle/>
          <a:p>
            <a:pPr marL="103505" marR="96520" algn="ctr"/>
            <a:r>
              <a:rPr lang="en-US" sz="1600" b="1">
                <a:latin typeface="Helvetica"/>
                <a:cs typeface="Helvetica"/>
              </a:rPr>
              <a:t>Curse Card(all players answer):</a:t>
            </a:r>
            <a:endParaRPr lang="en-US" sz="1600">
              <a:latin typeface="Helvetica"/>
              <a:cs typeface="Helvetica"/>
            </a:endParaRPr>
          </a:p>
          <a:p>
            <a:pPr marL="103505" marR="96520" algn="ctr"/>
            <a:r>
              <a:rPr lang="en-US" sz="1400">
                <a:latin typeface="Helvetica"/>
                <a:cs typeface="Calibri"/>
              </a:rPr>
              <a:t>A 28 </a:t>
            </a:r>
            <a:r>
              <a:rPr lang="en-US" sz="1400" err="1">
                <a:latin typeface="Helvetica"/>
                <a:cs typeface="Calibri"/>
              </a:rPr>
              <a:t>yo</a:t>
            </a:r>
            <a:r>
              <a:rPr lang="en-US" sz="1400">
                <a:latin typeface="Helvetica"/>
                <a:cs typeface="Calibri"/>
              </a:rPr>
              <a:t> woman presents with bilateral pain and swelling in the PIPs, MCPs, and ankles. She reports morning stiffness lasting 1.5 hours. On physical exam she has decreased hand grip strength and bogginess of the affected joints. +CCP . What is the MOA of the drug used for treatment?</a:t>
            </a:r>
            <a:endParaRPr lang="en-US" sz="1400">
              <a:solidFill>
                <a:srgbClr val="0078D4"/>
              </a:solidFill>
              <a:latin typeface="Helvetica"/>
              <a:cs typeface="Calibri"/>
            </a:endParaRP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943100"/>
          </a:xfrm>
          <a:prstGeom prst="rect">
            <a:avLst/>
          </a:prstGeom>
          <a:ln w="6350">
            <a:noFill/>
          </a:ln>
        </p:spPr>
        <p:txBody>
          <a:bodyPr vert="horz" wrap="square" lIns="0" tIns="0" rIns="0" bIns="0" rtlCol="0">
            <a:spAutoFit/>
          </a:bodyPr>
          <a:lstStyle/>
          <a:p>
            <a:pPr marL="92075" marR="84455" indent="-635" algn="ctr">
              <a:lnSpc>
                <a:spcPts val="2600"/>
              </a:lnSpc>
            </a:pPr>
            <a:r>
              <a:rPr sz="2600">
                <a:latin typeface="Helvetica"/>
                <a:cs typeface="Helvetica"/>
              </a:rPr>
              <a:t>Joint Venture - save this card and use it when you want your entire team to help answer. Draw again.</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943100"/>
          </a:xfrm>
          <a:prstGeom prst="rect">
            <a:avLst/>
          </a:prstGeom>
          <a:ln w="6350">
            <a:noFill/>
          </a:ln>
        </p:spPr>
        <p:txBody>
          <a:bodyPr vert="horz" wrap="square" lIns="0" tIns="0" rIns="0" bIns="0" rtlCol="0">
            <a:spAutoFit/>
          </a:bodyPr>
          <a:lstStyle/>
          <a:p>
            <a:pPr marL="92075" marR="84455" indent="-635" algn="ctr">
              <a:lnSpc>
                <a:spcPts val="2600"/>
              </a:lnSpc>
            </a:pPr>
            <a:r>
              <a:rPr sz="2600">
                <a:latin typeface="Helvetica"/>
                <a:cs typeface="Helvetica"/>
              </a:rPr>
              <a:t>Joint Venture - save this card and use it when you want your entire team to help answer. Draw agai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43100"/>
          </a:xfrm>
          <a:prstGeom prst="rect">
            <a:avLst/>
          </a:prstGeom>
          <a:ln w="6350">
            <a:noFill/>
          </a:ln>
        </p:spPr>
        <p:txBody>
          <a:bodyPr vert="horz" wrap="square" lIns="0" tIns="0" rIns="0" bIns="0" rtlCol="0">
            <a:spAutoFit/>
          </a:bodyPr>
          <a:lstStyle/>
          <a:p>
            <a:pPr marL="92075" marR="84455" indent="-635" algn="ctr">
              <a:lnSpc>
                <a:spcPts val="2600"/>
              </a:lnSpc>
            </a:pPr>
            <a:r>
              <a:rPr sz="2600">
                <a:latin typeface="Helvetica"/>
                <a:cs typeface="Helvetica"/>
              </a:rPr>
              <a:t>Joint Venture - save this card and use it when you want your entire team to help answer. Draw again.</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22" name="object 4">
            <a:extLst>
              <a:ext uri="{FF2B5EF4-FFF2-40B4-BE49-F238E27FC236}">
                <a16:creationId xmlns:a16="http://schemas.microsoft.com/office/drawing/2014/main" id="{5A190FFE-4715-4F13-3C8E-70A6EDB66EEC}"/>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7" name="object 8">
            <a:extLst>
              <a:ext uri="{FF2B5EF4-FFF2-40B4-BE49-F238E27FC236}">
                <a16:creationId xmlns:a16="http://schemas.microsoft.com/office/drawing/2014/main" id="{390E5244-8FAA-70AE-776B-1CECB7637ECC}"/>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1" name="object 13">
            <a:extLst>
              <a:ext uri="{FF2B5EF4-FFF2-40B4-BE49-F238E27FC236}">
                <a16:creationId xmlns:a16="http://schemas.microsoft.com/office/drawing/2014/main" id="{BB280096-825A-7B40-8E07-90DECE334E42}"/>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5" name="object 18">
            <a:extLst>
              <a:ext uri="{FF2B5EF4-FFF2-40B4-BE49-F238E27FC236}">
                <a16:creationId xmlns:a16="http://schemas.microsoft.com/office/drawing/2014/main" id="{4ED8B57E-E346-7C4F-D926-0C8ACC1FFFEC}"/>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823669"/>
            <a:ext cx="3200400" cy="1118961"/>
          </a:xfrm>
          <a:prstGeom prst="rect">
            <a:avLst/>
          </a:prstGeom>
          <a:ln w="6350">
            <a:noFill/>
          </a:ln>
        </p:spPr>
        <p:txBody>
          <a:bodyPr vert="horz" wrap="square" lIns="0" tIns="0" rIns="0" bIns="0" rtlCol="0" anchor="t">
            <a:spAutoFit/>
          </a:bodyPr>
          <a:lstStyle/>
          <a:p>
            <a:pPr marL="170180" marR="162560" algn="ctr">
              <a:lnSpc>
                <a:spcPts val="4700"/>
              </a:lnSpc>
              <a:tabLst>
                <a:tab pos="1431290" algn="l"/>
                <a:tab pos="1928495" algn="l"/>
                <a:tab pos="2127885" algn="l"/>
              </a:tabLst>
            </a:pPr>
            <a:r>
              <a:rPr sz="2200">
                <a:latin typeface="Helvetica"/>
                <a:cs typeface="Helvetica"/>
              </a:rPr>
              <a:t>Rheumatic fatigue</a:t>
            </a:r>
            <a:r>
              <a:rPr lang="en-US" sz="2200">
                <a:latin typeface="Helvetica"/>
                <a:cs typeface="Helvetica"/>
              </a:rPr>
              <a:t> – Lose a turn:(</a:t>
            </a:r>
            <a:endParaRPr lang="en-US" sz="4700">
              <a:latin typeface="Helvetica"/>
              <a:cs typeface="Helvetica"/>
            </a:endParaRP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3122605"/>
            <a:ext cx="3200400" cy="1118961"/>
          </a:xfrm>
          <a:prstGeom prst="rect">
            <a:avLst/>
          </a:prstGeom>
          <a:ln w="6350">
            <a:noFill/>
          </a:ln>
        </p:spPr>
        <p:txBody>
          <a:bodyPr vert="horz" wrap="square" lIns="0" tIns="0" rIns="0" bIns="0" rtlCol="0" anchor="t">
            <a:spAutoFit/>
          </a:bodyPr>
          <a:lstStyle/>
          <a:p>
            <a:pPr marL="170180" marR="162560" algn="ctr">
              <a:lnSpc>
                <a:spcPts val="4700"/>
              </a:lnSpc>
              <a:tabLst>
                <a:tab pos="1431290" algn="l"/>
                <a:tab pos="1928495" algn="l"/>
                <a:tab pos="2127885" algn="l"/>
              </a:tabLst>
            </a:pPr>
            <a:r>
              <a:rPr sz="2200">
                <a:latin typeface="Helvetica"/>
                <a:cs typeface="Helvetica"/>
              </a:rPr>
              <a:t>Rheumatic fatigue</a:t>
            </a:r>
            <a:r>
              <a:rPr lang="en-US" sz="2200">
                <a:latin typeface="Helvetica"/>
                <a:cs typeface="Helvetica"/>
              </a:rPr>
              <a:t> – Lose a turn:(</a:t>
            </a:r>
            <a:endParaRPr lang="en-US" sz="4700">
              <a:latin typeface="Helvetica"/>
              <a:cs typeface="Helvetica"/>
            </a:endParaRP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561891"/>
            <a:ext cx="3200400" cy="1231106"/>
          </a:xfrm>
          <a:prstGeom prst="rect">
            <a:avLst/>
          </a:prstGeom>
          <a:ln w="6350">
            <a:noFill/>
          </a:ln>
        </p:spPr>
        <p:txBody>
          <a:bodyPr vert="horz" wrap="square" lIns="0" tIns="0" rIns="0" bIns="0" rtlCol="0" anchor="t">
            <a:spAutoFit/>
          </a:bodyPr>
          <a:lstStyle/>
          <a:p>
            <a:pPr algn="ctr">
              <a:lnSpc>
                <a:spcPts val="3300"/>
              </a:lnSpc>
            </a:pPr>
            <a:r>
              <a:rPr sz="2200">
                <a:latin typeface="Helvetica"/>
                <a:cs typeface="Helvetica"/>
              </a:rPr>
              <a:t>Rheum-remission</a:t>
            </a:r>
            <a:endParaRPr lang="en-US" sz="2200">
              <a:latin typeface="Helvetica"/>
              <a:cs typeface="Helvetica"/>
            </a:endParaRPr>
          </a:p>
          <a:p>
            <a:pPr marL="273050" marR="265430" algn="ctr">
              <a:lnSpc>
                <a:spcPts val="3000"/>
              </a:lnSpc>
              <a:spcBef>
                <a:spcPts val="300"/>
              </a:spcBef>
            </a:pPr>
            <a:r>
              <a:rPr sz="2200">
                <a:latin typeface="Helvetica"/>
                <a:cs typeface="Helvetica"/>
              </a:rPr>
              <a:t>- move ahead 1 space</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946597"/>
            <a:ext cx="3200400" cy="1231106"/>
          </a:xfrm>
          <a:prstGeom prst="rect">
            <a:avLst/>
          </a:prstGeom>
          <a:ln w="6350">
            <a:noFill/>
          </a:ln>
        </p:spPr>
        <p:txBody>
          <a:bodyPr vert="horz" wrap="square" lIns="0" tIns="0" rIns="0" bIns="0" rtlCol="0" anchor="t">
            <a:spAutoFit/>
          </a:bodyPr>
          <a:lstStyle/>
          <a:p>
            <a:pPr algn="ctr">
              <a:lnSpc>
                <a:spcPts val="3300"/>
              </a:lnSpc>
            </a:pPr>
            <a:r>
              <a:rPr sz="2200">
                <a:latin typeface="Helvetica"/>
                <a:cs typeface="Helvetica"/>
              </a:rPr>
              <a:t>Rheum-remission</a:t>
            </a:r>
            <a:endParaRPr lang="en-US" sz="2200">
              <a:latin typeface="Helvetica"/>
              <a:cs typeface="Helvetica"/>
            </a:endParaRPr>
          </a:p>
          <a:p>
            <a:pPr marL="273050" marR="265430" algn="ctr">
              <a:lnSpc>
                <a:spcPts val="3000"/>
              </a:lnSpc>
              <a:spcBef>
                <a:spcPts val="300"/>
              </a:spcBef>
            </a:pPr>
            <a:r>
              <a:rPr sz="2200">
                <a:latin typeface="Helvetica"/>
                <a:cs typeface="Helvetica"/>
              </a:rPr>
              <a:t>- move ahead 1 space</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22" name="object 4">
            <a:extLst>
              <a:ext uri="{FF2B5EF4-FFF2-40B4-BE49-F238E27FC236}">
                <a16:creationId xmlns:a16="http://schemas.microsoft.com/office/drawing/2014/main" id="{13342765-6AF9-28D7-3641-0CED96BFB30C}"/>
              </a:ext>
            </a:extLst>
          </p:cNvPr>
          <p:cNvSpPr txBox="1"/>
          <p:nvPr/>
        </p:nvSpPr>
        <p:spPr>
          <a:xfrm>
            <a:off x="4114800" y="511205"/>
            <a:ext cx="3200400" cy="830997"/>
          </a:xfrm>
          <a:prstGeom prst="rect">
            <a:avLst/>
          </a:prstGeom>
          <a:ln w="6350">
            <a:noFill/>
          </a:ln>
        </p:spPr>
        <p:txBody>
          <a:bodyPr vert="horz" wrap="square" lIns="0" tIns="0" rIns="0" bIns="0" rtlCol="0" anchor="t">
            <a:spAutoFit/>
          </a:bodyPr>
          <a:lstStyle/>
          <a:p>
            <a:pPr marL="134620" marR="127000" indent="-635" algn="ctr"/>
            <a:r>
              <a:rPr lang="en-US">
                <a:latin typeface="Helvetica"/>
                <a:cs typeface="Calibri"/>
              </a:rPr>
              <a:t>Folate antimetabolite interfering with DNA synthesis (Methotrexate)</a:t>
            </a:r>
            <a:endParaRPr lang="en-US">
              <a:cs typeface="Calibri"/>
            </a:endParaRPr>
          </a:p>
        </p:txBody>
      </p:sp>
      <p:sp>
        <p:nvSpPr>
          <p:cNvPr id="24" name="object 5">
            <a:extLst>
              <a:ext uri="{FF2B5EF4-FFF2-40B4-BE49-F238E27FC236}">
                <a16:creationId xmlns:a16="http://schemas.microsoft.com/office/drawing/2014/main" id="{D453130E-6CB5-D1AB-5458-495385BFBDD3}"/>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6" name="object 8">
            <a:extLst>
              <a:ext uri="{FF2B5EF4-FFF2-40B4-BE49-F238E27FC236}">
                <a16:creationId xmlns:a16="http://schemas.microsoft.com/office/drawing/2014/main" id="{C66F7F05-F9E0-A5C8-1E9D-94E1155F9BA5}"/>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0" name="object 13">
            <a:extLst>
              <a:ext uri="{FF2B5EF4-FFF2-40B4-BE49-F238E27FC236}">
                <a16:creationId xmlns:a16="http://schemas.microsoft.com/office/drawing/2014/main" id="{51C6BB51-319F-C736-A0C8-E012BDE9BAEF}"/>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18">
            <a:extLst>
              <a:ext uri="{FF2B5EF4-FFF2-40B4-BE49-F238E27FC236}">
                <a16:creationId xmlns:a16="http://schemas.microsoft.com/office/drawing/2014/main" id="{E618FD04-BE78-C985-DC3E-D4F211B363BE}"/>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TextBox 37">
            <a:extLst>
              <a:ext uri="{FF2B5EF4-FFF2-40B4-BE49-F238E27FC236}">
                <a16:creationId xmlns:a16="http://schemas.microsoft.com/office/drawing/2014/main" id="{A5D89DBA-BD36-7FF7-7A7B-0390D813D1AE}"/>
              </a:ext>
            </a:extLst>
          </p:cNvPr>
          <p:cNvSpPr txBox="1"/>
          <p:nvPr/>
        </p:nvSpPr>
        <p:spPr>
          <a:xfrm>
            <a:off x="4048829" y="1619154"/>
            <a:ext cx="3257413" cy="738664"/>
          </a:xfrm>
          <a:prstGeom prst="rect">
            <a:avLst/>
          </a:prstGeom>
          <a:noFill/>
        </p:spPr>
        <p:txBody>
          <a:bodyPr wrap="square" lIns="91440" tIns="45720" rIns="91440" bIns="45720" rtlCol="0" anchor="t">
            <a:spAutoFit/>
          </a:bodyPr>
          <a:lstStyle/>
          <a:p>
            <a:pPr algn="ctr"/>
            <a:r>
              <a:rPr lang="en-US" sz="1400" b="1"/>
              <a:t>Correct</a:t>
            </a:r>
            <a:r>
              <a:rPr lang="en-US" sz="1400"/>
              <a:t>=All move forward 1 space. </a:t>
            </a:r>
            <a:endParaRPr lang="en-US"/>
          </a:p>
          <a:p>
            <a:pPr algn="ctr"/>
            <a:r>
              <a:rPr lang="en-US" sz="1400" b="1">
                <a:ea typeface="Calibri"/>
                <a:cs typeface="Calibri"/>
              </a:rPr>
              <a:t>Incorrect</a:t>
            </a:r>
            <a:r>
              <a:rPr lang="en-US" sz="1400">
                <a:ea typeface="Calibri"/>
                <a:cs typeface="Calibri"/>
              </a:rPr>
              <a:t>=stay in place</a:t>
            </a:r>
            <a:endParaRPr lang="en-US" sz="1400"/>
          </a:p>
          <a:p>
            <a:pPr algn="ctr"/>
            <a:r>
              <a:rPr lang="en-US" sz="1400" b="1"/>
              <a:t>3 incorrect curse cards=GAME OVER</a:t>
            </a:r>
            <a:endParaRPr lang="en-US" b="1">
              <a:ea typeface="Calibri"/>
              <a:cs typeface="Calibri"/>
            </a:endParaRPr>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753494"/>
            <a:ext cx="3200400" cy="1943100"/>
          </a:xfrm>
          <a:prstGeom prst="rect">
            <a:avLst/>
          </a:prstGeom>
          <a:ln w="6350">
            <a:noFill/>
          </a:ln>
        </p:spPr>
        <p:txBody>
          <a:bodyPr vert="horz" wrap="square" lIns="0" tIns="0" rIns="0" bIns="0" rtlCol="0">
            <a:spAutoFit/>
          </a:bodyPr>
          <a:lstStyle/>
          <a:p>
            <a:pPr marL="90170" marR="82550" indent="-635" algn="ctr">
              <a:lnSpc>
                <a:spcPts val="2200"/>
              </a:lnSpc>
            </a:pPr>
            <a:r>
              <a:rPr sz="2200">
                <a:latin typeface="Helvetica"/>
                <a:cs typeface="Helvetica"/>
              </a:rPr>
              <a:t>Knowledge seeker - save this card and use it to tap into external resources to answer a question. Draw again.</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 name="object 4"/>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3130402"/>
            <a:ext cx="3200400" cy="1943100"/>
          </a:xfrm>
          <a:prstGeom prst="rect">
            <a:avLst/>
          </a:prstGeom>
          <a:ln w="6350">
            <a:noFill/>
          </a:ln>
        </p:spPr>
        <p:txBody>
          <a:bodyPr vert="horz" wrap="square" lIns="0" tIns="0" rIns="0" bIns="0" rtlCol="0">
            <a:spAutoFit/>
          </a:bodyPr>
          <a:lstStyle/>
          <a:p>
            <a:pPr marL="90170" marR="82550" indent="-635" algn="ctr">
              <a:lnSpc>
                <a:spcPts val="2200"/>
              </a:lnSpc>
            </a:pPr>
            <a:r>
              <a:rPr sz="2200">
                <a:latin typeface="Helvetica"/>
                <a:cs typeface="Helvetica"/>
              </a:rPr>
              <a:t>Knowledge seeker - save this card and use it to tap into external resources to answer a question. Draw again.</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8" name="object 8"/>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507311"/>
            <a:ext cx="3200400" cy="1436291"/>
          </a:xfrm>
          <a:prstGeom prst="rect">
            <a:avLst/>
          </a:prstGeom>
          <a:ln w="6350">
            <a:noFill/>
          </a:ln>
        </p:spPr>
        <p:txBody>
          <a:bodyPr vert="horz" wrap="square" lIns="0" tIns="0" rIns="0" bIns="0" rtlCol="0" anchor="t">
            <a:spAutoFit/>
          </a:bodyPr>
          <a:lstStyle/>
          <a:p>
            <a:pPr marL="103505" marR="96520" algn="ctr">
              <a:lnSpc>
                <a:spcPts val="2800"/>
              </a:lnSpc>
            </a:pPr>
            <a:r>
              <a:rPr sz="2200">
                <a:latin typeface="Helvetica"/>
                <a:cs typeface="Helvetica"/>
              </a:rPr>
              <a:t>Turn this card over and place it next to the game board.</a:t>
            </a:r>
            <a:endParaRPr lang="en-US" sz="2200">
              <a:latin typeface="Helvetica"/>
              <a:cs typeface="Helvetica"/>
            </a:endParaRPr>
          </a:p>
          <a:p>
            <a:pPr algn="ctr">
              <a:lnSpc>
                <a:spcPts val="2800"/>
              </a:lnSpc>
            </a:pPr>
            <a:r>
              <a:rPr sz="2200">
                <a:latin typeface="Helvetica"/>
                <a:cs typeface="Helvetica"/>
              </a:rPr>
              <a:t>Lose this tur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4" name="object 14"/>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798450"/>
            <a:ext cx="3200400" cy="1436291"/>
          </a:xfrm>
          <a:prstGeom prst="rect">
            <a:avLst/>
          </a:prstGeom>
          <a:ln w="6350">
            <a:noFill/>
          </a:ln>
        </p:spPr>
        <p:txBody>
          <a:bodyPr vert="horz" wrap="square" lIns="0" tIns="0" rIns="0" bIns="0" rtlCol="0" anchor="t">
            <a:spAutoFit/>
          </a:bodyPr>
          <a:lstStyle/>
          <a:p>
            <a:pPr marL="103505" marR="96520" algn="ctr">
              <a:lnSpc>
                <a:spcPts val="2800"/>
              </a:lnSpc>
            </a:pPr>
            <a:r>
              <a:rPr sz="2200">
                <a:latin typeface="Helvetica"/>
                <a:cs typeface="Helvetica"/>
              </a:rPr>
              <a:t>Turn this card over and place it next to the game board.</a:t>
            </a:r>
            <a:endParaRPr lang="en-US" sz="2200">
              <a:latin typeface="Helvetica"/>
              <a:cs typeface="Helvetica"/>
            </a:endParaRPr>
          </a:p>
          <a:p>
            <a:pPr algn="ctr">
              <a:lnSpc>
                <a:spcPts val="2800"/>
              </a:lnSpc>
            </a:pPr>
            <a:r>
              <a:rPr sz="2200">
                <a:latin typeface="Helvetica"/>
                <a:cs typeface="Helvetica"/>
              </a:rPr>
              <a:t>Lose this turn.</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9" name="object 19"/>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692771"/>
          </a:xfrm>
          <a:prstGeom prst="rect">
            <a:avLst/>
          </a:prstGeom>
          <a:ln w="6350">
            <a:noFill/>
          </a:ln>
        </p:spPr>
        <p:txBody>
          <a:bodyPr vert="horz" wrap="square" lIns="0" tIns="0" rIns="0" bIns="0" rtlCol="0" anchor="t">
            <a:spAutoFit/>
          </a:bodyPr>
          <a:lstStyle/>
          <a:p>
            <a:pPr marL="175895" marR="168275" indent="-635" algn="ctr">
              <a:lnSpc>
                <a:spcPts val="2200"/>
              </a:lnSpc>
            </a:pPr>
            <a:r>
              <a:rPr sz="2200">
                <a:latin typeface="Helvetica"/>
                <a:cs typeface="Helvetica"/>
              </a:rPr>
              <a:t>50yo with 2mo </a:t>
            </a:r>
            <a:r>
              <a:rPr lang="en-US" sz="2200">
                <a:latin typeface="Helvetica"/>
                <a:cs typeface="Helvetica"/>
              </a:rPr>
              <a:t>history of</a:t>
            </a:r>
            <a:r>
              <a:rPr sz="2200">
                <a:latin typeface="Helvetica"/>
                <a:cs typeface="Helvetica"/>
              </a:rPr>
              <a:t> trouble getting out of chair and lifting objects overhead. Exam 4/5 muscle strength. CK elevated.</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795428"/>
          </a:xfrm>
          <a:prstGeom prst="rect">
            <a:avLst/>
          </a:prstGeom>
          <a:ln w="6350">
            <a:noFill/>
          </a:ln>
        </p:spPr>
        <p:txBody>
          <a:bodyPr vert="horz" wrap="square" lIns="0" tIns="0" rIns="0" bIns="0" rtlCol="0">
            <a:spAutoFit/>
          </a:bodyPr>
          <a:lstStyle/>
          <a:p>
            <a:pPr marL="79375" marR="71755" algn="ctr">
              <a:lnSpc>
                <a:spcPts val="2000"/>
              </a:lnSpc>
            </a:pPr>
            <a:r>
              <a:rPr sz="2200">
                <a:latin typeface="Helvetica"/>
                <a:cs typeface="Helvetica"/>
              </a:rPr>
              <a:t>50yo with progressive proximal muscle weakness over several months. 4/5 strength. Skin: heliotrope, gottrons, v-sign. CK high.</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795363"/>
          </a:xfrm>
          <a:prstGeom prst="rect">
            <a:avLst/>
          </a:prstGeom>
          <a:ln w="6350">
            <a:noFill/>
          </a:ln>
        </p:spPr>
        <p:txBody>
          <a:bodyPr vert="horz" wrap="square" lIns="0" tIns="0" rIns="0" bIns="0" rtlCol="0">
            <a:spAutoFit/>
          </a:bodyPr>
          <a:lstStyle/>
          <a:p>
            <a:pPr marL="104775" marR="97155" algn="ctr">
              <a:lnSpc>
                <a:spcPts val="2800"/>
              </a:lnSpc>
            </a:pPr>
            <a:r>
              <a:rPr sz="2200">
                <a:latin typeface="Helvetica"/>
                <a:cs typeface="Helvetica"/>
              </a:rPr>
              <a:t>62yo M with 1 year of asymmetric proximal and distal muscle weakness.</a:t>
            </a:r>
          </a:p>
          <a:p>
            <a:pPr algn="ctr">
              <a:lnSpc>
                <a:spcPts val="2800"/>
              </a:lnSpc>
            </a:pPr>
            <a:r>
              <a:rPr sz="2200">
                <a:latin typeface="Helvetica"/>
                <a:cs typeface="Helvetica"/>
              </a:rPr>
              <a:t>No pai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538883"/>
          </a:xfrm>
          <a:prstGeom prst="rect">
            <a:avLst/>
          </a:prstGeom>
          <a:ln w="6350">
            <a:noFill/>
          </a:ln>
        </p:spPr>
        <p:txBody>
          <a:bodyPr vert="horz" wrap="square" lIns="0" tIns="0" rIns="0" bIns="0" rtlCol="0">
            <a:spAutoFit/>
          </a:bodyPr>
          <a:lstStyle/>
          <a:p>
            <a:pPr marL="198755" marR="191135" algn="ctr">
              <a:lnSpc>
                <a:spcPts val="2400"/>
              </a:lnSpc>
            </a:pPr>
            <a:r>
              <a:rPr sz="2200">
                <a:latin typeface="Helvetica"/>
                <a:cs typeface="Helvetica"/>
              </a:rPr>
              <a:t>25yo with joint pain, frequent dislocations and bruising.</a:t>
            </a:r>
          </a:p>
          <a:p>
            <a:pPr marL="80645" marR="73025" algn="ctr">
              <a:lnSpc>
                <a:spcPts val="2400"/>
              </a:lnSpc>
            </a:pPr>
            <a:r>
              <a:rPr sz="2200">
                <a:latin typeface="Helvetica"/>
                <a:cs typeface="Helvetica"/>
              </a:rPr>
              <a:t>Hyperextensible skin and joint hypermobility</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FFFC3FCF-D291-5017-4A48-E5C65D65593B}"/>
              </a:ext>
            </a:extLst>
          </p:cNvPr>
          <p:cNvSpPr txBox="1"/>
          <p:nvPr/>
        </p:nvSpPr>
        <p:spPr>
          <a:xfrm>
            <a:off x="4114800" y="967954"/>
            <a:ext cx="3200400" cy="430887"/>
          </a:xfrm>
          <a:prstGeom prst="rect">
            <a:avLst/>
          </a:prstGeom>
          <a:ln w="6350">
            <a:solidFill>
              <a:schemeClr val="bg1"/>
            </a:solidFill>
          </a:ln>
        </p:spPr>
        <p:txBody>
          <a:bodyPr vert="horz" wrap="square" lIns="0" tIns="0" rIns="0" bIns="0" rtlCol="0">
            <a:spAutoFit/>
          </a:bodyPr>
          <a:lstStyle/>
          <a:p>
            <a:pPr marL="106045" algn="ctr">
              <a:lnSpc>
                <a:spcPct val="100000"/>
              </a:lnSpc>
            </a:pPr>
            <a:r>
              <a:rPr sz="2800">
                <a:latin typeface="Helvetica"/>
                <a:cs typeface="Helvetica"/>
              </a:rPr>
              <a:t>Rhabdomyolysis</a:t>
            </a:r>
            <a:endParaRPr sz="2400">
              <a:latin typeface="Helvetica"/>
              <a:cs typeface="Helvetica"/>
            </a:endParaRPr>
          </a:p>
        </p:txBody>
      </p:sp>
      <p:sp>
        <p:nvSpPr>
          <p:cNvPr id="32" name="object 8">
            <a:extLst>
              <a:ext uri="{FF2B5EF4-FFF2-40B4-BE49-F238E27FC236}">
                <a16:creationId xmlns:a16="http://schemas.microsoft.com/office/drawing/2014/main" id="{A63A8303-A105-D15D-D7EF-6907ECD9E31D}"/>
              </a:ext>
            </a:extLst>
          </p:cNvPr>
          <p:cNvSpPr txBox="1"/>
          <p:nvPr/>
        </p:nvSpPr>
        <p:spPr>
          <a:xfrm>
            <a:off x="4114800" y="2857500"/>
            <a:ext cx="3200400" cy="1292662"/>
          </a:xfrm>
          <a:prstGeom prst="rect">
            <a:avLst/>
          </a:prstGeom>
          <a:ln w="6350">
            <a:solidFill>
              <a:schemeClr val="bg1"/>
            </a:solidFill>
          </a:ln>
        </p:spPr>
        <p:txBody>
          <a:bodyPr vert="horz" wrap="square" lIns="0" tIns="0" rIns="0" bIns="0" rtlCol="0">
            <a:spAutoFit/>
          </a:bodyPr>
          <a:lstStyle/>
          <a:p>
            <a:pPr marL="87630" marR="80010" algn="ctr"/>
            <a:r>
              <a:rPr sz="2800">
                <a:latin typeface="Helvetica"/>
                <a:cs typeface="Helvetica"/>
              </a:rPr>
              <a:t>Neuroleptic malignant syndrome</a:t>
            </a:r>
          </a:p>
        </p:txBody>
      </p:sp>
      <p:sp>
        <p:nvSpPr>
          <p:cNvPr id="34" name="object 9">
            <a:extLst>
              <a:ext uri="{FF2B5EF4-FFF2-40B4-BE49-F238E27FC236}">
                <a16:creationId xmlns:a16="http://schemas.microsoft.com/office/drawing/2014/main" id="{0DD89CFB-1B33-713D-92AF-2D3C8056DB1E}"/>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6" name="object 13">
            <a:extLst>
              <a:ext uri="{FF2B5EF4-FFF2-40B4-BE49-F238E27FC236}">
                <a16:creationId xmlns:a16="http://schemas.microsoft.com/office/drawing/2014/main" id="{33A820CF-8D50-36EF-0565-1FECF8664270}"/>
              </a:ext>
            </a:extLst>
          </p:cNvPr>
          <p:cNvSpPr txBox="1"/>
          <p:nvPr/>
        </p:nvSpPr>
        <p:spPr>
          <a:xfrm>
            <a:off x="4114800" y="5675352"/>
            <a:ext cx="3200400" cy="430887"/>
          </a:xfrm>
          <a:prstGeom prst="rect">
            <a:avLst/>
          </a:prstGeom>
          <a:ln w="6350">
            <a:solidFill>
              <a:schemeClr val="bg1"/>
            </a:solidFill>
          </a:ln>
        </p:spPr>
        <p:txBody>
          <a:bodyPr vert="horz" wrap="square" lIns="0" tIns="0" rIns="0" bIns="0" rtlCol="0">
            <a:spAutoFit/>
          </a:bodyPr>
          <a:lstStyle/>
          <a:p>
            <a:pPr marL="106680" algn="ctr">
              <a:lnSpc>
                <a:spcPct val="100000"/>
              </a:lnSpc>
            </a:pPr>
            <a:r>
              <a:rPr sz="2800">
                <a:latin typeface="Helvetica"/>
                <a:cs typeface="Helvetica"/>
              </a:rPr>
              <a:t>Fibromyalgia</a:t>
            </a:r>
          </a:p>
        </p:txBody>
      </p:sp>
      <p:sp>
        <p:nvSpPr>
          <p:cNvPr id="38" name="object 14">
            <a:extLst>
              <a:ext uri="{FF2B5EF4-FFF2-40B4-BE49-F238E27FC236}">
                <a16:creationId xmlns:a16="http://schemas.microsoft.com/office/drawing/2014/main" id="{63872448-61CD-B359-6033-BA9781E0A6CB}"/>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0" name="object 18">
            <a:extLst>
              <a:ext uri="{FF2B5EF4-FFF2-40B4-BE49-F238E27FC236}">
                <a16:creationId xmlns:a16="http://schemas.microsoft.com/office/drawing/2014/main" id="{E18919CD-04BF-B379-39B2-2ECCFFBD8143}"/>
              </a:ext>
            </a:extLst>
          </p:cNvPr>
          <p:cNvSpPr txBox="1"/>
          <p:nvPr/>
        </p:nvSpPr>
        <p:spPr>
          <a:xfrm>
            <a:off x="4114800" y="7658100"/>
            <a:ext cx="3200400" cy="1058431"/>
          </a:xfrm>
          <a:prstGeom prst="rect">
            <a:avLst/>
          </a:prstGeom>
          <a:ln w="6350">
            <a:noFill/>
          </a:ln>
        </p:spPr>
        <p:txBody>
          <a:bodyPr vert="horz" wrap="square" lIns="0" tIns="0" rIns="0" bIns="0" rtlCol="0">
            <a:spAutoFit/>
          </a:bodyPr>
          <a:lstStyle/>
          <a:p>
            <a:pPr marL="246379" marR="117475" indent="-121285" algn="ctr">
              <a:lnSpc>
                <a:spcPts val="4300"/>
              </a:lnSpc>
            </a:pPr>
            <a:r>
              <a:rPr sz="2800">
                <a:latin typeface="Helvetica"/>
                <a:cs typeface="Helvetica"/>
              </a:rPr>
              <a:t>Polymyalgia rheumatica</a:t>
            </a:r>
          </a:p>
        </p:txBody>
      </p:sp>
      <p:sp>
        <p:nvSpPr>
          <p:cNvPr id="42" name="object 19">
            <a:extLst>
              <a:ext uri="{FF2B5EF4-FFF2-40B4-BE49-F238E27FC236}">
                <a16:creationId xmlns:a16="http://schemas.microsoft.com/office/drawing/2014/main" id="{35DAEB9D-202A-B957-9571-885A1973654A}"/>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4" name="Rectangle 43">
            <a:extLst>
              <a:ext uri="{FF2B5EF4-FFF2-40B4-BE49-F238E27FC236}">
                <a16:creationId xmlns:a16="http://schemas.microsoft.com/office/drawing/2014/main" id="{46ED1F76-44A0-3A2A-D379-7E84E0750561}"/>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TextBox 45">
            <a:extLst>
              <a:ext uri="{FF2B5EF4-FFF2-40B4-BE49-F238E27FC236}">
                <a16:creationId xmlns:a16="http://schemas.microsoft.com/office/drawing/2014/main" id="{56B57495-D036-69CB-92F6-838C6DC17505}"/>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48" name="Rectangle 47">
            <a:extLst>
              <a:ext uri="{FF2B5EF4-FFF2-40B4-BE49-F238E27FC236}">
                <a16:creationId xmlns:a16="http://schemas.microsoft.com/office/drawing/2014/main" id="{85955B73-0114-C4FE-8009-F2893B4C1D6A}"/>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a:extLst>
              <a:ext uri="{FF2B5EF4-FFF2-40B4-BE49-F238E27FC236}">
                <a16:creationId xmlns:a16="http://schemas.microsoft.com/office/drawing/2014/main" id="{3CDFC38B-AB1A-DB04-6F58-1ADA019CB3A1}"/>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2" name="Rectangle 51">
            <a:extLst>
              <a:ext uri="{FF2B5EF4-FFF2-40B4-BE49-F238E27FC236}">
                <a16:creationId xmlns:a16="http://schemas.microsoft.com/office/drawing/2014/main" id="{2EC5F120-61C4-09F8-41F1-BE11F45C8E86}"/>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TextBox 53">
            <a:extLst>
              <a:ext uri="{FF2B5EF4-FFF2-40B4-BE49-F238E27FC236}">
                <a16:creationId xmlns:a16="http://schemas.microsoft.com/office/drawing/2014/main" id="{038FCE29-572E-793C-EE30-FCF2D2518E00}"/>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6" name="Rectangle 55">
            <a:extLst>
              <a:ext uri="{FF2B5EF4-FFF2-40B4-BE49-F238E27FC236}">
                <a16:creationId xmlns:a16="http://schemas.microsoft.com/office/drawing/2014/main" id="{0998544F-342D-CC98-B491-A1DF192A4897}"/>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a:extLst>
              <a:ext uri="{FF2B5EF4-FFF2-40B4-BE49-F238E27FC236}">
                <a16:creationId xmlns:a16="http://schemas.microsoft.com/office/drawing/2014/main" id="{46522495-E728-DAF1-5C9E-6E4CE8A3C5C9}"/>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
        <p:nvSpPr>
          <p:cNvPr id="59" name="object 9">
            <a:extLst>
              <a:ext uri="{FF2B5EF4-FFF2-40B4-BE49-F238E27FC236}">
                <a16:creationId xmlns:a16="http://schemas.microsoft.com/office/drawing/2014/main" id="{AAB167D8-E466-D81E-0E99-776036AEAC42}"/>
              </a:ext>
            </a:extLst>
          </p:cNvPr>
          <p:cNvSpPr/>
          <p:nvPr/>
        </p:nvSpPr>
        <p:spPr>
          <a:xfrm>
            <a:off x="4013200" y="362157"/>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538883"/>
          </a:xfrm>
          <a:prstGeom prst="rect">
            <a:avLst/>
          </a:prstGeom>
          <a:ln w="6350">
            <a:noFill/>
          </a:ln>
        </p:spPr>
        <p:txBody>
          <a:bodyPr vert="horz" wrap="square" lIns="0" tIns="0" rIns="0" bIns="0" rtlCol="0" anchor="t">
            <a:spAutoFit/>
          </a:bodyPr>
          <a:lstStyle/>
          <a:p>
            <a:pPr marL="139700" marR="132080" indent="-635" algn="ctr">
              <a:lnSpc>
                <a:spcPts val="2400"/>
              </a:lnSpc>
            </a:pPr>
            <a:r>
              <a:rPr sz="2200">
                <a:latin typeface="Helvetica"/>
                <a:cs typeface="Helvetica"/>
              </a:rPr>
              <a:t>Young child presents with non-traumatic fracture and </a:t>
            </a:r>
            <a:r>
              <a:rPr lang="en-US" sz="2200">
                <a:latin typeface="Helvetica"/>
                <a:cs typeface="Helvetica"/>
              </a:rPr>
              <a:t>history of</a:t>
            </a:r>
            <a:r>
              <a:rPr sz="2200">
                <a:latin typeface="Helvetica"/>
                <a:cs typeface="Helvetica"/>
              </a:rPr>
              <a:t> other fractures. Blue sclera</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2308389"/>
          </a:xfrm>
          <a:prstGeom prst="rect">
            <a:avLst/>
          </a:prstGeom>
          <a:ln w="6350">
            <a:noFill/>
          </a:ln>
        </p:spPr>
        <p:txBody>
          <a:bodyPr vert="horz" wrap="square" lIns="0" tIns="0" rIns="0" bIns="0" rtlCol="0" anchor="t">
            <a:spAutoFit/>
          </a:bodyPr>
          <a:lstStyle/>
          <a:p>
            <a:pPr marL="213360" marR="205740" algn="ctr">
              <a:lnSpc>
                <a:spcPts val="2000"/>
              </a:lnSpc>
            </a:pPr>
            <a:r>
              <a:rPr sz="2100">
                <a:latin typeface="Helvetica"/>
                <a:cs typeface="Helvetica"/>
              </a:rPr>
              <a:t>30yo with cataracts and peripheral neuropathy presents with weakness.</a:t>
            </a:r>
            <a:endParaRPr lang="en-US" sz="2100">
              <a:latin typeface="Helvetica"/>
              <a:cs typeface="Helvetica"/>
            </a:endParaRPr>
          </a:p>
          <a:p>
            <a:pPr marL="199390" marR="191770" algn="ctr">
              <a:lnSpc>
                <a:spcPts val="2000"/>
              </a:lnSpc>
            </a:pPr>
            <a:r>
              <a:rPr lang="en-US" sz="2100">
                <a:latin typeface="Helvetica"/>
                <a:cs typeface="Helvetica"/>
              </a:rPr>
              <a:t>+Family History.</a:t>
            </a:r>
            <a:r>
              <a:rPr sz="2100">
                <a:latin typeface="Helvetica"/>
                <a:cs typeface="Helvetica"/>
              </a:rPr>
              <a:t> Exam: frontal hair loss, temporal muscle wasting, distal weakness</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538883"/>
          </a:xfrm>
          <a:prstGeom prst="rect">
            <a:avLst/>
          </a:prstGeom>
          <a:ln w="6350">
            <a:noFill/>
          </a:ln>
        </p:spPr>
        <p:txBody>
          <a:bodyPr vert="horz" wrap="square" lIns="0" tIns="0" rIns="0" bIns="0" rtlCol="0">
            <a:spAutoFit/>
          </a:bodyPr>
          <a:lstStyle/>
          <a:p>
            <a:pPr marL="131445" marR="123189" indent="-635" algn="ctr">
              <a:lnSpc>
                <a:spcPts val="2400"/>
              </a:lnSpc>
            </a:pPr>
            <a:r>
              <a:rPr sz="2200">
                <a:latin typeface="Helvetica"/>
                <a:cs typeface="Helvetica"/>
              </a:rPr>
              <a:t>14yo with leg pain + fever/weight loss. tender on bone. Xray: moth eaten, Path: small round blue cells</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43100"/>
          </a:xfrm>
          <a:prstGeom prst="rect">
            <a:avLst/>
          </a:prstGeom>
          <a:ln w="6350">
            <a:noFill/>
          </a:ln>
        </p:spPr>
        <p:txBody>
          <a:bodyPr vert="horz" wrap="square" lIns="0" tIns="0" rIns="0" bIns="0" rtlCol="0">
            <a:spAutoFit/>
          </a:bodyPr>
          <a:lstStyle/>
          <a:p>
            <a:pPr marL="97790" marR="90170" algn="ctr">
              <a:lnSpc>
                <a:spcPts val="2200"/>
              </a:lnSpc>
            </a:pPr>
            <a:r>
              <a:rPr sz="2200">
                <a:latin typeface="Helvetica"/>
                <a:cs typeface="Helvetica"/>
              </a:rPr>
              <a:t>18yo man with painful swelling below knee joint, pain at night. Xray: periosteal new bone formation with central radiolucent nidus</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9C72BB0C-1DE7-9C49-BA7B-53032D0D83EC}"/>
              </a:ext>
            </a:extLst>
          </p:cNvPr>
          <p:cNvSpPr txBox="1"/>
          <p:nvPr/>
        </p:nvSpPr>
        <p:spPr>
          <a:xfrm>
            <a:off x="4495800" y="641544"/>
            <a:ext cx="2438400" cy="1001877"/>
          </a:xfrm>
          <a:prstGeom prst="rect">
            <a:avLst/>
          </a:prstGeom>
          <a:ln w="6350">
            <a:noFill/>
          </a:ln>
        </p:spPr>
        <p:txBody>
          <a:bodyPr vert="horz" wrap="square" lIns="0" tIns="0" rIns="0" bIns="0" rtlCol="0">
            <a:spAutoFit/>
          </a:bodyPr>
          <a:lstStyle/>
          <a:p>
            <a:pPr marL="92075" marR="84455" indent="448309">
              <a:lnSpc>
                <a:spcPts val="4100"/>
              </a:lnSpc>
            </a:pPr>
            <a:r>
              <a:rPr sz="2800">
                <a:latin typeface="Helvetica"/>
                <a:cs typeface="Helvetica"/>
              </a:rPr>
              <a:t>Vertebral</a:t>
            </a:r>
            <a:r>
              <a:rPr lang="en-US" sz="2800">
                <a:latin typeface="Helvetica"/>
                <a:cs typeface="Helvetica"/>
              </a:rPr>
              <a:t>      </a:t>
            </a:r>
            <a:r>
              <a:rPr sz="2800">
                <a:latin typeface="Helvetica"/>
                <a:cs typeface="Helvetica"/>
              </a:rPr>
              <a:t>osteomyelitis</a:t>
            </a:r>
          </a:p>
        </p:txBody>
      </p:sp>
      <p:sp>
        <p:nvSpPr>
          <p:cNvPr id="32" name="object 5">
            <a:extLst>
              <a:ext uri="{FF2B5EF4-FFF2-40B4-BE49-F238E27FC236}">
                <a16:creationId xmlns:a16="http://schemas.microsoft.com/office/drawing/2014/main" id="{B1816331-F7BD-E5EB-A8D3-E0C5B4140EA3}"/>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C6DD68E1-1E8C-B619-C46A-877175FF8680}"/>
              </a:ext>
            </a:extLst>
          </p:cNvPr>
          <p:cNvSpPr txBox="1"/>
          <p:nvPr/>
        </p:nvSpPr>
        <p:spPr>
          <a:xfrm>
            <a:off x="4114800" y="3059072"/>
            <a:ext cx="3200400" cy="745397"/>
          </a:xfrm>
          <a:prstGeom prst="rect">
            <a:avLst/>
          </a:prstGeom>
          <a:ln w="6350">
            <a:noFill/>
          </a:ln>
        </p:spPr>
        <p:txBody>
          <a:bodyPr vert="horz" wrap="square" lIns="0" tIns="0" rIns="0" bIns="0" rtlCol="0">
            <a:spAutoFit/>
          </a:bodyPr>
          <a:lstStyle/>
          <a:p>
            <a:pPr marL="160655" marR="153035" indent="218440">
              <a:lnSpc>
                <a:spcPts val="6900"/>
              </a:lnSpc>
            </a:pPr>
            <a:r>
              <a:rPr sz="2800">
                <a:latin typeface="Helvetica"/>
                <a:cs typeface="Helvetica"/>
              </a:rPr>
              <a:t>Septic arthritis</a:t>
            </a:r>
          </a:p>
        </p:txBody>
      </p:sp>
      <p:sp>
        <p:nvSpPr>
          <p:cNvPr id="36" name="object 9">
            <a:extLst>
              <a:ext uri="{FF2B5EF4-FFF2-40B4-BE49-F238E27FC236}">
                <a16:creationId xmlns:a16="http://schemas.microsoft.com/office/drawing/2014/main" id="{DF1661B5-91BE-8130-EC67-B9807CF7A7CD}"/>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C66DB816-7F29-69D1-6CB5-1D139BD4B291}"/>
              </a:ext>
            </a:extLst>
          </p:cNvPr>
          <p:cNvSpPr txBox="1"/>
          <p:nvPr/>
        </p:nvSpPr>
        <p:spPr>
          <a:xfrm>
            <a:off x="4114800" y="5257800"/>
            <a:ext cx="3200400" cy="1292662"/>
          </a:xfrm>
          <a:prstGeom prst="rect">
            <a:avLst/>
          </a:prstGeom>
          <a:ln w="6350">
            <a:noFill/>
          </a:ln>
        </p:spPr>
        <p:txBody>
          <a:bodyPr vert="horz" wrap="square" lIns="0" tIns="0" rIns="0" bIns="0" rtlCol="0">
            <a:spAutoFit/>
          </a:bodyPr>
          <a:lstStyle/>
          <a:p>
            <a:pPr marL="96520" marR="88900" algn="ctr"/>
            <a:r>
              <a:rPr sz="2800">
                <a:latin typeface="Helvetica"/>
                <a:cs typeface="Helvetica"/>
              </a:rPr>
              <a:t>Disseminated gonococcal infection</a:t>
            </a:r>
          </a:p>
        </p:txBody>
      </p:sp>
      <p:sp>
        <p:nvSpPr>
          <p:cNvPr id="40" name="object 14">
            <a:extLst>
              <a:ext uri="{FF2B5EF4-FFF2-40B4-BE49-F238E27FC236}">
                <a16:creationId xmlns:a16="http://schemas.microsoft.com/office/drawing/2014/main" id="{C0DBDDF2-957D-ACF3-DBF9-19D5251C2E71}"/>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0E7D16CF-114A-AD55-9774-ECD51E3A44CB}"/>
              </a:ext>
            </a:extLst>
          </p:cNvPr>
          <p:cNvSpPr txBox="1"/>
          <p:nvPr/>
        </p:nvSpPr>
        <p:spPr>
          <a:xfrm>
            <a:off x="4114800" y="7658100"/>
            <a:ext cx="3200400" cy="1181414"/>
          </a:xfrm>
          <a:prstGeom prst="rect">
            <a:avLst/>
          </a:prstGeom>
          <a:ln w="6350">
            <a:noFill/>
          </a:ln>
        </p:spPr>
        <p:txBody>
          <a:bodyPr vert="horz" wrap="square" lIns="0" tIns="0" rIns="0" bIns="0" rtlCol="0">
            <a:spAutoFit/>
          </a:bodyPr>
          <a:lstStyle/>
          <a:p>
            <a:pPr marL="144145" marR="84455" indent="-52069" algn="ctr">
              <a:lnSpc>
                <a:spcPts val="4900"/>
              </a:lnSpc>
            </a:pPr>
            <a:r>
              <a:rPr sz="2800">
                <a:latin typeface="Helvetica"/>
                <a:cs typeface="Helvetica"/>
              </a:rPr>
              <a:t>Ankylosing spondylitis</a:t>
            </a:r>
          </a:p>
        </p:txBody>
      </p:sp>
      <p:sp>
        <p:nvSpPr>
          <p:cNvPr id="44" name="object 19">
            <a:extLst>
              <a:ext uri="{FF2B5EF4-FFF2-40B4-BE49-F238E27FC236}">
                <a16:creationId xmlns:a16="http://schemas.microsoft.com/office/drawing/2014/main" id="{94F48318-ED6A-620C-8665-828F9A40339A}"/>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13C0AFD9-BE1F-F406-17D2-0E6A30F20AC0}"/>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25A9B81D-E520-8944-62E7-EED22887BECF}"/>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52863611-E25B-5F21-6D9D-0FA90257DC32}"/>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E0E258FD-2B77-C2E6-2249-26C7786092B6}"/>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9E8C4212-4AEA-8C1F-7D51-DF07A99C8D40}"/>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CFB1B0DA-E07C-AD57-1049-98E84A578B3D}"/>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BDEDC870-1D81-5492-C84C-B76E632386DE}"/>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5F2577E9-80D1-0332-E247-6EE9E4FC891D}"/>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538883"/>
          </a:xfrm>
          <a:prstGeom prst="rect">
            <a:avLst/>
          </a:prstGeom>
          <a:ln w="6350">
            <a:noFill/>
          </a:ln>
        </p:spPr>
        <p:txBody>
          <a:bodyPr vert="horz" wrap="square" lIns="0" tIns="0" rIns="0" bIns="0" rtlCol="0" anchor="t">
            <a:spAutoFit/>
          </a:bodyPr>
          <a:lstStyle/>
          <a:p>
            <a:pPr marL="97790" marR="90170" algn="ctr">
              <a:lnSpc>
                <a:spcPts val="2400"/>
              </a:lnSpc>
            </a:pPr>
            <a:r>
              <a:rPr sz="2200">
                <a:latin typeface="Helvetica"/>
                <a:cs typeface="Helvetica"/>
              </a:rPr>
              <a:t>46yo with back pain and fevers. +</a:t>
            </a:r>
            <a:r>
              <a:rPr lang="en-US" sz="2200">
                <a:latin typeface="Helvetica"/>
                <a:cs typeface="Helvetica"/>
              </a:rPr>
              <a:t>IV Drug use</a:t>
            </a:r>
            <a:r>
              <a:rPr sz="2200">
                <a:latin typeface="Helvetica"/>
                <a:cs typeface="Helvetica"/>
              </a:rPr>
              <a:t>. Exam: point tenderness overlying spine. ESR/CRP high.</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506887"/>
          </a:xfrm>
          <a:prstGeom prst="rect">
            <a:avLst/>
          </a:prstGeom>
          <a:ln w="6350">
            <a:noFill/>
          </a:ln>
        </p:spPr>
        <p:txBody>
          <a:bodyPr vert="horz" wrap="square" lIns="0" tIns="0" rIns="0" bIns="0" rtlCol="0" anchor="t">
            <a:spAutoFit/>
          </a:bodyPr>
          <a:lstStyle/>
          <a:p>
            <a:pPr marL="135255" marR="128905" indent="-635" algn="ctr">
              <a:lnSpc>
                <a:spcPts val="3000"/>
              </a:lnSpc>
            </a:pPr>
            <a:r>
              <a:rPr lang="en-US" sz="2200">
                <a:latin typeface="Helvetica"/>
                <a:cs typeface="Helvetica"/>
              </a:rPr>
              <a:t>35yo man </a:t>
            </a:r>
            <a:r>
              <a:rPr sz="2200">
                <a:latin typeface="Helvetica"/>
                <a:cs typeface="Helvetica"/>
              </a:rPr>
              <a:t>with acute hot, red, swollen knee. 100K WBC mostly PMNs</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795363"/>
          </a:xfrm>
          <a:prstGeom prst="rect">
            <a:avLst/>
          </a:prstGeom>
          <a:ln w="6350">
            <a:noFill/>
          </a:ln>
        </p:spPr>
        <p:txBody>
          <a:bodyPr vert="horz" wrap="square" lIns="0" tIns="0" rIns="0" bIns="0" rtlCol="0" anchor="t">
            <a:spAutoFit/>
          </a:bodyPr>
          <a:lstStyle/>
          <a:p>
            <a:pPr marL="262255" marR="255270" algn="ctr">
              <a:lnSpc>
                <a:spcPts val="2000"/>
              </a:lnSpc>
            </a:pPr>
            <a:r>
              <a:rPr lang="en-US" sz="2000">
                <a:latin typeface="Helvetica"/>
                <a:cs typeface="Helvetica"/>
              </a:rPr>
              <a:t>47yo man</a:t>
            </a:r>
            <a:r>
              <a:rPr sz="2000">
                <a:latin typeface="Helvetica"/>
                <a:cs typeface="Helvetica"/>
              </a:rPr>
              <a:t> with acute monoarticular arthritis, fever, and pustular rash including hands/feet.</a:t>
            </a:r>
            <a:endParaRPr lang="en-US"/>
          </a:p>
          <a:p>
            <a:pPr marL="86360" marR="78740" algn="ctr">
              <a:lnSpc>
                <a:spcPts val="2000"/>
              </a:lnSpc>
            </a:pPr>
            <a:r>
              <a:rPr sz="2000">
                <a:latin typeface="Helvetica"/>
                <a:cs typeface="Helvetica"/>
              </a:rPr>
              <a:t>Synovial: 75K WBC mostly neutrophils, no organism on gram stai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2308389"/>
          </a:xfrm>
          <a:prstGeom prst="rect">
            <a:avLst/>
          </a:prstGeom>
          <a:ln w="6350">
            <a:solidFill>
              <a:schemeClr val="bg1"/>
            </a:solidFill>
          </a:ln>
        </p:spPr>
        <p:txBody>
          <a:bodyPr vert="horz" wrap="square" lIns="0" tIns="0" rIns="0" bIns="0" rtlCol="0" anchor="t">
            <a:spAutoFit/>
          </a:bodyPr>
          <a:lstStyle/>
          <a:p>
            <a:pPr marL="163830" marR="156210" algn="ctr">
              <a:lnSpc>
                <a:spcPts val="2000"/>
              </a:lnSpc>
            </a:pPr>
            <a:r>
              <a:rPr sz="2100">
                <a:latin typeface="Helvetica"/>
                <a:cs typeface="Helvetica"/>
              </a:rPr>
              <a:t>36yo man with worsening back pain and stiffness. Worse 1h in morning, better with activity. </a:t>
            </a:r>
            <a:r>
              <a:rPr lang="en-US" sz="2100">
                <a:latin typeface="Helvetica"/>
                <a:cs typeface="Helvetica"/>
              </a:rPr>
              <a:t>Long term disability</a:t>
            </a:r>
            <a:r>
              <a:rPr sz="2100">
                <a:latin typeface="Helvetica"/>
                <a:cs typeface="Helvetica"/>
              </a:rPr>
              <a:t> mobility forward flexion.</a:t>
            </a:r>
            <a:endParaRPr lang="en-US" sz="2100">
              <a:latin typeface="Helvetica"/>
              <a:cs typeface="Helvetica"/>
            </a:endParaRPr>
          </a:p>
          <a:p>
            <a:pPr algn="ctr">
              <a:lnSpc>
                <a:spcPts val="2000"/>
              </a:lnSpc>
            </a:pPr>
            <a:r>
              <a:rPr lang="en-US" sz="2100">
                <a:latin typeface="Helvetica"/>
                <a:cs typeface="Helvetica"/>
              </a:rPr>
              <a:t>Tender to Palpation</a:t>
            </a:r>
            <a:r>
              <a:rPr sz="2100">
                <a:latin typeface="Helvetica"/>
                <a:cs typeface="Helvetica"/>
              </a:rPr>
              <a:t> SI joint.</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8AD5690E-EC68-9616-D9C2-01966862D19C}"/>
              </a:ext>
            </a:extLst>
          </p:cNvPr>
          <p:cNvSpPr txBox="1"/>
          <p:nvPr/>
        </p:nvSpPr>
        <p:spPr>
          <a:xfrm>
            <a:off x="4114800" y="652336"/>
            <a:ext cx="3200400" cy="956993"/>
          </a:xfrm>
          <a:prstGeom prst="rect">
            <a:avLst/>
          </a:prstGeom>
          <a:ln w="6350">
            <a:noFill/>
          </a:ln>
        </p:spPr>
        <p:txBody>
          <a:bodyPr vert="horz" wrap="square" lIns="0" tIns="0" rIns="0" bIns="0" rtlCol="0">
            <a:spAutoFit/>
          </a:bodyPr>
          <a:lstStyle/>
          <a:p>
            <a:pPr marL="440690" marR="74930" indent="-358140" algn="ctr">
              <a:lnSpc>
                <a:spcPts val="3900"/>
              </a:lnSpc>
            </a:pPr>
            <a:r>
              <a:rPr sz="2800">
                <a:latin typeface="Helvetica"/>
                <a:cs typeface="Helvetica"/>
              </a:rPr>
              <a:t>Osteogenesis</a:t>
            </a:r>
            <a:r>
              <a:rPr lang="en-US" sz="2800">
                <a:latin typeface="Helvetica"/>
                <a:cs typeface="Helvetica"/>
              </a:rPr>
              <a:t> </a:t>
            </a:r>
            <a:r>
              <a:rPr sz="2800">
                <a:latin typeface="Helvetica"/>
                <a:cs typeface="Helvetica"/>
              </a:rPr>
              <a:t>imperfecta</a:t>
            </a:r>
          </a:p>
        </p:txBody>
      </p:sp>
      <p:sp>
        <p:nvSpPr>
          <p:cNvPr id="32" name="object 5">
            <a:extLst>
              <a:ext uri="{FF2B5EF4-FFF2-40B4-BE49-F238E27FC236}">
                <a16:creationId xmlns:a16="http://schemas.microsoft.com/office/drawing/2014/main" id="{8FEA69AA-3BBD-9DA6-64F1-2C22D7D8E7DC}"/>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AA52CBE8-5F23-31B1-D60C-0D0C1B74C4AF}"/>
              </a:ext>
            </a:extLst>
          </p:cNvPr>
          <p:cNvSpPr txBox="1"/>
          <p:nvPr/>
        </p:nvSpPr>
        <p:spPr>
          <a:xfrm>
            <a:off x="4114800" y="3133587"/>
            <a:ext cx="3200400" cy="861774"/>
          </a:xfrm>
          <a:prstGeom prst="rect">
            <a:avLst/>
          </a:prstGeom>
          <a:ln w="6350">
            <a:noFill/>
          </a:ln>
        </p:spPr>
        <p:txBody>
          <a:bodyPr vert="horz" wrap="square" lIns="0" tIns="0" rIns="0" bIns="0" rtlCol="0">
            <a:spAutoFit/>
          </a:bodyPr>
          <a:lstStyle/>
          <a:p>
            <a:pPr marL="109855" marR="102870" indent="114300" algn="ctr"/>
            <a:r>
              <a:rPr sz="2800">
                <a:latin typeface="Helvetica"/>
                <a:cs typeface="Helvetica"/>
              </a:rPr>
              <a:t>Myotonic dystrophy</a:t>
            </a:r>
          </a:p>
        </p:txBody>
      </p:sp>
      <p:sp>
        <p:nvSpPr>
          <p:cNvPr id="36" name="object 9">
            <a:extLst>
              <a:ext uri="{FF2B5EF4-FFF2-40B4-BE49-F238E27FC236}">
                <a16:creationId xmlns:a16="http://schemas.microsoft.com/office/drawing/2014/main" id="{118B49BF-51A4-C282-92DF-C04D9E6224D0}"/>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DA4EF882-54B9-9607-BF55-A29AEC6C2EB0}"/>
              </a:ext>
            </a:extLst>
          </p:cNvPr>
          <p:cNvSpPr txBox="1"/>
          <p:nvPr/>
        </p:nvSpPr>
        <p:spPr>
          <a:xfrm>
            <a:off x="4114800" y="5500980"/>
            <a:ext cx="3200400" cy="678071"/>
          </a:xfrm>
          <a:prstGeom prst="rect">
            <a:avLst/>
          </a:prstGeom>
          <a:ln w="6350">
            <a:noFill/>
          </a:ln>
        </p:spPr>
        <p:txBody>
          <a:bodyPr vert="horz" wrap="square" lIns="0" tIns="0" rIns="0" bIns="0" rtlCol="0">
            <a:spAutoFit/>
          </a:bodyPr>
          <a:lstStyle/>
          <a:p>
            <a:pPr marL="86995" marR="79375" indent="436880">
              <a:lnSpc>
                <a:spcPts val="6200"/>
              </a:lnSpc>
            </a:pPr>
            <a:r>
              <a:rPr sz="2800">
                <a:latin typeface="Helvetica"/>
                <a:cs typeface="Helvetica"/>
              </a:rPr>
              <a:t>Ewing sarcoma</a:t>
            </a:r>
          </a:p>
        </p:txBody>
      </p:sp>
      <p:sp>
        <p:nvSpPr>
          <p:cNvPr id="40" name="object 14">
            <a:extLst>
              <a:ext uri="{FF2B5EF4-FFF2-40B4-BE49-F238E27FC236}">
                <a16:creationId xmlns:a16="http://schemas.microsoft.com/office/drawing/2014/main" id="{D93A8445-D74E-BCE7-D033-97EC33C62F58}"/>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44C61D5C-3176-C139-5862-958087D814C5}"/>
              </a:ext>
            </a:extLst>
          </p:cNvPr>
          <p:cNvSpPr txBox="1"/>
          <p:nvPr/>
        </p:nvSpPr>
        <p:spPr>
          <a:xfrm>
            <a:off x="4114800" y="7792908"/>
            <a:ext cx="3200400" cy="678071"/>
          </a:xfrm>
          <a:prstGeom prst="rect">
            <a:avLst/>
          </a:prstGeom>
          <a:ln w="6350">
            <a:noFill/>
          </a:ln>
        </p:spPr>
        <p:txBody>
          <a:bodyPr vert="horz" wrap="square" lIns="0" tIns="0" rIns="0" bIns="0" rtlCol="0">
            <a:spAutoFit/>
          </a:bodyPr>
          <a:lstStyle/>
          <a:p>
            <a:pPr marL="86995" marR="79375" indent="153035">
              <a:lnSpc>
                <a:spcPts val="6200"/>
              </a:lnSpc>
            </a:pPr>
            <a:r>
              <a:rPr sz="2800">
                <a:latin typeface="Helvetica"/>
                <a:cs typeface="Helvetica"/>
              </a:rPr>
              <a:t>Osteoid osteoma</a:t>
            </a:r>
          </a:p>
        </p:txBody>
      </p:sp>
      <p:sp>
        <p:nvSpPr>
          <p:cNvPr id="44" name="object 19">
            <a:extLst>
              <a:ext uri="{FF2B5EF4-FFF2-40B4-BE49-F238E27FC236}">
                <a16:creationId xmlns:a16="http://schemas.microsoft.com/office/drawing/2014/main" id="{D822E3CB-386A-24F3-5D53-9B8C44EA04BD}"/>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29EE3AA9-B50D-A07F-2F25-5AE3EAE7D24F}"/>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DF723855-A96A-DF99-796C-A19A8BD82161}"/>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46C3F68D-45AF-C306-6647-77E14FF0C47D}"/>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78FE9172-BBF9-624A-5F59-F8687ADECE19}"/>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E4045289-C4E1-1A3B-C278-50CA4BA93EEF}"/>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C52F4A03-287A-9430-2B41-61664B10484C}"/>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92F9B11C-BABF-E47F-DEB7-34ECF9F324EB}"/>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86385373-276F-18D4-D0FF-F0515487C9D8}"/>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846659"/>
          </a:xfrm>
          <a:prstGeom prst="rect">
            <a:avLst/>
          </a:prstGeom>
          <a:ln w="6350">
            <a:solidFill>
              <a:schemeClr val="bg1"/>
            </a:solidFill>
          </a:ln>
        </p:spPr>
        <p:txBody>
          <a:bodyPr vert="horz" wrap="square" lIns="0" tIns="0" rIns="0" bIns="0" rtlCol="0" anchor="t">
            <a:spAutoFit/>
          </a:bodyPr>
          <a:lstStyle/>
          <a:p>
            <a:pPr marL="106045" marR="98425" algn="ctr">
              <a:lnSpc>
                <a:spcPts val="2400"/>
              </a:lnSpc>
            </a:pPr>
            <a:r>
              <a:rPr sz="2400">
                <a:latin typeface="Helvetica"/>
                <a:cs typeface="Helvetica"/>
              </a:rPr>
              <a:t>65yo M with </a:t>
            </a:r>
            <a:r>
              <a:rPr lang="en-US" sz="2400">
                <a:latin typeface="Helvetica"/>
                <a:cs typeface="Helvetica"/>
              </a:rPr>
              <a:t>Lower back pain </a:t>
            </a:r>
            <a:r>
              <a:rPr sz="2400">
                <a:latin typeface="Helvetica"/>
                <a:cs typeface="Helvetica"/>
              </a:rPr>
              <a:t>radiating to buttock. Feels better when pushing shopping cart (bending forward)</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943100"/>
          </a:xfrm>
          <a:prstGeom prst="rect">
            <a:avLst/>
          </a:prstGeom>
          <a:ln w="6350">
            <a:solidFill>
              <a:schemeClr val="bg1"/>
            </a:solidFill>
          </a:ln>
        </p:spPr>
        <p:txBody>
          <a:bodyPr vert="horz" wrap="square" lIns="0" tIns="0" rIns="0" bIns="0" rtlCol="0">
            <a:spAutoFit/>
          </a:bodyPr>
          <a:lstStyle/>
          <a:p>
            <a:pPr marL="199390" marR="191770" algn="ctr">
              <a:lnSpc>
                <a:spcPts val="2200"/>
              </a:lnSpc>
            </a:pPr>
            <a:r>
              <a:rPr sz="2200">
                <a:latin typeface="Helvetica"/>
                <a:cs typeface="Helvetica"/>
              </a:rPr>
              <a:t>64yo with chronic R lateral shoulder pain, worse with activity and sleeping on it. Limited ROM. +empty can test</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943100"/>
          </a:xfrm>
          <a:prstGeom prst="rect">
            <a:avLst/>
          </a:prstGeom>
          <a:ln w="6350">
            <a:solidFill>
              <a:schemeClr val="bg1"/>
            </a:solidFill>
          </a:ln>
        </p:spPr>
        <p:txBody>
          <a:bodyPr vert="horz" wrap="square" lIns="0" tIns="0" rIns="0" bIns="0" rtlCol="0">
            <a:spAutoFit/>
          </a:bodyPr>
          <a:lstStyle/>
          <a:p>
            <a:pPr marL="114300" marR="106680" algn="ctr">
              <a:lnSpc>
                <a:spcPts val="2400"/>
              </a:lnSpc>
            </a:pPr>
            <a:r>
              <a:rPr sz="2400">
                <a:latin typeface="Helvetica"/>
                <a:cs typeface="Helvetica"/>
              </a:rPr>
              <a:t>30yo man with acute right shoulder pain after a fall. Pain at top of shoulder, worse with cross body reach</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74900"/>
          </a:xfrm>
          <a:prstGeom prst="rect">
            <a:avLst/>
          </a:prstGeom>
          <a:ln w="6350">
            <a:solidFill>
              <a:schemeClr val="bg1"/>
            </a:solidFill>
          </a:ln>
        </p:spPr>
        <p:txBody>
          <a:bodyPr vert="horz" wrap="square" lIns="0" tIns="0" rIns="0" bIns="0" rtlCol="0" anchor="t">
            <a:spAutoFit/>
          </a:bodyPr>
          <a:lstStyle/>
          <a:p>
            <a:pPr marL="354330" marR="346710" algn="ctr">
              <a:lnSpc>
                <a:spcPts val="2200"/>
              </a:lnSpc>
            </a:pPr>
            <a:r>
              <a:rPr sz="2200">
                <a:latin typeface="Helvetica"/>
                <a:cs typeface="Helvetica"/>
              </a:rPr>
              <a:t>40yo F with lateral elbow pain, </a:t>
            </a:r>
            <a:r>
              <a:rPr lang="en-US" sz="2200">
                <a:latin typeface="Helvetica"/>
                <a:cs typeface="Helvetica"/>
              </a:rPr>
              <a:t>Tender to palpation </a:t>
            </a:r>
            <a:r>
              <a:rPr sz="2200">
                <a:latin typeface="Helvetica"/>
                <a:cs typeface="Helvetica"/>
              </a:rPr>
              <a:t>overlying lateral epicondyle and pain with resisted wrist extension</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6508C7AA-CD5C-5994-4814-7B95FA36BCDA}"/>
              </a:ext>
            </a:extLst>
          </p:cNvPr>
          <p:cNvSpPr txBox="1"/>
          <p:nvPr/>
        </p:nvSpPr>
        <p:spPr>
          <a:xfrm>
            <a:off x="4114800" y="457200"/>
            <a:ext cx="3200400" cy="620363"/>
          </a:xfrm>
          <a:prstGeom prst="rect">
            <a:avLst/>
          </a:prstGeom>
          <a:ln w="6350">
            <a:noFill/>
          </a:ln>
        </p:spPr>
        <p:txBody>
          <a:bodyPr vert="horz" wrap="square" lIns="0" tIns="0" rIns="0" bIns="0" rtlCol="0">
            <a:spAutoFit/>
          </a:bodyPr>
          <a:lstStyle/>
          <a:p>
            <a:pPr marL="391160" marR="106680" indent="-277495" algn="ctr">
              <a:lnSpc>
                <a:spcPts val="5600"/>
              </a:lnSpc>
            </a:pPr>
            <a:r>
              <a:rPr sz="2800">
                <a:latin typeface="Helvetica"/>
                <a:cs typeface="Helvetica"/>
              </a:rPr>
              <a:t>Scaphoid fracture</a:t>
            </a:r>
          </a:p>
        </p:txBody>
      </p:sp>
      <p:sp>
        <p:nvSpPr>
          <p:cNvPr id="32" name="object 5">
            <a:extLst>
              <a:ext uri="{FF2B5EF4-FFF2-40B4-BE49-F238E27FC236}">
                <a16:creationId xmlns:a16="http://schemas.microsoft.com/office/drawing/2014/main" id="{3C524506-6709-EBA1-104A-D25B0F9AEDFF}"/>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4DACC92D-A471-5317-945C-E76539D601BD}"/>
              </a:ext>
            </a:extLst>
          </p:cNvPr>
          <p:cNvSpPr txBox="1"/>
          <p:nvPr/>
        </p:nvSpPr>
        <p:spPr>
          <a:xfrm>
            <a:off x="4114800" y="2916494"/>
            <a:ext cx="3200400" cy="1091646"/>
          </a:xfrm>
          <a:prstGeom prst="rect">
            <a:avLst/>
          </a:prstGeom>
          <a:ln w="6350">
            <a:noFill/>
          </a:ln>
        </p:spPr>
        <p:txBody>
          <a:bodyPr vert="horz" wrap="square" lIns="0" tIns="0" rIns="0" bIns="0" rtlCol="0">
            <a:spAutoFit/>
          </a:bodyPr>
          <a:lstStyle/>
          <a:p>
            <a:pPr marL="167005" marR="73660" indent="-86360" algn="ctr">
              <a:lnSpc>
                <a:spcPts val="4500"/>
              </a:lnSpc>
            </a:pPr>
            <a:r>
              <a:rPr sz="2800">
                <a:latin typeface="Helvetica"/>
                <a:cs typeface="Helvetica"/>
              </a:rPr>
              <a:t>Dupuytren's contracture</a:t>
            </a:r>
          </a:p>
        </p:txBody>
      </p:sp>
      <p:sp>
        <p:nvSpPr>
          <p:cNvPr id="36" name="object 9">
            <a:extLst>
              <a:ext uri="{FF2B5EF4-FFF2-40B4-BE49-F238E27FC236}">
                <a16:creationId xmlns:a16="http://schemas.microsoft.com/office/drawing/2014/main" id="{2111DF97-F555-F705-F983-5A1FF737FC30}"/>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3605EDDA-9090-92AF-0EF1-3862668E2704}"/>
              </a:ext>
            </a:extLst>
          </p:cNvPr>
          <p:cNvSpPr txBox="1"/>
          <p:nvPr/>
        </p:nvSpPr>
        <p:spPr>
          <a:xfrm>
            <a:off x="4267200" y="5257800"/>
            <a:ext cx="3048000" cy="912109"/>
          </a:xfrm>
          <a:prstGeom prst="rect">
            <a:avLst/>
          </a:prstGeom>
          <a:ln w="6350">
            <a:noFill/>
          </a:ln>
        </p:spPr>
        <p:txBody>
          <a:bodyPr vert="horz" wrap="square" lIns="0" tIns="0" rIns="0" bIns="0" rtlCol="0">
            <a:spAutoFit/>
          </a:bodyPr>
          <a:lstStyle/>
          <a:p>
            <a:pPr marL="1022350" marR="87630" indent="-927100">
              <a:lnSpc>
                <a:spcPts val="3700"/>
              </a:lnSpc>
              <a:tabLst>
                <a:tab pos="1544320" algn="l"/>
              </a:tabLst>
            </a:pPr>
            <a:r>
              <a:rPr sz="2800">
                <a:latin typeface="Helvetica"/>
                <a:cs typeface="Helvetica"/>
              </a:rPr>
              <a:t>Osteonecrosis o</a:t>
            </a:r>
            <a:r>
              <a:rPr lang="en-US" sz="2800">
                <a:latin typeface="Helvetica"/>
                <a:cs typeface="Helvetica"/>
              </a:rPr>
              <a:t>f </a:t>
            </a:r>
            <a:r>
              <a:rPr sz="2800">
                <a:latin typeface="Helvetica"/>
                <a:cs typeface="Helvetica"/>
              </a:rPr>
              <a:t>hip</a:t>
            </a:r>
          </a:p>
        </p:txBody>
      </p:sp>
      <p:sp>
        <p:nvSpPr>
          <p:cNvPr id="40" name="object 14">
            <a:extLst>
              <a:ext uri="{FF2B5EF4-FFF2-40B4-BE49-F238E27FC236}">
                <a16:creationId xmlns:a16="http://schemas.microsoft.com/office/drawing/2014/main" id="{2D224EE8-C787-AD41-97DD-89D29C386C41}"/>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5234BCC9-BD0A-6BC6-DE7A-3349D67DBE78}"/>
              </a:ext>
            </a:extLst>
          </p:cNvPr>
          <p:cNvSpPr txBox="1"/>
          <p:nvPr/>
        </p:nvSpPr>
        <p:spPr>
          <a:xfrm>
            <a:off x="4114800" y="7658100"/>
            <a:ext cx="3200400" cy="1046761"/>
          </a:xfrm>
          <a:prstGeom prst="rect">
            <a:avLst/>
          </a:prstGeom>
          <a:ln w="6350">
            <a:noFill/>
          </a:ln>
        </p:spPr>
        <p:txBody>
          <a:bodyPr vert="horz" wrap="square" lIns="0" tIns="0" rIns="0" bIns="0" rtlCol="0">
            <a:spAutoFit/>
          </a:bodyPr>
          <a:lstStyle/>
          <a:p>
            <a:pPr marL="109220" marR="101600" indent="440055" algn="ctr">
              <a:lnSpc>
                <a:spcPts val="4300"/>
              </a:lnSpc>
            </a:pPr>
            <a:r>
              <a:rPr sz="2800">
                <a:latin typeface="Helvetica"/>
                <a:cs typeface="Helvetica"/>
              </a:rPr>
              <a:t>Meralgia paresthetica</a:t>
            </a:r>
          </a:p>
        </p:txBody>
      </p:sp>
      <p:sp>
        <p:nvSpPr>
          <p:cNvPr id="44" name="object 19">
            <a:extLst>
              <a:ext uri="{FF2B5EF4-FFF2-40B4-BE49-F238E27FC236}">
                <a16:creationId xmlns:a16="http://schemas.microsoft.com/office/drawing/2014/main" id="{78DF50DE-CFC3-F5EB-DFC0-990576776727}"/>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D882FB8F-859B-8D49-3834-18F5D0EC2800}"/>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63425ACD-990F-BB49-7538-FDE6A0E4E997}"/>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524879EC-58D4-C85C-EF13-86FD7B90A752}"/>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DFE32BAE-BE87-88ED-B993-CDFEDF15EB64}"/>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32D210C6-E268-4772-92F3-4AD51DCE2FA5}"/>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DBF48109-2026-ED61-9E03-FCC6BFEF8382}"/>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8AC5C1DE-1243-B549-9BED-DF71267BA78E}"/>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8E04D54B-0934-BCD0-7381-CE4426365957}"/>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398207"/>
            <a:ext cx="3200400" cy="1263231"/>
          </a:xfrm>
          <a:prstGeom prst="rect">
            <a:avLst/>
          </a:prstGeom>
          <a:ln w="6350">
            <a:noFill/>
          </a:ln>
        </p:spPr>
        <p:txBody>
          <a:bodyPr vert="horz" wrap="square" lIns="0" tIns="0" rIns="0" bIns="0" rtlCol="0">
            <a:spAutoFit/>
          </a:bodyPr>
          <a:lstStyle/>
          <a:p>
            <a:pPr marL="408305" marR="400685" indent="-635" algn="ctr">
              <a:lnSpc>
                <a:spcPts val="3400"/>
              </a:lnSpc>
            </a:pPr>
            <a:r>
              <a:rPr sz="2200">
                <a:latin typeface="Helvetica"/>
                <a:cs typeface="Helvetica"/>
              </a:rPr>
              <a:t>14yo fell on outstretched arm, pain in snuffbox</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923867"/>
            <a:ext cx="3200400" cy="1538883"/>
          </a:xfrm>
          <a:prstGeom prst="rect">
            <a:avLst/>
          </a:prstGeom>
          <a:ln w="6350">
            <a:noFill/>
          </a:ln>
        </p:spPr>
        <p:txBody>
          <a:bodyPr vert="horz" wrap="square" lIns="0" tIns="0" rIns="0" bIns="0" rtlCol="0">
            <a:spAutoFit/>
          </a:bodyPr>
          <a:lstStyle/>
          <a:p>
            <a:pPr marL="147955" marR="140335" indent="-635" algn="ctr">
              <a:lnSpc>
                <a:spcPts val="2400"/>
              </a:lnSpc>
            </a:pPr>
            <a:r>
              <a:rPr sz="2200">
                <a:latin typeface="Helvetica"/>
                <a:cs typeface="Helvetica"/>
              </a:rPr>
              <a:t>60yo M with gradual onset of loss of finger extension. Has painless nodularity of palmar fascia</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538883"/>
          </a:xfrm>
          <a:prstGeom prst="rect">
            <a:avLst/>
          </a:prstGeom>
          <a:ln w="6350">
            <a:noFill/>
          </a:ln>
        </p:spPr>
        <p:txBody>
          <a:bodyPr vert="horz" wrap="square" lIns="0" tIns="0" rIns="0" bIns="0" rtlCol="0" anchor="t">
            <a:spAutoFit/>
          </a:bodyPr>
          <a:lstStyle/>
          <a:p>
            <a:pPr marL="97155" marR="89535" algn="ctr">
              <a:lnSpc>
                <a:spcPts val="2400"/>
              </a:lnSpc>
            </a:pPr>
            <a:r>
              <a:rPr sz="2200">
                <a:latin typeface="Helvetica"/>
                <a:cs typeface="Helvetica"/>
              </a:rPr>
              <a:t>36yo M with anterior groin pain. h/o chronic glucocorticoid use.</a:t>
            </a:r>
            <a:r>
              <a:rPr lang="en-US" sz="2200">
                <a:latin typeface="Helvetica"/>
                <a:cs typeface="Helvetica"/>
              </a:rPr>
              <a:t> </a:t>
            </a:r>
            <a:r>
              <a:rPr sz="2200">
                <a:latin typeface="Helvetica"/>
                <a:cs typeface="Helvetica"/>
              </a:rPr>
              <a:t>Pain </a:t>
            </a:r>
            <a:r>
              <a:rPr lang="en-US" sz="2200">
                <a:latin typeface="Helvetica"/>
                <a:cs typeface="Helvetica"/>
              </a:rPr>
              <a:t>with range of motion </a:t>
            </a:r>
            <a:r>
              <a:rPr sz="2200">
                <a:latin typeface="Helvetica"/>
                <a:cs typeface="Helvetica"/>
              </a:rPr>
              <a:t>all directions</a:t>
            </a:r>
            <a:endParaRPr lang="en-US"/>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051635"/>
          </a:xfrm>
          <a:prstGeom prst="rect">
            <a:avLst/>
          </a:prstGeom>
          <a:ln w="6350">
            <a:noFill/>
          </a:ln>
        </p:spPr>
        <p:txBody>
          <a:bodyPr vert="horz" wrap="square" lIns="0" tIns="0" rIns="0" bIns="0" rtlCol="0">
            <a:spAutoFit/>
          </a:bodyPr>
          <a:lstStyle/>
          <a:p>
            <a:pPr marL="104775" marR="97155" algn="ctr">
              <a:lnSpc>
                <a:spcPts val="2800"/>
              </a:lnSpc>
            </a:pPr>
            <a:r>
              <a:rPr sz="2200">
                <a:latin typeface="Helvetica"/>
                <a:cs typeface="Helvetica"/>
              </a:rPr>
              <a:t>59yo with localized numbness on anterior thigh, no other findings</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DEEC29EA-276A-5A5E-2D9C-D8BD182F7C6F}"/>
              </a:ext>
            </a:extLst>
          </p:cNvPr>
          <p:cNvSpPr txBox="1"/>
          <p:nvPr/>
        </p:nvSpPr>
        <p:spPr>
          <a:xfrm>
            <a:off x="4114800" y="523344"/>
            <a:ext cx="3200400" cy="697307"/>
          </a:xfrm>
          <a:prstGeom prst="rect">
            <a:avLst/>
          </a:prstGeom>
          <a:ln w="6350">
            <a:noFill/>
          </a:ln>
        </p:spPr>
        <p:txBody>
          <a:bodyPr vert="horz" wrap="square" lIns="0" tIns="0" rIns="0" bIns="0" rtlCol="0">
            <a:spAutoFit/>
          </a:bodyPr>
          <a:lstStyle/>
          <a:p>
            <a:pPr marL="106045" marR="98425" indent="361315">
              <a:lnSpc>
                <a:spcPts val="6400"/>
              </a:lnSpc>
            </a:pPr>
            <a:r>
              <a:rPr sz="2800">
                <a:latin typeface="Helvetica"/>
                <a:cs typeface="Helvetica"/>
              </a:rPr>
              <a:t>Spinal stenosis</a:t>
            </a:r>
          </a:p>
        </p:txBody>
      </p:sp>
      <p:sp>
        <p:nvSpPr>
          <p:cNvPr id="32" name="object 5">
            <a:extLst>
              <a:ext uri="{FF2B5EF4-FFF2-40B4-BE49-F238E27FC236}">
                <a16:creationId xmlns:a16="http://schemas.microsoft.com/office/drawing/2014/main" id="{EA1EF86D-7C71-CE80-EA27-E07D5EB96990}"/>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0A19ED50-3051-8D2C-DB92-DB59AA778647}"/>
              </a:ext>
            </a:extLst>
          </p:cNvPr>
          <p:cNvSpPr txBox="1"/>
          <p:nvPr/>
        </p:nvSpPr>
        <p:spPr>
          <a:xfrm>
            <a:off x="4114800" y="2857500"/>
            <a:ext cx="3200400" cy="716543"/>
          </a:xfrm>
          <a:prstGeom prst="rect">
            <a:avLst/>
          </a:prstGeom>
          <a:ln w="6350">
            <a:noFill/>
          </a:ln>
        </p:spPr>
        <p:txBody>
          <a:bodyPr vert="horz" wrap="square" lIns="0" tIns="0" rIns="0" bIns="0" rtlCol="0">
            <a:spAutoFit/>
          </a:bodyPr>
          <a:lstStyle/>
          <a:p>
            <a:pPr marL="82550" marR="74930" indent="139700" algn="ctr">
              <a:lnSpc>
                <a:spcPts val="6600"/>
              </a:lnSpc>
              <a:tabLst>
                <a:tab pos="1666875" algn="l"/>
              </a:tabLst>
            </a:pPr>
            <a:r>
              <a:rPr sz="2800">
                <a:latin typeface="Helvetica"/>
                <a:cs typeface="Helvetica"/>
              </a:rPr>
              <a:t>Rotator cuf</a:t>
            </a:r>
            <a:r>
              <a:rPr lang="en-US" sz="2800">
                <a:latin typeface="Helvetica"/>
                <a:cs typeface="Helvetica"/>
              </a:rPr>
              <a:t>f </a:t>
            </a:r>
            <a:r>
              <a:rPr sz="2800">
                <a:latin typeface="Helvetica"/>
                <a:cs typeface="Helvetica"/>
              </a:rPr>
              <a:t>tear</a:t>
            </a:r>
          </a:p>
        </p:txBody>
      </p:sp>
      <p:sp>
        <p:nvSpPr>
          <p:cNvPr id="36" name="object 9">
            <a:extLst>
              <a:ext uri="{FF2B5EF4-FFF2-40B4-BE49-F238E27FC236}">
                <a16:creationId xmlns:a16="http://schemas.microsoft.com/office/drawing/2014/main" id="{5C287E1F-5F19-F930-33BF-31CD5DFBB073}"/>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55DA27D4-F93E-B02B-F414-E5665DB5CEE5}"/>
              </a:ext>
            </a:extLst>
          </p:cNvPr>
          <p:cNvSpPr txBox="1"/>
          <p:nvPr/>
        </p:nvSpPr>
        <p:spPr>
          <a:xfrm>
            <a:off x="4114800" y="5257800"/>
            <a:ext cx="3200400" cy="861774"/>
          </a:xfrm>
          <a:prstGeom prst="rect">
            <a:avLst/>
          </a:prstGeom>
          <a:ln w="6350">
            <a:noFill/>
          </a:ln>
        </p:spPr>
        <p:txBody>
          <a:bodyPr vert="horz" wrap="square" lIns="0" tIns="0" rIns="0" bIns="0" rtlCol="0">
            <a:spAutoFit/>
          </a:bodyPr>
          <a:lstStyle/>
          <a:p>
            <a:pPr marL="84455" marR="76835" indent="377825" algn="ctr">
              <a:tabLst>
                <a:tab pos="1542415" algn="l"/>
              </a:tabLst>
            </a:pPr>
            <a:r>
              <a:rPr lang="en-US" sz="2800">
                <a:latin typeface="Helvetica"/>
                <a:cs typeface="Helvetica"/>
              </a:rPr>
              <a:t>AC                Joint Separation</a:t>
            </a:r>
            <a:endParaRPr sz="2800">
              <a:latin typeface="Helvetica"/>
              <a:cs typeface="Helvetica"/>
            </a:endParaRPr>
          </a:p>
        </p:txBody>
      </p:sp>
      <p:sp>
        <p:nvSpPr>
          <p:cNvPr id="40" name="object 14">
            <a:extLst>
              <a:ext uri="{FF2B5EF4-FFF2-40B4-BE49-F238E27FC236}">
                <a16:creationId xmlns:a16="http://schemas.microsoft.com/office/drawing/2014/main" id="{B05CCC0A-4379-1099-D81B-4821CEBB429B}"/>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59856FFD-5B2F-70D1-52E8-71D2471FBB4F}"/>
              </a:ext>
            </a:extLst>
          </p:cNvPr>
          <p:cNvSpPr txBox="1"/>
          <p:nvPr/>
        </p:nvSpPr>
        <p:spPr>
          <a:xfrm>
            <a:off x="4114800" y="7658100"/>
            <a:ext cx="3200400" cy="1046761"/>
          </a:xfrm>
          <a:prstGeom prst="rect">
            <a:avLst/>
          </a:prstGeom>
          <a:ln w="6350">
            <a:noFill/>
          </a:ln>
        </p:spPr>
        <p:txBody>
          <a:bodyPr vert="horz" wrap="square" lIns="0" tIns="0" rIns="0" bIns="0" rtlCol="0">
            <a:spAutoFit/>
          </a:bodyPr>
          <a:lstStyle/>
          <a:p>
            <a:pPr marL="109855" marR="102235" indent="652145" algn="ctr">
              <a:lnSpc>
                <a:spcPts val="4300"/>
              </a:lnSpc>
            </a:pPr>
            <a:r>
              <a:rPr sz="2800">
                <a:latin typeface="Helvetica"/>
                <a:cs typeface="Helvetica"/>
              </a:rPr>
              <a:t>Lateral epicondylitis</a:t>
            </a:r>
          </a:p>
        </p:txBody>
      </p:sp>
      <p:sp>
        <p:nvSpPr>
          <p:cNvPr id="44" name="object 19">
            <a:extLst>
              <a:ext uri="{FF2B5EF4-FFF2-40B4-BE49-F238E27FC236}">
                <a16:creationId xmlns:a16="http://schemas.microsoft.com/office/drawing/2014/main" id="{99FEFFA9-D063-B0D7-7665-BE5E05A485BC}"/>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8BCE7945-4024-0C42-E4B8-1834C9EAE951}"/>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E919025F-375A-9136-E880-A046BA2DD1B2}"/>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89BD01BB-363D-CE14-98DA-03C85B927C08}"/>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83FBB9AF-4851-0464-9289-86558C53DBE3}"/>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F0378820-BADD-6C8B-1993-0DCCF2CA95CE}"/>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6ABF3366-8172-F6C9-B8BD-4D55C7C6BAC6}"/>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87784FB5-E30E-268F-383D-A1B4C2CFE906}"/>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0233B816-1FB5-4480-2BC0-7F9656D47997}"/>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943100"/>
          </a:xfrm>
          <a:prstGeom prst="rect">
            <a:avLst/>
          </a:prstGeom>
          <a:ln w="6350">
            <a:noFill/>
          </a:ln>
        </p:spPr>
        <p:txBody>
          <a:bodyPr vert="horz" wrap="square" lIns="0" tIns="0" rIns="0" bIns="0" rtlCol="0">
            <a:spAutoFit/>
          </a:bodyPr>
          <a:lstStyle/>
          <a:p>
            <a:pPr marL="137160" marR="130175" algn="ctr">
              <a:lnSpc>
                <a:spcPts val="2200"/>
              </a:lnSpc>
            </a:pPr>
            <a:r>
              <a:rPr sz="2200">
                <a:latin typeface="Helvetica"/>
                <a:cs typeface="Helvetica"/>
              </a:rPr>
              <a:t>25yo F with anterior knee pain worst when going up stairs. Pain with palpation to patella and with moving patella</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943100"/>
          </a:xfrm>
          <a:prstGeom prst="rect">
            <a:avLst/>
          </a:prstGeom>
          <a:ln w="6350">
            <a:noFill/>
          </a:ln>
        </p:spPr>
        <p:txBody>
          <a:bodyPr vert="horz" wrap="square" lIns="0" tIns="0" rIns="0" bIns="0" rtlCol="0">
            <a:spAutoFit/>
          </a:bodyPr>
          <a:lstStyle/>
          <a:p>
            <a:pPr marL="144780" marR="137160" algn="ctr">
              <a:lnSpc>
                <a:spcPts val="2200"/>
              </a:lnSpc>
            </a:pPr>
            <a:r>
              <a:rPr sz="2200">
                <a:latin typeface="Helvetica"/>
                <a:cs typeface="Helvetica"/>
              </a:rPr>
              <a:t>22yo with rotational injury then gradually increasing pain/stiff. "catching/locking" pain along joint line and with deep squatting</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538883"/>
          </a:xfrm>
          <a:prstGeom prst="rect">
            <a:avLst/>
          </a:prstGeom>
          <a:ln w="6350">
            <a:noFill/>
          </a:ln>
        </p:spPr>
        <p:txBody>
          <a:bodyPr vert="horz" wrap="square" lIns="0" tIns="0" rIns="0" bIns="0" rtlCol="0">
            <a:spAutoFit/>
          </a:bodyPr>
          <a:lstStyle/>
          <a:p>
            <a:pPr marL="207645" marR="200025" algn="ctr">
              <a:lnSpc>
                <a:spcPts val="2400"/>
              </a:lnSpc>
            </a:pPr>
            <a:r>
              <a:rPr sz="2200">
                <a:latin typeface="Helvetica"/>
                <a:cs typeface="Helvetica"/>
              </a:rPr>
              <a:t>30yo with acute pain after trauma from stop/twist motion.</a:t>
            </a:r>
          </a:p>
          <a:p>
            <a:pPr marL="150495" marR="142240" algn="ctr">
              <a:lnSpc>
                <a:spcPts val="2400"/>
              </a:lnSpc>
            </a:pPr>
            <a:r>
              <a:rPr sz="2200">
                <a:latin typeface="Helvetica"/>
                <a:cs typeface="Helvetica"/>
              </a:rPr>
              <a:t>Initial "pop" now feels unstable. +effusion</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43100"/>
          </a:xfrm>
          <a:prstGeom prst="rect">
            <a:avLst/>
          </a:prstGeom>
          <a:ln w="6350">
            <a:noFill/>
          </a:ln>
        </p:spPr>
        <p:txBody>
          <a:bodyPr vert="horz" wrap="square" lIns="0" tIns="0" rIns="0" bIns="0" rtlCol="0">
            <a:spAutoFit/>
          </a:bodyPr>
          <a:lstStyle/>
          <a:p>
            <a:pPr marL="98425" marR="90805" algn="ctr">
              <a:lnSpc>
                <a:spcPts val="2200"/>
              </a:lnSpc>
            </a:pPr>
            <a:r>
              <a:rPr sz="2200">
                <a:latin typeface="Helvetica"/>
                <a:cs typeface="Helvetica"/>
              </a:rPr>
              <a:t>27yo with trauma to shin/tibia resulting in knee pain, joint instability. Pain with ROM. +effusion, tibia can displace posteriorly.</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597F7069-7C69-F6D4-6FDA-29EFFE9E05C4}"/>
              </a:ext>
            </a:extLst>
          </p:cNvPr>
          <p:cNvSpPr txBox="1"/>
          <p:nvPr/>
        </p:nvSpPr>
        <p:spPr>
          <a:xfrm>
            <a:off x="4114800" y="754269"/>
            <a:ext cx="3200400" cy="553037"/>
          </a:xfrm>
          <a:prstGeom prst="rect">
            <a:avLst/>
          </a:prstGeom>
          <a:ln w="6350">
            <a:noFill/>
          </a:ln>
        </p:spPr>
        <p:txBody>
          <a:bodyPr vert="horz" wrap="square" lIns="0" tIns="0" rIns="0" bIns="0" rtlCol="0">
            <a:spAutoFit/>
          </a:bodyPr>
          <a:lstStyle/>
          <a:p>
            <a:pPr marL="611505" marR="84455" indent="-519430">
              <a:lnSpc>
                <a:spcPts val="4900"/>
              </a:lnSpc>
            </a:pPr>
            <a:r>
              <a:rPr sz="2800">
                <a:latin typeface="Helvetica"/>
                <a:cs typeface="Helvetica"/>
              </a:rPr>
              <a:t>Prepatellar bursitis</a:t>
            </a:r>
          </a:p>
        </p:txBody>
      </p:sp>
      <p:sp>
        <p:nvSpPr>
          <p:cNvPr id="32" name="object 5">
            <a:extLst>
              <a:ext uri="{FF2B5EF4-FFF2-40B4-BE49-F238E27FC236}">
                <a16:creationId xmlns:a16="http://schemas.microsoft.com/office/drawing/2014/main" id="{56CDD517-EFCA-A232-F41C-EF8BCF599D56}"/>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05A2A92C-7950-941B-1FD8-31B2C8009569}"/>
              </a:ext>
            </a:extLst>
          </p:cNvPr>
          <p:cNvSpPr txBox="1"/>
          <p:nvPr/>
        </p:nvSpPr>
        <p:spPr>
          <a:xfrm>
            <a:off x="4114800" y="2857500"/>
            <a:ext cx="3200400" cy="745397"/>
          </a:xfrm>
          <a:prstGeom prst="rect">
            <a:avLst/>
          </a:prstGeom>
          <a:ln w="6350">
            <a:noFill/>
          </a:ln>
        </p:spPr>
        <p:txBody>
          <a:bodyPr vert="horz" wrap="square" lIns="0" tIns="0" rIns="0" bIns="0" rtlCol="0">
            <a:spAutoFit/>
          </a:bodyPr>
          <a:lstStyle/>
          <a:p>
            <a:pPr marL="160655" marR="153035" indent="47625" algn="ctr">
              <a:lnSpc>
                <a:spcPts val="6900"/>
              </a:lnSpc>
            </a:pPr>
            <a:r>
              <a:rPr sz="2800">
                <a:latin typeface="Helvetica"/>
                <a:cs typeface="Helvetica"/>
              </a:rPr>
              <a:t>Plantar fasciitis</a:t>
            </a:r>
          </a:p>
        </p:txBody>
      </p:sp>
      <p:sp>
        <p:nvSpPr>
          <p:cNvPr id="36" name="object 9">
            <a:extLst>
              <a:ext uri="{FF2B5EF4-FFF2-40B4-BE49-F238E27FC236}">
                <a16:creationId xmlns:a16="http://schemas.microsoft.com/office/drawing/2014/main" id="{D9BB1D03-F25F-0C34-580A-1EC037477BC0}"/>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478D19BD-2A7A-65ED-60CD-0CF4BD92EFE3}"/>
              </a:ext>
            </a:extLst>
          </p:cNvPr>
          <p:cNvSpPr txBox="1"/>
          <p:nvPr/>
        </p:nvSpPr>
        <p:spPr>
          <a:xfrm>
            <a:off x="4114800" y="5451967"/>
            <a:ext cx="3200400" cy="861774"/>
          </a:xfrm>
          <a:prstGeom prst="rect">
            <a:avLst/>
          </a:prstGeom>
          <a:ln w="6350">
            <a:noFill/>
          </a:ln>
        </p:spPr>
        <p:txBody>
          <a:bodyPr vert="horz" wrap="square" lIns="0" tIns="0" rIns="0" bIns="0" rtlCol="0">
            <a:spAutoFit/>
          </a:bodyPr>
          <a:lstStyle/>
          <a:p>
            <a:pPr marL="286385" marR="278765" algn="ctr"/>
            <a:r>
              <a:rPr sz="2800">
                <a:latin typeface="Helvetica"/>
                <a:cs typeface="Helvetica"/>
              </a:rPr>
              <a:t>Tarsal tunnel syndrome</a:t>
            </a:r>
          </a:p>
        </p:txBody>
      </p:sp>
      <p:sp>
        <p:nvSpPr>
          <p:cNvPr id="40" name="object 14">
            <a:extLst>
              <a:ext uri="{FF2B5EF4-FFF2-40B4-BE49-F238E27FC236}">
                <a16:creationId xmlns:a16="http://schemas.microsoft.com/office/drawing/2014/main" id="{C2BCD4D9-73F4-3AA2-7C93-86BD70C307A3}"/>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290DB391-A07A-1FCE-7168-BD5572B457B7}"/>
              </a:ext>
            </a:extLst>
          </p:cNvPr>
          <p:cNvSpPr txBox="1"/>
          <p:nvPr/>
        </p:nvSpPr>
        <p:spPr>
          <a:xfrm>
            <a:off x="4013200" y="7793197"/>
            <a:ext cx="3302000" cy="620363"/>
          </a:xfrm>
          <a:prstGeom prst="rect">
            <a:avLst/>
          </a:prstGeom>
          <a:ln w="6350">
            <a:noFill/>
          </a:ln>
        </p:spPr>
        <p:txBody>
          <a:bodyPr vert="horz" wrap="square" lIns="0" tIns="0" rIns="0" bIns="0" rtlCol="0">
            <a:spAutoFit/>
          </a:bodyPr>
          <a:lstStyle/>
          <a:p>
            <a:pPr marL="74930" marR="67310" indent="296545">
              <a:lnSpc>
                <a:spcPts val="5600"/>
              </a:lnSpc>
            </a:pPr>
            <a:r>
              <a:rPr sz="2800">
                <a:latin typeface="Helvetica"/>
                <a:cs typeface="Helvetica"/>
              </a:rPr>
              <a:t>Achilles</a:t>
            </a:r>
            <a:r>
              <a:rPr lang="en-US" sz="2800">
                <a:latin typeface="Helvetica"/>
                <a:cs typeface="Helvetica"/>
              </a:rPr>
              <a:t> </a:t>
            </a:r>
            <a:r>
              <a:rPr sz="2800">
                <a:latin typeface="Helvetica"/>
                <a:cs typeface="Helvetica"/>
              </a:rPr>
              <a:t>tendonitis</a:t>
            </a:r>
          </a:p>
        </p:txBody>
      </p:sp>
      <p:sp>
        <p:nvSpPr>
          <p:cNvPr id="44" name="object 19">
            <a:extLst>
              <a:ext uri="{FF2B5EF4-FFF2-40B4-BE49-F238E27FC236}">
                <a16:creationId xmlns:a16="http://schemas.microsoft.com/office/drawing/2014/main" id="{D04A826C-DC49-3854-399E-5E44F37D9DC9}"/>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E2222911-C273-211D-12A5-7A585030E075}"/>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381B60CE-9664-D6F1-1C74-6419D9423951}"/>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0D5254E2-BC90-DF98-76EA-7420A24773DF}"/>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8DC52017-CF77-49E4-2916-B556CEF3C294}"/>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BBAC7892-AA7A-CA34-3FED-B415265C16A1}"/>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CB3CB4B4-88D9-A494-7943-29304AB0A4BB}"/>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2208D318-BD26-5F42-66D9-1277E6BFAE1F}"/>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98772210-11FA-C26F-7BE7-DF9AB52DC14E}"/>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943100"/>
          </a:xfrm>
          <a:prstGeom prst="rect">
            <a:avLst/>
          </a:prstGeom>
          <a:ln w="6350">
            <a:noFill/>
          </a:ln>
        </p:spPr>
        <p:txBody>
          <a:bodyPr vert="horz" wrap="square" lIns="0" tIns="0" rIns="0" bIns="0" rtlCol="0">
            <a:spAutoFit/>
          </a:bodyPr>
          <a:lstStyle/>
          <a:p>
            <a:pPr marL="339090" marR="331470" algn="ctr">
              <a:lnSpc>
                <a:spcPts val="2200"/>
              </a:lnSpc>
            </a:pPr>
            <a:r>
              <a:rPr sz="2200">
                <a:latin typeface="Helvetica"/>
                <a:cs typeface="Helvetica"/>
              </a:rPr>
              <a:t>48yo M with anterior knee pain after repetitive kneeling.</a:t>
            </a:r>
          </a:p>
          <a:p>
            <a:pPr marL="478790" marR="471170" algn="ctr">
              <a:lnSpc>
                <a:spcPts val="2200"/>
              </a:lnSpc>
            </a:pPr>
            <a:r>
              <a:rPr sz="2200">
                <a:latin typeface="Helvetica"/>
                <a:cs typeface="Helvetica"/>
              </a:rPr>
              <a:t>Swelling overlying patella, mild TTP, normal ROM.</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410707"/>
          </a:xfrm>
          <a:prstGeom prst="rect">
            <a:avLst/>
          </a:prstGeom>
          <a:ln w="6350">
            <a:noFill/>
          </a:ln>
        </p:spPr>
        <p:txBody>
          <a:bodyPr vert="horz" wrap="square" lIns="0" tIns="0" rIns="0" bIns="0" rtlCol="0">
            <a:spAutoFit/>
          </a:bodyPr>
          <a:lstStyle/>
          <a:p>
            <a:pPr marL="114300" marR="106680" indent="147955" algn="ctr">
              <a:lnSpc>
                <a:spcPts val="2800"/>
              </a:lnSpc>
            </a:pPr>
            <a:r>
              <a:rPr sz="2200">
                <a:latin typeface="Helvetica"/>
                <a:cs typeface="Helvetica"/>
              </a:rPr>
              <a:t>55yo M with heel pain. Worse with getting out of bed and</a:t>
            </a:r>
            <a:r>
              <a:rPr lang="en-US" sz="2200">
                <a:latin typeface="Helvetica"/>
                <a:cs typeface="Helvetica"/>
              </a:rPr>
              <a:t> </a:t>
            </a:r>
            <a:r>
              <a:rPr sz="2200">
                <a:latin typeface="Helvetica"/>
                <a:cs typeface="Helvetica"/>
              </a:rPr>
              <a:t>after inactivity.</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795363"/>
          </a:xfrm>
          <a:prstGeom prst="rect">
            <a:avLst/>
          </a:prstGeom>
          <a:ln w="6350">
            <a:noFill/>
          </a:ln>
        </p:spPr>
        <p:txBody>
          <a:bodyPr vert="horz" wrap="square" lIns="0" tIns="0" rIns="0" bIns="0" rtlCol="0">
            <a:spAutoFit/>
          </a:bodyPr>
          <a:lstStyle/>
          <a:p>
            <a:pPr marL="170815" marR="163195" algn="ctr">
              <a:lnSpc>
                <a:spcPts val="2000"/>
              </a:lnSpc>
            </a:pPr>
            <a:r>
              <a:rPr sz="2000">
                <a:latin typeface="Helvetica"/>
                <a:cs typeface="Helvetica"/>
              </a:rPr>
              <a:t>40yo M with gradual foot pain, intermittent numbness. Sensation is intact. Percussing inferior to medial malleolus causes pain, dorsiflexion</a:t>
            </a:r>
          </a:p>
          <a:p>
            <a:pPr algn="ctr">
              <a:lnSpc>
                <a:spcPts val="2000"/>
              </a:lnSpc>
            </a:pPr>
            <a:r>
              <a:rPr sz="2000">
                <a:latin typeface="Helvetica"/>
                <a:cs typeface="Helvetica"/>
              </a:rPr>
              <a:t>+eversion ankle elicits sx</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943100"/>
          </a:xfrm>
          <a:prstGeom prst="rect">
            <a:avLst/>
          </a:prstGeom>
          <a:ln w="6350">
            <a:noFill/>
          </a:ln>
        </p:spPr>
        <p:txBody>
          <a:bodyPr vert="horz" wrap="square" lIns="0" tIns="0" rIns="0" bIns="0" rtlCol="0">
            <a:spAutoFit/>
          </a:bodyPr>
          <a:lstStyle/>
          <a:p>
            <a:pPr marL="135255" marR="128905" algn="ctr">
              <a:lnSpc>
                <a:spcPts val="2000"/>
              </a:lnSpc>
            </a:pPr>
            <a:r>
              <a:rPr sz="2000">
                <a:latin typeface="Helvetica"/>
                <a:cs typeface="Helvetica"/>
              </a:rPr>
              <a:t>36yo M presents with heel/posterior lower leg pain, worse with movement. Prepping for a marathon. TTP over post calcaneus and just superior to it</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4">
            <a:extLst>
              <a:ext uri="{FF2B5EF4-FFF2-40B4-BE49-F238E27FC236}">
                <a16:creationId xmlns:a16="http://schemas.microsoft.com/office/drawing/2014/main" id="{D4004E63-2412-3773-8D57-D71549369288}"/>
              </a:ext>
            </a:extLst>
          </p:cNvPr>
          <p:cNvSpPr txBox="1"/>
          <p:nvPr/>
        </p:nvSpPr>
        <p:spPr>
          <a:xfrm>
            <a:off x="4114800" y="398206"/>
            <a:ext cx="3200400" cy="912109"/>
          </a:xfrm>
          <a:prstGeom prst="rect">
            <a:avLst/>
          </a:prstGeom>
          <a:ln w="6350">
            <a:noFill/>
          </a:ln>
        </p:spPr>
        <p:txBody>
          <a:bodyPr vert="horz" wrap="square" lIns="0" tIns="0" rIns="0" bIns="0" rtlCol="0">
            <a:spAutoFit/>
          </a:bodyPr>
          <a:lstStyle/>
          <a:p>
            <a:pPr marL="95250" marR="87630" algn="ctr">
              <a:lnSpc>
                <a:spcPts val="3700"/>
              </a:lnSpc>
            </a:pPr>
            <a:r>
              <a:rPr sz="2800">
                <a:latin typeface="Helvetica"/>
                <a:cs typeface="Helvetica"/>
              </a:rPr>
              <a:t>Patellofemoral pain syndrome</a:t>
            </a:r>
          </a:p>
        </p:txBody>
      </p:sp>
      <p:sp>
        <p:nvSpPr>
          <p:cNvPr id="32" name="object 5">
            <a:extLst>
              <a:ext uri="{FF2B5EF4-FFF2-40B4-BE49-F238E27FC236}">
                <a16:creationId xmlns:a16="http://schemas.microsoft.com/office/drawing/2014/main" id="{60D4EB16-CE03-3FBF-AE46-5E3AC7F9DAEA}"/>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4" name="object 8">
            <a:extLst>
              <a:ext uri="{FF2B5EF4-FFF2-40B4-BE49-F238E27FC236}">
                <a16:creationId xmlns:a16="http://schemas.microsoft.com/office/drawing/2014/main" id="{4FD6C889-8376-0410-162A-AF114696B045}"/>
              </a:ext>
            </a:extLst>
          </p:cNvPr>
          <p:cNvSpPr txBox="1"/>
          <p:nvPr/>
        </p:nvSpPr>
        <p:spPr>
          <a:xfrm>
            <a:off x="4114800" y="2923868"/>
            <a:ext cx="3200400" cy="620363"/>
          </a:xfrm>
          <a:prstGeom prst="rect">
            <a:avLst/>
          </a:prstGeom>
          <a:ln w="6350">
            <a:noFill/>
          </a:ln>
        </p:spPr>
        <p:txBody>
          <a:bodyPr vert="horz" wrap="square" lIns="0" tIns="0" rIns="0" bIns="0" rtlCol="0">
            <a:spAutoFit/>
          </a:bodyPr>
          <a:lstStyle/>
          <a:p>
            <a:pPr marL="747395" marR="87630" indent="-652145" algn="ctr">
              <a:lnSpc>
                <a:spcPts val="5600"/>
              </a:lnSpc>
            </a:pPr>
            <a:r>
              <a:rPr sz="2800">
                <a:latin typeface="Helvetica"/>
                <a:cs typeface="Helvetica"/>
              </a:rPr>
              <a:t>Meniscus injury</a:t>
            </a:r>
          </a:p>
        </p:txBody>
      </p:sp>
      <p:sp>
        <p:nvSpPr>
          <p:cNvPr id="36" name="object 9">
            <a:extLst>
              <a:ext uri="{FF2B5EF4-FFF2-40B4-BE49-F238E27FC236}">
                <a16:creationId xmlns:a16="http://schemas.microsoft.com/office/drawing/2014/main" id="{A36F1C8D-68CF-B7B0-44A6-633F8428A106}"/>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8" name="object 13">
            <a:extLst>
              <a:ext uri="{FF2B5EF4-FFF2-40B4-BE49-F238E27FC236}">
                <a16:creationId xmlns:a16="http://schemas.microsoft.com/office/drawing/2014/main" id="{C50DDDC6-9E3C-9AC7-2A8B-9FD93C56E9B9}"/>
              </a:ext>
            </a:extLst>
          </p:cNvPr>
          <p:cNvSpPr txBox="1"/>
          <p:nvPr/>
        </p:nvSpPr>
        <p:spPr>
          <a:xfrm>
            <a:off x="4114800" y="5257800"/>
            <a:ext cx="3200400" cy="812723"/>
          </a:xfrm>
          <a:prstGeom prst="rect">
            <a:avLst/>
          </a:prstGeom>
          <a:ln w="6350">
            <a:noFill/>
          </a:ln>
        </p:spPr>
        <p:txBody>
          <a:bodyPr vert="horz" wrap="square" lIns="0" tIns="0" rIns="0" bIns="0" rtlCol="0">
            <a:spAutoFit/>
          </a:bodyPr>
          <a:lstStyle/>
          <a:p>
            <a:pPr algn="ctr">
              <a:lnSpc>
                <a:spcPts val="7590"/>
              </a:lnSpc>
            </a:pPr>
            <a:r>
              <a:rPr sz="2800">
                <a:latin typeface="Helvetica"/>
                <a:cs typeface="Helvetica"/>
              </a:rPr>
              <a:t>ACL</a:t>
            </a:r>
            <a:r>
              <a:rPr lang="en-US" sz="2800">
                <a:latin typeface="Helvetica"/>
                <a:cs typeface="Helvetica"/>
              </a:rPr>
              <a:t> </a:t>
            </a:r>
            <a:r>
              <a:rPr sz="2800">
                <a:latin typeface="Helvetica"/>
                <a:cs typeface="Helvetica"/>
              </a:rPr>
              <a:t>tear</a:t>
            </a:r>
          </a:p>
        </p:txBody>
      </p:sp>
      <p:sp>
        <p:nvSpPr>
          <p:cNvPr id="40" name="object 14">
            <a:extLst>
              <a:ext uri="{FF2B5EF4-FFF2-40B4-BE49-F238E27FC236}">
                <a16:creationId xmlns:a16="http://schemas.microsoft.com/office/drawing/2014/main" id="{5A9299B4-084C-152B-82F7-D4A5A7670788}"/>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2" name="object 18">
            <a:extLst>
              <a:ext uri="{FF2B5EF4-FFF2-40B4-BE49-F238E27FC236}">
                <a16:creationId xmlns:a16="http://schemas.microsoft.com/office/drawing/2014/main" id="{A4B20BB7-73F7-40D5-AE39-CFD62FAC3E2D}"/>
              </a:ext>
            </a:extLst>
          </p:cNvPr>
          <p:cNvSpPr txBox="1"/>
          <p:nvPr/>
        </p:nvSpPr>
        <p:spPr>
          <a:xfrm>
            <a:off x="4114800" y="7658100"/>
            <a:ext cx="3200400" cy="812723"/>
          </a:xfrm>
          <a:prstGeom prst="rect">
            <a:avLst/>
          </a:prstGeom>
          <a:ln w="6350">
            <a:noFill/>
          </a:ln>
        </p:spPr>
        <p:txBody>
          <a:bodyPr vert="horz" wrap="square" lIns="0" tIns="0" rIns="0" bIns="0" rtlCol="0">
            <a:spAutoFit/>
          </a:bodyPr>
          <a:lstStyle/>
          <a:p>
            <a:pPr algn="ctr">
              <a:lnSpc>
                <a:spcPts val="7590"/>
              </a:lnSpc>
            </a:pPr>
            <a:r>
              <a:rPr sz="2800">
                <a:latin typeface="Helvetica"/>
                <a:cs typeface="Helvetica"/>
              </a:rPr>
              <a:t>PCL</a:t>
            </a:r>
            <a:r>
              <a:rPr lang="en-US" sz="2800">
                <a:latin typeface="Helvetica"/>
                <a:cs typeface="Helvetica"/>
              </a:rPr>
              <a:t> </a:t>
            </a:r>
            <a:r>
              <a:rPr sz="2800">
                <a:latin typeface="Helvetica"/>
                <a:cs typeface="Helvetica"/>
              </a:rPr>
              <a:t>tear</a:t>
            </a:r>
          </a:p>
        </p:txBody>
      </p:sp>
      <p:sp>
        <p:nvSpPr>
          <p:cNvPr id="44" name="object 19">
            <a:extLst>
              <a:ext uri="{FF2B5EF4-FFF2-40B4-BE49-F238E27FC236}">
                <a16:creationId xmlns:a16="http://schemas.microsoft.com/office/drawing/2014/main" id="{FAE987DF-85B7-4618-5D16-8A17A9E19B36}"/>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6" name="Rectangle 45">
            <a:extLst>
              <a:ext uri="{FF2B5EF4-FFF2-40B4-BE49-F238E27FC236}">
                <a16:creationId xmlns:a16="http://schemas.microsoft.com/office/drawing/2014/main" id="{EAC6C70B-3052-FDF4-8D0F-FA87736450A1}"/>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8" name="TextBox 47">
            <a:extLst>
              <a:ext uri="{FF2B5EF4-FFF2-40B4-BE49-F238E27FC236}">
                <a16:creationId xmlns:a16="http://schemas.microsoft.com/office/drawing/2014/main" id="{58D05697-67C7-0683-B33F-979E0D8850B9}"/>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50" name="Rectangle 49">
            <a:extLst>
              <a:ext uri="{FF2B5EF4-FFF2-40B4-BE49-F238E27FC236}">
                <a16:creationId xmlns:a16="http://schemas.microsoft.com/office/drawing/2014/main" id="{FB404445-AF8C-3997-500C-9E3937CEFB84}"/>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2" name="TextBox 51">
            <a:extLst>
              <a:ext uri="{FF2B5EF4-FFF2-40B4-BE49-F238E27FC236}">
                <a16:creationId xmlns:a16="http://schemas.microsoft.com/office/drawing/2014/main" id="{D3124F83-BE2D-A647-7D14-E4C64B75B171}"/>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4" name="Rectangle 53">
            <a:extLst>
              <a:ext uri="{FF2B5EF4-FFF2-40B4-BE49-F238E27FC236}">
                <a16:creationId xmlns:a16="http://schemas.microsoft.com/office/drawing/2014/main" id="{038BE8CA-723E-EFA7-2952-01DB7AC83150}"/>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TextBox 55">
            <a:extLst>
              <a:ext uri="{FF2B5EF4-FFF2-40B4-BE49-F238E27FC236}">
                <a16:creationId xmlns:a16="http://schemas.microsoft.com/office/drawing/2014/main" id="{3B0C1FAA-946E-4FDE-4469-E10ACFC050C8}"/>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8" name="Rectangle 57">
            <a:extLst>
              <a:ext uri="{FF2B5EF4-FFF2-40B4-BE49-F238E27FC236}">
                <a16:creationId xmlns:a16="http://schemas.microsoft.com/office/drawing/2014/main" id="{EC9B426E-3A31-878F-C6E2-8539F7ED1AD7}"/>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0" name="TextBox 59">
            <a:extLst>
              <a:ext uri="{FF2B5EF4-FFF2-40B4-BE49-F238E27FC236}">
                <a16:creationId xmlns:a16="http://schemas.microsoft.com/office/drawing/2014/main" id="{58AB44DF-F346-7F00-0409-ED3DBC29645A}"/>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object 2"/>
          <p:cNvSpPr txBox="1"/>
          <p:nvPr/>
        </p:nvSpPr>
        <p:spPr>
          <a:xfrm>
            <a:off x="457200" y="457200"/>
            <a:ext cx="3200400" cy="1667123"/>
          </a:xfrm>
          <a:prstGeom prst="rect">
            <a:avLst/>
          </a:prstGeom>
          <a:ln w="6350">
            <a:noFill/>
          </a:ln>
        </p:spPr>
        <p:txBody>
          <a:bodyPr vert="horz" wrap="square" lIns="0" tIns="0" rIns="0" bIns="0" rtlCol="0">
            <a:spAutoFit/>
          </a:bodyPr>
          <a:lstStyle/>
          <a:p>
            <a:pPr marL="82550" marR="74930" algn="ctr">
              <a:lnSpc>
                <a:spcPts val="2600"/>
              </a:lnSpc>
            </a:pPr>
            <a:r>
              <a:rPr sz="2200">
                <a:latin typeface="Helvetica"/>
                <a:cs typeface="Helvetica"/>
              </a:rPr>
              <a:t>72yo M with unintentional weight loss and acute onset of point tenderness overlying spine</a:t>
            </a:r>
          </a:p>
        </p:txBody>
      </p:sp>
      <p:sp>
        <p:nvSpPr>
          <p:cNvPr id="3" name="object 3"/>
          <p:cNvSpPr/>
          <p:nvPr/>
        </p:nvSpPr>
        <p:spPr>
          <a:xfrm>
            <a:off x="3556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6" name="object 6"/>
          <p:cNvSpPr txBox="1"/>
          <p:nvPr/>
        </p:nvSpPr>
        <p:spPr>
          <a:xfrm>
            <a:off x="457200" y="2857500"/>
            <a:ext cx="3200400" cy="1769780"/>
          </a:xfrm>
          <a:prstGeom prst="rect">
            <a:avLst/>
          </a:prstGeom>
          <a:ln w="6350">
            <a:noFill/>
          </a:ln>
        </p:spPr>
        <p:txBody>
          <a:bodyPr vert="horz" wrap="square" lIns="0" tIns="0" rIns="0" bIns="0" rtlCol="0" anchor="t">
            <a:spAutoFit/>
          </a:bodyPr>
          <a:lstStyle/>
          <a:p>
            <a:pPr marL="193675" marR="186055" algn="ctr">
              <a:lnSpc>
                <a:spcPts val="2800"/>
              </a:lnSpc>
            </a:pPr>
            <a:r>
              <a:rPr sz="2200">
                <a:latin typeface="Helvetica"/>
                <a:cs typeface="Helvetica"/>
              </a:rPr>
              <a:t>77yo woman with acute back pain localized to single vertebrae, </a:t>
            </a:r>
            <a:r>
              <a:rPr lang="en-US" sz="2200">
                <a:latin typeface="Helvetica"/>
                <a:cs typeface="Helvetica"/>
              </a:rPr>
              <a:t>tender to palpation </a:t>
            </a:r>
            <a:r>
              <a:rPr sz="2200">
                <a:latin typeface="Helvetica"/>
                <a:cs typeface="Helvetica"/>
              </a:rPr>
              <a:t>overlying</a:t>
            </a:r>
          </a:p>
        </p:txBody>
      </p:sp>
      <p:sp>
        <p:nvSpPr>
          <p:cNvPr id="7" name="object 7"/>
          <p:cNvSpPr/>
          <p:nvPr/>
        </p:nvSpPr>
        <p:spPr>
          <a:xfrm>
            <a:off x="3556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0" name="object 10"/>
          <p:cNvSpPr/>
          <p:nvPr/>
        </p:nvSpPr>
        <p:spPr>
          <a:xfrm>
            <a:off x="228600" y="26289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1" name="object 11"/>
          <p:cNvSpPr txBox="1"/>
          <p:nvPr/>
        </p:nvSpPr>
        <p:spPr>
          <a:xfrm>
            <a:off x="457200" y="5257800"/>
            <a:ext cx="3200400" cy="1943100"/>
          </a:xfrm>
          <a:prstGeom prst="rect">
            <a:avLst/>
          </a:prstGeom>
          <a:ln w="6350">
            <a:noFill/>
          </a:ln>
        </p:spPr>
        <p:txBody>
          <a:bodyPr vert="horz" wrap="square" lIns="0" tIns="0" rIns="0" bIns="0" rtlCol="0">
            <a:spAutoFit/>
          </a:bodyPr>
          <a:lstStyle/>
          <a:p>
            <a:pPr marL="137160" marR="129539" algn="ctr">
              <a:lnSpc>
                <a:spcPts val="2200"/>
              </a:lnSpc>
            </a:pPr>
            <a:r>
              <a:rPr sz="2200">
                <a:latin typeface="Helvetica"/>
                <a:cs typeface="Helvetica"/>
              </a:rPr>
              <a:t>42yo F with chronic back pain presents with acute onset of bilateral lower extremity weakness and new urinary incontinence</a:t>
            </a:r>
          </a:p>
        </p:txBody>
      </p:sp>
      <p:sp>
        <p:nvSpPr>
          <p:cNvPr id="12" name="object 12"/>
          <p:cNvSpPr/>
          <p:nvPr/>
        </p:nvSpPr>
        <p:spPr>
          <a:xfrm>
            <a:off x="3556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15" name="object 15"/>
          <p:cNvSpPr/>
          <p:nvPr/>
        </p:nvSpPr>
        <p:spPr>
          <a:xfrm>
            <a:off x="228600" y="50292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16" name="object 16"/>
          <p:cNvSpPr txBox="1"/>
          <p:nvPr/>
        </p:nvSpPr>
        <p:spPr>
          <a:xfrm>
            <a:off x="457200" y="7658100"/>
            <a:ext cx="3200400" cy="1410707"/>
          </a:xfrm>
          <a:prstGeom prst="rect">
            <a:avLst/>
          </a:prstGeom>
          <a:ln w="6350">
            <a:noFill/>
          </a:ln>
        </p:spPr>
        <p:txBody>
          <a:bodyPr vert="horz" wrap="square" lIns="0" tIns="0" rIns="0" bIns="0" rtlCol="0">
            <a:spAutoFit/>
          </a:bodyPr>
          <a:lstStyle/>
          <a:p>
            <a:pPr marL="114300" marR="106680" indent="-635" algn="ctr">
              <a:lnSpc>
                <a:spcPts val="2800"/>
              </a:lnSpc>
            </a:pPr>
            <a:r>
              <a:rPr sz="2200">
                <a:latin typeface="Helvetica"/>
                <a:cs typeface="Helvetica"/>
              </a:rPr>
              <a:t>51yo F with lateral "hip" pain worst when laying on opposite side. TTP lateral leg</a:t>
            </a:r>
          </a:p>
        </p:txBody>
      </p:sp>
      <p:sp>
        <p:nvSpPr>
          <p:cNvPr id="17" name="object 17"/>
          <p:cNvSpPr/>
          <p:nvPr/>
        </p:nvSpPr>
        <p:spPr>
          <a:xfrm>
            <a:off x="3556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20" name="object 20"/>
          <p:cNvSpPr/>
          <p:nvPr/>
        </p:nvSpPr>
        <p:spPr>
          <a:xfrm>
            <a:off x="228600" y="7429500"/>
            <a:ext cx="7315200" cy="0"/>
          </a:xfrm>
          <a:custGeom>
            <a:avLst/>
            <a:gdLst/>
            <a:ahLst/>
            <a:cxnLst/>
            <a:rect l="l" t="t" r="r" b="b"/>
            <a:pathLst>
              <a:path w="7315200">
                <a:moveTo>
                  <a:pt x="0" y="0"/>
                </a:moveTo>
                <a:lnTo>
                  <a:pt x="7315200" y="0"/>
                </a:lnTo>
              </a:path>
            </a:pathLst>
          </a:custGeom>
          <a:ln w="12700">
            <a:solidFill>
              <a:srgbClr val="000000"/>
            </a:solidFill>
          </a:ln>
        </p:spPr>
        <p:txBody>
          <a:bodyPr wrap="square" lIns="0" tIns="0" rIns="0" bIns="0" rtlCol="0"/>
          <a:lstStyle/>
          <a:p>
            <a:endParaRPr/>
          </a:p>
        </p:txBody>
      </p:sp>
      <p:sp>
        <p:nvSpPr>
          <p:cNvPr id="30" name="object 5">
            <a:extLst>
              <a:ext uri="{FF2B5EF4-FFF2-40B4-BE49-F238E27FC236}">
                <a16:creationId xmlns:a16="http://schemas.microsoft.com/office/drawing/2014/main" id="{6F446129-7CE6-F77E-8FD2-BD82349FA8E6}"/>
              </a:ext>
            </a:extLst>
          </p:cNvPr>
          <p:cNvSpPr/>
          <p:nvPr/>
        </p:nvSpPr>
        <p:spPr>
          <a:xfrm>
            <a:off x="4013200" y="3556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2" name="object 8">
            <a:extLst>
              <a:ext uri="{FF2B5EF4-FFF2-40B4-BE49-F238E27FC236}">
                <a16:creationId xmlns:a16="http://schemas.microsoft.com/office/drawing/2014/main" id="{835F0681-9BF0-97A1-F9A1-4E71B944B4D5}"/>
              </a:ext>
            </a:extLst>
          </p:cNvPr>
          <p:cNvSpPr txBox="1"/>
          <p:nvPr/>
        </p:nvSpPr>
        <p:spPr>
          <a:xfrm>
            <a:off x="4114800" y="2857500"/>
            <a:ext cx="3200400" cy="1136530"/>
          </a:xfrm>
          <a:prstGeom prst="rect">
            <a:avLst/>
          </a:prstGeom>
          <a:ln w="6350">
            <a:noFill/>
          </a:ln>
        </p:spPr>
        <p:txBody>
          <a:bodyPr vert="horz" wrap="square" lIns="0" tIns="0" rIns="0" bIns="0" rtlCol="0">
            <a:spAutoFit/>
          </a:bodyPr>
          <a:lstStyle/>
          <a:p>
            <a:pPr marL="286385" marR="278765" algn="ctr">
              <a:lnSpc>
                <a:spcPts val="4700"/>
              </a:lnSpc>
            </a:pPr>
            <a:r>
              <a:rPr sz="2800">
                <a:latin typeface="Helvetica"/>
                <a:cs typeface="Helvetica"/>
              </a:rPr>
              <a:t>Carpal tunnel syndrome</a:t>
            </a:r>
          </a:p>
        </p:txBody>
      </p:sp>
      <p:sp>
        <p:nvSpPr>
          <p:cNvPr id="34" name="object 9">
            <a:extLst>
              <a:ext uri="{FF2B5EF4-FFF2-40B4-BE49-F238E27FC236}">
                <a16:creationId xmlns:a16="http://schemas.microsoft.com/office/drawing/2014/main" id="{99742C3B-9630-6B02-BB50-9C9D8262C042}"/>
              </a:ext>
            </a:extLst>
          </p:cNvPr>
          <p:cNvSpPr/>
          <p:nvPr/>
        </p:nvSpPr>
        <p:spPr>
          <a:xfrm>
            <a:off x="4013200" y="27559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36" name="object 13">
            <a:extLst>
              <a:ext uri="{FF2B5EF4-FFF2-40B4-BE49-F238E27FC236}">
                <a16:creationId xmlns:a16="http://schemas.microsoft.com/office/drawing/2014/main" id="{30D77DFF-AC55-BB19-EC5B-0A685F059218}"/>
              </a:ext>
            </a:extLst>
          </p:cNvPr>
          <p:cNvSpPr txBox="1"/>
          <p:nvPr/>
        </p:nvSpPr>
        <p:spPr>
          <a:xfrm>
            <a:off x="4114800" y="5257800"/>
            <a:ext cx="3200400" cy="430887"/>
          </a:xfrm>
          <a:prstGeom prst="rect">
            <a:avLst/>
          </a:prstGeom>
          <a:ln w="6350">
            <a:noFill/>
          </a:ln>
        </p:spPr>
        <p:txBody>
          <a:bodyPr vert="horz" wrap="square" lIns="0" tIns="0" rIns="0" bIns="0" rtlCol="0">
            <a:spAutoFit/>
          </a:bodyPr>
          <a:lstStyle/>
          <a:p>
            <a:pPr marL="97155" algn="ctr">
              <a:lnSpc>
                <a:spcPct val="100000"/>
              </a:lnSpc>
            </a:pPr>
            <a:r>
              <a:rPr sz="2800">
                <a:latin typeface="Helvetica"/>
                <a:cs typeface="Helvetica"/>
              </a:rPr>
              <a:t>CPPD</a:t>
            </a:r>
          </a:p>
        </p:txBody>
      </p:sp>
      <p:sp>
        <p:nvSpPr>
          <p:cNvPr id="38" name="object 14">
            <a:extLst>
              <a:ext uri="{FF2B5EF4-FFF2-40B4-BE49-F238E27FC236}">
                <a16:creationId xmlns:a16="http://schemas.microsoft.com/office/drawing/2014/main" id="{2A59E2AB-7194-2873-357E-1511AAB57981}"/>
              </a:ext>
            </a:extLst>
          </p:cNvPr>
          <p:cNvSpPr/>
          <p:nvPr/>
        </p:nvSpPr>
        <p:spPr>
          <a:xfrm>
            <a:off x="4013200" y="51562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0" name="object 18">
            <a:extLst>
              <a:ext uri="{FF2B5EF4-FFF2-40B4-BE49-F238E27FC236}">
                <a16:creationId xmlns:a16="http://schemas.microsoft.com/office/drawing/2014/main" id="{107100AC-4164-C6B7-C63D-614BF1B77734}"/>
              </a:ext>
            </a:extLst>
          </p:cNvPr>
          <p:cNvSpPr txBox="1"/>
          <p:nvPr/>
        </p:nvSpPr>
        <p:spPr>
          <a:xfrm>
            <a:off x="4114800" y="7658100"/>
            <a:ext cx="3200400" cy="430887"/>
          </a:xfrm>
          <a:prstGeom prst="rect">
            <a:avLst/>
          </a:prstGeom>
          <a:ln w="6350">
            <a:noFill/>
          </a:ln>
        </p:spPr>
        <p:txBody>
          <a:bodyPr vert="horz" wrap="square" lIns="0" tIns="0" rIns="0" bIns="0" rtlCol="0">
            <a:spAutoFit/>
          </a:bodyPr>
          <a:lstStyle/>
          <a:p>
            <a:pPr marL="95885" algn="ctr">
              <a:lnSpc>
                <a:spcPct val="100000"/>
              </a:lnSpc>
            </a:pPr>
            <a:r>
              <a:rPr sz="2800">
                <a:latin typeface="Helvetica"/>
                <a:cs typeface="Helvetica"/>
              </a:rPr>
              <a:t>Gout</a:t>
            </a:r>
          </a:p>
        </p:txBody>
      </p:sp>
      <p:sp>
        <p:nvSpPr>
          <p:cNvPr id="42" name="object 19">
            <a:extLst>
              <a:ext uri="{FF2B5EF4-FFF2-40B4-BE49-F238E27FC236}">
                <a16:creationId xmlns:a16="http://schemas.microsoft.com/office/drawing/2014/main" id="{E08BC5EF-1F6D-EC3C-F94A-0C00FA16410E}"/>
              </a:ext>
            </a:extLst>
          </p:cNvPr>
          <p:cNvSpPr/>
          <p:nvPr/>
        </p:nvSpPr>
        <p:spPr>
          <a:xfrm>
            <a:off x="4013200" y="7556500"/>
            <a:ext cx="3403600" cy="2146300"/>
          </a:xfrm>
          <a:custGeom>
            <a:avLst/>
            <a:gdLst/>
            <a:ahLst/>
            <a:cxnLst/>
            <a:rect l="l" t="t" r="r" b="b"/>
            <a:pathLst>
              <a:path w="3403600" h="2146300">
                <a:moveTo>
                  <a:pt x="0" y="0"/>
                </a:moveTo>
                <a:lnTo>
                  <a:pt x="3403600" y="0"/>
                </a:lnTo>
                <a:lnTo>
                  <a:pt x="3403600" y="2146300"/>
                </a:lnTo>
                <a:lnTo>
                  <a:pt x="0" y="2146300"/>
                </a:lnTo>
                <a:lnTo>
                  <a:pt x="0" y="0"/>
                </a:lnTo>
                <a:close/>
              </a:path>
            </a:pathLst>
          </a:custGeom>
          <a:ln w="6350">
            <a:solidFill>
              <a:srgbClr val="000000"/>
            </a:solidFill>
          </a:ln>
        </p:spPr>
        <p:txBody>
          <a:bodyPr wrap="square" lIns="0" tIns="0" rIns="0" bIns="0" rtlCol="0"/>
          <a:lstStyle/>
          <a:p>
            <a:endParaRPr/>
          </a:p>
        </p:txBody>
      </p:sp>
      <p:sp>
        <p:nvSpPr>
          <p:cNvPr id="44" name="Rectangle 43">
            <a:extLst>
              <a:ext uri="{FF2B5EF4-FFF2-40B4-BE49-F238E27FC236}">
                <a16:creationId xmlns:a16="http://schemas.microsoft.com/office/drawing/2014/main" id="{3817646C-29CB-1DF4-5E2D-2748D93675A4}"/>
              </a:ext>
            </a:extLst>
          </p:cNvPr>
          <p:cNvSpPr/>
          <p:nvPr/>
        </p:nvSpPr>
        <p:spPr>
          <a:xfrm>
            <a:off x="6629400" y="1797240"/>
            <a:ext cx="304800" cy="304800"/>
          </a:xfrm>
          <a:prstGeom prst="rect">
            <a:avLst/>
          </a:prstGeom>
          <a:solidFill>
            <a:schemeClr val="accent2"/>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TextBox 45">
            <a:extLst>
              <a:ext uri="{FF2B5EF4-FFF2-40B4-BE49-F238E27FC236}">
                <a16:creationId xmlns:a16="http://schemas.microsoft.com/office/drawing/2014/main" id="{E405E2FD-799C-D7AB-FBCF-2618DEEDF496}"/>
              </a:ext>
            </a:extLst>
          </p:cNvPr>
          <p:cNvSpPr txBox="1"/>
          <p:nvPr/>
        </p:nvSpPr>
        <p:spPr>
          <a:xfrm>
            <a:off x="4339956" y="1732708"/>
            <a:ext cx="2467244" cy="369332"/>
          </a:xfrm>
          <a:prstGeom prst="rect">
            <a:avLst/>
          </a:prstGeom>
          <a:noFill/>
        </p:spPr>
        <p:txBody>
          <a:bodyPr wrap="square" rtlCol="0">
            <a:spAutoFit/>
          </a:bodyPr>
          <a:lstStyle/>
          <a:p>
            <a:r>
              <a:rPr lang="en-US"/>
              <a:t>If correct move to next </a:t>
            </a:r>
          </a:p>
        </p:txBody>
      </p:sp>
      <p:sp>
        <p:nvSpPr>
          <p:cNvPr id="48" name="Rectangle 47">
            <a:extLst>
              <a:ext uri="{FF2B5EF4-FFF2-40B4-BE49-F238E27FC236}">
                <a16:creationId xmlns:a16="http://schemas.microsoft.com/office/drawing/2014/main" id="{C15DCCC6-8BEF-0BD3-19FC-BD8D642D69A4}"/>
              </a:ext>
            </a:extLst>
          </p:cNvPr>
          <p:cNvSpPr/>
          <p:nvPr/>
        </p:nvSpPr>
        <p:spPr>
          <a:xfrm>
            <a:off x="6631039" y="6674040"/>
            <a:ext cx="304800" cy="304800"/>
          </a:xfrm>
          <a:prstGeom prst="rect">
            <a:avLst/>
          </a:prstGeom>
          <a:solidFill>
            <a:srgbClr val="749BAA"/>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0" name="TextBox 49">
            <a:extLst>
              <a:ext uri="{FF2B5EF4-FFF2-40B4-BE49-F238E27FC236}">
                <a16:creationId xmlns:a16="http://schemas.microsoft.com/office/drawing/2014/main" id="{C01D0879-62F8-DB86-6F97-4EFC61A0A0CB}"/>
              </a:ext>
            </a:extLst>
          </p:cNvPr>
          <p:cNvSpPr txBox="1"/>
          <p:nvPr/>
        </p:nvSpPr>
        <p:spPr>
          <a:xfrm>
            <a:off x="4341595" y="6609508"/>
            <a:ext cx="2467244" cy="369332"/>
          </a:xfrm>
          <a:prstGeom prst="rect">
            <a:avLst/>
          </a:prstGeom>
          <a:noFill/>
        </p:spPr>
        <p:txBody>
          <a:bodyPr wrap="square" rtlCol="0">
            <a:spAutoFit/>
          </a:bodyPr>
          <a:lstStyle/>
          <a:p>
            <a:r>
              <a:rPr lang="en-US"/>
              <a:t>If correct move to next </a:t>
            </a:r>
          </a:p>
        </p:txBody>
      </p:sp>
      <p:sp>
        <p:nvSpPr>
          <p:cNvPr id="52" name="Rectangle 51">
            <a:extLst>
              <a:ext uri="{FF2B5EF4-FFF2-40B4-BE49-F238E27FC236}">
                <a16:creationId xmlns:a16="http://schemas.microsoft.com/office/drawing/2014/main" id="{A959A935-0995-6BAA-68BE-386EC2D03188}"/>
              </a:ext>
            </a:extLst>
          </p:cNvPr>
          <p:cNvSpPr/>
          <p:nvPr/>
        </p:nvSpPr>
        <p:spPr>
          <a:xfrm>
            <a:off x="6629400" y="4280158"/>
            <a:ext cx="304800" cy="304800"/>
          </a:xfrm>
          <a:prstGeom prst="rect">
            <a:avLst/>
          </a:prstGeom>
          <a:solidFill>
            <a:srgbClr val="3C3939"/>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TextBox 53">
            <a:extLst>
              <a:ext uri="{FF2B5EF4-FFF2-40B4-BE49-F238E27FC236}">
                <a16:creationId xmlns:a16="http://schemas.microsoft.com/office/drawing/2014/main" id="{B1A8490D-3EC8-3975-290A-3BD30BAE19ED}"/>
              </a:ext>
            </a:extLst>
          </p:cNvPr>
          <p:cNvSpPr txBox="1"/>
          <p:nvPr/>
        </p:nvSpPr>
        <p:spPr>
          <a:xfrm>
            <a:off x="4339956" y="4215626"/>
            <a:ext cx="2467244" cy="369332"/>
          </a:xfrm>
          <a:prstGeom prst="rect">
            <a:avLst/>
          </a:prstGeom>
          <a:noFill/>
        </p:spPr>
        <p:txBody>
          <a:bodyPr wrap="square" rtlCol="0">
            <a:spAutoFit/>
          </a:bodyPr>
          <a:lstStyle/>
          <a:p>
            <a:r>
              <a:rPr lang="en-US"/>
              <a:t>If correct move to next </a:t>
            </a:r>
          </a:p>
        </p:txBody>
      </p:sp>
      <p:sp>
        <p:nvSpPr>
          <p:cNvPr id="56" name="Rectangle 55">
            <a:extLst>
              <a:ext uri="{FF2B5EF4-FFF2-40B4-BE49-F238E27FC236}">
                <a16:creationId xmlns:a16="http://schemas.microsoft.com/office/drawing/2014/main" id="{C2A302BB-329A-8916-5464-91D208F1DF10}"/>
              </a:ext>
            </a:extLst>
          </p:cNvPr>
          <p:cNvSpPr/>
          <p:nvPr/>
        </p:nvSpPr>
        <p:spPr>
          <a:xfrm>
            <a:off x="6629400" y="8938046"/>
            <a:ext cx="304800" cy="304800"/>
          </a:xfrm>
          <a:prstGeom prst="rect">
            <a:avLst/>
          </a:prstGeom>
          <a:solidFill>
            <a:srgbClr val="FFB600"/>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 name="TextBox 57">
            <a:extLst>
              <a:ext uri="{FF2B5EF4-FFF2-40B4-BE49-F238E27FC236}">
                <a16:creationId xmlns:a16="http://schemas.microsoft.com/office/drawing/2014/main" id="{5EABE30F-0E56-70CF-F70C-C9F69FE1D1D5}"/>
              </a:ext>
            </a:extLst>
          </p:cNvPr>
          <p:cNvSpPr txBox="1"/>
          <p:nvPr/>
        </p:nvSpPr>
        <p:spPr>
          <a:xfrm>
            <a:off x="4339956" y="8873514"/>
            <a:ext cx="2467244" cy="369332"/>
          </a:xfrm>
          <a:prstGeom prst="rect">
            <a:avLst/>
          </a:prstGeom>
          <a:noFill/>
        </p:spPr>
        <p:txBody>
          <a:bodyPr wrap="square" rtlCol="0">
            <a:spAutoFit/>
          </a:bodyPr>
          <a:lstStyle/>
          <a:p>
            <a:r>
              <a:rPr lang="en-US"/>
              <a:t>If correct move to next </a:t>
            </a:r>
          </a:p>
        </p:txBody>
      </p:sp>
      <p:sp>
        <p:nvSpPr>
          <p:cNvPr id="60" name="object 4">
            <a:extLst>
              <a:ext uri="{FF2B5EF4-FFF2-40B4-BE49-F238E27FC236}">
                <a16:creationId xmlns:a16="http://schemas.microsoft.com/office/drawing/2014/main" id="{AB662FC1-0C82-8ACA-0CB4-8FCEF738B8ED}"/>
              </a:ext>
            </a:extLst>
          </p:cNvPr>
          <p:cNvSpPr txBox="1"/>
          <p:nvPr/>
        </p:nvSpPr>
        <p:spPr>
          <a:xfrm>
            <a:off x="3657600" y="457200"/>
            <a:ext cx="3657600" cy="620363"/>
          </a:xfrm>
          <a:prstGeom prst="rect">
            <a:avLst/>
          </a:prstGeom>
          <a:ln w="6350">
            <a:noFill/>
          </a:ln>
        </p:spPr>
        <p:txBody>
          <a:bodyPr vert="horz" wrap="square" lIns="0" tIns="0" rIns="0" bIns="0" rtlCol="0">
            <a:spAutoFit/>
          </a:bodyPr>
          <a:lstStyle/>
          <a:p>
            <a:pPr marL="74930" marR="67310" indent="632460">
              <a:lnSpc>
                <a:spcPts val="5600"/>
              </a:lnSpc>
            </a:pPr>
            <a:r>
              <a:rPr sz="2800">
                <a:latin typeface="Helvetica"/>
                <a:cs typeface="Helvetica"/>
              </a:rPr>
              <a:t>Bicep</a:t>
            </a:r>
            <a:r>
              <a:rPr lang="en-US" sz="2800">
                <a:latin typeface="Helvetica"/>
                <a:cs typeface="Helvetica"/>
              </a:rPr>
              <a:t> </a:t>
            </a:r>
            <a:r>
              <a:rPr sz="2800">
                <a:latin typeface="Helvetica"/>
                <a:cs typeface="Helvetica"/>
              </a:rPr>
              <a:t>tendonitis</a:t>
            </a:r>
          </a:p>
        </p:txBody>
      </p:sp>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Application>Microsoft Office PowerPoint</Application>
  <PresentationFormat>Custom</PresentationFormat>
  <Slides>19</Slides>
  <Notes>19</Notes>
  <HiddenSlides>0</HiddenSlides>
  <ScaleCrop>false</ScaleCrop>
  <HeadingPairs>
    <vt:vector size="4" baseType="variant">
      <vt:variant>
        <vt:lpstr>Theme</vt:lpstr>
      </vt:variant>
      <vt:variant>
        <vt:i4>1</vt:i4>
      </vt:variant>
      <vt:variant>
        <vt:lpstr>Slide Titles</vt:lpstr>
      </vt:variant>
      <vt:variant>
        <vt:i4>19</vt:i4>
      </vt:variant>
    </vt:vector>
  </HeadingPairs>
  <TitlesOfParts>
    <vt:vector size="20" baseType="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ree Flash Cards</dc:title>
  <dc:subject>?</dc:subject>
  <dc:creator>www.kitzkikz.com/flashcards</dc:creator>
  <cp:keywords>?</cp:keywords>
  <cp:revision>81</cp:revision>
  <dcterms:created xsi:type="dcterms:W3CDTF">2023-06-29T09:38:07Z</dcterms:created>
  <dcterms:modified xsi:type="dcterms:W3CDTF">2023-08-07T19:23:39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reated">
    <vt:filetime>2023-06-29T00:00:00Z</vt:filetime>
  </property>
  <property fmtid="{D5CDD505-2E9C-101B-9397-08002B2CF9AE}" pid="3" name="LastSaved">
    <vt:filetime>2023-06-29T00:00:00Z</vt:filetime>
  </property>
</Properties>
</file>